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webextensions/webextension2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9" r:id="rId2"/>
    <p:sldId id="266" r:id="rId3"/>
    <p:sldId id="265" r:id="rId4"/>
    <p:sldId id="264" r:id="rId5"/>
    <p:sldId id="263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6314988-9075-4547-DCC7-7EF8E28B7E16}" name="Ben Wielockx" initials="BW" userId="ca51338419742875" providerId="Windows Live"/>
  <p188:author id="{B30C3AD9-195F-9F5B-B6CD-3B409C0B52FA}" name="Stephen Ariyeloye" initials="SA" userId="553a622a09ee930d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005" autoAdjust="0"/>
  </p:normalViewPr>
  <p:slideViewPr>
    <p:cSldViewPr snapToGrid="0">
      <p:cViewPr varScale="1">
        <p:scale>
          <a:sx n="102" d="100"/>
          <a:sy n="102" d="100"/>
        </p:scale>
        <p:origin x="156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n Wielockx" userId="ca51338419742875" providerId="LiveId" clId="{D5FDAE7E-CD82-492B-A50C-C600E21375E1}"/>
    <pc:docChg chg="undo redo custSel addSld modSld sldOrd">
      <pc:chgData name="Ben Wielockx" userId="ca51338419742875" providerId="LiveId" clId="{D5FDAE7E-CD82-492B-A50C-C600E21375E1}" dt="2025-01-07T09:43:03.682" v="2204" actId="20577"/>
      <pc:docMkLst>
        <pc:docMk/>
      </pc:docMkLst>
      <pc:sldChg chg="modSp mod ord">
        <pc:chgData name="Ben Wielockx" userId="ca51338419742875" providerId="LiveId" clId="{D5FDAE7E-CD82-492B-A50C-C600E21375E1}" dt="2025-01-07T09:43:00.891" v="2203" actId="20577"/>
        <pc:sldMkLst>
          <pc:docMk/>
          <pc:sldMk cId="651143520" sldId="259"/>
        </pc:sldMkLst>
        <pc:spChg chg="mod">
          <ac:chgData name="Ben Wielockx" userId="ca51338419742875" providerId="LiveId" clId="{D5FDAE7E-CD82-492B-A50C-C600E21375E1}" dt="2025-01-07T09:43:00.891" v="2203" actId="20577"/>
          <ac:spMkLst>
            <pc:docMk/>
            <pc:sldMk cId="651143520" sldId="259"/>
            <ac:spMk id="5" creationId="{B1DB247A-A1D1-AF90-C73B-696D42CEB0CF}"/>
          </ac:spMkLst>
        </pc:spChg>
        <pc:graphicFrameChg chg="mod">
          <ac:chgData name="Ben Wielockx" userId="ca51338419742875" providerId="LiveId" clId="{D5FDAE7E-CD82-492B-A50C-C600E21375E1}" dt="2025-01-06T16:19:59.378" v="1597"/>
          <ac:graphicFrameMkLst>
            <pc:docMk/>
            <pc:sldMk cId="651143520" sldId="259"/>
            <ac:graphicFrameMk id="8" creationId="{6D893D28-D144-F122-46F0-A7749BE21324}"/>
          </ac:graphicFrameMkLst>
        </pc:graphicFrameChg>
      </pc:sldChg>
      <pc:sldChg chg="modSp mod">
        <pc:chgData name="Ben Wielockx" userId="ca51338419742875" providerId="LiveId" clId="{D5FDAE7E-CD82-492B-A50C-C600E21375E1}" dt="2025-01-06T15:10:44.756" v="592" actId="20577"/>
        <pc:sldMkLst>
          <pc:docMk/>
          <pc:sldMk cId="1166237567" sldId="263"/>
        </pc:sldMkLst>
        <pc:spChg chg="mod">
          <ac:chgData name="Ben Wielockx" userId="ca51338419742875" providerId="LiveId" clId="{D5FDAE7E-CD82-492B-A50C-C600E21375E1}" dt="2025-01-06T15:10:44.756" v="592" actId="20577"/>
          <ac:spMkLst>
            <pc:docMk/>
            <pc:sldMk cId="1166237567" sldId="263"/>
            <ac:spMk id="4" creationId="{B9C95B7B-9A34-9199-D32B-9B5291E37C99}"/>
          </ac:spMkLst>
        </pc:spChg>
      </pc:sldChg>
      <pc:sldChg chg="modSp mod">
        <pc:chgData name="Ben Wielockx" userId="ca51338419742875" providerId="LiveId" clId="{D5FDAE7E-CD82-492B-A50C-C600E21375E1}" dt="2025-01-06T15:10:39.782" v="591" actId="20577"/>
        <pc:sldMkLst>
          <pc:docMk/>
          <pc:sldMk cId="4263733094" sldId="264"/>
        </pc:sldMkLst>
        <pc:spChg chg="mod">
          <ac:chgData name="Ben Wielockx" userId="ca51338419742875" providerId="LiveId" clId="{D5FDAE7E-CD82-492B-A50C-C600E21375E1}" dt="2025-01-06T15:10:39.782" v="591" actId="20577"/>
          <ac:spMkLst>
            <pc:docMk/>
            <pc:sldMk cId="4263733094" sldId="264"/>
            <ac:spMk id="5" creationId="{E660C72F-57D5-6CEB-8A4C-24482D871C67}"/>
          </ac:spMkLst>
        </pc:spChg>
      </pc:sldChg>
      <pc:sldChg chg="addSp delSp modSp new mod">
        <pc:chgData name="Ben Wielockx" userId="ca51338419742875" providerId="LiveId" clId="{D5FDAE7E-CD82-492B-A50C-C600E21375E1}" dt="2025-01-07T08:56:36.239" v="1856" actId="1036"/>
        <pc:sldMkLst>
          <pc:docMk/>
          <pc:sldMk cId="2228276662" sldId="265"/>
        </pc:sldMkLst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2" creationId="{4F5D8A7A-8B72-6E44-FE49-75F0AE2B596F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" creationId="{8C4773F1-78AA-3AA0-014A-E56A9D04BBAB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8" creationId="{FE7EDE62-CB0E-2445-892B-DB5936256623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9" creationId="{949D63F0-D0F8-2835-68CA-B2AFAACC61C5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0" creationId="{79D31681-024D-BAEA-6E72-A8BE5D2EE233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1" creationId="{AB568627-29FA-0F2A-5894-6ABF26D49480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2" creationId="{B4C82E2F-794B-25B0-D502-A4CB6D43FA2B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3" creationId="{4F05A73D-BA5B-3006-EEE1-6401774A611B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4" creationId="{CFB369F4-3528-B575-38C2-2187DED8594E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5" creationId="{D4F71F5A-0C2A-20C2-A46F-A115861156B0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6" creationId="{607470C5-0561-63E3-E21F-D1F942450453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7" creationId="{FE1D008C-5824-261A-B660-DD838F96AB45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18" creationId="{45C97D2C-1AFD-7B03-5401-7D15D43A6CB9}"/>
          </ac:spMkLst>
        </pc:spChg>
        <pc:spChg chg="add del mod">
          <ac:chgData name="Ben Wielockx" userId="ca51338419742875" providerId="LiveId" clId="{D5FDAE7E-CD82-492B-A50C-C600E21375E1}" dt="2025-01-07T08:53:34.862" v="1822" actId="478"/>
          <ac:spMkLst>
            <pc:docMk/>
            <pc:sldMk cId="2228276662" sldId="265"/>
            <ac:spMk id="19" creationId="{ACCCFC87-096E-2EEB-ADB4-9B0792FC5CCD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20" creationId="{8083AA0B-9D68-EFD3-C65E-33330E7A080A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21" creationId="{2D6A69C6-F9D0-B902-55F9-6A72BE80A8D0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22" creationId="{A19F7A6D-2123-CB9F-3AD3-854072347CE5}"/>
          </ac:spMkLst>
        </pc:spChg>
        <pc:spChg chg="add del mod">
          <ac:chgData name="Ben Wielockx" userId="ca51338419742875" providerId="LiveId" clId="{D5FDAE7E-CD82-492B-A50C-C600E21375E1}" dt="2025-01-07T08:50:52.080" v="1759" actId="478"/>
          <ac:spMkLst>
            <pc:docMk/>
            <pc:sldMk cId="2228276662" sldId="265"/>
            <ac:spMk id="23" creationId="{571A038F-CE4F-6F84-8838-E17BBD6E8929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24" creationId="{DFC26621-51B5-1552-E798-8DD26B83FD32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25" creationId="{36CC88A9-D938-5626-A14E-859AAF441EE7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26" creationId="{CBEE21FF-A9D3-33B4-510D-FA257FD9D13B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27" creationId="{28F96097-4D12-1731-D51B-7650A3E60CC7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28" creationId="{C4AEE32E-FBED-D6D6-87DC-3A7861898BF8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29" creationId="{D023A6C2-C99D-EC83-1CB8-92B5E9114FDC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30" creationId="{34ACDA6D-8B68-8203-C459-0B1C702BE296}"/>
          </ac:spMkLst>
        </pc:spChg>
        <pc:spChg chg="add mod">
          <ac:chgData name="Ben Wielockx" userId="ca51338419742875" providerId="LiveId" clId="{D5FDAE7E-CD82-492B-A50C-C600E21375E1}" dt="2025-01-06T15:10:35.370" v="590" actId="20577"/>
          <ac:spMkLst>
            <pc:docMk/>
            <pc:sldMk cId="2228276662" sldId="265"/>
            <ac:spMk id="31" creationId="{B3EE7EEE-30F6-276F-1E8F-C9AFDC985E0B}"/>
          </ac:spMkLst>
        </pc:spChg>
        <pc:spChg chg="add mod">
          <ac:chgData name="Ben Wielockx" userId="ca51338419742875" providerId="LiveId" clId="{D5FDAE7E-CD82-492B-A50C-C600E21375E1}" dt="2025-01-06T15:47:35.862" v="1440" actId="1076"/>
          <ac:spMkLst>
            <pc:docMk/>
            <pc:sldMk cId="2228276662" sldId="265"/>
            <ac:spMk id="32" creationId="{D4577C57-7621-27D2-4E50-14CEA9856959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34" creationId="{22774924-2C19-20A1-4369-B277D5BA59CF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35" creationId="{42127B10-49A8-ABFE-0C41-6122FCADFBEB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36" creationId="{D7718595-D921-B7C0-6FA4-813765C1B816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37" creationId="{7C13280E-646E-7D71-A1DE-395572B37E39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38" creationId="{9BF30553-982C-2ACC-3278-AA7850C9716F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39" creationId="{43392F98-3AFC-AA09-1F04-19E2683CB6BB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40" creationId="{0F9C0172-775C-0DC3-FB5A-B427D784C20E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41" creationId="{28F27394-B656-8366-A87B-92769AD229B0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42" creationId="{B3614013-7E82-2C0C-CA1A-8F7406C28890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43" creationId="{9EABEC74-6630-138E-0D5A-613EC55CF3C9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44" creationId="{2109A002-5D0B-6E68-ADEF-492B60E8862D}"/>
          </ac:spMkLst>
        </pc:spChg>
        <pc:spChg chg="mod">
          <ac:chgData name="Ben Wielockx" userId="ca51338419742875" providerId="LiveId" clId="{D5FDAE7E-CD82-492B-A50C-C600E21375E1}" dt="2025-01-06T15:48:09.906" v="1444"/>
          <ac:spMkLst>
            <pc:docMk/>
            <pc:sldMk cId="2228276662" sldId="265"/>
            <ac:spMk id="45" creationId="{9CB0DDC3-E847-4434-DFFD-8B55C1198A48}"/>
          </ac:spMkLst>
        </pc:spChg>
        <pc:spChg chg="add mod">
          <ac:chgData name="Ben Wielockx" userId="ca51338419742875" providerId="LiveId" clId="{D5FDAE7E-CD82-492B-A50C-C600E21375E1}" dt="2025-01-06T15:49:58.240" v="1562" actId="20577"/>
          <ac:spMkLst>
            <pc:docMk/>
            <pc:sldMk cId="2228276662" sldId="265"/>
            <ac:spMk id="46" creationId="{453227A4-E0FA-64D3-0CAC-A56AFD7C952A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48" creationId="{42C51BAF-D25D-3FA3-6B5B-E8396E6E1D08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49" creationId="{366F8562-DE25-9ECF-68E5-8F7F23A17956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0" creationId="{376959AC-F5F3-66C9-819C-6BE76D4D2E8D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1" creationId="{ACEF8BF9-0418-1E07-D1CA-76C5F7A85963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2" creationId="{BD97BF47-BB62-F4A1-9F79-1F95C31210F4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3" creationId="{CBD538A5-495D-1FE4-589D-E42E26B4E1C8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4" creationId="{89B54D38-E6FE-5818-A2BB-0F6CAFBE03EA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5" creationId="{B916D758-6A13-4531-6797-35FD123A689D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6" creationId="{EFCB3EC0-BD81-EA61-EB14-1DDC352B216A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7" creationId="{89860C4C-6774-C79D-DFC5-F3AE18489B04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8" creationId="{2499F9D8-5046-A2C4-9482-FBC7239CB7C2}"/>
          </ac:spMkLst>
        </pc:spChg>
        <pc:spChg chg="mod">
          <ac:chgData name="Ben Wielockx" userId="ca51338419742875" providerId="LiveId" clId="{D5FDAE7E-CD82-492B-A50C-C600E21375E1}" dt="2025-01-06T15:50:16.631" v="1563"/>
          <ac:spMkLst>
            <pc:docMk/>
            <pc:sldMk cId="2228276662" sldId="265"/>
            <ac:spMk id="59" creationId="{3445EEDD-C4CE-CE49-6164-CD1D16190672}"/>
          </ac:spMkLst>
        </pc:spChg>
        <pc:spChg chg="add mod">
          <ac:chgData name="Ben Wielockx" userId="ca51338419742875" providerId="LiveId" clId="{D5FDAE7E-CD82-492B-A50C-C600E21375E1}" dt="2025-01-06T15:52:05.588" v="1586" actId="14100"/>
          <ac:spMkLst>
            <pc:docMk/>
            <pc:sldMk cId="2228276662" sldId="265"/>
            <ac:spMk id="60" creationId="{71A24628-C11C-5CE8-B4F4-44D16710ACF4}"/>
          </ac:spMkLst>
        </pc:spChg>
        <pc:spChg chg="add mod">
          <ac:chgData name="Ben Wielockx" userId="ca51338419742875" providerId="LiveId" clId="{D5FDAE7E-CD82-492B-A50C-C600E21375E1}" dt="2025-01-06T15:52:09.039" v="1587" actId="14100"/>
          <ac:spMkLst>
            <pc:docMk/>
            <pc:sldMk cId="2228276662" sldId="265"/>
            <ac:spMk id="61" creationId="{8F869734-5530-7EC9-9D84-00D60EFABF2C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62" creationId="{FFDA9EFF-1456-614F-A3D1-805F37874CC7}"/>
          </ac:spMkLst>
        </pc:spChg>
        <pc:spChg chg="add mod">
          <ac:chgData name="Ben Wielockx" userId="ca51338419742875" providerId="LiveId" clId="{D5FDAE7E-CD82-492B-A50C-C600E21375E1}" dt="2025-01-07T08:56:20.242" v="1846" actId="1036"/>
          <ac:spMkLst>
            <pc:docMk/>
            <pc:sldMk cId="2228276662" sldId="265"/>
            <ac:spMk id="63" creationId="{441E4FE1-2B6F-AEA9-32CB-81EACD8D1114}"/>
          </ac:spMkLst>
        </pc:spChg>
        <pc:spChg chg="add mod">
          <ac:chgData name="Ben Wielockx" userId="ca51338419742875" providerId="LiveId" clId="{D5FDAE7E-CD82-492B-A50C-C600E21375E1}" dt="2025-01-06T15:52:17.047" v="1590" actId="20577"/>
          <ac:spMkLst>
            <pc:docMk/>
            <pc:sldMk cId="2228276662" sldId="265"/>
            <ac:spMk id="64" creationId="{95AC5848-9492-5DBE-7AB4-8D6FE4F2298D}"/>
          </ac:spMkLst>
        </pc:spChg>
        <pc:spChg chg="add mod">
          <ac:chgData name="Ben Wielockx" userId="ca51338419742875" providerId="LiveId" clId="{D5FDAE7E-CD82-492B-A50C-C600E21375E1}" dt="2025-01-06T15:52:29.198" v="1593" actId="20577"/>
          <ac:spMkLst>
            <pc:docMk/>
            <pc:sldMk cId="2228276662" sldId="265"/>
            <ac:spMk id="65" creationId="{0FB17F84-4C62-A13F-6330-6266FF84EC7A}"/>
          </ac:spMkLst>
        </pc:spChg>
        <pc:spChg chg="add del mod">
          <ac:chgData name="Ben Wielockx" userId="ca51338419742875" providerId="LiveId" clId="{D5FDAE7E-CD82-492B-A50C-C600E21375E1}" dt="2025-01-07T08:53:32.051" v="1821" actId="478"/>
          <ac:spMkLst>
            <pc:docMk/>
            <pc:sldMk cId="2228276662" sldId="265"/>
            <ac:spMk id="66" creationId="{C8BC3D1F-FC58-4356-0522-FA640A2FF358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69" creationId="{95B288CB-8524-E7CE-D863-8468ED1903F2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0" creationId="{7C5E90A5-DA71-57A3-3EAD-1F59545CF825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1" creationId="{E3BC8FA1-E859-F433-F8AB-5A4462DB89B5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2" creationId="{93F38821-F398-EB6B-2352-47C705656BFE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3" creationId="{3A28A30D-D324-5A79-4480-2521A9CE28F6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4" creationId="{A40F6EC1-3660-CD05-CEAF-336FEC3C8F33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5" creationId="{EC8A5E3A-28EE-8DAC-7BCD-C43987CB0302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6" creationId="{85EE31F8-94F2-609E-A976-86DCE25D3786}"/>
          </ac:spMkLst>
        </pc:spChg>
        <pc:spChg chg="add mod">
          <ac:chgData name="Ben Wielockx" userId="ca51338419742875" providerId="LiveId" clId="{D5FDAE7E-CD82-492B-A50C-C600E21375E1}" dt="2025-01-07T08:54:58.961" v="1837" actId="1076"/>
          <ac:spMkLst>
            <pc:docMk/>
            <pc:sldMk cId="2228276662" sldId="265"/>
            <ac:spMk id="77" creationId="{F2320F22-F6E8-1141-6191-E39413A521D0}"/>
          </ac:spMkLst>
        </pc:spChg>
        <pc:spChg chg="add mod">
          <ac:chgData name="Ben Wielockx" userId="ca51338419742875" providerId="LiveId" clId="{D5FDAE7E-CD82-492B-A50C-C600E21375E1}" dt="2025-01-06T15:46:26.900" v="1415" actId="1076"/>
          <ac:spMkLst>
            <pc:docMk/>
            <pc:sldMk cId="2228276662" sldId="265"/>
            <ac:spMk id="85" creationId="{C5D138F5-BE7E-D125-B745-06FB4AA595A1}"/>
          </ac:spMkLst>
        </pc:spChg>
        <pc:spChg chg="add del mod">
          <ac:chgData name="Ben Wielockx" userId="ca51338419742875" providerId="LiveId" clId="{D5FDAE7E-CD82-492B-A50C-C600E21375E1}" dt="2025-01-06T15:47:28.098" v="1437" actId="478"/>
          <ac:spMkLst>
            <pc:docMk/>
            <pc:sldMk cId="2228276662" sldId="265"/>
            <ac:spMk id="87" creationId="{D3E9EAD8-632A-4929-1421-36BD718EEE21}"/>
          </ac:spMkLst>
        </pc:spChg>
        <pc:spChg chg="add mod">
          <ac:chgData name="Ben Wielockx" userId="ca51338419742875" providerId="LiveId" clId="{D5FDAE7E-CD82-492B-A50C-C600E21375E1}" dt="2025-01-06T15:49:34.648" v="1555" actId="1076"/>
          <ac:spMkLst>
            <pc:docMk/>
            <pc:sldMk cId="2228276662" sldId="265"/>
            <ac:spMk id="88" creationId="{6EC287BD-32C9-B301-A48A-28C2630455A9}"/>
          </ac:spMkLst>
        </pc:spChg>
        <pc:spChg chg="add mod">
          <ac:chgData name="Ben Wielockx" userId="ca51338419742875" providerId="LiveId" clId="{D5FDAE7E-CD82-492B-A50C-C600E21375E1}" dt="2025-01-06T15:47:42.927" v="1442" actId="6549"/>
          <ac:spMkLst>
            <pc:docMk/>
            <pc:sldMk cId="2228276662" sldId="265"/>
            <ac:spMk id="89" creationId="{0CCB9016-D47B-DAFD-589B-C5F3E83286B5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94" creationId="{66527953-F438-0F0B-81E4-B86D33AA779A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95" creationId="{8EEC547B-C876-7D54-FB33-704078852814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96" creationId="{E7ACDC30-3F33-C0BD-47A0-8F7BA3C10F65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97" creationId="{6BDE0A5F-3F59-5F18-83EB-AE1DF11D4B93}"/>
          </ac:spMkLst>
        </pc:spChg>
        <pc:spChg chg="mod">
          <ac:chgData name="Ben Wielockx" userId="ca51338419742875" providerId="LiveId" clId="{D5FDAE7E-CD82-492B-A50C-C600E21375E1}" dt="2025-01-06T15:48:29.504" v="1452" actId="1037"/>
          <ac:spMkLst>
            <pc:docMk/>
            <pc:sldMk cId="2228276662" sldId="265"/>
            <ac:spMk id="98" creationId="{7C14EEFE-4717-15E2-4533-C6CF7CD1BC3E}"/>
          </ac:spMkLst>
        </pc:spChg>
        <pc:spChg chg="mod">
          <ac:chgData name="Ben Wielockx" userId="ca51338419742875" providerId="LiveId" clId="{D5FDAE7E-CD82-492B-A50C-C600E21375E1}" dt="2025-01-06T15:48:34.927" v="1460" actId="1037"/>
          <ac:spMkLst>
            <pc:docMk/>
            <pc:sldMk cId="2228276662" sldId="265"/>
            <ac:spMk id="99" creationId="{1227B21F-06E8-F4E5-DBD3-ED91E03CCE79}"/>
          </ac:spMkLst>
        </pc:spChg>
        <pc:spChg chg="mod">
          <ac:chgData name="Ben Wielockx" userId="ca51338419742875" providerId="LiveId" clId="{D5FDAE7E-CD82-492B-A50C-C600E21375E1}" dt="2025-01-06T15:48:42.150" v="1471" actId="1037"/>
          <ac:spMkLst>
            <pc:docMk/>
            <pc:sldMk cId="2228276662" sldId="265"/>
            <ac:spMk id="100" creationId="{9F4AE1BB-B0DF-FAFF-2B1F-4F2CE1BA2985}"/>
          </ac:spMkLst>
        </pc:spChg>
        <pc:spChg chg="mod">
          <ac:chgData name="Ben Wielockx" userId="ca51338419742875" providerId="LiveId" clId="{D5FDAE7E-CD82-492B-A50C-C600E21375E1}" dt="2025-01-06T15:48:48.900" v="1485" actId="1038"/>
          <ac:spMkLst>
            <pc:docMk/>
            <pc:sldMk cId="2228276662" sldId="265"/>
            <ac:spMk id="101" creationId="{E5AB6A24-5B94-7F33-4BA8-639EF74E0219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02" creationId="{F55FE29A-C9E0-1518-B83D-DB633379F3BA}"/>
          </ac:spMkLst>
        </pc:spChg>
        <pc:spChg chg="mod">
          <ac:chgData name="Ben Wielockx" userId="ca51338419742875" providerId="LiveId" clId="{D5FDAE7E-CD82-492B-A50C-C600E21375E1}" dt="2025-01-06T15:48:57.069" v="1499" actId="1038"/>
          <ac:spMkLst>
            <pc:docMk/>
            <pc:sldMk cId="2228276662" sldId="265"/>
            <ac:spMk id="103" creationId="{DA3CABAB-D796-FE48-F091-2A79C7FB48AA}"/>
          </ac:spMkLst>
        </pc:spChg>
        <pc:spChg chg="mod">
          <ac:chgData name="Ben Wielockx" userId="ca51338419742875" providerId="LiveId" clId="{D5FDAE7E-CD82-492B-A50C-C600E21375E1}" dt="2025-01-06T15:49:22.535" v="1539" actId="1038"/>
          <ac:spMkLst>
            <pc:docMk/>
            <pc:sldMk cId="2228276662" sldId="265"/>
            <ac:spMk id="104" creationId="{4376DDF1-1951-374D-8C0B-2D756BFE6EE8}"/>
          </ac:spMkLst>
        </pc:spChg>
        <pc:spChg chg="mod">
          <ac:chgData name="Ben Wielockx" userId="ca51338419742875" providerId="LiveId" clId="{D5FDAE7E-CD82-492B-A50C-C600E21375E1}" dt="2025-01-06T15:49:28.726" v="1554" actId="1038"/>
          <ac:spMkLst>
            <pc:docMk/>
            <pc:sldMk cId="2228276662" sldId="265"/>
            <ac:spMk id="105" creationId="{16447EC4-3463-EF24-59B8-C0B0D67CFF1A}"/>
          </ac:spMkLst>
        </pc:spChg>
        <pc:spChg chg="mod">
          <ac:chgData name="Ben Wielockx" userId="ca51338419742875" providerId="LiveId" clId="{D5FDAE7E-CD82-492B-A50C-C600E21375E1}" dt="2025-01-07T08:56:36.239" v="1856" actId="1036"/>
          <ac:spMkLst>
            <pc:docMk/>
            <pc:sldMk cId="2228276662" sldId="265"/>
            <ac:spMk id="106" creationId="{83260E3D-9B50-304F-3976-F3E8B69B188A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07" creationId="{D82541B8-2BE1-622D-2947-45DD35664A4A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08" creationId="{383E937A-092C-C4C7-1367-CDD1EAACDCA6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09" creationId="{5E90F78C-3BB0-A298-B1B4-BD199CDDF43A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10" creationId="{E7DB7F70-BE35-E6DF-F957-877382F9711A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11" creationId="{0D1D8BDF-5F3A-93FE-801B-727A421031BB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12" creationId="{788E175F-8B2D-ABB4-C4A6-EFD8796DD9E3}"/>
          </ac:spMkLst>
        </pc:spChg>
        <pc:spChg chg="mod">
          <ac:chgData name="Ben Wielockx" userId="ca51338419742875" providerId="LiveId" clId="{D5FDAE7E-CD82-492B-A50C-C600E21375E1}" dt="2025-01-06T15:48:03.763" v="1443" actId="165"/>
          <ac:spMkLst>
            <pc:docMk/>
            <pc:sldMk cId="2228276662" sldId="265"/>
            <ac:spMk id="113" creationId="{31C49769-0397-C522-7A8A-D7E2F92EACA8}"/>
          </ac:spMkLst>
        </pc:spChg>
        <pc:spChg chg="mod">
          <ac:chgData name="Ben Wielockx" userId="ca51338419742875" providerId="LiveId" clId="{D5FDAE7E-CD82-492B-A50C-C600E21375E1}" dt="2025-01-07T08:56:29.987" v="1854" actId="1037"/>
          <ac:spMkLst>
            <pc:docMk/>
            <pc:sldMk cId="2228276662" sldId="265"/>
            <ac:spMk id="119" creationId="{7DC7425A-F3BC-E0EC-4201-47F07F561A6E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0" creationId="{C2714984-9F17-F312-B391-5FE222F39326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1" creationId="{6840320C-11B2-0BB3-9BA6-6C7CA7D53A0D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2" creationId="{27216130-9131-E37F-7E61-B00B7E114FD3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3" creationId="{80F4C2D9-01DB-B2EB-4B5E-140DBA17372A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4" creationId="{CBF211D3-0EC6-1544-B7E1-C24120707312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5" creationId="{1A9AF7AC-5D54-3250-4EA0-9178A5FD8A95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6" creationId="{2CC85B0E-1772-D5D9-1B52-EB975B5E145B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7" creationId="{57D71C7D-FB65-FEEF-FA3D-D513B726ABB4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8" creationId="{43C96C39-994B-5650-4AFE-158ADF808080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29" creationId="{001FBDCF-20AD-6201-D511-3872B10D58A6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0" creationId="{BDA7F884-6308-5CE8-8A9B-294AF22BD392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1" creationId="{477195FC-DF6F-1803-9AF7-66747A383D48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2" creationId="{019586DA-AE45-BEC5-77E2-DA9A4048E03D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3" creationId="{4EFDCD6F-1491-C2C2-F2B9-E6E894405A85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4" creationId="{E3DCB1DF-483B-160B-15A2-BB0957FA11A7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5" creationId="{68D3B565-77C2-94E6-5F8C-B7E99455BCFA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6" creationId="{49ABBCFC-2955-B150-CE51-463E3A5D2535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7" creationId="{FBB817E2-AACF-11A8-FA87-3D518ADD22E2}"/>
          </ac:spMkLst>
        </pc:spChg>
        <pc:spChg chg="mod">
          <ac:chgData name="Ben Wielockx" userId="ca51338419742875" providerId="LiveId" clId="{D5FDAE7E-CD82-492B-A50C-C600E21375E1}" dt="2025-01-06T15:50:26.275" v="1565" actId="165"/>
          <ac:spMkLst>
            <pc:docMk/>
            <pc:sldMk cId="2228276662" sldId="265"/>
            <ac:spMk id="138" creationId="{2E65ADF9-4EB7-90AD-AE94-E917B2000684}"/>
          </ac:spMkLst>
        </pc:spChg>
        <pc:spChg chg="add del mod">
          <ac:chgData name="Ben Wielockx" userId="ca51338419742875" providerId="LiveId" clId="{D5FDAE7E-CD82-492B-A50C-C600E21375E1}" dt="2025-01-06T15:49:51.877" v="1559" actId="478"/>
          <ac:spMkLst>
            <pc:docMk/>
            <pc:sldMk cId="2228276662" sldId="265"/>
            <ac:spMk id="139" creationId="{F8FD7068-0844-FDE8-8FB0-CAF057F7F3BE}"/>
          </ac:spMkLst>
        </pc:spChg>
        <pc:grpChg chg="add del mod">
          <ac:chgData name="Ben Wielockx" userId="ca51338419742875" providerId="LiveId" clId="{D5FDAE7E-CD82-492B-A50C-C600E21375E1}" dt="2025-01-06T15:48:14.988" v="1446" actId="478"/>
          <ac:grpSpMkLst>
            <pc:docMk/>
            <pc:sldMk cId="2228276662" sldId="265"/>
            <ac:grpSpMk id="33" creationId="{25CCCF0D-E2C4-7507-8A66-203FCEE4DC0F}"/>
          </ac:grpSpMkLst>
        </pc:grpChg>
        <pc:grpChg chg="add mod">
          <ac:chgData name="Ben Wielockx" userId="ca51338419742875" providerId="LiveId" clId="{D5FDAE7E-CD82-492B-A50C-C600E21375E1}" dt="2025-01-06T15:50:39.920" v="1574" actId="1038"/>
          <ac:grpSpMkLst>
            <pc:docMk/>
            <pc:sldMk cId="2228276662" sldId="265"/>
            <ac:grpSpMk id="47" creationId="{87DA6F75-E16F-AC71-EED4-DE283DE17E26}"/>
          </ac:grpSpMkLst>
        </pc:grpChg>
        <pc:grpChg chg="add del mod">
          <ac:chgData name="Ben Wielockx" userId="ca51338419742875" providerId="LiveId" clId="{D5FDAE7E-CD82-492B-A50C-C600E21375E1}" dt="2025-01-06T15:48:03.763" v="1443" actId="165"/>
          <ac:grpSpMkLst>
            <pc:docMk/>
            <pc:sldMk cId="2228276662" sldId="265"/>
            <ac:grpSpMk id="90" creationId="{AE8CDA16-0DF7-7DC8-4804-CDE82344230A}"/>
          </ac:grpSpMkLst>
        </pc:grpChg>
        <pc:grpChg chg="mod topLvl">
          <ac:chgData name="Ben Wielockx" userId="ca51338419742875" providerId="LiveId" clId="{D5FDAE7E-CD82-492B-A50C-C600E21375E1}" dt="2025-01-06T15:48:03.763" v="1443" actId="165"/>
          <ac:grpSpMkLst>
            <pc:docMk/>
            <pc:sldMk cId="2228276662" sldId="265"/>
            <ac:grpSpMk id="92" creationId="{B5DEACF3-2735-29F2-9444-EA037990938E}"/>
          </ac:grpSpMkLst>
        </pc:grpChg>
        <pc:grpChg chg="mod topLvl">
          <ac:chgData name="Ben Wielockx" userId="ca51338419742875" providerId="LiveId" clId="{D5FDAE7E-CD82-492B-A50C-C600E21375E1}" dt="2025-01-06T15:48:03.763" v="1443" actId="165"/>
          <ac:grpSpMkLst>
            <pc:docMk/>
            <pc:sldMk cId="2228276662" sldId="265"/>
            <ac:grpSpMk id="93" creationId="{25E6F8D6-7B6D-135C-CC02-8873C1B37D7D}"/>
          </ac:grpSpMkLst>
        </pc:grpChg>
        <pc:grpChg chg="add del mod">
          <ac:chgData name="Ben Wielockx" userId="ca51338419742875" providerId="LiveId" clId="{D5FDAE7E-CD82-492B-A50C-C600E21375E1}" dt="2025-01-06T15:50:26.275" v="1565" actId="165"/>
          <ac:grpSpMkLst>
            <pc:docMk/>
            <pc:sldMk cId="2228276662" sldId="265"/>
            <ac:grpSpMk id="115" creationId="{343F1E03-4217-394A-812D-540E8813AA9A}"/>
          </ac:grpSpMkLst>
        </pc:grpChg>
        <pc:grpChg chg="del mod topLvl">
          <ac:chgData name="Ben Wielockx" userId="ca51338419742875" providerId="LiveId" clId="{D5FDAE7E-CD82-492B-A50C-C600E21375E1}" dt="2025-01-06T15:50:29.876" v="1566" actId="478"/>
          <ac:grpSpMkLst>
            <pc:docMk/>
            <pc:sldMk cId="2228276662" sldId="265"/>
            <ac:grpSpMk id="116" creationId="{052CCDB4-C425-36E4-C551-75D917A08D5F}"/>
          </ac:grpSpMkLst>
        </pc:grpChg>
        <pc:grpChg chg="mod topLvl">
          <ac:chgData name="Ben Wielockx" userId="ca51338419742875" providerId="LiveId" clId="{D5FDAE7E-CD82-492B-A50C-C600E21375E1}" dt="2025-01-06T15:50:26.275" v="1565" actId="165"/>
          <ac:grpSpMkLst>
            <pc:docMk/>
            <pc:sldMk cId="2228276662" sldId="265"/>
            <ac:grpSpMk id="117" creationId="{282D4C65-6FC2-5C91-63FD-DBD400070A07}"/>
          </ac:grpSpMkLst>
        </pc:grpChg>
        <pc:picChg chg="add mod">
          <ac:chgData name="Ben Wielockx" userId="ca51338419742875" providerId="LiveId" clId="{D5FDAE7E-CD82-492B-A50C-C600E21375E1}" dt="2025-01-07T08:54:58.961" v="1837" actId="1076"/>
          <ac:picMkLst>
            <pc:docMk/>
            <pc:sldMk cId="2228276662" sldId="265"/>
            <ac:picMk id="3" creationId="{840BAF0A-4CA6-6354-4058-7E13E1CFB4A1}"/>
          </ac:picMkLst>
        </pc:picChg>
        <pc:picChg chg="add mod">
          <ac:chgData name="Ben Wielockx" userId="ca51338419742875" providerId="LiveId" clId="{D5FDAE7E-CD82-492B-A50C-C600E21375E1}" dt="2025-01-07T08:54:58.961" v="1837" actId="1076"/>
          <ac:picMkLst>
            <pc:docMk/>
            <pc:sldMk cId="2228276662" sldId="265"/>
            <ac:picMk id="4" creationId="{B3FD5997-FD62-1B05-1F9B-90DCA0815A5D}"/>
          </ac:picMkLst>
        </pc:picChg>
        <pc:picChg chg="add mod">
          <ac:chgData name="Ben Wielockx" userId="ca51338419742875" providerId="LiveId" clId="{D5FDAE7E-CD82-492B-A50C-C600E21375E1}" dt="2025-01-07T08:54:58.961" v="1837" actId="1076"/>
          <ac:picMkLst>
            <pc:docMk/>
            <pc:sldMk cId="2228276662" sldId="265"/>
            <ac:picMk id="5" creationId="{AC3442F5-AB2A-2878-57CF-4855E250608D}"/>
          </ac:picMkLst>
        </pc:picChg>
        <pc:picChg chg="add mod">
          <ac:chgData name="Ben Wielockx" userId="ca51338419742875" providerId="LiveId" clId="{D5FDAE7E-CD82-492B-A50C-C600E21375E1}" dt="2025-01-07T08:54:58.961" v="1837" actId="1076"/>
          <ac:picMkLst>
            <pc:docMk/>
            <pc:sldMk cId="2228276662" sldId="265"/>
            <ac:picMk id="6" creationId="{36AEB419-430C-C271-3931-4208FC18AAC5}"/>
          </ac:picMkLst>
        </pc:picChg>
        <pc:picChg chg="add mod">
          <ac:chgData name="Ben Wielockx" userId="ca51338419742875" providerId="LiveId" clId="{D5FDAE7E-CD82-492B-A50C-C600E21375E1}" dt="2025-01-06T15:46:38.742" v="1417" actId="1076"/>
          <ac:picMkLst>
            <pc:docMk/>
            <pc:sldMk cId="2228276662" sldId="265"/>
            <ac:picMk id="86" creationId="{DF8454F2-33B3-8659-5DA4-7907C8D4AD69}"/>
          </ac:picMkLst>
        </pc:picChg>
        <pc:picChg chg="mod topLvl">
          <ac:chgData name="Ben Wielockx" userId="ca51338419742875" providerId="LiveId" clId="{D5FDAE7E-CD82-492B-A50C-C600E21375E1}" dt="2025-01-07T08:56:11.491" v="1839" actId="1036"/>
          <ac:picMkLst>
            <pc:docMk/>
            <pc:sldMk cId="2228276662" sldId="265"/>
            <ac:picMk id="91" creationId="{52913FCE-54C5-4AEA-DE3A-84D1D82C2841}"/>
          </ac:picMkLst>
        </pc:picChg>
        <pc:picChg chg="add mod">
          <ac:chgData name="Ben Wielockx" userId="ca51338419742875" providerId="LiveId" clId="{D5FDAE7E-CD82-492B-A50C-C600E21375E1}" dt="2025-01-06T15:46:26.900" v="1415" actId="1076"/>
          <ac:picMkLst>
            <pc:docMk/>
            <pc:sldMk cId="2228276662" sldId="265"/>
            <ac:picMk id="114" creationId="{C73599B3-BB15-5713-B64F-B0611FF10740}"/>
          </ac:picMkLst>
        </pc:picChg>
        <pc:picChg chg="mod topLvl">
          <ac:chgData name="Ben Wielockx" userId="ca51338419742875" providerId="LiveId" clId="{D5FDAE7E-CD82-492B-A50C-C600E21375E1}" dt="2025-01-06T15:50:26.275" v="1565" actId="165"/>
          <ac:picMkLst>
            <pc:docMk/>
            <pc:sldMk cId="2228276662" sldId="265"/>
            <ac:picMk id="118" creationId="{8E704042-D025-F2F7-E697-B5C9097296FF}"/>
          </ac:picMkLst>
        </pc:picChg>
        <pc:cxnChg chg="add del mod">
          <ac:chgData name="Ben Wielockx" userId="ca51338419742875" providerId="LiveId" clId="{D5FDAE7E-CD82-492B-A50C-C600E21375E1}" dt="2025-01-07T08:53:26.063" v="1820" actId="478"/>
          <ac:cxnSpMkLst>
            <pc:docMk/>
            <pc:sldMk cId="2228276662" sldId="265"/>
            <ac:cxnSpMk id="68" creationId="{0839980E-CC0D-65AD-8AD7-7240F9EB3098}"/>
          </ac:cxnSpMkLst>
        </pc:cxnChg>
      </pc:sldChg>
      <pc:sldChg chg="addSp delSp modSp add mod ord">
        <pc:chgData name="Ben Wielockx" userId="ca51338419742875" providerId="LiveId" clId="{D5FDAE7E-CD82-492B-A50C-C600E21375E1}" dt="2025-01-07T09:43:03.682" v="2204" actId="20577"/>
        <pc:sldMkLst>
          <pc:docMk/>
          <pc:sldMk cId="3715113999" sldId="266"/>
        </pc:sldMkLst>
        <pc:spChg chg="add mod">
          <ac:chgData name="Ben Wielockx" userId="ca51338419742875" providerId="LiveId" clId="{D5FDAE7E-CD82-492B-A50C-C600E21375E1}" dt="2025-01-06T15:18:57.464" v="628" actId="1076"/>
          <ac:spMkLst>
            <pc:docMk/>
            <pc:sldMk cId="3715113999" sldId="266"/>
            <ac:spMk id="3" creationId="{3C4A11C9-8A3C-FBA2-097F-FC55417C99B2}"/>
          </ac:spMkLst>
        </pc:spChg>
        <pc:spChg chg="add mod topLvl">
          <ac:chgData name="Ben Wielockx" userId="ca51338419742875" providerId="LiveId" clId="{D5FDAE7E-CD82-492B-A50C-C600E21375E1}" dt="2025-01-06T15:45:45.763" v="1406" actId="1076"/>
          <ac:spMkLst>
            <pc:docMk/>
            <pc:sldMk cId="3715113999" sldId="266"/>
            <ac:spMk id="4" creationId="{70DFCACB-228F-3397-FC6E-93F7904E1477}"/>
          </ac:spMkLst>
        </pc:spChg>
        <pc:spChg chg="add mod">
          <ac:chgData name="Ben Wielockx" userId="ca51338419742875" providerId="LiveId" clId="{D5FDAE7E-CD82-492B-A50C-C600E21375E1}" dt="2025-01-07T09:41:26.126" v="2164" actId="1076"/>
          <ac:spMkLst>
            <pc:docMk/>
            <pc:sldMk cId="3715113999" sldId="266"/>
            <ac:spMk id="5" creationId="{C520B958-0E2B-CD3C-0D39-EC2FE81065DE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9" creationId="{4DD52106-6979-F7DF-CD7B-7AA7875C3EAB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0" creationId="{650F8B91-7275-6A50-841A-5A109602F4D1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1" creationId="{EC0BB0F7-14D8-2754-1C84-57A6181C92D2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2" creationId="{72479C90-A836-5590-AFB0-A583ADFAA1FF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3" creationId="{18E4D24B-2C16-D087-BA4B-98071A063A2F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4" creationId="{B49ED500-D456-8648-2593-C589CEF480B8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5" creationId="{ED934257-8E99-D312-E395-8924770003C3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6" creationId="{663B7041-5C93-1179-3255-26B65125DF8B}"/>
          </ac:spMkLst>
        </pc:spChg>
        <pc:spChg chg="del mod topLvl">
          <ac:chgData name="Ben Wielockx" userId="ca51338419742875" providerId="LiveId" clId="{D5FDAE7E-CD82-492B-A50C-C600E21375E1}" dt="2025-01-07T09:41:17.555" v="2162" actId="21"/>
          <ac:spMkLst>
            <pc:docMk/>
            <pc:sldMk cId="3715113999" sldId="266"/>
            <ac:spMk id="17" creationId="{C520B958-0E2B-CD3C-0D39-EC2FE81065DE}"/>
          </ac:spMkLst>
        </pc:spChg>
        <pc:spChg chg="mod">
          <ac:chgData name="Ben Wielockx" userId="ca51338419742875" providerId="LiveId" clId="{D5FDAE7E-CD82-492B-A50C-C600E21375E1}" dt="2025-01-06T15:24:35.269" v="854" actId="165"/>
          <ac:spMkLst>
            <pc:docMk/>
            <pc:sldMk cId="3715113999" sldId="266"/>
            <ac:spMk id="19" creationId="{FF755454-27B7-64BE-957C-D52E24E76BCC}"/>
          </ac:spMkLst>
        </pc:spChg>
        <pc:spChg chg="mod">
          <ac:chgData name="Ben Wielockx" userId="ca51338419742875" providerId="LiveId" clId="{D5FDAE7E-CD82-492B-A50C-C600E21375E1}" dt="2025-01-07T09:28:24.677" v="2087" actId="1036"/>
          <ac:spMkLst>
            <pc:docMk/>
            <pc:sldMk cId="3715113999" sldId="266"/>
            <ac:spMk id="20" creationId="{5613CC97-9BA2-5FFD-C944-018854F0E76D}"/>
          </ac:spMkLst>
        </pc:spChg>
        <pc:spChg chg="mod">
          <ac:chgData name="Ben Wielockx" userId="ca51338419742875" providerId="LiveId" clId="{D5FDAE7E-CD82-492B-A50C-C600E21375E1}" dt="2025-01-07T09:28:29.918" v="2090" actId="1038"/>
          <ac:spMkLst>
            <pc:docMk/>
            <pc:sldMk cId="3715113999" sldId="266"/>
            <ac:spMk id="21" creationId="{A7469F69-8053-ED24-7046-2A3184B936BB}"/>
          </ac:spMkLst>
        </pc:spChg>
        <pc:spChg chg="mod">
          <ac:chgData name="Ben Wielockx" userId="ca51338419742875" providerId="LiveId" clId="{D5FDAE7E-CD82-492B-A50C-C600E21375E1}" dt="2025-01-07T09:28:35.905" v="2092" actId="1036"/>
          <ac:spMkLst>
            <pc:docMk/>
            <pc:sldMk cId="3715113999" sldId="266"/>
            <ac:spMk id="22" creationId="{0B7FEE35-1180-F264-C2D3-2C265C9CF747}"/>
          </ac:spMkLst>
        </pc:spChg>
        <pc:spChg chg="mod">
          <ac:chgData name="Ben Wielockx" userId="ca51338419742875" providerId="LiveId" clId="{D5FDAE7E-CD82-492B-A50C-C600E21375E1}" dt="2025-01-07T09:28:46.009" v="2098" actId="1036"/>
          <ac:spMkLst>
            <pc:docMk/>
            <pc:sldMk cId="3715113999" sldId="266"/>
            <ac:spMk id="23" creationId="{269778F8-86DB-4C48-B52B-3077EAC6D161}"/>
          </ac:spMkLst>
        </pc:spChg>
        <pc:spChg chg="mod">
          <ac:chgData name="Ben Wielockx" userId="ca51338419742875" providerId="LiveId" clId="{D5FDAE7E-CD82-492B-A50C-C600E21375E1}" dt="2025-01-07T09:28:52.421" v="2100" actId="1036"/>
          <ac:spMkLst>
            <pc:docMk/>
            <pc:sldMk cId="3715113999" sldId="266"/>
            <ac:spMk id="24" creationId="{246F1153-DAFC-296E-273F-E6A23444999D}"/>
          </ac:spMkLst>
        </pc:spChg>
        <pc:spChg chg="mod">
          <ac:chgData name="Ben Wielockx" userId="ca51338419742875" providerId="LiveId" clId="{D5FDAE7E-CD82-492B-A50C-C600E21375E1}" dt="2025-01-07T09:28:59.011" v="2106" actId="1037"/>
          <ac:spMkLst>
            <pc:docMk/>
            <pc:sldMk cId="3715113999" sldId="266"/>
            <ac:spMk id="25" creationId="{3C1D1CCD-5579-958C-3C80-2D7717BB5B49}"/>
          </ac:spMkLst>
        </pc:spChg>
        <pc:spChg chg="add mod">
          <ac:chgData name="Ben Wielockx" userId="ca51338419742875" providerId="LiveId" clId="{D5FDAE7E-CD82-492B-A50C-C600E21375E1}" dt="2025-01-06T15:31:14.083" v="1071" actId="5793"/>
          <ac:spMkLst>
            <pc:docMk/>
            <pc:sldMk cId="3715113999" sldId="266"/>
            <ac:spMk id="26" creationId="{7B80C21A-D422-9CAA-643A-6EBDFA5DDE79}"/>
          </ac:spMkLst>
        </pc:spChg>
        <pc:spChg chg="add mod">
          <ac:chgData name="Ben Wielockx" userId="ca51338419742875" providerId="LiveId" clId="{D5FDAE7E-CD82-492B-A50C-C600E21375E1}" dt="2025-01-07T07:49:15.794" v="1724" actId="1037"/>
          <ac:spMkLst>
            <pc:docMk/>
            <pc:sldMk cId="3715113999" sldId="266"/>
            <ac:spMk id="28" creationId="{172BCC6B-9A1E-8946-5A0A-55FD0EE73C23}"/>
          </ac:spMkLst>
        </pc:spChg>
        <pc:spChg chg="add mod">
          <ac:chgData name="Ben Wielockx" userId="ca51338419742875" providerId="LiveId" clId="{D5FDAE7E-CD82-492B-A50C-C600E21375E1}" dt="2025-01-06T15:45:45.763" v="1406" actId="1076"/>
          <ac:spMkLst>
            <pc:docMk/>
            <pc:sldMk cId="3715113999" sldId="266"/>
            <ac:spMk id="29" creationId="{D9301A54-C137-1F98-7F70-58F786FB621E}"/>
          </ac:spMkLst>
        </pc:spChg>
        <pc:spChg chg="add mod">
          <ac:chgData name="Ben Wielockx" userId="ca51338419742875" providerId="LiveId" clId="{D5FDAE7E-CD82-492B-A50C-C600E21375E1}" dt="2025-01-06T15:45:45.763" v="1406" actId="1076"/>
          <ac:spMkLst>
            <pc:docMk/>
            <pc:sldMk cId="3715113999" sldId="266"/>
            <ac:spMk id="30" creationId="{2BEEF91E-5199-EDAB-2A23-6009B58D956F}"/>
          </ac:spMkLst>
        </pc:spChg>
        <pc:spChg chg="mod">
          <ac:chgData name="Ben Wielockx" userId="ca51338419742875" providerId="LiveId" clId="{D5FDAE7E-CD82-492B-A50C-C600E21375E1}" dt="2025-01-07T09:43:03.682" v="2204" actId="20577"/>
          <ac:spMkLst>
            <pc:docMk/>
            <pc:sldMk cId="3715113999" sldId="266"/>
            <ac:spMk id="31" creationId="{E19DF6EB-24C7-47F2-DD21-8B6D74A10840}"/>
          </ac:spMkLst>
        </pc:spChg>
        <pc:spChg chg="add mod">
          <ac:chgData name="Ben Wielockx" userId="ca51338419742875" providerId="LiveId" clId="{D5FDAE7E-CD82-492B-A50C-C600E21375E1}" dt="2025-01-07T09:42:23.159" v="2199" actId="1076"/>
          <ac:spMkLst>
            <pc:docMk/>
            <pc:sldMk cId="3715113999" sldId="266"/>
            <ac:spMk id="32" creationId="{2F48FBC7-6ABF-C404-D3F1-0895A7A02E7D}"/>
          </ac:spMkLst>
        </pc:spChg>
        <pc:spChg chg="mod">
          <ac:chgData name="Ben Wielockx" userId="ca51338419742875" providerId="LiveId" clId="{D5FDAE7E-CD82-492B-A50C-C600E21375E1}" dt="2025-01-07T09:27:03.358" v="2050" actId="1037"/>
          <ac:spMkLst>
            <pc:docMk/>
            <pc:sldMk cId="3715113999" sldId="266"/>
            <ac:spMk id="37" creationId="{75247D44-1D0D-4885-7545-8BF51C3A0467}"/>
          </ac:spMkLst>
        </pc:spChg>
        <pc:spChg chg="mod">
          <ac:chgData name="Ben Wielockx" userId="ca51338419742875" providerId="LiveId" clId="{D5FDAE7E-CD82-492B-A50C-C600E21375E1}" dt="2025-01-07T09:26:56.928" v="2022" actId="1037"/>
          <ac:spMkLst>
            <pc:docMk/>
            <pc:sldMk cId="3715113999" sldId="266"/>
            <ac:spMk id="38" creationId="{6BF44BB9-1F35-FEBF-5D15-164B9D4BABB3}"/>
          </ac:spMkLst>
        </pc:spChg>
        <pc:spChg chg="mod">
          <ac:chgData name="Ben Wielockx" userId="ca51338419742875" providerId="LiveId" clId="{D5FDAE7E-CD82-492B-A50C-C600E21375E1}" dt="2025-01-07T09:27:41.049" v="2072" actId="1036"/>
          <ac:spMkLst>
            <pc:docMk/>
            <pc:sldMk cId="3715113999" sldId="266"/>
            <ac:spMk id="39" creationId="{65DE4B0B-28AA-440E-89E7-4CAE74827D35}"/>
          </ac:spMkLst>
        </pc:spChg>
        <pc:spChg chg="mod">
          <ac:chgData name="Ben Wielockx" userId="ca51338419742875" providerId="LiveId" clId="{D5FDAE7E-CD82-492B-A50C-C600E21375E1}" dt="2025-01-07T09:27:37.314" v="2071" actId="1036"/>
          <ac:spMkLst>
            <pc:docMk/>
            <pc:sldMk cId="3715113999" sldId="266"/>
            <ac:spMk id="40" creationId="{9DED3E1E-F1F1-27F2-E045-77A6651E9786}"/>
          </ac:spMkLst>
        </pc:spChg>
        <pc:spChg chg="mod">
          <ac:chgData name="Ben Wielockx" userId="ca51338419742875" providerId="LiveId" clId="{D5FDAE7E-CD82-492B-A50C-C600E21375E1}" dt="2025-01-07T09:30:11.283" v="2127" actId="1035"/>
          <ac:spMkLst>
            <pc:docMk/>
            <pc:sldMk cId="3715113999" sldId="266"/>
            <ac:spMk id="41" creationId="{BA4DF42E-9675-DC3B-22D4-E1E54E27B262}"/>
          </ac:spMkLst>
        </pc:spChg>
        <pc:spChg chg="mod">
          <ac:chgData name="Ben Wielockx" userId="ca51338419742875" providerId="LiveId" clId="{D5FDAE7E-CD82-492B-A50C-C600E21375E1}" dt="2025-01-07T09:30:16.707" v="2129" actId="1035"/>
          <ac:spMkLst>
            <pc:docMk/>
            <pc:sldMk cId="3715113999" sldId="266"/>
            <ac:spMk id="42" creationId="{8219FC31-C5CC-450E-9108-856BF1E10C47}"/>
          </ac:spMkLst>
        </pc:spChg>
        <pc:spChg chg="mod">
          <ac:chgData name="Ben Wielockx" userId="ca51338419742875" providerId="LiveId" clId="{D5FDAE7E-CD82-492B-A50C-C600E21375E1}" dt="2025-01-07T09:30:14.142" v="2128" actId="1035"/>
          <ac:spMkLst>
            <pc:docMk/>
            <pc:sldMk cId="3715113999" sldId="266"/>
            <ac:spMk id="43" creationId="{7CB1B505-06B2-44C4-20D8-156A690F9115}"/>
          </ac:spMkLst>
        </pc:spChg>
        <pc:spChg chg="mod">
          <ac:chgData name="Ben Wielockx" userId="ca51338419742875" providerId="LiveId" clId="{D5FDAE7E-CD82-492B-A50C-C600E21375E1}" dt="2025-01-07T09:30:18.913" v="2130" actId="1035"/>
          <ac:spMkLst>
            <pc:docMk/>
            <pc:sldMk cId="3715113999" sldId="266"/>
            <ac:spMk id="44" creationId="{1DD7DE4A-6921-C0BB-2337-467FC33C0C96}"/>
          </ac:spMkLst>
        </pc:spChg>
        <pc:spChg chg="mod">
          <ac:chgData name="Ben Wielockx" userId="ca51338419742875" providerId="LiveId" clId="{D5FDAE7E-CD82-492B-A50C-C600E21375E1}" dt="2025-01-07T09:30:22.600" v="2132" actId="1035"/>
          <ac:spMkLst>
            <pc:docMk/>
            <pc:sldMk cId="3715113999" sldId="266"/>
            <ac:spMk id="45" creationId="{F3130B31-4013-DCB2-4668-ED54B8B11523}"/>
          </ac:spMkLst>
        </pc:spChg>
        <pc:spChg chg="mod">
          <ac:chgData name="Ben Wielockx" userId="ca51338419742875" providerId="LiveId" clId="{D5FDAE7E-CD82-492B-A50C-C600E21375E1}" dt="2025-01-07T09:30:21.004" v="2131" actId="1035"/>
          <ac:spMkLst>
            <pc:docMk/>
            <pc:sldMk cId="3715113999" sldId="266"/>
            <ac:spMk id="46" creationId="{D68C546F-C45E-4B25-275E-734376782F80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48" creationId="{E306681B-2268-702D-2DFE-3A31E9B6D00E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49" creationId="{931545CF-50CF-70C7-2937-442238960B66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0" creationId="{9089AA44-BD19-83B9-6B48-6345FD966C5E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1" creationId="{FD21C57A-7A0A-0BAF-A51E-7289A91F277E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2" creationId="{EF5520C8-5D83-8CA3-6538-AADC531543E3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3" creationId="{67915E21-86E8-3B61-5365-DA5EA4FE3D45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4" creationId="{9BDA36A9-9BE0-BE85-F647-75CC6B106FFB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5" creationId="{CB4DB0E5-89B2-F4E4-33E6-AFFB5D3CC210}"/>
          </ac:spMkLst>
        </pc:spChg>
        <pc:spChg chg="mod">
          <ac:chgData name="Ben Wielockx" userId="ca51338419742875" providerId="LiveId" clId="{D5FDAE7E-CD82-492B-A50C-C600E21375E1}" dt="2025-01-06T15:19:37.276" v="630" actId="165"/>
          <ac:spMkLst>
            <pc:docMk/>
            <pc:sldMk cId="3715113999" sldId="266"/>
            <ac:spMk id="56" creationId="{61E5B8A2-23BD-53F7-9FD1-B838762680FE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58" creationId="{F1179958-425B-8917-187B-1C9C0B4BB1A1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59" creationId="{85E23874-7718-5BB0-38A5-A7E1C0A0197A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60" creationId="{A77CCDA0-ABA5-1967-40EB-331F94D2DEEB}"/>
          </ac:spMkLst>
        </pc:spChg>
        <pc:spChg chg="add del mod">
          <ac:chgData name="Ben Wielockx" userId="ca51338419742875" providerId="LiveId" clId="{D5FDAE7E-CD82-492B-A50C-C600E21375E1}" dt="2025-01-06T15:38:04.734" v="1205" actId="478"/>
          <ac:spMkLst>
            <pc:docMk/>
            <pc:sldMk cId="3715113999" sldId="266"/>
            <ac:spMk id="62" creationId="{44833F9B-449A-DA31-1259-7DA4032BBDD7}"/>
          </ac:spMkLst>
        </pc:spChg>
        <pc:spChg chg="add del mod">
          <ac:chgData name="Ben Wielockx" userId="ca51338419742875" providerId="LiveId" clId="{D5FDAE7E-CD82-492B-A50C-C600E21375E1}" dt="2025-01-06T15:45:32.441" v="1404" actId="21"/>
          <ac:spMkLst>
            <pc:docMk/>
            <pc:sldMk cId="3715113999" sldId="266"/>
            <ac:spMk id="63" creationId="{441E4FE1-2B6F-AEA9-32CB-81EACD8D1114}"/>
          </ac:spMkLst>
        </pc:spChg>
        <pc:spChg chg="del mod">
          <ac:chgData name="Ben Wielockx" userId="ca51338419742875" providerId="LiveId" clId="{D5FDAE7E-CD82-492B-A50C-C600E21375E1}" dt="2025-01-06T15:38:57.968" v="1215" actId="478"/>
          <ac:spMkLst>
            <pc:docMk/>
            <pc:sldMk cId="3715113999" sldId="266"/>
            <ac:spMk id="68" creationId="{29FD3AEE-1348-57A9-57CF-FDB178F6FDE8}"/>
          </ac:spMkLst>
        </pc:spChg>
        <pc:spChg chg="mod">
          <ac:chgData name="Ben Wielockx" userId="ca51338419742875" providerId="LiveId" clId="{D5FDAE7E-CD82-492B-A50C-C600E21375E1}" dt="2025-01-06T16:35:49.118" v="1694" actId="1076"/>
          <ac:spMkLst>
            <pc:docMk/>
            <pc:sldMk cId="3715113999" sldId="266"/>
            <ac:spMk id="69" creationId="{2FD04B24-5982-81D8-1CB7-D3C46B11D6E9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0" creationId="{E0BEDC14-75EA-5AFB-FCB2-500F57901956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1" creationId="{D2D4FC90-F0C7-D3E9-9146-3E22D315FEAF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2" creationId="{5D20B243-B7D9-7727-C696-F66D0B944F7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3" creationId="{915578E4-B6F0-4041-BD87-F8636376A69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4" creationId="{21819095-BE8D-8167-2F0F-66A4EE48A410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5" creationId="{12FEB2C0-FF51-866F-C74F-F1567D89B398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76" creationId="{24A2C61E-6412-3136-28B0-1F579E3FD428}"/>
          </ac:spMkLst>
        </pc:spChg>
        <pc:spChg chg="mod">
          <ac:chgData name="Ben Wielockx" userId="ca51338419742875" providerId="LiveId" clId="{D5FDAE7E-CD82-492B-A50C-C600E21375E1}" dt="2025-01-06T16:35:44.558" v="1693" actId="1038"/>
          <ac:spMkLst>
            <pc:docMk/>
            <pc:sldMk cId="3715113999" sldId="266"/>
            <ac:spMk id="77" creationId="{423038D5-A214-7AC0-DA5D-690A8AF1307D}"/>
          </ac:spMkLst>
        </pc:spChg>
        <pc:spChg chg="mod">
          <ac:chgData name="Ben Wielockx" userId="ca51338419742875" providerId="LiveId" clId="{D5FDAE7E-CD82-492B-A50C-C600E21375E1}" dt="2025-01-06T16:35:38.392" v="1685" actId="1038"/>
          <ac:spMkLst>
            <pc:docMk/>
            <pc:sldMk cId="3715113999" sldId="266"/>
            <ac:spMk id="78" creationId="{8C671081-DD47-1089-03BE-FBEEB2E9EFD0}"/>
          </ac:spMkLst>
        </pc:spChg>
        <pc:spChg chg="mod">
          <ac:chgData name="Ben Wielockx" userId="ca51338419742875" providerId="LiveId" clId="{D5FDAE7E-CD82-492B-A50C-C600E21375E1}" dt="2025-01-06T16:42:44.482" v="1713" actId="1037"/>
          <ac:spMkLst>
            <pc:docMk/>
            <pc:sldMk cId="3715113999" sldId="266"/>
            <ac:spMk id="79" creationId="{9C7CE885-88AB-C769-CFF5-FE242614409D}"/>
          </ac:spMkLst>
        </pc:spChg>
        <pc:spChg chg="mod">
          <ac:chgData name="Ben Wielockx" userId="ca51338419742875" providerId="LiveId" clId="{D5FDAE7E-CD82-492B-A50C-C600E21375E1}" dt="2025-01-06T16:35:15.503" v="1650" actId="1076"/>
          <ac:spMkLst>
            <pc:docMk/>
            <pc:sldMk cId="3715113999" sldId="266"/>
            <ac:spMk id="80" creationId="{F4B6007A-9D13-8E85-6760-73135AB61DD1}"/>
          </ac:spMkLst>
        </pc:spChg>
        <pc:spChg chg="mod">
          <ac:chgData name="Ben Wielockx" userId="ca51338419742875" providerId="LiveId" clId="{D5FDAE7E-CD82-492B-A50C-C600E21375E1}" dt="2025-01-06T16:35:11.549" v="1649" actId="1037"/>
          <ac:spMkLst>
            <pc:docMk/>
            <pc:sldMk cId="3715113999" sldId="266"/>
            <ac:spMk id="81" creationId="{85B0FA02-A547-26E1-9BEF-A341F955FCA2}"/>
          </ac:spMkLst>
        </pc:spChg>
        <pc:spChg chg="mod">
          <ac:chgData name="Ben Wielockx" userId="ca51338419742875" providerId="LiveId" clId="{D5FDAE7E-CD82-492B-A50C-C600E21375E1}" dt="2025-01-06T16:35:53.693" v="1699" actId="1038"/>
          <ac:spMkLst>
            <pc:docMk/>
            <pc:sldMk cId="3715113999" sldId="266"/>
            <ac:spMk id="82" creationId="{89B2F9E7-DC20-5F76-D4D7-8CE1142BB611}"/>
          </ac:spMkLst>
        </pc:spChg>
        <pc:spChg chg="mod">
          <ac:chgData name="Ben Wielockx" userId="ca51338419742875" providerId="LiveId" clId="{D5FDAE7E-CD82-492B-A50C-C600E21375E1}" dt="2025-01-06T16:35:55.805" v="1702" actId="1038"/>
          <ac:spMkLst>
            <pc:docMk/>
            <pc:sldMk cId="3715113999" sldId="266"/>
            <ac:spMk id="83" creationId="{609495D8-59F1-B129-B146-14AF8E58B694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84" creationId="{D38E01CC-6654-4B44-E53A-362AD4AB7CF7}"/>
          </ac:spMkLst>
        </pc:spChg>
        <pc:spChg chg="add del mod">
          <ac:chgData name="Ben Wielockx" userId="ca51338419742875" providerId="LiveId" clId="{D5FDAE7E-CD82-492B-A50C-C600E21375E1}" dt="2025-01-06T15:45:32.441" v="1404" actId="21"/>
          <ac:spMkLst>
            <pc:docMk/>
            <pc:sldMk cId="3715113999" sldId="266"/>
            <ac:spMk id="85" creationId="{C5D138F5-BE7E-D125-B745-06FB4AA595A1}"/>
          </ac:spMkLst>
        </pc:spChg>
        <pc:spChg chg="add del mod">
          <ac:chgData name="Ben Wielockx" userId="ca51338419742875" providerId="LiveId" clId="{D5FDAE7E-CD82-492B-A50C-C600E21375E1}" dt="2025-01-06T15:45:32.441" v="1404" actId="21"/>
          <ac:spMkLst>
            <pc:docMk/>
            <pc:sldMk cId="3715113999" sldId="266"/>
            <ac:spMk id="87" creationId="{D3E9EAD8-632A-4929-1421-36BD718EEE21}"/>
          </ac:spMkLst>
        </pc:spChg>
        <pc:spChg chg="add del mod">
          <ac:chgData name="Ben Wielockx" userId="ca51338419742875" providerId="LiveId" clId="{D5FDAE7E-CD82-492B-A50C-C600E21375E1}" dt="2025-01-06T15:45:32.441" v="1404" actId="21"/>
          <ac:spMkLst>
            <pc:docMk/>
            <pc:sldMk cId="3715113999" sldId="266"/>
            <ac:spMk id="88" creationId="{6EC287BD-32C9-B301-A48A-28C2630455A9}"/>
          </ac:spMkLst>
        </pc:spChg>
        <pc:spChg chg="add del mod">
          <ac:chgData name="Ben Wielockx" userId="ca51338419742875" providerId="LiveId" clId="{D5FDAE7E-CD82-492B-A50C-C600E21375E1}" dt="2025-01-06T15:45:32.441" v="1404" actId="21"/>
          <ac:spMkLst>
            <pc:docMk/>
            <pc:sldMk cId="3715113999" sldId="266"/>
            <ac:spMk id="89" creationId="{0CCB9016-D47B-DAFD-589B-C5F3E83286B5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94" creationId="{66527953-F438-0F0B-81E4-B86D33AA779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95" creationId="{8EEC547B-C876-7D54-FB33-704078852814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96" creationId="{E7ACDC30-3F33-C0BD-47A0-8F7BA3C10F65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97" creationId="{6BDE0A5F-3F59-5F18-83EB-AE1DF11D4B93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98" creationId="{7C14EEFE-4717-15E2-4533-C6CF7CD1BC3E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99" creationId="{1227B21F-06E8-F4E5-DBD3-ED91E03CCE79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0" creationId="{9F4AE1BB-B0DF-FAFF-2B1F-4F2CE1BA2985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1" creationId="{E5AB6A24-5B94-7F33-4BA8-639EF74E0219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2" creationId="{F55FE29A-C9E0-1518-B83D-DB633379F3B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3" creationId="{DA3CABAB-D796-FE48-F091-2A79C7FB48A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4" creationId="{4376DDF1-1951-374D-8C0B-2D756BFE6EE8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5" creationId="{16447EC4-3463-EF24-59B8-C0B0D67CFF1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6" creationId="{83260E3D-9B50-304F-3976-F3E8B69B188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7" creationId="{D82541B8-2BE1-622D-2947-45DD35664A4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8" creationId="{383E937A-092C-C4C7-1367-CDD1EAACDCA6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09" creationId="{5E90F78C-3BB0-A298-B1B4-BD199CDDF43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10" creationId="{E7DB7F70-BE35-E6DF-F957-877382F9711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11" creationId="{0D1D8BDF-5F3A-93FE-801B-727A421031BB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12" creationId="{788E175F-8B2D-ABB4-C4A6-EFD8796DD9E3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13" creationId="{31C49769-0397-C522-7A8A-D7E2F92EACA8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19" creationId="{7DC7425A-F3BC-E0EC-4201-47F07F561A6E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0" creationId="{C2714984-9F17-F312-B391-5FE222F39326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1" creationId="{6840320C-11B2-0BB3-9BA6-6C7CA7D53A0D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2" creationId="{27216130-9131-E37F-7E61-B00B7E114FD3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3" creationId="{80F4C2D9-01DB-B2EB-4B5E-140DBA17372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4" creationId="{CBF211D3-0EC6-1544-B7E1-C24120707312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5" creationId="{1A9AF7AC-5D54-3250-4EA0-9178A5FD8A95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6" creationId="{2CC85B0E-1772-D5D9-1B52-EB975B5E145B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7" creationId="{57D71C7D-FB65-FEEF-FA3D-D513B726ABB4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8" creationId="{43C96C39-994B-5650-4AFE-158ADF808080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29" creationId="{001FBDCF-20AD-6201-D511-3872B10D58A6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0" creationId="{BDA7F884-6308-5CE8-8A9B-294AF22BD392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1" creationId="{477195FC-DF6F-1803-9AF7-66747A383D48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2" creationId="{019586DA-AE45-BEC5-77E2-DA9A4048E03D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3" creationId="{4EFDCD6F-1491-C2C2-F2B9-E6E894405A85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4" creationId="{E3DCB1DF-483B-160B-15A2-BB0957FA11A7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5" creationId="{68D3B565-77C2-94E6-5F8C-B7E99455BCFA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6" creationId="{49ABBCFC-2955-B150-CE51-463E3A5D2535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7" creationId="{FBB817E2-AACF-11A8-FA87-3D518ADD22E2}"/>
          </ac:spMkLst>
        </pc:spChg>
        <pc:spChg chg="mod">
          <ac:chgData name="Ben Wielockx" userId="ca51338419742875" providerId="LiveId" clId="{D5FDAE7E-CD82-492B-A50C-C600E21375E1}" dt="2025-01-06T08:59:32.619" v="14"/>
          <ac:spMkLst>
            <pc:docMk/>
            <pc:sldMk cId="3715113999" sldId="266"/>
            <ac:spMk id="138" creationId="{2E65ADF9-4EB7-90AD-AE94-E917B2000684}"/>
          </ac:spMkLst>
        </pc:spChg>
        <pc:spChg chg="add del mod">
          <ac:chgData name="Ben Wielockx" userId="ca51338419742875" providerId="LiveId" clId="{D5FDAE7E-CD82-492B-A50C-C600E21375E1}" dt="2025-01-06T15:45:32.441" v="1404" actId="21"/>
          <ac:spMkLst>
            <pc:docMk/>
            <pc:sldMk cId="3715113999" sldId="266"/>
            <ac:spMk id="139" creationId="{F8FD7068-0844-FDE8-8FB0-CAF057F7F3BE}"/>
          </ac:spMkLst>
        </pc:spChg>
        <pc:spChg chg="add del mod">
          <ac:chgData name="Ben Wielockx" userId="ca51338419742875" providerId="LiveId" clId="{D5FDAE7E-CD82-492B-A50C-C600E21375E1}" dt="2025-01-06T15:06:37.495" v="528" actId="478"/>
          <ac:spMkLst>
            <pc:docMk/>
            <pc:sldMk cId="3715113999" sldId="266"/>
            <ac:spMk id="141" creationId="{E3933F51-EC79-9F48-A650-1804E77E4874}"/>
          </ac:spMkLst>
        </pc:spChg>
        <pc:spChg chg="add del mod">
          <ac:chgData name="Ben Wielockx" userId="ca51338419742875" providerId="LiveId" clId="{D5FDAE7E-CD82-492B-A50C-C600E21375E1}" dt="2025-01-06T15:17:16.840" v="619" actId="478"/>
          <ac:spMkLst>
            <pc:docMk/>
            <pc:sldMk cId="3715113999" sldId="266"/>
            <ac:spMk id="144" creationId="{FB780439-6C00-7136-FEB3-48AE525C95B3}"/>
          </ac:spMkLst>
        </pc:spChg>
        <pc:spChg chg="del mod topLvl">
          <ac:chgData name="Ben Wielockx" userId="ca51338419742875" providerId="LiveId" clId="{D5FDAE7E-CD82-492B-A50C-C600E21375E1}" dt="2025-01-07T09:42:12.871" v="2197" actId="21"/>
          <ac:spMkLst>
            <pc:docMk/>
            <pc:sldMk cId="3715113999" sldId="266"/>
            <ac:spMk id="147" creationId="{CDDD2AFE-78D9-E9B4-36A9-2754E8FBC381}"/>
          </ac:spMkLst>
        </pc:spChg>
        <pc:spChg chg="mod">
          <ac:chgData name="Ben Wielockx" userId="ca51338419742875" providerId="LiveId" clId="{D5FDAE7E-CD82-492B-A50C-C600E21375E1}" dt="2025-01-06T15:19:45.436" v="631"/>
          <ac:spMkLst>
            <pc:docMk/>
            <pc:sldMk cId="3715113999" sldId="266"/>
            <ac:spMk id="148" creationId="{F4CA6155-6982-FAAB-B2BD-BDC71DD8557B}"/>
          </ac:spMkLst>
        </pc:spChg>
        <pc:spChg chg="mod">
          <ac:chgData name="Ben Wielockx" userId="ca51338419742875" providerId="LiveId" clId="{D5FDAE7E-CD82-492B-A50C-C600E21375E1}" dt="2025-01-06T15:20:23.103" v="659" actId="1038"/>
          <ac:spMkLst>
            <pc:docMk/>
            <pc:sldMk cId="3715113999" sldId="266"/>
            <ac:spMk id="149" creationId="{6AA32A3A-0642-6E6E-6203-ABE4F1929D4E}"/>
          </ac:spMkLst>
        </pc:spChg>
        <pc:spChg chg="mod">
          <ac:chgData name="Ben Wielockx" userId="ca51338419742875" providerId="LiveId" clId="{D5FDAE7E-CD82-492B-A50C-C600E21375E1}" dt="2025-01-06T15:20:31.782" v="669" actId="1037"/>
          <ac:spMkLst>
            <pc:docMk/>
            <pc:sldMk cId="3715113999" sldId="266"/>
            <ac:spMk id="150" creationId="{56816816-F23C-B072-90ED-02B68566EAB6}"/>
          </ac:spMkLst>
        </pc:spChg>
        <pc:spChg chg="mod">
          <ac:chgData name="Ben Wielockx" userId="ca51338419742875" providerId="LiveId" clId="{D5FDAE7E-CD82-492B-A50C-C600E21375E1}" dt="2025-01-06T15:20:43.347" v="703" actId="1037"/>
          <ac:spMkLst>
            <pc:docMk/>
            <pc:sldMk cId="3715113999" sldId="266"/>
            <ac:spMk id="151" creationId="{736DD3AB-88B6-89AD-70C1-96A6DC184177}"/>
          </ac:spMkLst>
        </pc:spChg>
        <pc:spChg chg="mod">
          <ac:chgData name="Ben Wielockx" userId="ca51338419742875" providerId="LiveId" clId="{D5FDAE7E-CD82-492B-A50C-C600E21375E1}" dt="2025-01-06T15:20:54.846" v="730" actId="1037"/>
          <ac:spMkLst>
            <pc:docMk/>
            <pc:sldMk cId="3715113999" sldId="266"/>
            <ac:spMk id="152" creationId="{747130C6-FC73-2105-276A-5A410A0940C4}"/>
          </ac:spMkLst>
        </pc:spChg>
        <pc:spChg chg="mod">
          <ac:chgData name="Ben Wielockx" userId="ca51338419742875" providerId="LiveId" clId="{D5FDAE7E-CD82-492B-A50C-C600E21375E1}" dt="2025-01-06T15:21:04.721" v="757" actId="1038"/>
          <ac:spMkLst>
            <pc:docMk/>
            <pc:sldMk cId="3715113999" sldId="266"/>
            <ac:spMk id="153" creationId="{ED4E8D28-38C9-AD92-BE87-D0AC3EECB76A}"/>
          </ac:spMkLst>
        </pc:spChg>
        <pc:spChg chg="mod">
          <ac:chgData name="Ben Wielockx" userId="ca51338419742875" providerId="LiveId" clId="{D5FDAE7E-CD82-492B-A50C-C600E21375E1}" dt="2025-01-06T15:21:18.044" v="801" actId="1037"/>
          <ac:spMkLst>
            <pc:docMk/>
            <pc:sldMk cId="3715113999" sldId="266"/>
            <ac:spMk id="154" creationId="{6F23F9E3-12F8-8220-DE60-CA4A6A2CB648}"/>
          </ac:spMkLst>
        </pc:spChg>
        <pc:spChg chg="mod">
          <ac:chgData name="Ben Wielockx" userId="ca51338419742875" providerId="LiveId" clId="{D5FDAE7E-CD82-492B-A50C-C600E21375E1}" dt="2025-01-06T15:21:24.657" v="807" actId="1037"/>
          <ac:spMkLst>
            <pc:docMk/>
            <pc:sldMk cId="3715113999" sldId="266"/>
            <ac:spMk id="155" creationId="{A591EA11-D970-379D-0811-E289E135E4F3}"/>
          </ac:spMkLst>
        </pc:spChg>
        <pc:spChg chg="mod">
          <ac:chgData name="Ben Wielockx" userId="ca51338419742875" providerId="LiveId" clId="{D5FDAE7E-CD82-492B-A50C-C600E21375E1}" dt="2025-01-06T15:21:29.789" v="818" actId="1037"/>
          <ac:spMkLst>
            <pc:docMk/>
            <pc:sldMk cId="3715113999" sldId="266"/>
            <ac:spMk id="156" creationId="{32783935-F847-3DE3-5497-060D5DA98D52}"/>
          </ac:spMkLst>
        </pc:spChg>
        <pc:spChg chg="mod">
          <ac:chgData name="Ben Wielockx" userId="ca51338419742875" providerId="LiveId" clId="{D5FDAE7E-CD82-492B-A50C-C600E21375E1}" dt="2025-01-06T15:27:27.905" v="930" actId="255"/>
          <ac:spMkLst>
            <pc:docMk/>
            <pc:sldMk cId="3715113999" sldId="266"/>
            <ac:spMk id="158" creationId="{A8CF5AEF-3C04-095D-AD06-B4A85AAD98A5}"/>
          </ac:spMkLst>
        </pc:spChg>
        <pc:spChg chg="mod">
          <ac:chgData name="Ben Wielockx" userId="ca51338419742875" providerId="LiveId" clId="{D5FDAE7E-CD82-492B-A50C-C600E21375E1}" dt="2025-01-06T15:27:27.905" v="930" actId="255"/>
          <ac:spMkLst>
            <pc:docMk/>
            <pc:sldMk cId="3715113999" sldId="266"/>
            <ac:spMk id="160" creationId="{8FC73919-3A24-A436-13EB-5B5DD987FDB5}"/>
          </ac:spMkLst>
        </pc:spChg>
        <pc:spChg chg="mod">
          <ac:chgData name="Ben Wielockx" userId="ca51338419742875" providerId="LiveId" clId="{D5FDAE7E-CD82-492B-A50C-C600E21375E1}" dt="2025-01-06T15:27:27.905" v="930" actId="255"/>
          <ac:spMkLst>
            <pc:docMk/>
            <pc:sldMk cId="3715113999" sldId="266"/>
            <ac:spMk id="161" creationId="{916E0180-27ED-17C7-397F-670C4C443E1D}"/>
          </ac:spMkLst>
        </pc:spChg>
        <pc:spChg chg="mod">
          <ac:chgData name="Ben Wielockx" userId="ca51338419742875" providerId="LiveId" clId="{D5FDAE7E-CD82-492B-A50C-C600E21375E1}" dt="2025-01-06T16:33:56.507" v="1618" actId="20577"/>
          <ac:spMkLst>
            <pc:docMk/>
            <pc:sldMk cId="3715113999" sldId="266"/>
            <ac:spMk id="162" creationId="{9B1A6687-5CC0-DBBB-7DAF-D9BAECB16023}"/>
          </ac:spMkLst>
        </pc:spChg>
        <pc:spChg chg="mod">
          <ac:chgData name="Ben Wielockx" userId="ca51338419742875" providerId="LiveId" clId="{D5FDAE7E-CD82-492B-A50C-C600E21375E1}" dt="2025-01-06T15:27:41.155" v="936" actId="1038"/>
          <ac:spMkLst>
            <pc:docMk/>
            <pc:sldMk cId="3715113999" sldId="266"/>
            <ac:spMk id="163" creationId="{8EE0B665-5985-BB61-2537-B707EC5F6B2E}"/>
          </ac:spMkLst>
        </pc:spChg>
        <pc:spChg chg="mod">
          <ac:chgData name="Ben Wielockx" userId="ca51338419742875" providerId="LiveId" clId="{D5FDAE7E-CD82-492B-A50C-C600E21375E1}" dt="2025-01-06T15:27:50.225" v="981" actId="1038"/>
          <ac:spMkLst>
            <pc:docMk/>
            <pc:sldMk cId="3715113999" sldId="266"/>
            <ac:spMk id="164" creationId="{4B4B54C6-4369-73A6-1E18-107F483199D0}"/>
          </ac:spMkLst>
        </pc:spChg>
        <pc:spChg chg="mod">
          <ac:chgData name="Ben Wielockx" userId="ca51338419742875" providerId="LiveId" clId="{D5FDAE7E-CD82-492B-A50C-C600E21375E1}" dt="2025-01-06T16:34:01.506" v="1621" actId="20577"/>
          <ac:spMkLst>
            <pc:docMk/>
            <pc:sldMk cId="3715113999" sldId="266"/>
            <ac:spMk id="165" creationId="{D313E3B4-AAA2-6002-E191-6BB63299BC6E}"/>
          </ac:spMkLst>
        </pc:spChg>
        <pc:spChg chg="mod">
          <ac:chgData name="Ben Wielockx" userId="ca51338419742875" providerId="LiveId" clId="{D5FDAE7E-CD82-492B-A50C-C600E21375E1}" dt="2025-01-06T15:28:05.747" v="1053" actId="1037"/>
          <ac:spMkLst>
            <pc:docMk/>
            <pc:sldMk cId="3715113999" sldId="266"/>
            <ac:spMk id="166" creationId="{BA68EA00-090E-3122-0918-5CB2DA58546B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68" creationId="{0B6BFBF9-7076-5E10-5F32-78279D12D0D6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0" creationId="{1B26C54F-709F-0506-B83D-1D2ED8367A19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1" creationId="{F575EB4B-4451-899D-2883-155408A6A3EA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2" creationId="{60337F64-0760-A0C5-1372-2D4C344B0F50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3" creationId="{D6A55B42-F390-D75F-193C-4278C133D796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4" creationId="{06DD5EE2-A6E5-1B0A-7B00-51FF696442FC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5" creationId="{FAC6A5B7-ED79-829D-77CC-E8F16DA61C0F}"/>
          </ac:spMkLst>
        </pc:spChg>
        <pc:spChg chg="mod">
          <ac:chgData name="Ben Wielockx" userId="ca51338419742875" providerId="LiveId" clId="{D5FDAE7E-CD82-492B-A50C-C600E21375E1}" dt="2025-01-06T15:28:16.490" v="1054"/>
          <ac:spMkLst>
            <pc:docMk/>
            <pc:sldMk cId="3715113999" sldId="266"/>
            <ac:spMk id="176" creationId="{F7649F46-71A9-A5A6-5DD5-4F72D074F37D}"/>
          </ac:spMkLst>
        </pc:spChg>
        <pc:spChg chg="add mod">
          <ac:chgData name="Ben Wielockx" userId="ca51338419742875" providerId="LiveId" clId="{D5FDAE7E-CD82-492B-A50C-C600E21375E1}" dt="2025-01-06T15:45:45.763" v="1406" actId="1076"/>
          <ac:spMkLst>
            <pc:docMk/>
            <pc:sldMk cId="3715113999" sldId="266"/>
            <ac:spMk id="177" creationId="{1B0B4988-458A-86D5-1F2F-DB10CE4E0517}"/>
          </ac:spMkLst>
        </pc:spChg>
        <pc:spChg chg="add mod">
          <ac:chgData name="Ben Wielockx" userId="ca51338419742875" providerId="LiveId" clId="{D5FDAE7E-CD82-492B-A50C-C600E21375E1}" dt="2025-01-06T15:45:45.763" v="1406" actId="1076"/>
          <ac:spMkLst>
            <pc:docMk/>
            <pc:sldMk cId="3715113999" sldId="266"/>
            <ac:spMk id="178" creationId="{A3790FA7-C7D8-4AED-57AF-4101A3964A62}"/>
          </ac:spMkLst>
        </pc:spChg>
        <pc:spChg chg="mod">
          <ac:chgData name="Ben Wielockx" userId="ca51338419742875" providerId="LiveId" clId="{D5FDAE7E-CD82-492B-A50C-C600E21375E1}" dt="2025-01-06T15:36:55.428" v="1200" actId="1036"/>
          <ac:spMkLst>
            <pc:docMk/>
            <pc:sldMk cId="3715113999" sldId="266"/>
            <ac:spMk id="180" creationId="{33D08B7D-D591-D695-6674-509EB232371F}"/>
          </ac:spMkLst>
        </pc:spChg>
        <pc:spChg chg="mod">
          <ac:chgData name="Ben Wielockx" userId="ca51338419742875" providerId="LiveId" clId="{D5FDAE7E-CD82-492B-A50C-C600E21375E1}" dt="2025-01-07T09:25:05.774" v="1865" actId="1036"/>
          <ac:spMkLst>
            <pc:docMk/>
            <pc:sldMk cId="3715113999" sldId="266"/>
            <ac:spMk id="182" creationId="{0FACB8D2-69CC-5359-B0CB-C931F6A74F1E}"/>
          </ac:spMkLst>
        </pc:spChg>
        <pc:spChg chg="mod">
          <ac:chgData name="Ben Wielockx" userId="ca51338419742875" providerId="LiveId" clId="{D5FDAE7E-CD82-492B-A50C-C600E21375E1}" dt="2025-01-07T09:25:03.208" v="1864" actId="1036"/>
          <ac:spMkLst>
            <pc:docMk/>
            <pc:sldMk cId="3715113999" sldId="266"/>
            <ac:spMk id="183" creationId="{D1333F97-8536-6911-EBA6-75D151B7BE68}"/>
          </ac:spMkLst>
        </pc:spChg>
        <pc:spChg chg="mod">
          <ac:chgData name="Ben Wielockx" userId="ca51338419742875" providerId="LiveId" clId="{D5FDAE7E-CD82-492B-A50C-C600E21375E1}" dt="2025-01-06T15:36:34.580" v="1170" actId="1038"/>
          <ac:spMkLst>
            <pc:docMk/>
            <pc:sldMk cId="3715113999" sldId="266"/>
            <ac:spMk id="184" creationId="{669D7ACC-2FFE-4F6E-256E-F6D54DB12ED6}"/>
          </ac:spMkLst>
        </pc:spChg>
        <pc:spChg chg="mod">
          <ac:chgData name="Ben Wielockx" userId="ca51338419742875" providerId="LiveId" clId="{D5FDAE7E-CD82-492B-A50C-C600E21375E1}" dt="2025-01-06T15:36:47.533" v="1198" actId="1037"/>
          <ac:spMkLst>
            <pc:docMk/>
            <pc:sldMk cId="3715113999" sldId="266"/>
            <ac:spMk id="185" creationId="{08F4A4A0-BCD4-0AC1-C0CA-B6BD2987B2E8}"/>
          </ac:spMkLst>
        </pc:spChg>
        <pc:spChg chg="del mod">
          <ac:chgData name="Ben Wielockx" userId="ca51338419742875" providerId="LiveId" clId="{D5FDAE7E-CD82-492B-A50C-C600E21375E1}" dt="2025-01-06T15:34:36.783" v="1093" actId="478"/>
          <ac:spMkLst>
            <pc:docMk/>
            <pc:sldMk cId="3715113999" sldId="266"/>
            <ac:spMk id="186" creationId="{5E1634D6-F925-D41A-46B9-90CBCA020473}"/>
          </ac:spMkLst>
        </pc:spChg>
        <pc:spChg chg="del mod">
          <ac:chgData name="Ben Wielockx" userId="ca51338419742875" providerId="LiveId" clId="{D5FDAE7E-CD82-492B-A50C-C600E21375E1}" dt="2025-01-06T15:34:35.277" v="1092" actId="478"/>
          <ac:spMkLst>
            <pc:docMk/>
            <pc:sldMk cId="3715113999" sldId="266"/>
            <ac:spMk id="187" creationId="{80969C58-D055-96BE-DAC9-85B91236B34E}"/>
          </ac:spMkLst>
        </pc:spChg>
        <pc:spChg chg="del mod">
          <ac:chgData name="Ben Wielockx" userId="ca51338419742875" providerId="LiveId" clId="{D5FDAE7E-CD82-492B-A50C-C600E21375E1}" dt="2025-01-06T15:34:22.655" v="1090" actId="478"/>
          <ac:spMkLst>
            <pc:docMk/>
            <pc:sldMk cId="3715113999" sldId="266"/>
            <ac:spMk id="188" creationId="{20280C50-23BC-FB61-143F-E0CC21B83476}"/>
          </ac:spMkLst>
        </pc:spChg>
        <pc:spChg chg="add mod">
          <ac:chgData name="Ben Wielockx" userId="ca51338419742875" providerId="LiveId" clId="{D5FDAE7E-CD82-492B-A50C-C600E21375E1}" dt="2025-01-06T16:33:24.717" v="1614" actId="14100"/>
          <ac:spMkLst>
            <pc:docMk/>
            <pc:sldMk cId="3715113999" sldId="266"/>
            <ac:spMk id="189" creationId="{DFBD328A-B4D6-824A-1D6D-993D11430FD3}"/>
          </ac:spMkLst>
        </pc:spChg>
        <pc:spChg chg="add mod">
          <ac:chgData name="Ben Wielockx" userId="ca51338419742875" providerId="LiveId" clId="{D5FDAE7E-CD82-492B-A50C-C600E21375E1}" dt="2025-01-06T15:37:54.168" v="1204"/>
          <ac:spMkLst>
            <pc:docMk/>
            <pc:sldMk cId="3715113999" sldId="266"/>
            <ac:spMk id="190" creationId="{08487011-AF5A-C1FD-A465-44FC90EF1A09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191" creationId="{6D9ACE8D-1C55-9FD2-8CE6-AF3069F28685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192" creationId="{1AA30AFA-06EF-5422-4E67-07DA26E6C48B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193" creationId="{16E2D63F-247A-F50C-F823-7EF015E26205}"/>
          </ac:spMkLst>
        </pc:spChg>
        <pc:spChg chg="add mod">
          <ac:chgData name="Ben Wielockx" userId="ca51338419742875" providerId="LiveId" clId="{D5FDAE7E-CD82-492B-A50C-C600E21375E1}" dt="2025-01-06T15:45:45.763" v="1406" actId="1076"/>
          <ac:spMkLst>
            <pc:docMk/>
            <pc:sldMk cId="3715113999" sldId="266"/>
            <ac:spMk id="194" creationId="{3A7F6FF2-00EE-07ED-72C7-C6A44488A48E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195" creationId="{AD1B3929-9DD9-F34A-455B-A3E918CE6F03}"/>
          </ac:spMkLst>
        </pc:spChg>
        <pc:spChg chg="add mod">
          <ac:chgData name="Ben Wielockx" userId="ca51338419742875" providerId="LiveId" clId="{D5FDAE7E-CD82-492B-A50C-C600E21375E1}" dt="2025-01-06T15:45:40.041" v="1405" actId="1076"/>
          <ac:spMkLst>
            <pc:docMk/>
            <pc:sldMk cId="3715113999" sldId="266"/>
            <ac:spMk id="196" creationId="{2E972E2F-76F0-6D8D-E38C-BFB4477235A3}"/>
          </ac:spMkLst>
        </pc:spChg>
        <pc:spChg chg="mod">
          <ac:chgData name="Ben Wielockx" userId="ca51338419742875" providerId="LiveId" clId="{D5FDAE7E-CD82-492B-A50C-C600E21375E1}" dt="2025-01-07T09:25:21.497" v="1867" actId="1076"/>
          <ac:spMkLst>
            <pc:docMk/>
            <pc:sldMk cId="3715113999" sldId="266"/>
            <ac:spMk id="198" creationId="{4481D34B-473D-3131-7EC8-96B024AD1EBF}"/>
          </ac:spMkLst>
        </pc:spChg>
        <pc:spChg chg="mod">
          <ac:chgData name="Ben Wielockx" userId="ca51338419742875" providerId="LiveId" clId="{D5FDAE7E-CD82-492B-A50C-C600E21375E1}" dt="2025-01-07T09:25:30.481" v="1882" actId="1037"/>
          <ac:spMkLst>
            <pc:docMk/>
            <pc:sldMk cId="3715113999" sldId="266"/>
            <ac:spMk id="200" creationId="{A3B3FAF0-8B3C-E8EB-108C-059EE9C8B2C0}"/>
          </ac:spMkLst>
        </pc:spChg>
        <pc:spChg chg="mod">
          <ac:chgData name="Ben Wielockx" userId="ca51338419742875" providerId="LiveId" clId="{D5FDAE7E-CD82-492B-A50C-C600E21375E1}" dt="2025-01-07T09:25:42.562" v="1918" actId="1038"/>
          <ac:spMkLst>
            <pc:docMk/>
            <pc:sldMk cId="3715113999" sldId="266"/>
            <ac:spMk id="201" creationId="{3370DB46-6E8B-7B7C-20E1-A5B779A72EFD}"/>
          </ac:spMkLst>
        </pc:spChg>
        <pc:spChg chg="mod">
          <ac:chgData name="Ben Wielockx" userId="ca51338419742875" providerId="LiveId" clId="{D5FDAE7E-CD82-492B-A50C-C600E21375E1}" dt="2025-01-07T09:26:08.797" v="1960" actId="1038"/>
          <ac:spMkLst>
            <pc:docMk/>
            <pc:sldMk cId="3715113999" sldId="266"/>
            <ac:spMk id="202" creationId="{4DCBD695-AB69-0873-5AF8-6EB4C1560E43}"/>
          </ac:spMkLst>
        </pc:spChg>
        <pc:spChg chg="mod">
          <ac:chgData name="Ben Wielockx" userId="ca51338419742875" providerId="LiveId" clId="{D5FDAE7E-CD82-492B-A50C-C600E21375E1}" dt="2025-01-07T09:26:11.407" v="1961" actId="1036"/>
          <ac:spMkLst>
            <pc:docMk/>
            <pc:sldMk cId="3715113999" sldId="266"/>
            <ac:spMk id="203" creationId="{9753A117-DD04-FC62-1197-60D6931ECFF5}"/>
          </ac:spMkLst>
        </pc:spChg>
        <pc:spChg chg="add mod">
          <ac:chgData name="Ben Wielockx" userId="ca51338419742875" providerId="LiveId" clId="{D5FDAE7E-CD82-492B-A50C-C600E21375E1}" dt="2025-01-06T16:32:35.107" v="1599" actId="1076"/>
          <ac:spMkLst>
            <pc:docMk/>
            <pc:sldMk cId="3715113999" sldId="266"/>
            <ac:spMk id="204" creationId="{7BA59D1C-10E0-7A48-237F-2A97301D7293}"/>
          </ac:spMkLst>
        </pc:spChg>
        <pc:spChg chg="add mod">
          <ac:chgData name="Ben Wielockx" userId="ca51338419742875" providerId="LiveId" clId="{D5FDAE7E-CD82-492B-A50C-C600E21375E1}" dt="2025-01-06T16:32:46.103" v="1603" actId="20577"/>
          <ac:spMkLst>
            <pc:docMk/>
            <pc:sldMk cId="3715113999" sldId="266"/>
            <ac:spMk id="205" creationId="{D8DA224C-F36D-8F23-17BF-DDE18232C61C}"/>
          </ac:spMkLst>
        </pc:spChg>
        <pc:spChg chg="add mod">
          <ac:chgData name="Ben Wielockx" userId="ca51338419742875" providerId="LiveId" clId="{D5FDAE7E-CD82-492B-A50C-C600E21375E1}" dt="2025-01-06T16:33:02.128" v="1609" actId="20577"/>
          <ac:spMkLst>
            <pc:docMk/>
            <pc:sldMk cId="3715113999" sldId="266"/>
            <ac:spMk id="206" creationId="{F4D5CBFA-5C37-FACB-F23E-BC88E4EC3D2D}"/>
          </ac:spMkLst>
        </pc:spChg>
        <pc:spChg chg="add mod">
          <ac:chgData name="Ben Wielockx" userId="ca51338419742875" providerId="LiveId" clId="{D5FDAE7E-CD82-492B-A50C-C600E21375E1}" dt="2025-01-06T16:33:18.817" v="1613" actId="1076"/>
          <ac:spMkLst>
            <pc:docMk/>
            <pc:sldMk cId="3715113999" sldId="266"/>
            <ac:spMk id="207" creationId="{5AC01E17-B82B-E0C6-CEE2-BA397927F12B}"/>
          </ac:spMkLst>
        </pc:spChg>
        <pc:grpChg chg="add del mod topLvl">
          <ac:chgData name="Ben Wielockx" userId="ca51338419742875" providerId="LiveId" clId="{D5FDAE7E-CD82-492B-A50C-C600E21375E1}" dt="2025-01-06T15:24:35.269" v="854" actId="165"/>
          <ac:grpSpMkLst>
            <pc:docMk/>
            <pc:sldMk cId="3715113999" sldId="266"/>
            <ac:grpSpMk id="5" creationId="{470D340D-1967-1137-C066-C476A72676D2}"/>
          </ac:grpSpMkLst>
        </pc:grpChg>
        <pc:grpChg chg="del mod topLvl">
          <ac:chgData name="Ben Wielockx" userId="ca51338419742875" providerId="LiveId" clId="{D5FDAE7E-CD82-492B-A50C-C600E21375E1}" dt="2025-01-07T09:41:17.555" v="2162" actId="21"/>
          <ac:grpSpMkLst>
            <pc:docMk/>
            <pc:sldMk cId="3715113999" sldId="266"/>
            <ac:grpSpMk id="7" creationId="{4349AD65-7BF0-5BB8-381D-2107DD0B337B}"/>
          </ac:grpSpMkLst>
        </pc:grpChg>
        <pc:grpChg chg="mod topLvl">
          <ac:chgData name="Ben Wielockx" userId="ca51338419742875" providerId="LiveId" clId="{D5FDAE7E-CD82-492B-A50C-C600E21375E1}" dt="2025-01-06T15:45:45.763" v="1406" actId="1076"/>
          <ac:grpSpMkLst>
            <pc:docMk/>
            <pc:sldMk cId="3715113999" sldId="266"/>
            <ac:grpSpMk id="8" creationId="{7ACCDF28-E12B-C4E1-C7C7-CA241A96CF02}"/>
          </ac:grpSpMkLst>
        </pc:grpChg>
        <pc:grpChg chg="del mod topLvl">
          <ac:chgData name="Ben Wielockx" userId="ca51338419742875" providerId="LiveId" clId="{D5FDAE7E-CD82-492B-A50C-C600E21375E1}" dt="2025-01-07T09:42:27.741" v="2200" actId="478"/>
          <ac:grpSpMkLst>
            <pc:docMk/>
            <pc:sldMk cId="3715113999" sldId="266"/>
            <ac:grpSpMk id="18" creationId="{414EDC4C-9A8C-3396-2E04-79B0A2AF02EB}"/>
          </ac:grpSpMkLst>
        </pc:grpChg>
        <pc:grpChg chg="add del mod">
          <ac:chgData name="Ben Wielockx" userId="ca51338419742875" providerId="LiveId" clId="{D5FDAE7E-CD82-492B-A50C-C600E21375E1}" dt="2025-01-06T15:19:37.276" v="630" actId="165"/>
          <ac:grpSpMkLst>
            <pc:docMk/>
            <pc:sldMk cId="3715113999" sldId="266"/>
            <ac:grpSpMk id="32" creationId="{393CEB5A-0E43-63ED-616C-9297B8F056F1}"/>
          </ac:grpSpMkLst>
        </pc:grpChg>
        <pc:grpChg chg="mod topLvl">
          <ac:chgData name="Ben Wielockx" userId="ca51338419742875" providerId="LiveId" clId="{D5FDAE7E-CD82-492B-A50C-C600E21375E1}" dt="2025-01-06T15:45:45.763" v="1406" actId="1076"/>
          <ac:grpSpMkLst>
            <pc:docMk/>
            <pc:sldMk cId="3715113999" sldId="266"/>
            <ac:grpSpMk id="34" creationId="{E8B54BC1-8E3A-838A-4ECC-F23CF339B2EA}"/>
          </ac:grpSpMkLst>
        </pc:grpChg>
        <pc:grpChg chg="mod topLvl">
          <ac:chgData name="Ben Wielockx" userId="ca51338419742875" providerId="LiveId" clId="{D5FDAE7E-CD82-492B-A50C-C600E21375E1}" dt="2025-01-06T15:45:45.763" v="1406" actId="1076"/>
          <ac:grpSpMkLst>
            <pc:docMk/>
            <pc:sldMk cId="3715113999" sldId="266"/>
            <ac:grpSpMk id="35" creationId="{86378094-CC7C-7902-6FB2-115DEF5A5904}"/>
          </ac:grpSpMkLst>
        </pc:grpChg>
        <pc:grpChg chg="mod">
          <ac:chgData name="Ben Wielockx" userId="ca51338419742875" providerId="LiveId" clId="{D5FDAE7E-CD82-492B-A50C-C600E21375E1}" dt="2025-01-06T15:19:37.276" v="630" actId="165"/>
          <ac:grpSpMkLst>
            <pc:docMk/>
            <pc:sldMk cId="3715113999" sldId="266"/>
            <ac:grpSpMk id="36" creationId="{73BA2163-F30F-157A-8174-86BAB324ACB3}"/>
          </ac:grpSpMkLst>
        </pc:grpChg>
        <pc:grpChg chg="mod">
          <ac:chgData name="Ben Wielockx" userId="ca51338419742875" providerId="LiveId" clId="{D5FDAE7E-CD82-492B-A50C-C600E21375E1}" dt="2025-01-06T15:19:37.276" v="630" actId="165"/>
          <ac:grpSpMkLst>
            <pc:docMk/>
            <pc:sldMk cId="3715113999" sldId="266"/>
            <ac:grpSpMk id="47" creationId="{A1827599-B661-FA3D-C944-EF7F793CF158}"/>
          </ac:grpSpMkLst>
        </pc:grpChg>
        <pc:grpChg chg="add mod">
          <ac:chgData name="Ben Wielockx" userId="ca51338419742875" providerId="LiveId" clId="{D5FDAE7E-CD82-492B-A50C-C600E21375E1}" dt="2025-01-06T15:45:40.041" v="1405" actId="1076"/>
          <ac:grpSpMkLst>
            <pc:docMk/>
            <pc:sldMk cId="3715113999" sldId="266"/>
            <ac:grpSpMk id="64" creationId="{3D14C485-A2F3-BE8B-A584-6DCFD75AAFE2}"/>
          </ac:grpSpMkLst>
        </pc:grpChg>
        <pc:grpChg chg="mod">
          <ac:chgData name="Ben Wielockx" userId="ca51338419742875" providerId="LiveId" clId="{D5FDAE7E-CD82-492B-A50C-C600E21375E1}" dt="2025-01-06T08:59:32.619" v="14"/>
          <ac:grpSpMkLst>
            <pc:docMk/>
            <pc:sldMk cId="3715113999" sldId="266"/>
            <ac:grpSpMk id="66" creationId="{93F264BA-6EC2-D5CE-2020-3AE98DF04A6E}"/>
          </ac:grpSpMkLst>
        </pc:grpChg>
        <pc:grpChg chg="mod">
          <ac:chgData name="Ben Wielockx" userId="ca51338419742875" providerId="LiveId" clId="{D5FDAE7E-CD82-492B-A50C-C600E21375E1}" dt="2025-01-06T08:59:32.619" v="14"/>
          <ac:grpSpMkLst>
            <pc:docMk/>
            <pc:sldMk cId="3715113999" sldId="266"/>
            <ac:grpSpMk id="67" creationId="{B0E8A7B2-91FC-DA9E-2960-1AF3BA2DF277}"/>
          </ac:grpSpMkLst>
        </pc:grpChg>
        <pc:grpChg chg="add del mod">
          <ac:chgData name="Ben Wielockx" userId="ca51338419742875" providerId="LiveId" clId="{D5FDAE7E-CD82-492B-A50C-C600E21375E1}" dt="2025-01-06T15:45:32.441" v="1404" actId="21"/>
          <ac:grpSpMkLst>
            <pc:docMk/>
            <pc:sldMk cId="3715113999" sldId="266"/>
            <ac:grpSpMk id="90" creationId="{AE8CDA16-0DF7-7DC8-4804-CDE82344230A}"/>
          </ac:grpSpMkLst>
        </pc:grpChg>
        <pc:grpChg chg="mod">
          <ac:chgData name="Ben Wielockx" userId="ca51338419742875" providerId="LiveId" clId="{D5FDAE7E-CD82-492B-A50C-C600E21375E1}" dt="2025-01-06T08:59:32.619" v="14"/>
          <ac:grpSpMkLst>
            <pc:docMk/>
            <pc:sldMk cId="3715113999" sldId="266"/>
            <ac:grpSpMk id="92" creationId="{B5DEACF3-2735-29F2-9444-EA037990938E}"/>
          </ac:grpSpMkLst>
        </pc:grpChg>
        <pc:grpChg chg="mod">
          <ac:chgData name="Ben Wielockx" userId="ca51338419742875" providerId="LiveId" clId="{D5FDAE7E-CD82-492B-A50C-C600E21375E1}" dt="2025-01-06T08:59:32.619" v="14"/>
          <ac:grpSpMkLst>
            <pc:docMk/>
            <pc:sldMk cId="3715113999" sldId="266"/>
            <ac:grpSpMk id="93" creationId="{25E6F8D6-7B6D-135C-CC02-8873C1B37D7D}"/>
          </ac:grpSpMkLst>
        </pc:grpChg>
        <pc:grpChg chg="add del mod">
          <ac:chgData name="Ben Wielockx" userId="ca51338419742875" providerId="LiveId" clId="{D5FDAE7E-CD82-492B-A50C-C600E21375E1}" dt="2025-01-06T15:45:32.441" v="1404" actId="21"/>
          <ac:grpSpMkLst>
            <pc:docMk/>
            <pc:sldMk cId="3715113999" sldId="266"/>
            <ac:grpSpMk id="115" creationId="{343F1E03-4217-394A-812D-540E8813AA9A}"/>
          </ac:grpSpMkLst>
        </pc:grpChg>
        <pc:grpChg chg="mod">
          <ac:chgData name="Ben Wielockx" userId="ca51338419742875" providerId="LiveId" clId="{D5FDAE7E-CD82-492B-A50C-C600E21375E1}" dt="2025-01-06T08:59:32.619" v="14"/>
          <ac:grpSpMkLst>
            <pc:docMk/>
            <pc:sldMk cId="3715113999" sldId="266"/>
            <ac:grpSpMk id="116" creationId="{052CCDB4-C425-36E4-C551-75D917A08D5F}"/>
          </ac:grpSpMkLst>
        </pc:grpChg>
        <pc:grpChg chg="mod">
          <ac:chgData name="Ben Wielockx" userId="ca51338419742875" providerId="LiveId" clId="{D5FDAE7E-CD82-492B-A50C-C600E21375E1}" dt="2025-01-06T08:59:32.619" v="14"/>
          <ac:grpSpMkLst>
            <pc:docMk/>
            <pc:sldMk cId="3715113999" sldId="266"/>
            <ac:grpSpMk id="117" creationId="{282D4C65-6FC2-5C91-63FD-DBD400070A07}"/>
          </ac:grpSpMkLst>
        </pc:grpChg>
        <pc:grpChg chg="add del mod">
          <ac:chgData name="Ben Wielockx" userId="ca51338419742875" providerId="LiveId" clId="{D5FDAE7E-CD82-492B-A50C-C600E21375E1}" dt="2025-01-06T15:24:20.398" v="853" actId="165"/>
          <ac:grpSpMkLst>
            <pc:docMk/>
            <pc:sldMk cId="3715113999" sldId="266"/>
            <ac:grpSpMk id="142" creationId="{1C5ABDA8-A942-334F-500C-EA480DD1B0B5}"/>
          </ac:grpSpMkLst>
        </pc:grpChg>
        <pc:grpChg chg="add mod">
          <ac:chgData name="Ben Wielockx" userId="ca51338419742875" providerId="LiveId" clId="{D5FDAE7E-CD82-492B-A50C-C600E21375E1}" dt="2025-01-06T15:45:45.763" v="1406" actId="1076"/>
          <ac:grpSpMkLst>
            <pc:docMk/>
            <pc:sldMk cId="3715113999" sldId="266"/>
            <ac:grpSpMk id="143" creationId="{179E75FF-0753-D5F1-196E-BE48D5A6DBBA}"/>
          </ac:grpSpMkLst>
        </pc:grpChg>
        <pc:grpChg chg="add del mod">
          <ac:chgData name="Ben Wielockx" userId="ca51338419742875" providerId="LiveId" clId="{D5FDAE7E-CD82-492B-A50C-C600E21375E1}" dt="2025-01-07T09:42:12.871" v="2197" actId="21"/>
          <ac:grpSpMkLst>
            <pc:docMk/>
            <pc:sldMk cId="3715113999" sldId="266"/>
            <ac:grpSpMk id="145" creationId="{1A904567-58DC-6E5C-E63B-49F8100B1D94}"/>
          </ac:grpSpMkLst>
        </pc:grpChg>
        <pc:grpChg chg="del mod topLvl">
          <ac:chgData name="Ben Wielockx" userId="ca51338419742875" providerId="LiveId" clId="{D5FDAE7E-CD82-492B-A50C-C600E21375E1}" dt="2025-01-07T09:42:27.741" v="2200" actId="478"/>
          <ac:grpSpMkLst>
            <pc:docMk/>
            <pc:sldMk cId="3715113999" sldId="266"/>
            <ac:grpSpMk id="146" creationId="{8BF83586-796C-96E8-F932-387511BD4EDF}"/>
          </ac:grpSpMkLst>
        </pc:grpChg>
        <pc:grpChg chg="add mod">
          <ac:chgData name="Ben Wielockx" userId="ca51338419742875" providerId="LiveId" clId="{D5FDAE7E-CD82-492B-A50C-C600E21375E1}" dt="2025-01-06T15:45:45.763" v="1406" actId="1076"/>
          <ac:grpSpMkLst>
            <pc:docMk/>
            <pc:sldMk cId="3715113999" sldId="266"/>
            <ac:grpSpMk id="157" creationId="{0B1FEC2C-991E-F757-FBD1-E7363C7669F8}"/>
          </ac:grpSpMkLst>
        </pc:grpChg>
        <pc:grpChg chg="mod">
          <ac:chgData name="Ben Wielockx" userId="ca51338419742875" providerId="LiveId" clId="{D5FDAE7E-CD82-492B-A50C-C600E21375E1}" dt="2025-01-06T15:24:42.919" v="855"/>
          <ac:grpSpMkLst>
            <pc:docMk/>
            <pc:sldMk cId="3715113999" sldId="266"/>
            <ac:grpSpMk id="159" creationId="{FCD5200A-7E43-0302-6C00-31AC51FF29ED}"/>
          </ac:grpSpMkLst>
        </pc:grpChg>
        <pc:grpChg chg="add del mod">
          <ac:chgData name="Ben Wielockx" userId="ca51338419742875" providerId="LiveId" clId="{D5FDAE7E-CD82-492B-A50C-C600E21375E1}" dt="2025-01-06T15:28:28.653" v="1056" actId="478"/>
          <ac:grpSpMkLst>
            <pc:docMk/>
            <pc:sldMk cId="3715113999" sldId="266"/>
            <ac:grpSpMk id="167" creationId="{1A705F21-BC1D-FACB-7DA0-25F6094B13FC}"/>
          </ac:grpSpMkLst>
        </pc:grpChg>
        <pc:grpChg chg="mod">
          <ac:chgData name="Ben Wielockx" userId="ca51338419742875" providerId="LiveId" clId="{D5FDAE7E-CD82-492B-A50C-C600E21375E1}" dt="2025-01-06T15:28:16.490" v="1054"/>
          <ac:grpSpMkLst>
            <pc:docMk/>
            <pc:sldMk cId="3715113999" sldId="266"/>
            <ac:grpSpMk id="169" creationId="{16A92F76-7B7C-90F5-8083-D8E038CDB2EF}"/>
          </ac:grpSpMkLst>
        </pc:grpChg>
        <pc:grpChg chg="add mod">
          <ac:chgData name="Ben Wielockx" userId="ca51338419742875" providerId="LiveId" clId="{D5FDAE7E-CD82-492B-A50C-C600E21375E1}" dt="2025-01-06T15:45:40.041" v="1405" actId="1076"/>
          <ac:grpSpMkLst>
            <pc:docMk/>
            <pc:sldMk cId="3715113999" sldId="266"/>
            <ac:grpSpMk id="179" creationId="{DF107D49-2612-2C70-7813-5EE1C09D3758}"/>
          </ac:grpSpMkLst>
        </pc:grpChg>
        <pc:grpChg chg="mod">
          <ac:chgData name="Ben Wielockx" userId="ca51338419742875" providerId="LiveId" clId="{D5FDAE7E-CD82-492B-A50C-C600E21375E1}" dt="2025-01-06T15:33:54.400" v="1080"/>
          <ac:grpSpMkLst>
            <pc:docMk/>
            <pc:sldMk cId="3715113999" sldId="266"/>
            <ac:grpSpMk id="181" creationId="{C18829D6-6539-3912-11AE-C0EEDB9A4737}"/>
          </ac:grpSpMkLst>
        </pc:grpChg>
        <pc:grpChg chg="add mod">
          <ac:chgData name="Ben Wielockx" userId="ca51338419742875" providerId="LiveId" clId="{D5FDAE7E-CD82-492B-A50C-C600E21375E1}" dt="2025-01-06T15:45:40.041" v="1405" actId="1076"/>
          <ac:grpSpMkLst>
            <pc:docMk/>
            <pc:sldMk cId="3715113999" sldId="266"/>
            <ac:grpSpMk id="197" creationId="{47949810-98CA-1911-2911-1FB53BB32609}"/>
          </ac:grpSpMkLst>
        </pc:grpChg>
        <pc:grpChg chg="mod">
          <ac:chgData name="Ben Wielockx" userId="ca51338419742875" providerId="LiveId" clId="{D5FDAE7E-CD82-492B-A50C-C600E21375E1}" dt="2025-01-06T15:43:50.619" v="1394"/>
          <ac:grpSpMkLst>
            <pc:docMk/>
            <pc:sldMk cId="3715113999" sldId="266"/>
            <ac:grpSpMk id="199" creationId="{2C4B1C8C-B6D0-9DC5-8DC9-CE2AEA3B8F32}"/>
          </ac:grpSpMkLst>
        </pc:grpChg>
        <pc:picChg chg="add mod">
          <ac:chgData name="Ben Wielockx" userId="ca51338419742875" providerId="LiveId" clId="{D5FDAE7E-CD82-492B-A50C-C600E21375E1}" dt="2025-01-06T15:25:27.663" v="859" actId="1076"/>
          <ac:picMkLst>
            <pc:docMk/>
            <pc:sldMk cId="3715113999" sldId="266"/>
            <ac:picMk id="2" creationId="{8DB53366-6E1B-ACA7-CE06-E38D4CD9B256}"/>
          </ac:picMkLst>
        </pc:picChg>
        <pc:picChg chg="mod topLvl">
          <ac:chgData name="Ben Wielockx" userId="ca51338419742875" providerId="LiveId" clId="{D5FDAE7E-CD82-492B-A50C-C600E21375E1}" dt="2025-01-06T15:45:45.763" v="1406" actId="1076"/>
          <ac:picMkLst>
            <pc:docMk/>
            <pc:sldMk cId="3715113999" sldId="266"/>
            <ac:picMk id="6" creationId="{A8A5EF39-3A7E-7C76-F976-DD7DF9206EE6}"/>
          </ac:picMkLst>
        </pc:picChg>
        <pc:picChg chg="add mod">
          <ac:chgData name="Ben Wielockx" userId="ca51338419742875" providerId="LiveId" clId="{D5FDAE7E-CD82-492B-A50C-C600E21375E1}" dt="2025-01-06T15:45:45.763" v="1406" actId="1076"/>
          <ac:picMkLst>
            <pc:docMk/>
            <pc:sldMk cId="3715113999" sldId="266"/>
            <ac:picMk id="27" creationId="{219F3263-6790-C25B-FB33-11B96AACA8E5}"/>
          </ac:picMkLst>
        </pc:picChg>
        <pc:picChg chg="mod topLvl">
          <ac:chgData name="Ben Wielockx" userId="ca51338419742875" providerId="LiveId" clId="{D5FDAE7E-CD82-492B-A50C-C600E21375E1}" dt="2025-01-06T15:45:45.763" v="1406" actId="1076"/>
          <ac:picMkLst>
            <pc:docMk/>
            <pc:sldMk cId="3715113999" sldId="266"/>
            <ac:picMk id="33" creationId="{CC5EFDBA-5352-E2FA-378B-702E2FCFB423}"/>
          </ac:picMkLst>
        </pc:picChg>
        <pc:picChg chg="add mod">
          <ac:chgData name="Ben Wielockx" userId="ca51338419742875" providerId="LiveId" clId="{D5FDAE7E-CD82-492B-A50C-C600E21375E1}" dt="2025-01-06T15:45:40.041" v="1405" actId="1076"/>
          <ac:picMkLst>
            <pc:docMk/>
            <pc:sldMk cId="3715113999" sldId="266"/>
            <ac:picMk id="57" creationId="{682DE793-7163-393C-AF34-6DD0AA38DF34}"/>
          </ac:picMkLst>
        </pc:picChg>
        <pc:picChg chg="add mod">
          <ac:chgData name="Ben Wielockx" userId="ca51338419742875" providerId="LiveId" clId="{D5FDAE7E-CD82-492B-A50C-C600E21375E1}" dt="2025-01-06T15:45:40.041" v="1405" actId="1076"/>
          <ac:picMkLst>
            <pc:docMk/>
            <pc:sldMk cId="3715113999" sldId="266"/>
            <ac:picMk id="61" creationId="{86D97B3E-8C9D-011B-AC9B-A9706203C76C}"/>
          </ac:picMkLst>
        </pc:picChg>
        <pc:picChg chg="mod">
          <ac:chgData name="Ben Wielockx" userId="ca51338419742875" providerId="LiveId" clId="{D5FDAE7E-CD82-492B-A50C-C600E21375E1}" dt="2025-01-06T08:59:32.619" v="14"/>
          <ac:picMkLst>
            <pc:docMk/>
            <pc:sldMk cId="3715113999" sldId="266"/>
            <ac:picMk id="65" creationId="{D97A36B1-B44D-93DF-3081-E6A3A3FE8C0C}"/>
          </ac:picMkLst>
        </pc:picChg>
        <pc:picChg chg="add del mod">
          <ac:chgData name="Ben Wielockx" userId="ca51338419742875" providerId="LiveId" clId="{D5FDAE7E-CD82-492B-A50C-C600E21375E1}" dt="2025-01-06T15:45:32.441" v="1404" actId="21"/>
          <ac:picMkLst>
            <pc:docMk/>
            <pc:sldMk cId="3715113999" sldId="266"/>
            <ac:picMk id="86" creationId="{DF8454F2-33B3-8659-5DA4-7907C8D4AD69}"/>
          </ac:picMkLst>
        </pc:picChg>
        <pc:picChg chg="mod">
          <ac:chgData name="Ben Wielockx" userId="ca51338419742875" providerId="LiveId" clId="{D5FDAE7E-CD82-492B-A50C-C600E21375E1}" dt="2025-01-06T08:59:32.619" v="14"/>
          <ac:picMkLst>
            <pc:docMk/>
            <pc:sldMk cId="3715113999" sldId="266"/>
            <ac:picMk id="91" creationId="{52913FCE-54C5-4AEA-DE3A-84D1D82C2841}"/>
          </ac:picMkLst>
        </pc:picChg>
        <pc:picChg chg="add del mod">
          <ac:chgData name="Ben Wielockx" userId="ca51338419742875" providerId="LiveId" clId="{D5FDAE7E-CD82-492B-A50C-C600E21375E1}" dt="2025-01-06T15:45:32.441" v="1404" actId="21"/>
          <ac:picMkLst>
            <pc:docMk/>
            <pc:sldMk cId="3715113999" sldId="266"/>
            <ac:picMk id="114" creationId="{C73599B3-BB15-5713-B64F-B0611FF10740}"/>
          </ac:picMkLst>
        </pc:picChg>
        <pc:picChg chg="mod">
          <ac:chgData name="Ben Wielockx" userId="ca51338419742875" providerId="LiveId" clId="{D5FDAE7E-CD82-492B-A50C-C600E21375E1}" dt="2025-01-06T08:59:32.619" v="14"/>
          <ac:picMkLst>
            <pc:docMk/>
            <pc:sldMk cId="3715113999" sldId="266"/>
            <ac:picMk id="118" creationId="{8E704042-D025-F2F7-E697-B5C9097296FF}"/>
          </ac:picMkLst>
        </pc:picChg>
        <pc:picChg chg="add del mod modCrop">
          <ac:chgData name="Ben Wielockx" userId="ca51338419742875" providerId="LiveId" clId="{D5FDAE7E-CD82-492B-A50C-C600E21375E1}" dt="2025-01-06T15:06:13.714" v="525" actId="478"/>
          <ac:picMkLst>
            <pc:docMk/>
            <pc:sldMk cId="3715113999" sldId="266"/>
            <ac:picMk id="140" creationId="{13333822-F03B-C20B-1FF8-5C870B2211D5}"/>
          </ac:picMkLst>
        </pc:picChg>
        <pc:cxnChg chg="add del mod">
          <ac:chgData name="Ben Wielockx" userId="ca51338419742875" providerId="LiveId" clId="{D5FDAE7E-CD82-492B-A50C-C600E21375E1}" dt="2025-01-07T09:25:10.474" v="1866" actId="478"/>
          <ac:cxnSpMkLst>
            <pc:docMk/>
            <pc:sldMk cId="3715113999" sldId="266"/>
            <ac:cxnSpMk id="209" creationId="{2A78FAF0-399D-786B-D9CA-F5DC66DB0F4A}"/>
          </ac:cxnSpMkLst>
        </pc:cxnChg>
        <pc:cxnChg chg="add del mod">
          <ac:chgData name="Ben Wielockx" userId="ca51338419742875" providerId="LiveId" clId="{D5FDAE7E-CD82-492B-A50C-C600E21375E1}" dt="2025-01-07T09:28:02.985" v="2077" actId="478"/>
          <ac:cxnSpMkLst>
            <pc:docMk/>
            <pc:sldMk cId="3715113999" sldId="266"/>
            <ac:cxnSpMk id="211" creationId="{02CFEC7A-B498-E6D1-D30A-E907A12892BB}"/>
          </ac:cxnSpMkLst>
        </pc:cxnChg>
        <pc:cxnChg chg="add del mod">
          <ac:chgData name="Ben Wielockx" userId="ca51338419742875" providerId="LiveId" clId="{D5FDAE7E-CD82-492B-A50C-C600E21375E1}" dt="2025-01-07T09:29:15.705" v="2108" actId="478"/>
          <ac:cxnSpMkLst>
            <pc:docMk/>
            <pc:sldMk cId="3715113999" sldId="266"/>
            <ac:cxnSpMk id="213" creationId="{32F38F50-0024-D069-6FE5-83E500F7E414}"/>
          </ac:cxnSpMkLst>
        </pc:cxnChg>
        <pc:cxnChg chg="add del mod">
          <ac:chgData name="Ben Wielockx" userId="ca51338419742875" providerId="LiveId" clId="{D5FDAE7E-CD82-492B-A50C-C600E21375E1}" dt="2025-01-07T09:30:29.237" v="2133" actId="478"/>
          <ac:cxnSpMkLst>
            <pc:docMk/>
            <pc:sldMk cId="3715113999" sldId="266"/>
            <ac:cxnSpMk id="215" creationId="{4A5CE31B-2D71-2BEE-02B8-28020A798178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624A60-4335-41F2-9CD7-6F8BFF7E6C76}" type="datetimeFigureOut">
              <a:rPr lang="en-DE" smtClean="0"/>
              <a:t>07/01/2025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9D1582-64F8-4C62-BCE2-1DFBFBE5EA0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17736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869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444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485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351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1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937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507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11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11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762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427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CE86A7-D88B-494C-9EFE-5AE0032EFA5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C1C9BB-29CD-4B19-9882-2419297632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271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microsoft.com/office/2007/relationships/hdphoto" Target="../media/hdphoto2.wdp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microsoft.com/office/2007/relationships/hdphoto" Target="../media/hdphoto4.wdp"/><Relationship Id="rId7" Type="http://schemas.openxmlformats.org/officeDocument/2006/relationships/image" Target="../media/image13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7.emf"/><Relationship Id="rId7" Type="http://schemas.microsoft.com/office/2007/relationships/hdphoto" Target="../media/hdphoto5.wdp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tiff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3" Type="http://schemas.openxmlformats.org/officeDocument/2006/relationships/oleObject" Target="../embeddings/oleObject3.bin"/><Relationship Id="rId7" Type="http://schemas.openxmlformats.org/officeDocument/2006/relationships/image" Target="../media/image25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6.wdp"/><Relationship Id="rId5" Type="http://schemas.openxmlformats.org/officeDocument/2006/relationships/image" Target="../media/image24.png"/><Relationship Id="rId10" Type="http://schemas.microsoft.com/office/2007/relationships/hdphoto" Target="../media/hdphoto8.wdp"/><Relationship Id="rId4" Type="http://schemas.openxmlformats.org/officeDocument/2006/relationships/image" Target="../media/image23.emf"/><Relationship Id="rId9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1DB247A-A1D1-AF90-C73B-696D42CEB0CF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  <a:endParaRPr lang="en-DE" dirty="0"/>
          </a:p>
        </p:txBody>
      </p:sp>
      <p:sp>
        <p:nvSpPr>
          <p:cNvPr id="2" name="Rounded Rectangle 23">
            <a:extLst>
              <a:ext uri="{FF2B5EF4-FFF2-40B4-BE49-F238E27FC236}">
                <a16:creationId xmlns:a16="http://schemas.microsoft.com/office/drawing/2014/main" id="{756DE633-C7FC-6EA1-0C77-CBBBB730EFAB}"/>
              </a:ext>
            </a:extLst>
          </p:cNvPr>
          <p:cNvSpPr/>
          <p:nvPr/>
        </p:nvSpPr>
        <p:spPr>
          <a:xfrm>
            <a:off x="1920239" y="496342"/>
            <a:ext cx="6137911" cy="565427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D893D28-D144-F122-46F0-A7749BE213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2303818"/>
              </p:ext>
            </p:extLst>
          </p:nvPr>
        </p:nvGraphicFramePr>
        <p:xfrm>
          <a:off x="2327275" y="811213"/>
          <a:ext cx="5251450" cy="5357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371161" imgH="6497899" progId="Prism10.Document">
                  <p:embed/>
                </p:oleObj>
              </mc:Choice>
              <mc:Fallback>
                <p:oleObj name="Prism 10" r:id="rId2" imgW="6371161" imgH="6497899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D893D28-D144-F122-46F0-A7749BE213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27275" y="811213"/>
                        <a:ext cx="5251450" cy="5357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C44E0B98-79F3-CFA8-FF7D-59A6226B8E76}"/>
              </a:ext>
            </a:extLst>
          </p:cNvPr>
          <p:cNvSpPr txBox="1"/>
          <p:nvPr/>
        </p:nvSpPr>
        <p:spPr>
          <a:xfrm>
            <a:off x="2274436" y="76195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A602871-5150-C049-6918-C2965A249767}"/>
              </a:ext>
            </a:extLst>
          </p:cNvPr>
          <p:cNvSpPr txBox="1"/>
          <p:nvPr/>
        </p:nvSpPr>
        <p:spPr>
          <a:xfrm>
            <a:off x="2274436" y="371963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51143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10BD5DB-9C54-850E-5862-CAC785E07BB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E19DF6EB-24C7-47F2-DD21-8B6D74A10840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  <a:endParaRPr lang="en-DE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DFCACB-228F-3397-FC6E-93F7904E1477}"/>
              </a:ext>
            </a:extLst>
          </p:cNvPr>
          <p:cNvSpPr txBox="1"/>
          <p:nvPr/>
        </p:nvSpPr>
        <p:spPr>
          <a:xfrm>
            <a:off x="2192463" y="1501000"/>
            <a:ext cx="2401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u="sng" dirty="0"/>
              <a:t>Uncropped blot - Ponceau (Fig2A - Hif1</a:t>
            </a:r>
            <a:r>
              <a:rPr lang="el-GR" sz="9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9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900" u="sng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8A5EF39-3A7E-7C76-F976-DD7DF9206E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51072" t="25195" r="6526" b="5625"/>
          <a:stretch/>
        </p:blipFill>
        <p:spPr>
          <a:xfrm>
            <a:off x="2535778" y="1911824"/>
            <a:ext cx="1510797" cy="1676406"/>
          </a:xfrm>
          <a:prstGeom prst="rect">
            <a:avLst/>
          </a:prstGeo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7ACCDF28-E12B-C4E1-C7C7-CA241A96CF02}"/>
              </a:ext>
            </a:extLst>
          </p:cNvPr>
          <p:cNvGrpSpPr/>
          <p:nvPr/>
        </p:nvGrpSpPr>
        <p:grpSpPr>
          <a:xfrm>
            <a:off x="2249632" y="1748741"/>
            <a:ext cx="383676" cy="1795879"/>
            <a:chOff x="10455195" y="3511453"/>
            <a:chExt cx="493596" cy="2941874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DD52106-6979-F7DF-CD7B-7AA7875C3EAB}"/>
                </a:ext>
              </a:extLst>
            </p:cNvPr>
            <p:cNvSpPr/>
            <p:nvPr/>
          </p:nvSpPr>
          <p:spPr>
            <a:xfrm>
              <a:off x="10460989" y="3511453"/>
              <a:ext cx="445578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u="sng" dirty="0" err="1"/>
                <a:t>kDa</a:t>
              </a:r>
              <a:endParaRPr lang="en-US" sz="731" u="sng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650F8B91-7275-6A50-841A-5A109602F4D1}"/>
                </a:ext>
              </a:extLst>
            </p:cNvPr>
            <p:cNvSpPr/>
            <p:nvPr/>
          </p:nvSpPr>
          <p:spPr>
            <a:xfrm>
              <a:off x="10466479" y="3870017"/>
              <a:ext cx="482312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250-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EC0BB0F7-14D8-2754-1C84-57A6181C92D2}"/>
                </a:ext>
              </a:extLst>
            </p:cNvPr>
            <p:cNvSpPr/>
            <p:nvPr/>
          </p:nvSpPr>
          <p:spPr>
            <a:xfrm>
              <a:off x="10461457" y="4234134"/>
              <a:ext cx="482312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30-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2479C90-A836-5590-AFB0-A583ADFAA1FF}"/>
                </a:ext>
              </a:extLst>
            </p:cNvPr>
            <p:cNvSpPr/>
            <p:nvPr/>
          </p:nvSpPr>
          <p:spPr>
            <a:xfrm>
              <a:off x="10455195" y="4583774"/>
              <a:ext cx="482312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00-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18E4D24B-2C16-D087-BA4B-98071A063A2F}"/>
                </a:ext>
              </a:extLst>
            </p:cNvPr>
            <p:cNvSpPr/>
            <p:nvPr/>
          </p:nvSpPr>
          <p:spPr>
            <a:xfrm>
              <a:off x="10500347" y="4833131"/>
              <a:ext cx="417485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70-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B49ED500-D456-8648-2593-C589CEF480B8}"/>
                </a:ext>
              </a:extLst>
            </p:cNvPr>
            <p:cNvSpPr/>
            <p:nvPr/>
          </p:nvSpPr>
          <p:spPr>
            <a:xfrm>
              <a:off x="10524189" y="5209811"/>
              <a:ext cx="417485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55-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ED934257-8E99-D312-E395-8924770003C3}"/>
                </a:ext>
              </a:extLst>
            </p:cNvPr>
            <p:cNvSpPr/>
            <p:nvPr/>
          </p:nvSpPr>
          <p:spPr>
            <a:xfrm>
              <a:off x="10531278" y="5753267"/>
              <a:ext cx="417485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35-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63B7041-5C93-1179-3255-26B65125DF8B}"/>
                </a:ext>
              </a:extLst>
            </p:cNvPr>
            <p:cNvSpPr/>
            <p:nvPr/>
          </p:nvSpPr>
          <p:spPr>
            <a:xfrm>
              <a:off x="10519163" y="6100252"/>
              <a:ext cx="417485" cy="3530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25-</a:t>
              </a:r>
            </a:p>
          </p:txBody>
        </p:sp>
      </p:grpSp>
      <p:grpSp>
        <p:nvGrpSpPr>
          <p:cNvPr id="143" name="Group 142">
            <a:extLst>
              <a:ext uri="{FF2B5EF4-FFF2-40B4-BE49-F238E27FC236}">
                <a16:creationId xmlns:a16="http://schemas.microsoft.com/office/drawing/2014/main" id="{179E75FF-0753-D5F1-196E-BE48D5A6DBBA}"/>
              </a:ext>
            </a:extLst>
          </p:cNvPr>
          <p:cNvGrpSpPr/>
          <p:nvPr/>
        </p:nvGrpSpPr>
        <p:grpSpPr>
          <a:xfrm>
            <a:off x="1543099" y="317884"/>
            <a:ext cx="3023712" cy="1025584"/>
            <a:chOff x="2138192" y="1049292"/>
            <a:chExt cx="3023712" cy="102558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DB53366-6E1B-ACA7-CE06-E38D4CD9B2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-12525" r="-1"/>
            <a:stretch/>
          </p:blipFill>
          <p:spPr>
            <a:xfrm>
              <a:off x="2568192" y="1407080"/>
              <a:ext cx="2418867" cy="66779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C4A11C9-8A3C-FBA2-097F-FC55417C99B2}"/>
                </a:ext>
              </a:extLst>
            </p:cNvPr>
            <p:cNvSpPr txBox="1"/>
            <p:nvPr/>
          </p:nvSpPr>
          <p:spPr>
            <a:xfrm>
              <a:off x="2138192" y="1542972"/>
              <a:ext cx="741730" cy="217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13" u="sng" dirty="0"/>
                <a:t>Anti-Hif1</a:t>
              </a:r>
              <a:r>
                <a:rPr lang="el-GR" sz="813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n-US" sz="813" u="sng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B80C21A-D422-9CAA-643A-6EBDFA5DDE79}"/>
                </a:ext>
              </a:extLst>
            </p:cNvPr>
            <p:cNvSpPr txBox="1"/>
            <p:nvPr/>
          </p:nvSpPr>
          <p:spPr>
            <a:xfrm>
              <a:off x="2760399" y="1049292"/>
              <a:ext cx="24015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u="sng" dirty="0"/>
                <a:t>Uncropped blots for Figure 2A – Hif1α</a:t>
              </a:r>
              <a:endParaRPr lang="en-DE" sz="1000" u="sng" dirty="0"/>
            </a:p>
          </p:txBody>
        </p:sp>
      </p:grpSp>
      <p:pic>
        <p:nvPicPr>
          <p:cNvPr id="27" name="Picture 26">
            <a:extLst>
              <a:ext uri="{FF2B5EF4-FFF2-40B4-BE49-F238E27FC236}">
                <a16:creationId xmlns:a16="http://schemas.microsoft.com/office/drawing/2014/main" id="{219F3263-6790-C25B-FB33-11B96AACA8E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16155" y="4192817"/>
            <a:ext cx="1852583" cy="634039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72BCC6B-9A1E-8946-5A0A-55FD0EE73C23}"/>
              </a:ext>
            </a:extLst>
          </p:cNvPr>
          <p:cNvSpPr txBox="1"/>
          <p:nvPr/>
        </p:nvSpPr>
        <p:spPr>
          <a:xfrm>
            <a:off x="1725604" y="4396570"/>
            <a:ext cx="741730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u="sng" dirty="0"/>
              <a:t>Anti-Hif2</a:t>
            </a:r>
            <a:r>
              <a:rPr lang="el-GR" sz="813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813" u="sng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9301A54-C137-1F98-7F70-58F786FB621E}"/>
              </a:ext>
            </a:extLst>
          </p:cNvPr>
          <p:cNvSpPr txBox="1"/>
          <p:nvPr/>
        </p:nvSpPr>
        <p:spPr>
          <a:xfrm>
            <a:off x="2184609" y="4885167"/>
            <a:ext cx="21339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u="sng" dirty="0"/>
              <a:t>Uncropped blot - Ponceau (Fig2A – Hif2α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BEEF91E-5199-EDAB-2A23-6009B58D956F}"/>
              </a:ext>
            </a:extLst>
          </p:cNvPr>
          <p:cNvSpPr txBox="1"/>
          <p:nvPr/>
        </p:nvSpPr>
        <p:spPr>
          <a:xfrm>
            <a:off x="2165307" y="3790408"/>
            <a:ext cx="22266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Uncropped blots for Figure 2A - Hif2α</a:t>
            </a:r>
            <a:endParaRPr lang="en-DE" sz="1000" u="sng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CC5EFDBA-5352-E2FA-378B-702E2FCFB42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37084" y="5377424"/>
            <a:ext cx="1614817" cy="1312658"/>
          </a:xfrm>
          <a:prstGeom prst="rect">
            <a:avLst/>
          </a:prstGeom>
        </p:spPr>
      </p:pic>
      <p:grpSp>
        <p:nvGrpSpPr>
          <p:cNvPr id="34" name="Group 33">
            <a:extLst>
              <a:ext uri="{FF2B5EF4-FFF2-40B4-BE49-F238E27FC236}">
                <a16:creationId xmlns:a16="http://schemas.microsoft.com/office/drawing/2014/main" id="{E8B54BC1-8E3A-838A-4ECC-F23CF339B2EA}"/>
              </a:ext>
            </a:extLst>
          </p:cNvPr>
          <p:cNvGrpSpPr/>
          <p:nvPr/>
        </p:nvGrpSpPr>
        <p:grpSpPr>
          <a:xfrm>
            <a:off x="2163747" y="5160245"/>
            <a:ext cx="362722" cy="1593374"/>
            <a:chOff x="311955" y="3529841"/>
            <a:chExt cx="446427" cy="1961076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1827599-B661-FA3D-C944-EF7F793CF158}"/>
                </a:ext>
              </a:extLst>
            </p:cNvPr>
            <p:cNvGrpSpPr/>
            <p:nvPr/>
          </p:nvGrpSpPr>
          <p:grpSpPr>
            <a:xfrm>
              <a:off x="311955" y="3529841"/>
              <a:ext cx="446427" cy="1741774"/>
              <a:chOff x="3449493" y="4428205"/>
              <a:chExt cx="757980" cy="2118513"/>
            </a:xfrm>
          </p:grpSpPr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931545CF-50CF-70C7-2937-442238960B66}"/>
                  </a:ext>
                </a:extLst>
              </p:cNvPr>
              <p:cNvSpPr/>
              <p:nvPr/>
            </p:nvSpPr>
            <p:spPr>
              <a:xfrm>
                <a:off x="3454784" y="4428205"/>
                <a:ext cx="690730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u="sng" dirty="0" err="1"/>
                  <a:t>kDa</a:t>
                </a:r>
                <a:endParaRPr lang="en-US" sz="731" u="sng" dirty="0"/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9089AA44-BD19-83B9-6B48-6345FD966C5E}"/>
                  </a:ext>
                </a:extLst>
              </p:cNvPr>
              <p:cNvSpPr/>
              <p:nvPr/>
            </p:nvSpPr>
            <p:spPr>
              <a:xfrm>
                <a:off x="3459799" y="4684186"/>
                <a:ext cx="747674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250-</a:t>
                </a:r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FD21C57A-7A0A-0BAF-A51E-7289A91F277E}"/>
                  </a:ext>
                </a:extLst>
              </p:cNvPr>
              <p:cNvSpPr/>
              <p:nvPr/>
            </p:nvSpPr>
            <p:spPr>
              <a:xfrm>
                <a:off x="3455210" y="4944130"/>
                <a:ext cx="747674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130-</a:t>
                </a:r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EF5520C8-5D83-8CA3-6538-AADC531543E3}"/>
                  </a:ext>
                </a:extLst>
              </p:cNvPr>
              <p:cNvSpPr/>
              <p:nvPr/>
            </p:nvSpPr>
            <p:spPr>
              <a:xfrm>
                <a:off x="3449493" y="5193738"/>
                <a:ext cx="747674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100-</a:t>
                </a:r>
              </a:p>
            </p:txBody>
          </p: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67915E21-86E8-3B61-5365-DA5EA4FE3D45}"/>
                  </a:ext>
                </a:extLst>
              </p:cNvPr>
              <p:cNvSpPr/>
              <p:nvPr/>
            </p:nvSpPr>
            <p:spPr>
              <a:xfrm>
                <a:off x="3490717" y="5371755"/>
                <a:ext cx="647180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70-</a:t>
                </a:r>
              </a:p>
            </p:txBody>
          </p:sp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9BDA36A9-9BE0-BE85-F647-75CC6B106FFB}"/>
                  </a:ext>
                </a:extLst>
              </p:cNvPr>
              <p:cNvSpPr/>
              <p:nvPr/>
            </p:nvSpPr>
            <p:spPr>
              <a:xfrm>
                <a:off x="3512483" y="5640669"/>
                <a:ext cx="647180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55-</a:t>
                </a:r>
              </a:p>
            </p:txBody>
          </p:sp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CB4DB0E5-89B2-F4E4-33E6-AFFB5D3CC210}"/>
                  </a:ext>
                </a:extLst>
              </p:cNvPr>
              <p:cNvSpPr/>
              <p:nvPr/>
            </p:nvSpPr>
            <p:spPr>
              <a:xfrm>
                <a:off x="3518957" y="6028643"/>
                <a:ext cx="647180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35-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61E5B8A2-23BD-53F7-9FD1-B838762680FE}"/>
                  </a:ext>
                </a:extLst>
              </p:cNvPr>
              <p:cNvSpPr/>
              <p:nvPr/>
            </p:nvSpPr>
            <p:spPr>
              <a:xfrm>
                <a:off x="3508824" y="6240136"/>
                <a:ext cx="647180" cy="3065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25-</a:t>
                </a:r>
              </a:p>
            </p:txBody>
          </p:sp>
        </p:grp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E306681B-2268-702D-2DFE-3A31E9B6D00E}"/>
                </a:ext>
              </a:extLst>
            </p:cNvPr>
            <p:cNvSpPr/>
            <p:nvPr/>
          </p:nvSpPr>
          <p:spPr>
            <a:xfrm>
              <a:off x="354974" y="5238855"/>
              <a:ext cx="381169" cy="252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5-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86378094-CC7C-7902-6FB2-115DEF5A5904}"/>
              </a:ext>
            </a:extLst>
          </p:cNvPr>
          <p:cNvGrpSpPr/>
          <p:nvPr/>
        </p:nvGrpSpPr>
        <p:grpSpPr>
          <a:xfrm>
            <a:off x="2387818" y="5135403"/>
            <a:ext cx="1740214" cy="245463"/>
            <a:chOff x="9224839" y="3198370"/>
            <a:chExt cx="2141793" cy="302108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73BA2163-F30F-157A-8174-86BAB324ACB3}"/>
                </a:ext>
              </a:extLst>
            </p:cNvPr>
            <p:cNvGrpSpPr/>
            <p:nvPr/>
          </p:nvGrpSpPr>
          <p:grpSpPr>
            <a:xfrm>
              <a:off x="9387106" y="3198546"/>
              <a:ext cx="1979526" cy="301932"/>
              <a:chOff x="8530807" y="6151929"/>
              <a:chExt cx="1979526" cy="301932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BF44BB9-1F35-FEBF-5D15-164B9D4BABB3}"/>
                  </a:ext>
                </a:extLst>
              </p:cNvPr>
              <p:cNvSpPr txBox="1"/>
              <p:nvPr/>
            </p:nvSpPr>
            <p:spPr>
              <a:xfrm>
                <a:off x="8530807" y="6151929"/>
                <a:ext cx="359470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M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5DE4B0B-28AA-440E-89E7-4CAE74827D35}"/>
                  </a:ext>
                </a:extLst>
              </p:cNvPr>
              <p:cNvSpPr txBox="1"/>
              <p:nvPr/>
            </p:nvSpPr>
            <p:spPr>
              <a:xfrm>
                <a:off x="8712796" y="6154479"/>
                <a:ext cx="404844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DED3E1E-F1F1-27F2-E045-77A6651E9786}"/>
                  </a:ext>
                </a:extLst>
              </p:cNvPr>
              <p:cNvSpPr txBox="1"/>
              <p:nvPr/>
            </p:nvSpPr>
            <p:spPr>
              <a:xfrm>
                <a:off x="8930281" y="6154719"/>
                <a:ext cx="402873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H1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A4DF42E-9675-DC3B-22D4-E1E54E27B262}"/>
                  </a:ext>
                </a:extLst>
              </p:cNvPr>
              <p:cNvSpPr txBox="1"/>
              <p:nvPr/>
            </p:nvSpPr>
            <p:spPr>
              <a:xfrm>
                <a:off x="9137453" y="6154969"/>
                <a:ext cx="404844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2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219FC31-C5CC-450E-9108-856BF1E10C47}"/>
                  </a:ext>
                </a:extLst>
              </p:cNvPr>
              <p:cNvSpPr txBox="1"/>
              <p:nvPr/>
            </p:nvSpPr>
            <p:spPr>
              <a:xfrm>
                <a:off x="9344256" y="6152290"/>
                <a:ext cx="402873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H2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CB1B505-06B2-44C4-20D8-156A690F9115}"/>
                  </a:ext>
                </a:extLst>
              </p:cNvPr>
              <p:cNvSpPr txBox="1"/>
              <p:nvPr/>
            </p:nvSpPr>
            <p:spPr>
              <a:xfrm>
                <a:off x="9547590" y="6152288"/>
                <a:ext cx="404844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3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DD7DE4A-6921-C0BB-2337-467FC33C0C96}"/>
                  </a:ext>
                </a:extLst>
              </p:cNvPr>
              <p:cNvSpPr txBox="1"/>
              <p:nvPr/>
            </p:nvSpPr>
            <p:spPr>
              <a:xfrm>
                <a:off x="9754445" y="6155555"/>
                <a:ext cx="402873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H3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3130B31-4013-DCB2-4668-ED54B8B11523}"/>
                  </a:ext>
                </a:extLst>
              </p:cNvPr>
              <p:cNvSpPr txBox="1"/>
              <p:nvPr/>
            </p:nvSpPr>
            <p:spPr>
              <a:xfrm>
                <a:off x="9993854" y="6154237"/>
                <a:ext cx="310144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C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68C546F-C45E-4B25-275E-734376782F80}"/>
                  </a:ext>
                </a:extLst>
              </p:cNvPr>
              <p:cNvSpPr txBox="1"/>
              <p:nvPr/>
            </p:nvSpPr>
            <p:spPr>
              <a:xfrm>
                <a:off x="10150865" y="6153512"/>
                <a:ext cx="359468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M</a:t>
                </a:r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5247D44-1D0D-4885-7545-8BF51C3A0467}"/>
                </a:ext>
              </a:extLst>
            </p:cNvPr>
            <p:cNvSpPr txBox="1"/>
            <p:nvPr/>
          </p:nvSpPr>
          <p:spPr>
            <a:xfrm>
              <a:off x="9224839" y="3198370"/>
              <a:ext cx="359467" cy="2983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5" dirty="0"/>
                <a:t>M</a:t>
              </a:r>
            </a:p>
          </p:txBody>
        </p:sp>
      </p:grpSp>
      <p:pic>
        <p:nvPicPr>
          <p:cNvPr id="57" name="Picture 56">
            <a:extLst>
              <a:ext uri="{FF2B5EF4-FFF2-40B4-BE49-F238E27FC236}">
                <a16:creationId xmlns:a16="http://schemas.microsoft.com/office/drawing/2014/main" id="{682DE793-7163-393C-AF34-6DD0AA38DF3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45741" y="1061220"/>
            <a:ext cx="1936791" cy="1585097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F1179958-425B-8917-187B-1C9C0B4BB1A1}"/>
              </a:ext>
            </a:extLst>
          </p:cNvPr>
          <p:cNvSpPr txBox="1"/>
          <p:nvPr/>
        </p:nvSpPr>
        <p:spPr>
          <a:xfrm>
            <a:off x="6401226" y="560106"/>
            <a:ext cx="2119878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u="sng" dirty="0"/>
              <a:t>Uncropped blots for Figure 2B – Hif1</a:t>
            </a:r>
            <a:r>
              <a:rPr lang="el-GR" sz="975" u="sng" dirty="0"/>
              <a:t>α</a:t>
            </a:r>
            <a:endParaRPr lang="en-DE" sz="975" u="sng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5E23874-7718-5BB0-38A5-A7E1C0A0197A}"/>
              </a:ext>
            </a:extLst>
          </p:cNvPr>
          <p:cNvSpPr txBox="1"/>
          <p:nvPr/>
        </p:nvSpPr>
        <p:spPr>
          <a:xfrm>
            <a:off x="5978426" y="1317926"/>
            <a:ext cx="741730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u="sng" dirty="0"/>
              <a:t>Anti-Hif1</a:t>
            </a:r>
            <a:r>
              <a:rPr lang="el-GR" sz="813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813" u="sng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77CCDA0-ABA5-1967-40EB-331F94D2DEEB}"/>
              </a:ext>
            </a:extLst>
          </p:cNvPr>
          <p:cNvSpPr txBox="1"/>
          <p:nvPr/>
        </p:nvSpPr>
        <p:spPr>
          <a:xfrm>
            <a:off x="5823042" y="2004697"/>
            <a:ext cx="931513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u="sng" dirty="0"/>
              <a:t>Anti-</a:t>
            </a:r>
            <a:r>
              <a:rPr lang="el-GR" sz="813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813" u="sng" dirty="0"/>
              <a:t>-tubulin</a:t>
            </a: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86D97B3E-8C9D-011B-AC9B-A9706203C76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5064" t="-4402" r="-417" b="1942"/>
          <a:stretch/>
        </p:blipFill>
        <p:spPr>
          <a:xfrm>
            <a:off x="6204624" y="3491843"/>
            <a:ext cx="2424363" cy="573506"/>
          </a:xfrm>
          <a:prstGeom prst="rect">
            <a:avLst/>
          </a:prstGeom>
        </p:spPr>
      </p:pic>
      <p:grpSp>
        <p:nvGrpSpPr>
          <p:cNvPr id="64" name="Group 63">
            <a:extLst>
              <a:ext uri="{FF2B5EF4-FFF2-40B4-BE49-F238E27FC236}">
                <a16:creationId xmlns:a16="http://schemas.microsoft.com/office/drawing/2014/main" id="{3D14C485-A2F3-BE8B-A584-6DCFD75AAFE2}"/>
              </a:ext>
            </a:extLst>
          </p:cNvPr>
          <p:cNvGrpSpPr/>
          <p:nvPr/>
        </p:nvGrpSpPr>
        <p:grpSpPr>
          <a:xfrm>
            <a:off x="6375496" y="4496447"/>
            <a:ext cx="1863804" cy="1759687"/>
            <a:chOff x="6192817" y="461004"/>
            <a:chExt cx="2293914" cy="2165768"/>
          </a:xfrm>
        </p:grpSpPr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D97A36B1-B44D-93DF-3081-E6A3A3FE8C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2218" t="14135" r="42688" b="15566"/>
            <a:stretch/>
          </p:blipFill>
          <p:spPr>
            <a:xfrm>
              <a:off x="6536248" y="759311"/>
              <a:ext cx="1878511" cy="1867461"/>
            </a:xfrm>
            <a:prstGeom prst="rect">
              <a:avLst/>
            </a:prstGeom>
          </p:spPr>
        </p:pic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93F264BA-6EC2-D5CE-2020-3AE98DF04A6E}"/>
                </a:ext>
              </a:extLst>
            </p:cNvPr>
            <p:cNvGrpSpPr/>
            <p:nvPr/>
          </p:nvGrpSpPr>
          <p:grpSpPr>
            <a:xfrm>
              <a:off x="6592460" y="461004"/>
              <a:ext cx="1894271" cy="306087"/>
              <a:chOff x="8570363" y="6141703"/>
              <a:chExt cx="1894271" cy="306087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423038D5-A214-7AC0-DA5D-690A8AF1307D}"/>
                  </a:ext>
                </a:extLst>
              </p:cNvPr>
              <p:cNvSpPr txBox="1"/>
              <p:nvPr/>
            </p:nvSpPr>
            <p:spPr>
              <a:xfrm>
                <a:off x="8570363" y="6143915"/>
                <a:ext cx="359467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M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8C671081-DD47-1089-03BE-FBEEB2E9EFD0}"/>
                  </a:ext>
                </a:extLst>
              </p:cNvPr>
              <p:cNvSpPr txBox="1"/>
              <p:nvPr/>
            </p:nvSpPr>
            <p:spPr>
              <a:xfrm>
                <a:off x="8786738" y="6141704"/>
                <a:ext cx="404843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1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9C7CE885-88AB-C769-CFF5-FE242614409D}"/>
                  </a:ext>
                </a:extLst>
              </p:cNvPr>
              <p:cNvSpPr txBox="1"/>
              <p:nvPr/>
            </p:nvSpPr>
            <p:spPr>
              <a:xfrm>
                <a:off x="9073222" y="6141704"/>
                <a:ext cx="400899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D1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F4B6007A-9D13-8E85-6760-73135AB61DD1}"/>
                  </a:ext>
                </a:extLst>
              </p:cNvPr>
              <p:cNvSpPr txBox="1"/>
              <p:nvPr/>
            </p:nvSpPr>
            <p:spPr>
              <a:xfrm>
                <a:off x="9324751" y="6143915"/>
                <a:ext cx="404843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2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85B0FA02-A547-26E1-9BEF-A341F955FCA2}"/>
                  </a:ext>
                </a:extLst>
              </p:cNvPr>
              <p:cNvSpPr txBox="1"/>
              <p:nvPr/>
            </p:nvSpPr>
            <p:spPr>
              <a:xfrm>
                <a:off x="9586026" y="6144401"/>
                <a:ext cx="400899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D2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89B2F9E7-DC20-5F76-D4D7-8CE1142BB611}"/>
                  </a:ext>
                </a:extLst>
              </p:cNvPr>
              <p:cNvSpPr txBox="1"/>
              <p:nvPr/>
            </p:nvSpPr>
            <p:spPr>
              <a:xfrm>
                <a:off x="9877725" y="6141703"/>
                <a:ext cx="310144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C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609495D8-59F1-B129-B146-14AF8E58B694}"/>
                  </a:ext>
                </a:extLst>
              </p:cNvPr>
              <p:cNvSpPr txBox="1"/>
              <p:nvPr/>
            </p:nvSpPr>
            <p:spPr>
              <a:xfrm>
                <a:off x="10105165" y="6149484"/>
                <a:ext cx="359469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M</a:t>
                </a:r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B0E8A7B2-91FC-DA9E-2960-1AF3BA2DF277}"/>
                </a:ext>
              </a:extLst>
            </p:cNvPr>
            <p:cNvGrpSpPr/>
            <p:nvPr/>
          </p:nvGrpSpPr>
          <p:grpSpPr>
            <a:xfrm>
              <a:off x="6192817" y="528995"/>
              <a:ext cx="470891" cy="2083267"/>
              <a:chOff x="10419056" y="3530206"/>
              <a:chExt cx="1179594" cy="2618510"/>
            </a:xfrm>
          </p:grpSpPr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2FD04B24-5982-81D8-1CB7-D3C46B11D6E9}"/>
                  </a:ext>
                </a:extLst>
              </p:cNvPr>
              <p:cNvSpPr/>
              <p:nvPr/>
            </p:nvSpPr>
            <p:spPr>
              <a:xfrm>
                <a:off x="10434394" y="3530206"/>
                <a:ext cx="1019090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u="sng" dirty="0" err="1"/>
                  <a:t>kDa</a:t>
                </a:r>
                <a:endParaRPr lang="en-US" sz="731" u="sng" dirty="0"/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E0BEDC14-75EA-5AFB-FCB2-500F57901956}"/>
                  </a:ext>
                </a:extLst>
              </p:cNvPr>
              <p:cNvSpPr/>
              <p:nvPr/>
            </p:nvSpPr>
            <p:spPr>
              <a:xfrm>
                <a:off x="10419056" y="3880784"/>
                <a:ext cx="1103105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250-</a:t>
                </a: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D2D4FC90-F0C7-D3E9-9146-3E22D315FEAF}"/>
                  </a:ext>
                </a:extLst>
              </p:cNvPr>
              <p:cNvSpPr/>
              <p:nvPr/>
            </p:nvSpPr>
            <p:spPr>
              <a:xfrm>
                <a:off x="10483570" y="4174437"/>
                <a:ext cx="1103105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130-</a:t>
                </a:r>
              </a:p>
            </p:txBody>
          </p:sp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5D20B243-B7D9-7727-C696-F66D0B944F7A}"/>
                  </a:ext>
                </a:extLst>
              </p:cNvPr>
              <p:cNvSpPr/>
              <p:nvPr/>
            </p:nvSpPr>
            <p:spPr>
              <a:xfrm>
                <a:off x="10495545" y="4445395"/>
                <a:ext cx="1103105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100-</a:t>
                </a:r>
              </a:p>
            </p:txBody>
          </p:sp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915578E4-B6F0-4041-BD87-F8636376A69A}"/>
                  </a:ext>
                </a:extLst>
              </p:cNvPr>
              <p:cNvSpPr/>
              <p:nvPr/>
            </p:nvSpPr>
            <p:spPr>
              <a:xfrm>
                <a:off x="10581052" y="4683011"/>
                <a:ext cx="954839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70-</a:t>
                </a: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21819095-BE8D-8167-2F0F-66A4EE48A410}"/>
                  </a:ext>
                </a:extLst>
              </p:cNvPr>
              <p:cNvSpPr/>
              <p:nvPr/>
            </p:nvSpPr>
            <p:spPr>
              <a:xfrm>
                <a:off x="10561588" y="5031670"/>
                <a:ext cx="954839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55-</a:t>
                </a: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12FEB2C0-FF51-866F-C74F-F1567D89B398}"/>
                  </a:ext>
                </a:extLst>
              </p:cNvPr>
              <p:cNvSpPr/>
              <p:nvPr/>
            </p:nvSpPr>
            <p:spPr>
              <a:xfrm>
                <a:off x="10524397" y="5511310"/>
                <a:ext cx="954839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35-</a:t>
                </a:r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24A2C61E-6412-3136-28B0-1F579E3FD428}"/>
                  </a:ext>
                </a:extLst>
              </p:cNvPr>
              <p:cNvSpPr/>
              <p:nvPr/>
            </p:nvSpPr>
            <p:spPr>
              <a:xfrm>
                <a:off x="10502759" y="5831894"/>
                <a:ext cx="954839" cy="3168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31" dirty="0"/>
                  <a:t>25-</a:t>
                </a:r>
              </a:p>
            </p:txBody>
          </p:sp>
        </p:grpSp>
      </p:grpSp>
      <p:sp>
        <p:nvSpPr>
          <p:cNvPr id="84" name="TextBox 83">
            <a:extLst>
              <a:ext uri="{FF2B5EF4-FFF2-40B4-BE49-F238E27FC236}">
                <a16:creationId xmlns:a16="http://schemas.microsoft.com/office/drawing/2014/main" id="{D38E01CC-6654-4B44-E53A-362AD4AB7CF7}"/>
              </a:ext>
            </a:extLst>
          </p:cNvPr>
          <p:cNvSpPr txBox="1"/>
          <p:nvPr/>
        </p:nvSpPr>
        <p:spPr>
          <a:xfrm>
            <a:off x="5756783" y="3631320"/>
            <a:ext cx="741730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u="sng" dirty="0"/>
              <a:t>Anti-Hif2a</a:t>
            </a:r>
          </a:p>
        </p:txBody>
      </p: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0B1FEC2C-991E-F757-FBD1-E7363C7669F8}"/>
              </a:ext>
            </a:extLst>
          </p:cNvPr>
          <p:cNvGrpSpPr/>
          <p:nvPr/>
        </p:nvGrpSpPr>
        <p:grpSpPr>
          <a:xfrm>
            <a:off x="3188223" y="491907"/>
            <a:ext cx="1195128" cy="216488"/>
            <a:chOff x="2338945" y="1919766"/>
            <a:chExt cx="1306391" cy="225619"/>
          </a:xfrm>
        </p:grpSpPr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A8CF5AEF-3C04-095D-AD06-B4A85AAD98A5}"/>
                </a:ext>
              </a:extLst>
            </p:cNvPr>
            <p:cNvSpPr txBox="1"/>
            <p:nvPr/>
          </p:nvSpPr>
          <p:spPr>
            <a:xfrm>
              <a:off x="2338945" y="1920322"/>
              <a:ext cx="298233" cy="224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M</a:t>
              </a:r>
            </a:p>
          </p:txBody>
        </p: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FCD5200A-7E43-0302-6C00-31AC51FF29ED}"/>
                </a:ext>
              </a:extLst>
            </p:cNvPr>
            <p:cNvGrpSpPr/>
            <p:nvPr/>
          </p:nvGrpSpPr>
          <p:grpSpPr>
            <a:xfrm>
              <a:off x="2460427" y="1919766"/>
              <a:ext cx="1184909" cy="225619"/>
              <a:chOff x="8782973" y="6139162"/>
              <a:chExt cx="1844527" cy="230710"/>
            </a:xfrm>
          </p:grpSpPr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8FC73919-3A24-A436-13EB-5B5DD987FDB5}"/>
                  </a:ext>
                </a:extLst>
              </p:cNvPr>
              <p:cNvSpPr txBox="1"/>
              <p:nvPr/>
            </p:nvSpPr>
            <p:spPr>
              <a:xfrm>
                <a:off x="8782973" y="6139728"/>
                <a:ext cx="513350" cy="2295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1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916E0180-27ED-17C7-397F-670C4C443E1D}"/>
                  </a:ext>
                </a:extLst>
              </p:cNvPr>
              <p:cNvSpPr txBox="1"/>
              <p:nvPr/>
            </p:nvSpPr>
            <p:spPr>
              <a:xfrm>
                <a:off x="9006087" y="6139727"/>
                <a:ext cx="510621" cy="2295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H1</a:t>
                </a:r>
              </a:p>
            </p:txBody>
          </p: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9B1A6687-5CC0-DBBB-7DAF-D9BAECB16023}"/>
                  </a:ext>
                </a:extLst>
              </p:cNvPr>
              <p:cNvSpPr txBox="1"/>
              <p:nvPr/>
            </p:nvSpPr>
            <p:spPr>
              <a:xfrm>
                <a:off x="9208152" y="6140125"/>
                <a:ext cx="589725" cy="2295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1</a:t>
                </a:r>
              </a:p>
            </p:txBody>
          </p:sp>
          <p:sp>
            <p:nvSpPr>
              <p:cNvPr id="163" name="TextBox 162">
                <a:extLst>
                  <a:ext uri="{FF2B5EF4-FFF2-40B4-BE49-F238E27FC236}">
                    <a16:creationId xmlns:a16="http://schemas.microsoft.com/office/drawing/2014/main" id="{8EE0B665-5985-BB61-2537-B707EC5F6B2E}"/>
                  </a:ext>
                </a:extLst>
              </p:cNvPr>
              <p:cNvSpPr txBox="1"/>
              <p:nvPr/>
            </p:nvSpPr>
            <p:spPr>
              <a:xfrm>
                <a:off x="9489942" y="6139730"/>
                <a:ext cx="513350" cy="2295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N2</a:t>
                </a:r>
              </a:p>
            </p:txBody>
          </p: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4B4B54C6-4369-73A6-1E18-107F483199D0}"/>
                  </a:ext>
                </a:extLst>
              </p:cNvPr>
              <p:cNvSpPr txBox="1"/>
              <p:nvPr/>
            </p:nvSpPr>
            <p:spPr>
              <a:xfrm>
                <a:off x="9703310" y="6140274"/>
                <a:ext cx="510621" cy="2295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H2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D313E3B4-AAA2-6002-E191-6BB63299BC6E}"/>
                  </a:ext>
                </a:extLst>
              </p:cNvPr>
              <p:cNvSpPr txBox="1"/>
              <p:nvPr/>
            </p:nvSpPr>
            <p:spPr>
              <a:xfrm>
                <a:off x="9893584" y="6139162"/>
                <a:ext cx="589725" cy="2295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2</a:t>
                </a:r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BA68EA00-090E-3122-0918-5CB2DA58546B}"/>
                  </a:ext>
                </a:extLst>
              </p:cNvPr>
              <p:cNvSpPr txBox="1"/>
              <p:nvPr/>
            </p:nvSpPr>
            <p:spPr>
              <a:xfrm>
                <a:off x="10163248" y="6140126"/>
                <a:ext cx="464252" cy="2295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M</a:t>
                </a:r>
              </a:p>
            </p:txBody>
          </p:sp>
        </p:grpSp>
      </p:grpSp>
      <p:sp>
        <p:nvSpPr>
          <p:cNvPr id="177" name="Rectangle: Rounded Corners 176">
            <a:extLst>
              <a:ext uri="{FF2B5EF4-FFF2-40B4-BE49-F238E27FC236}">
                <a16:creationId xmlns:a16="http://schemas.microsoft.com/office/drawing/2014/main" id="{1B0B4988-458A-86D5-1F2F-DB10CE4E0517}"/>
              </a:ext>
            </a:extLst>
          </p:cNvPr>
          <p:cNvSpPr/>
          <p:nvPr/>
        </p:nvSpPr>
        <p:spPr>
          <a:xfrm>
            <a:off x="1543099" y="311143"/>
            <a:ext cx="3271501" cy="340926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78" name="Rectangle: Rounded Corners 177">
            <a:extLst>
              <a:ext uri="{FF2B5EF4-FFF2-40B4-BE49-F238E27FC236}">
                <a16:creationId xmlns:a16="http://schemas.microsoft.com/office/drawing/2014/main" id="{A3790FA7-C7D8-4AED-57AF-4101A3964A62}"/>
              </a:ext>
            </a:extLst>
          </p:cNvPr>
          <p:cNvSpPr/>
          <p:nvPr/>
        </p:nvSpPr>
        <p:spPr>
          <a:xfrm>
            <a:off x="1552472" y="3779479"/>
            <a:ext cx="3271501" cy="297414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grpSp>
        <p:nvGrpSpPr>
          <p:cNvPr id="179" name="Group 178">
            <a:extLst>
              <a:ext uri="{FF2B5EF4-FFF2-40B4-BE49-F238E27FC236}">
                <a16:creationId xmlns:a16="http://schemas.microsoft.com/office/drawing/2014/main" id="{DF107D49-2612-2C70-7813-5EE1C09D3758}"/>
              </a:ext>
            </a:extLst>
          </p:cNvPr>
          <p:cNvGrpSpPr/>
          <p:nvPr/>
        </p:nvGrpSpPr>
        <p:grpSpPr>
          <a:xfrm>
            <a:off x="6522727" y="848982"/>
            <a:ext cx="995829" cy="257034"/>
            <a:chOff x="2320114" y="1925734"/>
            <a:chExt cx="1088544" cy="267875"/>
          </a:xfrm>
        </p:grpSpPr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33D08B7D-D591-D695-6674-509EB232371F}"/>
                </a:ext>
              </a:extLst>
            </p:cNvPr>
            <p:cNvSpPr txBox="1"/>
            <p:nvPr/>
          </p:nvSpPr>
          <p:spPr>
            <a:xfrm>
              <a:off x="2320114" y="1925736"/>
              <a:ext cx="334534" cy="265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5" dirty="0"/>
                <a:t>M</a:t>
              </a:r>
            </a:p>
          </p:txBody>
        </p: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C18829D6-6539-3912-11AE-C0EEDB9A4737}"/>
                </a:ext>
              </a:extLst>
            </p:cNvPr>
            <p:cNvGrpSpPr/>
            <p:nvPr/>
          </p:nvGrpSpPr>
          <p:grpSpPr>
            <a:xfrm>
              <a:off x="2486109" y="1925734"/>
              <a:ext cx="922549" cy="267875"/>
              <a:chOff x="8822950" y="6145254"/>
              <a:chExt cx="1436116" cy="273919"/>
            </a:xfrm>
          </p:grpSpPr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0FACB8D2-69CC-5359-B0CB-C931F6A74F1E}"/>
                  </a:ext>
                </a:extLst>
              </p:cNvPr>
              <p:cNvSpPr txBox="1"/>
              <p:nvPr/>
            </p:nvSpPr>
            <p:spPr>
              <a:xfrm>
                <a:off x="8822950" y="6147334"/>
                <a:ext cx="586491" cy="2718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1</a:t>
                </a: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D1333F97-8536-6911-EBA6-75D151B7BE68}"/>
                  </a:ext>
                </a:extLst>
              </p:cNvPr>
              <p:cNvSpPr txBox="1"/>
              <p:nvPr/>
            </p:nvSpPr>
            <p:spPr>
              <a:xfrm>
                <a:off x="9126083" y="6145454"/>
                <a:ext cx="559719" cy="258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2</a:t>
                </a:r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669D7ACC-2FFE-4F6E-256E-F6D54DB12ED6}"/>
                  </a:ext>
                </a:extLst>
              </p:cNvPr>
              <p:cNvSpPr txBox="1"/>
              <p:nvPr/>
            </p:nvSpPr>
            <p:spPr>
              <a:xfrm>
                <a:off x="9416780" y="6145660"/>
                <a:ext cx="554264" cy="258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D1</a:t>
                </a: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08F4A4A0-BCD4-0AC1-C0CA-B6BD2987B2E8}"/>
                  </a:ext>
                </a:extLst>
              </p:cNvPr>
              <p:cNvSpPr txBox="1"/>
              <p:nvPr/>
            </p:nvSpPr>
            <p:spPr>
              <a:xfrm>
                <a:off x="9704801" y="6145254"/>
                <a:ext cx="554265" cy="258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D2</a:t>
                </a:r>
              </a:p>
            </p:txBody>
          </p:sp>
        </p:grpSp>
      </p:grpSp>
      <p:sp>
        <p:nvSpPr>
          <p:cNvPr id="189" name="Rectangle: Rounded Corners 188">
            <a:extLst>
              <a:ext uri="{FF2B5EF4-FFF2-40B4-BE49-F238E27FC236}">
                <a16:creationId xmlns:a16="http://schemas.microsoft.com/office/drawing/2014/main" id="{DFBD328A-B4D6-824A-1D6D-993D11430FD3}"/>
              </a:ext>
            </a:extLst>
          </p:cNvPr>
          <p:cNvSpPr/>
          <p:nvPr/>
        </p:nvSpPr>
        <p:spPr>
          <a:xfrm>
            <a:off x="5787731" y="389081"/>
            <a:ext cx="3049016" cy="2334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6D9ACE8D-1C55-9FD2-8CE6-AF3069F28685}"/>
              </a:ext>
            </a:extLst>
          </p:cNvPr>
          <p:cNvSpPr txBox="1"/>
          <p:nvPr/>
        </p:nvSpPr>
        <p:spPr>
          <a:xfrm>
            <a:off x="6431457" y="3148252"/>
            <a:ext cx="22266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Uncropped blots for Figure 2B - Hif2α</a:t>
            </a:r>
            <a:endParaRPr lang="en-DE" sz="1000" u="sng" dirty="0"/>
          </a:p>
        </p:txBody>
      </p:sp>
      <p:sp>
        <p:nvSpPr>
          <p:cNvPr id="192" name="Rectangle: Rounded Corners 191">
            <a:extLst>
              <a:ext uri="{FF2B5EF4-FFF2-40B4-BE49-F238E27FC236}">
                <a16:creationId xmlns:a16="http://schemas.microsoft.com/office/drawing/2014/main" id="{1AA30AFA-06EF-5422-4E67-07DA26E6C48B}"/>
              </a:ext>
            </a:extLst>
          </p:cNvPr>
          <p:cNvSpPr/>
          <p:nvPr/>
        </p:nvSpPr>
        <p:spPr>
          <a:xfrm>
            <a:off x="5787731" y="2905057"/>
            <a:ext cx="3049016" cy="370286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16E2D63F-247A-F50C-F823-7EF015E26205}"/>
              </a:ext>
            </a:extLst>
          </p:cNvPr>
          <p:cNvSpPr txBox="1"/>
          <p:nvPr/>
        </p:nvSpPr>
        <p:spPr>
          <a:xfrm>
            <a:off x="6358564" y="4329821"/>
            <a:ext cx="21339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u="sng" dirty="0"/>
              <a:t>Uncropped blot - Ponceau (Fig2A – Hif2α)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3A7F6FF2-00EE-07ED-72C7-C6A44488A48E}"/>
              </a:ext>
            </a:extLst>
          </p:cNvPr>
          <p:cNvSpPr txBox="1"/>
          <p:nvPr/>
        </p:nvSpPr>
        <p:spPr>
          <a:xfrm>
            <a:off x="2306848" y="505923"/>
            <a:ext cx="10118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/>
              <a:t>- Data not presented-  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AD1B3929-9DD9-F34A-455B-A3E918CE6F03}"/>
              </a:ext>
            </a:extLst>
          </p:cNvPr>
          <p:cNvSpPr txBox="1"/>
          <p:nvPr/>
        </p:nvSpPr>
        <p:spPr>
          <a:xfrm>
            <a:off x="7432590" y="863481"/>
            <a:ext cx="10118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/>
              <a:t>- Data not presented-  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2E972E2F-76F0-6D8D-E38C-BFB4477235A3}"/>
              </a:ext>
            </a:extLst>
          </p:cNvPr>
          <p:cNvSpPr txBox="1"/>
          <p:nvPr/>
        </p:nvSpPr>
        <p:spPr>
          <a:xfrm>
            <a:off x="7520069" y="3348201"/>
            <a:ext cx="10118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/>
              <a:t>- Data not presented-  </a:t>
            </a:r>
          </a:p>
        </p:txBody>
      </p:sp>
      <p:grpSp>
        <p:nvGrpSpPr>
          <p:cNvPr id="197" name="Group 196">
            <a:extLst>
              <a:ext uri="{FF2B5EF4-FFF2-40B4-BE49-F238E27FC236}">
                <a16:creationId xmlns:a16="http://schemas.microsoft.com/office/drawing/2014/main" id="{47949810-98CA-1911-2911-1FB53BB32609}"/>
              </a:ext>
            </a:extLst>
          </p:cNvPr>
          <p:cNvGrpSpPr/>
          <p:nvPr/>
        </p:nvGrpSpPr>
        <p:grpSpPr>
          <a:xfrm>
            <a:off x="6288799" y="3325272"/>
            <a:ext cx="1196163" cy="257203"/>
            <a:chOff x="2290604" y="1925438"/>
            <a:chExt cx="1307528" cy="268050"/>
          </a:xfrm>
        </p:grpSpPr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4481D34B-473D-3131-7EC8-96B024AD1EBF}"/>
                </a:ext>
              </a:extLst>
            </p:cNvPr>
            <p:cNvSpPr txBox="1"/>
            <p:nvPr/>
          </p:nvSpPr>
          <p:spPr>
            <a:xfrm>
              <a:off x="2290604" y="1927645"/>
              <a:ext cx="334534" cy="265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5" dirty="0"/>
                <a:t>M</a:t>
              </a:r>
            </a:p>
          </p:txBody>
        </p:sp>
        <p:grpSp>
          <p:nvGrpSpPr>
            <p:cNvPr id="199" name="Group 198">
              <a:extLst>
                <a:ext uri="{FF2B5EF4-FFF2-40B4-BE49-F238E27FC236}">
                  <a16:creationId xmlns:a16="http://schemas.microsoft.com/office/drawing/2014/main" id="{2C4B1C8C-B6D0-9DC5-8DC9-CE2AEA3B8F32}"/>
                </a:ext>
              </a:extLst>
            </p:cNvPr>
            <p:cNvGrpSpPr/>
            <p:nvPr/>
          </p:nvGrpSpPr>
          <p:grpSpPr>
            <a:xfrm>
              <a:off x="2451790" y="1925438"/>
              <a:ext cx="1146342" cy="268050"/>
              <a:chOff x="8769539" y="6144931"/>
              <a:chExt cx="1784493" cy="274097"/>
            </a:xfrm>
          </p:grpSpPr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A3B3FAF0-8B3C-E8EB-108C-059EE9C8B2C0}"/>
                  </a:ext>
                </a:extLst>
              </p:cNvPr>
              <p:cNvSpPr txBox="1"/>
              <p:nvPr/>
            </p:nvSpPr>
            <p:spPr>
              <a:xfrm>
                <a:off x="8769539" y="6147189"/>
                <a:ext cx="586490" cy="2718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1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3370DB46-6E8B-7B7C-20E1-A5B779A72EFD}"/>
                  </a:ext>
                </a:extLst>
              </p:cNvPr>
              <p:cNvSpPr txBox="1"/>
              <p:nvPr/>
            </p:nvSpPr>
            <p:spPr>
              <a:xfrm>
                <a:off x="9099344" y="6145454"/>
                <a:ext cx="559720" cy="258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N2</a:t>
                </a: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4DCBD695-AB69-0873-5AF8-6EB4C1560E43}"/>
                  </a:ext>
                </a:extLst>
              </p:cNvPr>
              <p:cNvSpPr txBox="1"/>
              <p:nvPr/>
            </p:nvSpPr>
            <p:spPr>
              <a:xfrm>
                <a:off x="9417289" y="6145338"/>
                <a:ext cx="554263" cy="258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D1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9753A117-DD04-FC62-1197-60D6931ECFF5}"/>
                  </a:ext>
                </a:extLst>
              </p:cNvPr>
              <p:cNvSpPr txBox="1"/>
              <p:nvPr/>
            </p:nvSpPr>
            <p:spPr>
              <a:xfrm>
                <a:off x="9737906" y="6144931"/>
                <a:ext cx="816126" cy="2582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75" dirty="0"/>
                  <a:t>D2   C</a:t>
                </a:r>
              </a:p>
            </p:txBody>
          </p:sp>
        </p:grpSp>
      </p:grpSp>
      <p:sp>
        <p:nvSpPr>
          <p:cNvPr id="204" name="TextBox 203">
            <a:extLst>
              <a:ext uri="{FF2B5EF4-FFF2-40B4-BE49-F238E27FC236}">
                <a16:creationId xmlns:a16="http://schemas.microsoft.com/office/drawing/2014/main" id="{7BA59D1C-10E0-7A48-237F-2A97301D7293}"/>
              </a:ext>
            </a:extLst>
          </p:cNvPr>
          <p:cNvSpPr txBox="1"/>
          <p:nvPr/>
        </p:nvSpPr>
        <p:spPr>
          <a:xfrm>
            <a:off x="1675852" y="35133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D8DA224C-F36D-8F23-17BF-DDE18232C61C}"/>
              </a:ext>
            </a:extLst>
          </p:cNvPr>
          <p:cNvSpPr txBox="1"/>
          <p:nvPr/>
        </p:nvSpPr>
        <p:spPr>
          <a:xfrm>
            <a:off x="1605490" y="388504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F4D5CBFA-5C37-FACB-F23E-BC88E4EC3D2D}"/>
              </a:ext>
            </a:extLst>
          </p:cNvPr>
          <p:cNvSpPr txBox="1"/>
          <p:nvPr/>
        </p:nvSpPr>
        <p:spPr>
          <a:xfrm>
            <a:off x="5838786" y="476652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5AC01E17-B82B-E0C6-CEE2-BA397927F12B}"/>
              </a:ext>
            </a:extLst>
          </p:cNvPr>
          <p:cNvSpPr txBox="1"/>
          <p:nvPr/>
        </p:nvSpPr>
        <p:spPr>
          <a:xfrm>
            <a:off x="5824358" y="3023505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20B958-0E2B-CD3C-0D39-EC2FE81065DE}"/>
              </a:ext>
            </a:extLst>
          </p:cNvPr>
          <p:cNvSpPr txBox="1"/>
          <p:nvPr/>
        </p:nvSpPr>
        <p:spPr>
          <a:xfrm>
            <a:off x="2461612" y="1715552"/>
            <a:ext cx="1633781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/>
              <a:t>M  N1  H1 HS1 N2 H2 HS2 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F48FBC7-6ABF-C404-D3F1-0895A7A02E7D}"/>
              </a:ext>
            </a:extLst>
          </p:cNvPr>
          <p:cNvSpPr txBox="1"/>
          <p:nvPr/>
        </p:nvSpPr>
        <p:spPr>
          <a:xfrm>
            <a:off x="2491361" y="3995981"/>
            <a:ext cx="1781257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dirty="0"/>
              <a:t>M </a:t>
            </a:r>
            <a:r>
              <a:rPr lang="en-US" sz="975" dirty="0" err="1"/>
              <a:t>M</a:t>
            </a:r>
            <a:r>
              <a:rPr lang="en-US" sz="975" dirty="0"/>
              <a:t> N1 H1 N2 H2 N3 H3  C  M</a:t>
            </a:r>
          </a:p>
        </p:txBody>
      </p:sp>
    </p:spTree>
    <p:extLst>
      <p:ext uri="{BB962C8B-B14F-4D97-AF65-F5344CB8AC3E}">
        <p14:creationId xmlns:p14="http://schemas.microsoft.com/office/powerpoint/2010/main" val="3715113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ounded Rectangle 37">
            <a:extLst>
              <a:ext uri="{FF2B5EF4-FFF2-40B4-BE49-F238E27FC236}">
                <a16:creationId xmlns:a16="http://schemas.microsoft.com/office/drawing/2014/main" id="{4F5D8A7A-8B72-6E44-FE49-75F0AE2B596F}"/>
              </a:ext>
            </a:extLst>
          </p:cNvPr>
          <p:cNvSpPr/>
          <p:nvPr/>
        </p:nvSpPr>
        <p:spPr>
          <a:xfrm>
            <a:off x="956418" y="2351724"/>
            <a:ext cx="3572324" cy="198120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40BAF0A-4CA6-6354-4058-7E13E1CFB4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75607" y="3606901"/>
            <a:ext cx="2303385" cy="23503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3FD5997-FD62-1B05-1F9B-90DCA0815A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2585" y="2691220"/>
            <a:ext cx="2288595" cy="23178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C3442F5-AB2A-2878-57CF-4855E25060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72585" y="2972783"/>
            <a:ext cx="2288596" cy="21022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6AEB419-430C-C271-3931-4208FC18AAC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74092" y="3887702"/>
            <a:ext cx="2303385" cy="23178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C4773F1-78AA-3AA0-014A-E56A9D04BBAB}"/>
              </a:ext>
            </a:extLst>
          </p:cNvPr>
          <p:cNvSpPr txBox="1"/>
          <p:nvPr/>
        </p:nvSpPr>
        <p:spPr>
          <a:xfrm>
            <a:off x="1962122" y="2475197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1</a:t>
            </a:r>
            <a:endParaRPr lang="en-US" sz="1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7EDE62-CB0E-2445-892B-DB5936256623}"/>
              </a:ext>
            </a:extLst>
          </p:cNvPr>
          <p:cNvSpPr txBox="1"/>
          <p:nvPr/>
        </p:nvSpPr>
        <p:spPr>
          <a:xfrm>
            <a:off x="2220068" y="2476963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1</a:t>
            </a:r>
            <a:endParaRPr lang="en-US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9D63F0-D0F8-2835-68CA-B2AFAACC61C5}"/>
              </a:ext>
            </a:extLst>
          </p:cNvPr>
          <p:cNvSpPr txBox="1"/>
          <p:nvPr/>
        </p:nvSpPr>
        <p:spPr>
          <a:xfrm>
            <a:off x="2461693" y="2476461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2</a:t>
            </a:r>
            <a:endParaRPr lang="en-US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D31681-024D-BAEA-6E72-A8BE5D2EE233}"/>
              </a:ext>
            </a:extLst>
          </p:cNvPr>
          <p:cNvSpPr txBox="1"/>
          <p:nvPr/>
        </p:nvSpPr>
        <p:spPr>
          <a:xfrm>
            <a:off x="2704519" y="2476929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2</a:t>
            </a:r>
            <a:endParaRPr lang="en-US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568627-29FA-0F2A-5894-6ABF26D49480}"/>
              </a:ext>
            </a:extLst>
          </p:cNvPr>
          <p:cNvSpPr txBox="1"/>
          <p:nvPr/>
        </p:nvSpPr>
        <p:spPr>
          <a:xfrm>
            <a:off x="3988320" y="2474941"/>
            <a:ext cx="3805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C</a:t>
            </a:r>
            <a:endParaRPr lang="en-US" sz="1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C82E2F-794B-25B0-D502-A4CB6D43FA2B}"/>
              </a:ext>
            </a:extLst>
          </p:cNvPr>
          <p:cNvSpPr txBox="1"/>
          <p:nvPr/>
        </p:nvSpPr>
        <p:spPr>
          <a:xfrm>
            <a:off x="2961354" y="2475771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3</a:t>
            </a:r>
            <a:endParaRPr lang="en-US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05A73D-BA5B-3006-EEE1-6401774A611B}"/>
              </a:ext>
            </a:extLst>
          </p:cNvPr>
          <p:cNvSpPr txBox="1"/>
          <p:nvPr/>
        </p:nvSpPr>
        <p:spPr>
          <a:xfrm>
            <a:off x="1311054" y="2933728"/>
            <a:ext cx="795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Ponceau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FB369F4-3528-B575-38C2-2187DED8594E}"/>
              </a:ext>
            </a:extLst>
          </p:cNvPr>
          <p:cNvSpPr txBox="1"/>
          <p:nvPr/>
        </p:nvSpPr>
        <p:spPr>
          <a:xfrm>
            <a:off x="1405640" y="2627177"/>
            <a:ext cx="589774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IF1</a:t>
            </a:r>
            <a:r>
              <a:rPr lang="el-GR" sz="1200" dirty="0">
                <a:cs typeface="Times New Roman" panose="02020603050405020304" pitchFamily="18" charset="0"/>
              </a:rPr>
              <a:t>α</a:t>
            </a:r>
            <a:endParaRPr lang="en-US" sz="1200" dirty="0"/>
          </a:p>
        </p:txBody>
      </p:sp>
      <p:sp>
        <p:nvSpPr>
          <p:cNvPr id="15" name="Isosceles Triangle 14">
            <a:extLst>
              <a:ext uri="{FF2B5EF4-FFF2-40B4-BE49-F238E27FC236}">
                <a16:creationId xmlns:a16="http://schemas.microsoft.com/office/drawing/2014/main" id="{D4F71F5A-0C2A-20C2-A46F-A115861156B0}"/>
              </a:ext>
            </a:extLst>
          </p:cNvPr>
          <p:cNvSpPr/>
          <p:nvPr/>
        </p:nvSpPr>
        <p:spPr>
          <a:xfrm rot="5400000">
            <a:off x="1897152" y="2743603"/>
            <a:ext cx="68240" cy="5095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07470C5-0561-63E3-E21F-D1F942450453}"/>
              </a:ext>
            </a:extLst>
          </p:cNvPr>
          <p:cNvSpPr txBox="1"/>
          <p:nvPr/>
        </p:nvSpPr>
        <p:spPr>
          <a:xfrm>
            <a:off x="3212356" y="2475770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3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E1D008C-5824-261A-B660-DD838F96AB45}"/>
              </a:ext>
            </a:extLst>
          </p:cNvPr>
          <p:cNvSpPr txBox="1"/>
          <p:nvPr/>
        </p:nvSpPr>
        <p:spPr>
          <a:xfrm>
            <a:off x="3446732" y="2475472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4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5C97D2C-1AFD-7B03-5401-7D15D43A6CB9}"/>
              </a:ext>
            </a:extLst>
          </p:cNvPr>
          <p:cNvSpPr txBox="1"/>
          <p:nvPr/>
        </p:nvSpPr>
        <p:spPr>
          <a:xfrm>
            <a:off x="3696063" y="2475471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4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6CC88A9-D938-5626-A14E-859AAF441EE7}"/>
              </a:ext>
            </a:extLst>
          </p:cNvPr>
          <p:cNvSpPr txBox="1"/>
          <p:nvPr/>
        </p:nvSpPr>
        <p:spPr>
          <a:xfrm>
            <a:off x="1311054" y="3851098"/>
            <a:ext cx="795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Ponceau</a:t>
            </a:r>
            <a:endParaRPr lang="en-US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BEE21FF-A9D3-33B4-510D-FA257FD9D13B}"/>
              </a:ext>
            </a:extLst>
          </p:cNvPr>
          <p:cNvSpPr txBox="1"/>
          <p:nvPr/>
        </p:nvSpPr>
        <p:spPr>
          <a:xfrm>
            <a:off x="1415165" y="3554072"/>
            <a:ext cx="589774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IF2</a:t>
            </a:r>
            <a:r>
              <a:rPr lang="el-GR" sz="1200" dirty="0">
                <a:cs typeface="Times New Roman" panose="02020603050405020304" pitchFamily="18" charset="0"/>
              </a:rPr>
              <a:t>α</a:t>
            </a:r>
            <a:endParaRPr lang="en-US" sz="1200" dirty="0"/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28F96097-4D12-1731-D51B-7650A3E60CC7}"/>
              </a:ext>
            </a:extLst>
          </p:cNvPr>
          <p:cNvSpPr/>
          <p:nvPr/>
        </p:nvSpPr>
        <p:spPr>
          <a:xfrm rot="5400000">
            <a:off x="1899678" y="3680023"/>
            <a:ext cx="68240" cy="5095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3EE7EEE-30F6-276F-1E8F-C9AFDC985E0B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  <a:endParaRPr lang="en-DE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41E4FE1-2B6F-AEA9-32CB-81EACD8D1114}"/>
              </a:ext>
            </a:extLst>
          </p:cNvPr>
          <p:cNvSpPr txBox="1"/>
          <p:nvPr/>
        </p:nvSpPr>
        <p:spPr>
          <a:xfrm>
            <a:off x="6496761" y="4978791"/>
            <a:ext cx="1048685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u="sng" dirty="0"/>
              <a:t>Ponceau staining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5D138F5-BE7E-D125-B745-06FB4AA595A1}"/>
              </a:ext>
            </a:extLst>
          </p:cNvPr>
          <p:cNvSpPr txBox="1"/>
          <p:nvPr/>
        </p:nvSpPr>
        <p:spPr>
          <a:xfrm>
            <a:off x="5746102" y="4236425"/>
            <a:ext cx="741730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u="sng" dirty="0"/>
              <a:t>Anti-Hif2a</a:t>
            </a:r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DF8454F2-33B3-8659-5DA4-7907C8D4AD6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50442" y="389162"/>
            <a:ext cx="1694073" cy="1129382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6EC287BD-32C9-B301-A48A-28C2630455A9}"/>
              </a:ext>
            </a:extLst>
          </p:cNvPr>
          <p:cNvSpPr txBox="1"/>
          <p:nvPr/>
        </p:nvSpPr>
        <p:spPr>
          <a:xfrm>
            <a:off x="6457560" y="1636125"/>
            <a:ext cx="1048685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5" u="sng" dirty="0"/>
              <a:t>Ponceau staining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CCB9016-D47B-DAFD-589B-C5F3E83286B5}"/>
              </a:ext>
            </a:extLst>
          </p:cNvPr>
          <p:cNvSpPr txBox="1"/>
          <p:nvPr/>
        </p:nvSpPr>
        <p:spPr>
          <a:xfrm>
            <a:off x="5569752" y="1213182"/>
            <a:ext cx="741730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u="sng" dirty="0"/>
              <a:t>Anti-Hif1</a:t>
            </a:r>
            <a:r>
              <a:rPr lang="el-GR" sz="813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813" u="sng" dirty="0"/>
          </a:p>
        </p:txBody>
      </p:sp>
      <p:pic>
        <p:nvPicPr>
          <p:cNvPr id="91" name="Picture 90">
            <a:extLst>
              <a:ext uri="{FF2B5EF4-FFF2-40B4-BE49-F238E27FC236}">
                <a16:creationId xmlns:a16="http://schemas.microsoft.com/office/drawing/2014/main" id="{52913FCE-54C5-4AEA-DE3A-84D1D82C28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30342" y="1977809"/>
            <a:ext cx="1714173" cy="1218544"/>
          </a:xfrm>
          <a:prstGeom prst="rect">
            <a:avLst/>
          </a:prstGeom>
        </p:spPr>
      </p:pic>
      <p:grpSp>
        <p:nvGrpSpPr>
          <p:cNvPr id="92" name="Group 91">
            <a:extLst>
              <a:ext uri="{FF2B5EF4-FFF2-40B4-BE49-F238E27FC236}">
                <a16:creationId xmlns:a16="http://schemas.microsoft.com/office/drawing/2014/main" id="{B5DEACF3-2735-29F2-9444-EA037990938E}"/>
              </a:ext>
            </a:extLst>
          </p:cNvPr>
          <p:cNvGrpSpPr/>
          <p:nvPr/>
        </p:nvGrpSpPr>
        <p:grpSpPr>
          <a:xfrm>
            <a:off x="5866765" y="1755464"/>
            <a:ext cx="373627" cy="1463629"/>
            <a:chOff x="10458176" y="3543201"/>
            <a:chExt cx="1151936" cy="2566442"/>
          </a:xfrm>
        </p:grpSpPr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83260E3D-9B50-304F-3976-F3E8B69B188A}"/>
                </a:ext>
              </a:extLst>
            </p:cNvPr>
            <p:cNvSpPr/>
            <p:nvPr/>
          </p:nvSpPr>
          <p:spPr>
            <a:xfrm>
              <a:off x="10460988" y="3543201"/>
              <a:ext cx="1019091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u="sng" dirty="0" err="1"/>
                <a:t>kDa</a:t>
              </a:r>
              <a:endParaRPr lang="en-US" sz="731" u="sng" dirty="0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82541B8-2BE1-622D-2947-45DD35664A4A}"/>
                </a:ext>
              </a:extLst>
            </p:cNvPr>
            <p:cNvSpPr/>
            <p:nvPr/>
          </p:nvSpPr>
          <p:spPr>
            <a:xfrm>
              <a:off x="10507003" y="3950540"/>
              <a:ext cx="1103109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250-</a:t>
              </a: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383E937A-092C-C4C7-1367-CDD1EAACDCA6}"/>
                </a:ext>
              </a:extLst>
            </p:cNvPr>
            <p:cNvSpPr/>
            <p:nvPr/>
          </p:nvSpPr>
          <p:spPr>
            <a:xfrm>
              <a:off x="10461456" y="4234133"/>
              <a:ext cx="1103109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30-</a:t>
              </a: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5E90F78C-3BB0-A298-B1B4-BD199CDDF43A}"/>
                </a:ext>
              </a:extLst>
            </p:cNvPr>
            <p:cNvSpPr/>
            <p:nvPr/>
          </p:nvSpPr>
          <p:spPr>
            <a:xfrm>
              <a:off x="10458176" y="4481937"/>
              <a:ext cx="1103109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00-</a:t>
              </a: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E7DB7F70-BE35-E6DF-F957-877382F9711A}"/>
                </a:ext>
              </a:extLst>
            </p:cNvPr>
            <p:cNvSpPr/>
            <p:nvPr/>
          </p:nvSpPr>
          <p:spPr>
            <a:xfrm>
              <a:off x="10582133" y="4702056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70-</a:t>
              </a: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0D1D8BDF-5F3A-93FE-801B-727A421031BB}"/>
                </a:ext>
              </a:extLst>
            </p:cNvPr>
            <p:cNvSpPr/>
            <p:nvPr/>
          </p:nvSpPr>
          <p:spPr>
            <a:xfrm>
              <a:off x="10562688" y="5082856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55-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788E175F-8B2D-ABB4-C4A6-EFD8796DD9E3}"/>
                </a:ext>
              </a:extLst>
            </p:cNvPr>
            <p:cNvSpPr/>
            <p:nvPr/>
          </p:nvSpPr>
          <p:spPr>
            <a:xfrm>
              <a:off x="10562688" y="5478328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35-</a:t>
              </a:r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31C49769-0397-C522-7A8A-D7E2F92EACA8}"/>
                </a:ext>
              </a:extLst>
            </p:cNvPr>
            <p:cNvSpPr/>
            <p:nvPr/>
          </p:nvSpPr>
          <p:spPr>
            <a:xfrm>
              <a:off x="10582133" y="5750531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25-</a:t>
              </a:r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25E6F8D6-7B6D-135C-CC02-8873C1B37D7D}"/>
              </a:ext>
            </a:extLst>
          </p:cNvPr>
          <p:cNvGrpSpPr/>
          <p:nvPr/>
        </p:nvGrpSpPr>
        <p:grpSpPr>
          <a:xfrm>
            <a:off x="6102357" y="1806064"/>
            <a:ext cx="1777256" cy="224056"/>
            <a:chOff x="6275162" y="6182173"/>
            <a:chExt cx="2610137" cy="462359"/>
          </a:xfrm>
        </p:grpSpPr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6527953-F438-0F0B-81E4-B86D33AA779A}"/>
                </a:ext>
              </a:extLst>
            </p:cNvPr>
            <p:cNvSpPr txBox="1"/>
            <p:nvPr/>
          </p:nvSpPr>
          <p:spPr>
            <a:xfrm>
              <a:off x="6453814" y="6182173"/>
              <a:ext cx="407751" cy="461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M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8EEC547B-C876-7D54-FB33-704078852814}"/>
                </a:ext>
              </a:extLst>
            </p:cNvPr>
            <p:cNvSpPr txBox="1"/>
            <p:nvPr/>
          </p:nvSpPr>
          <p:spPr>
            <a:xfrm>
              <a:off x="6632466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1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E7ACDC30-3F33-C0BD-47A0-8F7BA3C10F65}"/>
                </a:ext>
              </a:extLst>
            </p:cNvPr>
            <p:cNvSpPr txBox="1"/>
            <p:nvPr/>
          </p:nvSpPr>
          <p:spPr>
            <a:xfrm>
              <a:off x="6854397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BDE0A5F-3F59-5F18-83EB-AE1DF11D4B93}"/>
                </a:ext>
              </a:extLst>
            </p:cNvPr>
            <p:cNvSpPr txBox="1"/>
            <p:nvPr/>
          </p:nvSpPr>
          <p:spPr>
            <a:xfrm>
              <a:off x="7073125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2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C14EEFE-4717-15E2-4533-C6CF7CD1BC3E}"/>
                </a:ext>
              </a:extLst>
            </p:cNvPr>
            <p:cNvSpPr txBox="1"/>
            <p:nvPr/>
          </p:nvSpPr>
          <p:spPr>
            <a:xfrm>
              <a:off x="7265651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2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1227B21F-06E8-F4E5-DBD3-ED91E03CCE79}"/>
                </a:ext>
              </a:extLst>
            </p:cNvPr>
            <p:cNvSpPr txBox="1"/>
            <p:nvPr/>
          </p:nvSpPr>
          <p:spPr>
            <a:xfrm>
              <a:off x="7474575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3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9F4AE1BB-B0DF-FAFF-2B1F-4F2CE1BA2985}"/>
                </a:ext>
              </a:extLst>
            </p:cNvPr>
            <p:cNvSpPr txBox="1"/>
            <p:nvPr/>
          </p:nvSpPr>
          <p:spPr>
            <a:xfrm>
              <a:off x="7681805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3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E5AB6A24-5B94-7F33-4BA8-639EF74E0219}"/>
                </a:ext>
              </a:extLst>
            </p:cNvPr>
            <p:cNvSpPr txBox="1"/>
            <p:nvPr/>
          </p:nvSpPr>
          <p:spPr>
            <a:xfrm>
              <a:off x="7885825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4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55FE29A-C9E0-1518-B83D-DB633379F3BA}"/>
                </a:ext>
              </a:extLst>
            </p:cNvPr>
            <p:cNvSpPr txBox="1"/>
            <p:nvPr/>
          </p:nvSpPr>
          <p:spPr>
            <a:xfrm>
              <a:off x="6275162" y="6182173"/>
              <a:ext cx="40775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M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DA3CABAB-D796-FE48-F091-2A79C7FB48AA}"/>
                </a:ext>
              </a:extLst>
            </p:cNvPr>
            <p:cNvSpPr txBox="1"/>
            <p:nvPr/>
          </p:nvSpPr>
          <p:spPr>
            <a:xfrm>
              <a:off x="8078349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4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4376DDF1-1951-374D-8C0B-2D756BFE6EE8}"/>
                </a:ext>
              </a:extLst>
            </p:cNvPr>
            <p:cNvSpPr txBox="1"/>
            <p:nvPr/>
          </p:nvSpPr>
          <p:spPr>
            <a:xfrm>
              <a:off x="8331383" y="6182173"/>
              <a:ext cx="355958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53" dirty="0"/>
                <a:t>C</a:t>
              </a:r>
              <a:endParaRPr lang="en-US" sz="853" dirty="0"/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16447EC4-3463-EF24-59B8-C0B0D67CFF1A}"/>
                </a:ext>
              </a:extLst>
            </p:cNvPr>
            <p:cNvSpPr txBox="1"/>
            <p:nvPr/>
          </p:nvSpPr>
          <p:spPr>
            <a:xfrm>
              <a:off x="8477548" y="6183141"/>
              <a:ext cx="40775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M</a:t>
              </a:r>
            </a:p>
          </p:txBody>
        </p:sp>
      </p:grpSp>
      <p:pic>
        <p:nvPicPr>
          <p:cNvPr id="114" name="Picture 113">
            <a:extLst>
              <a:ext uri="{FF2B5EF4-FFF2-40B4-BE49-F238E27FC236}">
                <a16:creationId xmlns:a16="http://schemas.microsoft.com/office/drawing/2014/main" id="{C73599B3-BB15-5713-B64F-B0611FF1074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11482" y="3895220"/>
            <a:ext cx="1590051" cy="990686"/>
          </a:xfrm>
          <a:prstGeom prst="rect">
            <a:avLst/>
          </a:prstGeom>
        </p:spPr>
      </p:pic>
      <p:grpSp>
        <p:nvGrpSpPr>
          <p:cNvPr id="117" name="Group 116">
            <a:extLst>
              <a:ext uri="{FF2B5EF4-FFF2-40B4-BE49-F238E27FC236}">
                <a16:creationId xmlns:a16="http://schemas.microsoft.com/office/drawing/2014/main" id="{282D4C65-6FC2-5C91-63FD-DBD400070A07}"/>
              </a:ext>
            </a:extLst>
          </p:cNvPr>
          <p:cNvGrpSpPr/>
          <p:nvPr/>
        </p:nvGrpSpPr>
        <p:grpSpPr>
          <a:xfrm>
            <a:off x="5949074" y="5045425"/>
            <a:ext cx="373627" cy="1454576"/>
            <a:chOff x="10458176" y="3559075"/>
            <a:chExt cx="1151936" cy="2550568"/>
          </a:xfrm>
        </p:grpSpPr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7DC7425A-F3BC-E0EC-4201-47F07F561A6E}"/>
                </a:ext>
              </a:extLst>
            </p:cNvPr>
            <p:cNvSpPr/>
            <p:nvPr/>
          </p:nvSpPr>
          <p:spPr>
            <a:xfrm>
              <a:off x="10488899" y="3559075"/>
              <a:ext cx="1019091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u="sng" dirty="0" err="1"/>
                <a:t>kDa</a:t>
              </a:r>
              <a:endParaRPr lang="en-US" sz="731" u="sng" dirty="0"/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C2714984-9F17-F312-B391-5FE222F39326}"/>
                </a:ext>
              </a:extLst>
            </p:cNvPr>
            <p:cNvSpPr/>
            <p:nvPr/>
          </p:nvSpPr>
          <p:spPr>
            <a:xfrm>
              <a:off x="10507003" y="3950540"/>
              <a:ext cx="1103109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250-</a:t>
              </a: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6840320C-11B2-0BB3-9BA6-6C7CA7D53A0D}"/>
                </a:ext>
              </a:extLst>
            </p:cNvPr>
            <p:cNvSpPr/>
            <p:nvPr/>
          </p:nvSpPr>
          <p:spPr>
            <a:xfrm>
              <a:off x="10461456" y="4234133"/>
              <a:ext cx="1103109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30-</a:t>
              </a: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27216130-9131-E37F-7E61-B00B7E114FD3}"/>
                </a:ext>
              </a:extLst>
            </p:cNvPr>
            <p:cNvSpPr/>
            <p:nvPr/>
          </p:nvSpPr>
          <p:spPr>
            <a:xfrm>
              <a:off x="10458176" y="4481937"/>
              <a:ext cx="1103109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100-</a:t>
              </a: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80F4C2D9-01DB-B2EB-4B5E-140DBA17372A}"/>
                </a:ext>
              </a:extLst>
            </p:cNvPr>
            <p:cNvSpPr/>
            <p:nvPr/>
          </p:nvSpPr>
          <p:spPr>
            <a:xfrm>
              <a:off x="10582133" y="4702056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70-</a:t>
              </a: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CBF211D3-0EC6-1544-B7E1-C24120707312}"/>
                </a:ext>
              </a:extLst>
            </p:cNvPr>
            <p:cNvSpPr/>
            <p:nvPr/>
          </p:nvSpPr>
          <p:spPr>
            <a:xfrm>
              <a:off x="10562688" y="5082856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55-</a:t>
              </a: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1A9AF7AC-5D54-3250-4EA0-9178A5FD8A95}"/>
                </a:ext>
              </a:extLst>
            </p:cNvPr>
            <p:cNvSpPr/>
            <p:nvPr/>
          </p:nvSpPr>
          <p:spPr>
            <a:xfrm>
              <a:off x="10562688" y="5478328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35-</a:t>
              </a: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2CC85B0E-1772-D5D9-1B52-EB975B5E145B}"/>
                </a:ext>
              </a:extLst>
            </p:cNvPr>
            <p:cNvSpPr/>
            <p:nvPr/>
          </p:nvSpPr>
          <p:spPr>
            <a:xfrm>
              <a:off x="10582133" y="5750531"/>
              <a:ext cx="954842" cy="3591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31" dirty="0"/>
                <a:t>25-</a:t>
              </a:r>
            </a:p>
          </p:txBody>
        </p:sp>
      </p:grpSp>
      <p:pic>
        <p:nvPicPr>
          <p:cNvPr id="118" name="Picture 117">
            <a:extLst>
              <a:ext uri="{FF2B5EF4-FFF2-40B4-BE49-F238E27FC236}">
                <a16:creationId xmlns:a16="http://schemas.microsoft.com/office/drawing/2014/main" id="{8E704042-D025-F2F7-E697-B5C9097296F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53578" y="5302085"/>
            <a:ext cx="1689692" cy="110461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D4577C57-7621-27D2-4E50-14CEA9856959}"/>
              </a:ext>
            </a:extLst>
          </p:cNvPr>
          <p:cNvSpPr txBox="1"/>
          <p:nvPr/>
        </p:nvSpPr>
        <p:spPr>
          <a:xfrm>
            <a:off x="5759384" y="269638"/>
            <a:ext cx="225742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u="sng" dirty="0"/>
              <a:t>Uncropped blots for Supp. Fig 3A – Hif1</a:t>
            </a:r>
            <a:r>
              <a:rPr lang="el-GR" sz="975" u="sng" dirty="0"/>
              <a:t>α</a:t>
            </a:r>
            <a:endParaRPr lang="en-DE" sz="975" u="sng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53227A4-E0FA-64D3-0CAC-A56AFD7C952A}"/>
              </a:ext>
            </a:extLst>
          </p:cNvPr>
          <p:cNvSpPr txBox="1"/>
          <p:nvPr/>
        </p:nvSpPr>
        <p:spPr>
          <a:xfrm>
            <a:off x="5853189" y="3668188"/>
            <a:ext cx="225742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u="sng" dirty="0"/>
              <a:t>Uncropped blots for Supp. Fig 3A – Hif2</a:t>
            </a:r>
            <a:r>
              <a:rPr lang="el-GR" sz="975" u="sng" dirty="0"/>
              <a:t>α</a:t>
            </a:r>
            <a:endParaRPr lang="en-DE" sz="975" u="sng" dirty="0"/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87DA6F75-E16F-AC71-EED4-DE283DE17E26}"/>
              </a:ext>
            </a:extLst>
          </p:cNvPr>
          <p:cNvGrpSpPr/>
          <p:nvPr/>
        </p:nvGrpSpPr>
        <p:grpSpPr>
          <a:xfrm>
            <a:off x="6204926" y="5133573"/>
            <a:ext cx="1777256" cy="224056"/>
            <a:chOff x="6275162" y="6182173"/>
            <a:chExt cx="2610137" cy="462359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2C51BAF-D25D-3FA3-6B5B-E8396E6E1D08}"/>
                </a:ext>
              </a:extLst>
            </p:cNvPr>
            <p:cNvSpPr txBox="1"/>
            <p:nvPr/>
          </p:nvSpPr>
          <p:spPr>
            <a:xfrm>
              <a:off x="6453814" y="6182173"/>
              <a:ext cx="407751" cy="461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M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66F8562-DE25-9ECF-68E5-8F7F23A17956}"/>
                </a:ext>
              </a:extLst>
            </p:cNvPr>
            <p:cNvSpPr txBox="1"/>
            <p:nvPr/>
          </p:nvSpPr>
          <p:spPr>
            <a:xfrm>
              <a:off x="6632466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76959AC-F5F3-66C9-819C-6BE76D4D2E8D}"/>
                </a:ext>
              </a:extLst>
            </p:cNvPr>
            <p:cNvSpPr txBox="1"/>
            <p:nvPr/>
          </p:nvSpPr>
          <p:spPr>
            <a:xfrm>
              <a:off x="6854397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CEF8BF9-0418-1E07-D1CA-76C5F7A85963}"/>
                </a:ext>
              </a:extLst>
            </p:cNvPr>
            <p:cNvSpPr txBox="1"/>
            <p:nvPr/>
          </p:nvSpPr>
          <p:spPr>
            <a:xfrm>
              <a:off x="7073125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2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D97BF47-BB62-F4A1-9F79-1F95C31210F4}"/>
                </a:ext>
              </a:extLst>
            </p:cNvPr>
            <p:cNvSpPr txBox="1"/>
            <p:nvPr/>
          </p:nvSpPr>
          <p:spPr>
            <a:xfrm>
              <a:off x="7265651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BD538A5-495D-1FE4-589D-E42E26B4E1C8}"/>
                </a:ext>
              </a:extLst>
            </p:cNvPr>
            <p:cNvSpPr txBox="1"/>
            <p:nvPr/>
          </p:nvSpPr>
          <p:spPr>
            <a:xfrm>
              <a:off x="7474575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9B54D38-E6FE-5818-A2BB-0F6CAFBE03EA}"/>
                </a:ext>
              </a:extLst>
            </p:cNvPr>
            <p:cNvSpPr txBox="1"/>
            <p:nvPr/>
          </p:nvSpPr>
          <p:spPr>
            <a:xfrm>
              <a:off x="7681805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B916D758-6A13-4531-6797-35FD123A689D}"/>
                </a:ext>
              </a:extLst>
            </p:cNvPr>
            <p:cNvSpPr txBox="1"/>
            <p:nvPr/>
          </p:nvSpPr>
          <p:spPr>
            <a:xfrm>
              <a:off x="7885825" y="6182173"/>
              <a:ext cx="45719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N4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FCB3EC0-BD81-EA61-EB14-1DDC352B216A}"/>
                </a:ext>
              </a:extLst>
            </p:cNvPr>
            <p:cNvSpPr txBox="1"/>
            <p:nvPr/>
          </p:nvSpPr>
          <p:spPr>
            <a:xfrm>
              <a:off x="6275162" y="6182173"/>
              <a:ext cx="40775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M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89860C4C-6774-C79D-DFC5-F3AE18489B04}"/>
                </a:ext>
              </a:extLst>
            </p:cNvPr>
            <p:cNvSpPr txBox="1"/>
            <p:nvPr/>
          </p:nvSpPr>
          <p:spPr>
            <a:xfrm>
              <a:off x="8078349" y="6182173"/>
              <a:ext cx="454836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H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499F9D8-5046-A2C4-9482-FBC7239CB7C2}"/>
                </a:ext>
              </a:extLst>
            </p:cNvPr>
            <p:cNvSpPr txBox="1"/>
            <p:nvPr/>
          </p:nvSpPr>
          <p:spPr>
            <a:xfrm>
              <a:off x="8331383" y="6182173"/>
              <a:ext cx="355958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53" dirty="0"/>
                <a:t>C</a:t>
              </a:r>
              <a:endParaRPr lang="en-US" sz="853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445EEDD-C4CE-CE49-6164-CD1D16190672}"/>
                </a:ext>
              </a:extLst>
            </p:cNvPr>
            <p:cNvSpPr txBox="1"/>
            <p:nvPr/>
          </p:nvSpPr>
          <p:spPr>
            <a:xfrm>
              <a:off x="8477548" y="6183141"/>
              <a:ext cx="407751" cy="46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53" dirty="0"/>
                <a:t>M</a:t>
              </a:r>
            </a:p>
          </p:txBody>
        </p:sp>
      </p:grpSp>
      <p:sp>
        <p:nvSpPr>
          <p:cNvPr id="60" name="Rounded Rectangle 37">
            <a:extLst>
              <a:ext uri="{FF2B5EF4-FFF2-40B4-BE49-F238E27FC236}">
                <a16:creationId xmlns:a16="http://schemas.microsoft.com/office/drawing/2014/main" id="{71A24628-C11C-5CE8-B4F4-44D16710ACF4}"/>
              </a:ext>
            </a:extLst>
          </p:cNvPr>
          <p:cNvSpPr/>
          <p:nvPr/>
        </p:nvSpPr>
        <p:spPr>
          <a:xfrm>
            <a:off x="5302546" y="221203"/>
            <a:ext cx="3007199" cy="312112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ounded Rectangle 37">
            <a:extLst>
              <a:ext uri="{FF2B5EF4-FFF2-40B4-BE49-F238E27FC236}">
                <a16:creationId xmlns:a16="http://schemas.microsoft.com/office/drawing/2014/main" id="{8F869734-5530-7EC9-9D84-00D60EFABF2C}"/>
              </a:ext>
            </a:extLst>
          </p:cNvPr>
          <p:cNvSpPr/>
          <p:nvPr/>
        </p:nvSpPr>
        <p:spPr>
          <a:xfrm>
            <a:off x="5302546" y="3596954"/>
            <a:ext cx="3007199" cy="312112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FDA9EFF-1456-614F-A3D1-805F37874CC7}"/>
              </a:ext>
            </a:extLst>
          </p:cNvPr>
          <p:cNvSpPr txBox="1"/>
          <p:nvPr/>
        </p:nvSpPr>
        <p:spPr>
          <a:xfrm>
            <a:off x="990288" y="238626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5AC5848-9492-5DBE-7AB4-8D6FE4F2298D}"/>
              </a:ext>
            </a:extLst>
          </p:cNvPr>
          <p:cNvSpPr txBox="1"/>
          <p:nvPr/>
        </p:nvSpPr>
        <p:spPr>
          <a:xfrm>
            <a:off x="5402308" y="26963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FB17F84-4C62-A13F-6330-6266FF84EC7A}"/>
              </a:ext>
            </a:extLst>
          </p:cNvPr>
          <p:cNvSpPr txBox="1"/>
          <p:nvPr/>
        </p:nvSpPr>
        <p:spPr>
          <a:xfrm>
            <a:off x="5400093" y="363731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5B288CB-8524-E7CE-D863-8468ED1903F2}"/>
              </a:ext>
            </a:extLst>
          </p:cNvPr>
          <p:cNvSpPr txBox="1"/>
          <p:nvPr/>
        </p:nvSpPr>
        <p:spPr>
          <a:xfrm>
            <a:off x="1975485" y="3421203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1</a:t>
            </a:r>
            <a:endParaRPr lang="en-US" sz="10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C5E90A5-DA71-57A3-3EAD-1F59545CF825}"/>
              </a:ext>
            </a:extLst>
          </p:cNvPr>
          <p:cNvSpPr txBox="1"/>
          <p:nvPr/>
        </p:nvSpPr>
        <p:spPr>
          <a:xfrm>
            <a:off x="2233431" y="3422969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1</a:t>
            </a:r>
            <a:endParaRPr lang="en-US" sz="10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3BC8FA1-E859-F433-F8AB-5A4462DB89B5}"/>
              </a:ext>
            </a:extLst>
          </p:cNvPr>
          <p:cNvSpPr txBox="1"/>
          <p:nvPr/>
        </p:nvSpPr>
        <p:spPr>
          <a:xfrm>
            <a:off x="2475056" y="3422467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2</a:t>
            </a:r>
            <a:endParaRPr lang="en-US" sz="10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3F38821-F398-EB6B-2352-47C705656BFE}"/>
              </a:ext>
            </a:extLst>
          </p:cNvPr>
          <p:cNvSpPr txBox="1"/>
          <p:nvPr/>
        </p:nvSpPr>
        <p:spPr>
          <a:xfrm>
            <a:off x="2717882" y="3422935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2</a:t>
            </a:r>
            <a:endParaRPr lang="en-US" sz="1000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A28A30D-D324-5A79-4480-2521A9CE28F6}"/>
              </a:ext>
            </a:extLst>
          </p:cNvPr>
          <p:cNvSpPr txBox="1"/>
          <p:nvPr/>
        </p:nvSpPr>
        <p:spPr>
          <a:xfrm>
            <a:off x="4001683" y="3420947"/>
            <a:ext cx="3805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C</a:t>
            </a:r>
            <a:endParaRPr lang="en-US" sz="10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40F6EC1-3660-CD05-CEAF-336FEC3C8F33}"/>
              </a:ext>
            </a:extLst>
          </p:cNvPr>
          <p:cNvSpPr txBox="1"/>
          <p:nvPr/>
        </p:nvSpPr>
        <p:spPr>
          <a:xfrm>
            <a:off x="2974717" y="3421777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3</a:t>
            </a:r>
            <a:endParaRPr lang="en-US" sz="10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C8A5E3A-28EE-8DAC-7BCD-C43987CB0302}"/>
              </a:ext>
            </a:extLst>
          </p:cNvPr>
          <p:cNvSpPr txBox="1"/>
          <p:nvPr/>
        </p:nvSpPr>
        <p:spPr>
          <a:xfrm>
            <a:off x="3225719" y="3421776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3</a:t>
            </a:r>
            <a:endParaRPr lang="en-US" sz="10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5EE31F8-94F2-609E-A976-86DCE25D3786}"/>
              </a:ext>
            </a:extLst>
          </p:cNvPr>
          <p:cNvSpPr txBox="1"/>
          <p:nvPr/>
        </p:nvSpPr>
        <p:spPr>
          <a:xfrm>
            <a:off x="3460095" y="3421478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N4</a:t>
            </a:r>
            <a:endParaRPr lang="en-US" sz="10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2320F22-F6E8-1141-6191-E39413A521D0}"/>
              </a:ext>
            </a:extLst>
          </p:cNvPr>
          <p:cNvSpPr txBox="1"/>
          <p:nvPr/>
        </p:nvSpPr>
        <p:spPr>
          <a:xfrm>
            <a:off x="3709426" y="3421477"/>
            <a:ext cx="493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H4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2282766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708055-4096-7D4D-BAB0-956194F7B7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660C72F-57D5-6CEB-8A4C-24482D871C67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  <a:endParaRPr lang="en-DE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BEFC369-2F77-889C-DFB2-70E585F1B89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92163" y="503238"/>
          <a:ext cx="8197850" cy="381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8083853" imgH="3756199" progId="Prism10.Document">
                  <p:embed/>
                </p:oleObj>
              </mc:Choice>
              <mc:Fallback>
                <p:oleObj name="Prism 10" r:id="rId2" imgW="8083853" imgH="375619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BEFC369-2F77-889C-DFB2-70E585F1B8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92163" y="503238"/>
                        <a:ext cx="8197850" cy="381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ounded Rectangle 23">
            <a:extLst>
              <a:ext uri="{FF2B5EF4-FFF2-40B4-BE49-F238E27FC236}">
                <a16:creationId xmlns:a16="http://schemas.microsoft.com/office/drawing/2014/main" id="{DC7B28A8-9149-128C-D8F4-9C470A345C4C}"/>
              </a:ext>
            </a:extLst>
          </p:cNvPr>
          <p:cNvSpPr/>
          <p:nvPr/>
        </p:nvSpPr>
        <p:spPr>
          <a:xfrm>
            <a:off x="591402" y="496342"/>
            <a:ext cx="8402473" cy="362983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FE91759-FAB0-D97C-C88F-A13DB76A781A}"/>
              </a:ext>
            </a:extLst>
          </p:cNvPr>
          <p:cNvSpPr txBox="1"/>
          <p:nvPr/>
        </p:nvSpPr>
        <p:spPr>
          <a:xfrm>
            <a:off x="727238" y="56672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1D3740-70F5-3C4C-84C0-97B95D08BE26}"/>
              </a:ext>
            </a:extLst>
          </p:cNvPr>
          <p:cNvSpPr txBox="1"/>
          <p:nvPr/>
        </p:nvSpPr>
        <p:spPr>
          <a:xfrm>
            <a:off x="1724936" y="428635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6356B12-8AF8-4CA2-BEB9-3B840076B1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7660" y="4196539"/>
            <a:ext cx="1844377" cy="2447914"/>
          </a:xfrm>
          <a:prstGeom prst="rect">
            <a:avLst/>
          </a:prstGeom>
        </p:spPr>
      </p:pic>
      <p:sp>
        <p:nvSpPr>
          <p:cNvPr id="9" name="Rounded Rectangle 30">
            <a:extLst>
              <a:ext uri="{FF2B5EF4-FFF2-40B4-BE49-F238E27FC236}">
                <a16:creationId xmlns:a16="http://schemas.microsoft.com/office/drawing/2014/main" id="{3AE711F7-CEDD-B2EF-232C-EFA878512BB3}"/>
              </a:ext>
            </a:extLst>
          </p:cNvPr>
          <p:cNvSpPr/>
          <p:nvPr/>
        </p:nvSpPr>
        <p:spPr>
          <a:xfrm>
            <a:off x="1577295" y="4253183"/>
            <a:ext cx="6977765" cy="248426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D44389-D767-7F25-7491-7AD8EA9DB7C5}"/>
              </a:ext>
            </a:extLst>
          </p:cNvPr>
          <p:cNvSpPr txBox="1"/>
          <p:nvPr/>
        </p:nvSpPr>
        <p:spPr>
          <a:xfrm>
            <a:off x="4151317" y="6085102"/>
            <a:ext cx="1635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Anti- (Meta)vincul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441870-29F2-1013-4CAF-F64AE861140F}"/>
              </a:ext>
            </a:extLst>
          </p:cNvPr>
          <p:cNvSpPr txBox="1"/>
          <p:nvPr/>
        </p:nvSpPr>
        <p:spPr>
          <a:xfrm>
            <a:off x="4431184" y="5467035"/>
            <a:ext cx="1076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Anti-Cyp11a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92E596-EA29-184F-EE08-99CEDB1A6D50}"/>
              </a:ext>
            </a:extLst>
          </p:cNvPr>
          <p:cNvSpPr txBox="1"/>
          <p:nvPr/>
        </p:nvSpPr>
        <p:spPr>
          <a:xfrm>
            <a:off x="4598169" y="4866149"/>
            <a:ext cx="9128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Anti-</a:t>
            </a:r>
            <a:r>
              <a:rPr lang="en-US" sz="1000" u="sng" dirty="0" err="1"/>
              <a:t>StaR</a:t>
            </a:r>
            <a:endParaRPr lang="en-US" sz="1000" u="sng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7950FBC-FD7F-5137-3661-3A9CB9A74CD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9" t="30102" r="9929" b="47668"/>
          <a:stretch/>
        </p:blipFill>
        <p:spPr>
          <a:xfrm>
            <a:off x="5318267" y="5953962"/>
            <a:ext cx="2048488" cy="58008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6FAE942-77A1-4F1B-35FC-8FABE586718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789" t="45763" r="12719" b="35691"/>
          <a:stretch/>
        </p:blipFill>
        <p:spPr>
          <a:xfrm>
            <a:off x="5318267" y="4734215"/>
            <a:ext cx="2048488" cy="50333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BFD345F-7965-1276-1325-1AB247C5FD6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17" t="45876" r="13627" b="30656"/>
          <a:stretch/>
        </p:blipFill>
        <p:spPr>
          <a:xfrm>
            <a:off x="5318267" y="5276618"/>
            <a:ext cx="2048488" cy="61969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1C33554-9250-66BD-DBB8-B4DA7F075380}"/>
              </a:ext>
            </a:extLst>
          </p:cNvPr>
          <p:cNvSpPr txBox="1"/>
          <p:nvPr/>
        </p:nvSpPr>
        <p:spPr>
          <a:xfrm>
            <a:off x="5318267" y="4400572"/>
            <a:ext cx="2255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ncropped blots for Figure 3D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42637330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C95B7B-9A34-9199-D32B-9B5291E37C99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</a:t>
            </a:r>
            <a:endParaRPr lang="en-DE" dirty="0"/>
          </a:p>
        </p:txBody>
      </p:sp>
      <p:sp>
        <p:nvSpPr>
          <p:cNvPr id="3" name="Rounded Rectangle 23">
            <a:extLst>
              <a:ext uri="{FF2B5EF4-FFF2-40B4-BE49-F238E27FC236}">
                <a16:creationId xmlns:a16="http://schemas.microsoft.com/office/drawing/2014/main" id="{6B1E1C3F-A015-283C-65BC-DE2A6E756657}"/>
              </a:ext>
            </a:extLst>
          </p:cNvPr>
          <p:cNvSpPr/>
          <p:nvPr/>
        </p:nvSpPr>
        <p:spPr>
          <a:xfrm>
            <a:off x="559558" y="496342"/>
            <a:ext cx="8633064" cy="362983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F225A6-953A-49EA-FA64-BE61E5F7FDC0}"/>
              </a:ext>
            </a:extLst>
          </p:cNvPr>
          <p:cNvSpPr txBox="1"/>
          <p:nvPr/>
        </p:nvSpPr>
        <p:spPr>
          <a:xfrm>
            <a:off x="713379" y="61222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63A11F-B31A-6B32-1CF2-637D102B2D68}"/>
              </a:ext>
            </a:extLst>
          </p:cNvPr>
          <p:cNvSpPr txBox="1"/>
          <p:nvPr/>
        </p:nvSpPr>
        <p:spPr>
          <a:xfrm>
            <a:off x="1669701" y="4246684"/>
            <a:ext cx="2806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8" name="Rounded Rectangle 30">
            <a:extLst>
              <a:ext uri="{FF2B5EF4-FFF2-40B4-BE49-F238E27FC236}">
                <a16:creationId xmlns:a16="http://schemas.microsoft.com/office/drawing/2014/main" id="{923B4201-FBEC-106F-954B-ED6F7E2AAA6F}"/>
              </a:ext>
            </a:extLst>
          </p:cNvPr>
          <p:cNvSpPr/>
          <p:nvPr/>
        </p:nvSpPr>
        <p:spPr>
          <a:xfrm>
            <a:off x="1577295" y="4253183"/>
            <a:ext cx="6977765" cy="248426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D797FCD7-D5B2-AB45-77C9-5B3BB461A1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t="-11769" r="-26424"/>
          <a:stretch/>
        </p:blipFill>
        <p:spPr>
          <a:xfrm>
            <a:off x="1772057" y="4098889"/>
            <a:ext cx="2379260" cy="2484261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7996114"/>
              </p:ext>
            </p:extLst>
          </p:nvPr>
        </p:nvGraphicFramePr>
        <p:xfrm>
          <a:off x="713379" y="496342"/>
          <a:ext cx="8529432" cy="3864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8028780" imgH="3637412" progId="Prism10.Document">
                  <p:embed/>
                </p:oleObj>
              </mc:Choice>
              <mc:Fallback>
                <p:oleObj name="Prism 10" r:id="rId3" imgW="8028780" imgH="3637412" progId="Prism10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3379" y="496342"/>
                        <a:ext cx="8529432" cy="38641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22784E3-AA58-A8C4-AE46-BEA5081CC55A}"/>
              </a:ext>
            </a:extLst>
          </p:cNvPr>
          <p:cNvSpPr txBox="1"/>
          <p:nvPr/>
        </p:nvSpPr>
        <p:spPr>
          <a:xfrm>
            <a:off x="4151317" y="6026350"/>
            <a:ext cx="1635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Anti- (Meta)vinc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CF5B59-B14A-FB9D-F9F7-9AB4BACE5BFD}"/>
              </a:ext>
            </a:extLst>
          </p:cNvPr>
          <p:cNvSpPr txBox="1"/>
          <p:nvPr/>
        </p:nvSpPr>
        <p:spPr>
          <a:xfrm>
            <a:off x="4431184" y="5408283"/>
            <a:ext cx="1076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Anti-Cyp11a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A4154C-9EEA-3FF9-5795-6CB9233D4EA8}"/>
              </a:ext>
            </a:extLst>
          </p:cNvPr>
          <p:cNvSpPr txBox="1"/>
          <p:nvPr/>
        </p:nvSpPr>
        <p:spPr>
          <a:xfrm>
            <a:off x="4598169" y="4807397"/>
            <a:ext cx="9128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Anti-</a:t>
            </a:r>
            <a:r>
              <a:rPr lang="en-US" sz="1000" u="sng" dirty="0" err="1"/>
              <a:t>StaR</a:t>
            </a:r>
            <a:endParaRPr lang="en-US" sz="1000" u="sng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B78F65D-7AF1-5BB9-00E5-DCF9260F24C9}"/>
              </a:ext>
            </a:extLst>
          </p:cNvPr>
          <p:cNvSpPr txBox="1"/>
          <p:nvPr/>
        </p:nvSpPr>
        <p:spPr>
          <a:xfrm>
            <a:off x="5318267" y="4400572"/>
            <a:ext cx="2255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ncropped blots for Figure 4D</a:t>
            </a:r>
            <a:endParaRPr lang="en-DE" sz="1200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AD3F83D-1E60-E51C-7952-EBB049C768A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077" t="50710" r="9816" b="31055"/>
          <a:stretch/>
        </p:blipFill>
        <p:spPr>
          <a:xfrm>
            <a:off x="5355306" y="5295533"/>
            <a:ext cx="1995763" cy="53974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A1C96A5-8A9F-7110-3969-843E9E75EAA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619" t="37032" r="10787" b="42325"/>
          <a:stretch/>
        </p:blipFill>
        <p:spPr>
          <a:xfrm>
            <a:off x="5355309" y="4717666"/>
            <a:ext cx="1995761" cy="49427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7C0EEC7-20D6-1022-93D7-BECC7EDCA3C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12" t="44462" r="13207" b="31660"/>
          <a:stretch/>
        </p:blipFill>
        <p:spPr>
          <a:xfrm>
            <a:off x="5355308" y="5908632"/>
            <a:ext cx="1995761" cy="590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6237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2" Type="http://schemas.microsoft.com/office/2011/relationships/webextension" Target="webextension2.xml"/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1">
    <wetp:webextensionref xmlns:r="http://schemas.openxmlformats.org/officeDocument/2006/relationships" r:id="rId1"/>
  </wetp:taskpane>
  <wetp:taskpane dockstate="right" visibility="0" width="350" row="0">
    <wetp:webextensionref xmlns:r="http://schemas.openxmlformats.org/officeDocument/2006/relationships" r:id="rId2"/>
  </wetp:taskpane>
</wetp:taskpanes>
</file>

<file path=ppt/webextensions/webextension1.xml><?xml version="1.0" encoding="utf-8"?>
<we:webextension xmlns:we="http://schemas.microsoft.com/office/webextensions/webextension/2010/11" id="{7E9A8902-EB1F-4AE8-BB77-0C320978DF14}">
  <we:reference id="wa200006038" version="1.0.0.3" store="en-US" storeType="OMEX"/>
  <we:alternateReferences>
    <we:reference id="wa200006038" version="1.0.0.3" store="" storeType="OMEX"/>
  </we:alternateReferences>
  <we:properties>
    <we:property name="660568e8c28129074205aeab_1712172558308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66.29117599212623,&quot;y&quot;:17.088778983441955},&quot;rotate&quot;:0,&quot;skewX&quot;:0,&quot;scale&quot;:{&quot;x&quot;:1,&quot;y&quot;:1}},&quot;path&quot;:{&quot;type&quot;:&quot;RECT&quot;,&quot;size&quot;:{&quot;x&quot;:1263.7844000901623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535.7149671949715,&quot;y&quot;:96.03279202263849},&quot;rotate&quot;:0,&quot;skewX&quot;:0,&quot;scale&quot;:{&quot;x&quot;:1,&quot;y&quot;:1}},&quot;text&quot;:{&quot;textData&quot;:{&quot;lineSpacing&quot;:&quot;normal&quot;,&quot;alignment&quot;:&quot;center&quot;,&quot;lines&quot;:[{&quot;runs&quot;:[{&quot;style&quot;:{&quot;fontWeight&quot;:&quot;bold&quot;,&quot;fontStyle&quot;:&quot;normal&quot;,&quot;fontSize&quot;:18.666666666666664,&quot;fontFamily&quot;:&quot;Roboto&quot;,&quot;color&quot;:&quot;black&quot;,&quot;decoration&quot;:&quot;none&quot;},&quot;range&quot;:[0,16]}],&quot;text&quot;:&quot;Mouse Ad. Glands &quot;},{&quot;runs&quot;:[{&quot;style&quot;:{&quot;fontWeight&quot;:&quot;bold&quot;,&quot;fontStyle&quot;:&quot;italic&quot;,&quot;fontSize&quot;:18.666666666666664,&quot;fontFamily&quot;:&quot;Roboto&quot;,&quot;color&quot;:&quot;black&quot;,&quot;decoration&quot;:&quot;none&quot;},&quot;range&quot;:[0,6]}],&quot;text&quot;:&quot;ex vivo&quot;,&quot;baseStyle&quot;:{&quot;fontFamily&quot;:&quot;Roboto&quot;,&quot;fontSize&quot;:18.666666666666664,&quot;color&quot;:&quot;black&quot;,&quot;fontWeight&quot;:&quot;bold&quot;,&quot;fontStyle&quot;:&quot;italic&quot;,&quot;decoration&quot;:&quot;none&quot;,&quot;script&quot;:&quot;none&quot;}}],&quot;verticalAlign&quot;:&quot;TOP&quot;,&quot;_lastCaretLocation&quot;:{&quot;lineIndex&quot;:1,&quot;runIndex&quot;:0,&quot;charIndex&quot;:0}},&quot;format&quot;:&quot;BETTER_TEXT&quot;,&quot;size&quot;:{&quot;x&quot;:458.10963204412633,&quot;y&quot;:43.093333333333334},&quot;targetSize&quot;:{&quot;x&quot;:458.10963204412633,&quot;y&quot;:40.45495813527425},&quot;verticalAlign&quot;:&quot;TOP&quot;},&quot;parent&quot;:{&quot;type&quot;:&quot;CHILD&quot;,&quot;parentId&quot;:&quot;8563537e-9ecc-4632-9afc-00afd7e3699c&quot;,&quot;order&quot;:&quot;9999999999998&quot;}},&quot;e41eec1d-3196-45a6-82cf-753d1e42e3fa&quot;:{&quot;type&quot;:&quot;FIGURE_OBJECT&quot;,&quot;id&quot;:&quot;e41eec1d-3196-45a6-82cf-753d1e42e3fa&quot;,&quot;relativeTransform&quot;:{&quot;translate&quot;:{&quot;x&quot;:-340.9557589709548,&quot;y&quot;:-10.46770226935675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8&quot;}},&quot;8c1f0d3b-62cb-45cf-903b-2957e7ae9337&quot;:{&quot;id&quot;:&quot;8c1f0d3b-62cb-45cf-903b-2957e7ae9337&quot;,&quot;type&quot;:&quot;FIGURE_OBJECT&quot;,&quot;relativeTransform&quot;:{&quot;translate&quot;:{&quot;x&quot;:-353.3938578673129,&quot;y&quot;:2.092206499155836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5% O2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7]}],&quot;text&quot;:&quot;Analysis&quot;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4,&quot;runIndex&quot;:-1,&quot;charIndex&quot;:-1,&quot;endOfLine&quot;:true}},&quot;format&quot;:&quot;BETTER_TEXT&quot;,&quot;size&quot;:{&quot;x&quot;:107.4680801421614,&quot;y&quot;:127.46666666666665},&quot;targetSize&quot;:{&quot;x&quot;:107.4680801421614,&quot;y&quot;:91.32}},&quot;parent&quot;:{&quot;type&quot;:&quot;CHILD&quot;,&quot;parentId&quot;:&quot;8563537e-9ecc-4632-9afc-00afd7e3699c&quot;,&quot;order&quot;:&quot;99999999999999975&quot;}},&quot;c969259a-799b-4d6a-ad6e-4d8c96378898&quot;:{&quot;type&quot;:&quot;FIGURE_OBJECT&quot;,&quot;id&quot;:&quot;c969259a-799b-4d6a-ad6e-4d8c96378898&quot;,&quot;parent&quot;:{&quot;type&quot;:&quot;CHILD&quot;,&quot;parentId&quot;:&quot;8563537e-9ecc-4632-9afc-00afd7e3699c&quot;,&quot;order&quot;:&quot;99999999999999999999999999999999997&quot;},&quot;relativeTransform&quot;:{&quot;translate&quot;:{&quot;x&quot;:-622.4590000000001,&quot;y&quot;:92.387},&quot;rotate&quot;:0,&quot;skewX&quot;:0,&quot;scale&quot;:{&quot;x&quot;:1,&quot;y&quot;:1}}},&quot;01a26c66-2ae1-4962-90bf-91461eb2ca01&quot;:{&quot;id&quot;:&quot;01a26c66-2ae1-4962-90bf-91461eb2ca01&quot;,&quot;name&quot;:&quot;Petri dish 2&quot;,&quot;displayName&quot;:&quot;Petri dish&quot;,&quot;type&quot;:&quot;FIGURE_OBJECT&quot;,&quot;relativeTransform&quot;:{&quot;translate&quot;:{&quot;x&quot;:486.7079052810173,&quot;y&quot;:-99.19074854064138},&quot;rotate&quot;:0,&quot;skewX&quot;:0,&quot;scale&quot;:{&quot;x&quot;:2.188081819218629,&quot;y&quot;:2.188081819218629}},&quot;image&quot;:{&quot;url&quot;:&quot;https://icons.biorender.com/biorender/5ee0f3bac4e9c30027d95cee/20220929172958/image/petri-dish-2.png&quot;,&quot;fallbackUrl&quot;:&quot;https://res.cloudinary.com/dlcjuc3ej/image/upload/v1664472598/vupt6ioewxdstmrts8mx.svg#/keystone/api/icons/5ee0f3bac4e9c30027d95cee/20220929172958/image/petri-dish-2.svg&quot;,&quot;isPremium&quot;:false,&quot;size&quot;:{&quot;x&quot;:100,&quot;y&quot;:74.76923076923077}},&quot;source&quot;:{&quot;id&quot;:&quot;5ee0f3bac4e9c30027d95cee&quot;,&quot;type&quot;:&quot;ASSETS&quot;},&quot;isPremium&quot;:false,&quot;parent&quot;:{&quot;type&quot;:&quot;CHILD&quot;,&quot;parentId&quot;:&quot;c969259a-799b-4d6a-ad6e-4d8c96378898&quot;,&quot;order&quot;:&quot;2&quot;},&quot;styles&quot;:{&quot;petri_dish&quot;:[{&quot;styleName&quot;:&quot;MONOCHROME_COLOR&quot;,&quot;index&quot;:0,&quot;color&quot;:&quot;#FF0D00&quot;}],&quot;liquid&quot;:[{&quot;styleName&quot;:&quot;MONOCHROME_COLOR&quot;,&quot;index&quot;:0,&quot;color&quot;:&quot;#FF0D00&quot;}]},&quot;opacity&quot;:0.96},&quot;2604914f-a174-4b15-ae47-03a7f94c46a9&quot;:{&quot;type&quot;:&quot;FIGURE_OBJECT&quot;,&quot;id&quot;:&quot;2604914f-a174-4b15-ae47-03a7f94c46a9&quot;,&quot;name&quot;:&quot;Adrenal gland (left)&quot;,&quot;relativeTransform&quot;:{&quot;translate&quot;:{&quot;x&quot;:495.8606423434204,&quot;y&quot;:-107.42718587062562},&quot;rotate&quot;:-2.116303241129531e-15,&quot;skewX&quot;:-2.037921639606213e-15,&quot;scale&quot;:{&quot;x&quot;:0.5768171747645309,&quot;y&quot;:0.6140908121435612}},&quot;opacity&quot;:1,&quot;image&quot;:{&quot;url&quot;:&quot;https://icons.biorender.com/biorender/5c9546e5c2753f33003dad3d/adrenal-gland-left.png&quot;,&quot;fallbackUrl&quot;:&quot;https://res.cloudinary.com/dlcjuc3ej/image/upload/v1553286881/z6jc1hdzosv7xhvk6vc1.svg#/keystone/api/icons/5c9546e5c2753f33003dad3d/adrenal-gland-left.svg#/keystone/api/icons/5c9546e5c2753f33003dad3d/adrenal-gland-left.svg&quot;,&quot;size&quot;:{&quot;x&quot;:239,&quot;y&quot;:185},&quot;isPremium&quot;:false},&quot;source&quot;:{&quot;id&quot;:&quot;5c9545ecc2753f33003dad37&quot;,&quot;type&quot;:&quot;ASSETS&quot;},&quot;pathStyles&quot;:[{&quot;type&quot;:&quot;FILL&quot;,&quot;fillStyle&quot;:&quot;rgb(0,0,0)&quot;}],&quot;isLocked&quot;:false,&quot;parent&quot;:{&quot;type&quot;:&quot;CHILD&quot;,&quot;parentId&quot;:&quot;c969259a-799b-4d6a-ad6e-4d8c96378898&quot;,&quot;order&quot;:&quot;6&quot;}},&quot;ad43b8e3-fa7a-4ab1-bafc-0011d666f137&quot;:{&quot;type&quot;:&quot;FIGURE_OBJECT&quot;,&quot;id&quot;:&quot;ad43b8e3-fa7a-4ab1-bafc-0011d666f137&quot;,&quot;parent&quot;:{&quot;type&quot;:&quot;CHILD&quot;,&quot;parentId&quot;:&quot;8563537e-9ecc-4632-9afc-00afd7e3699c&quot;,&quot;order&quot;:&quot;99999999999999999999999999999999998&quot;},&quot;relativeTransform&quot;:{&quot;translate&quot;:{&quot;x&quot;:-1032.868,&quot;y&quot;:92.387},&quot;rotate&quot;:0,&quot;skewX&quot;:0,&quot;scale&quot;:{&quot;x&quot;:1,&quot;y&quot;:1}},&quot;opacity&quot;:1},&quot;de845eee-07f6-48f8-b953-ce1177fe458d&quot;:{&quot;id&quot;:&quot;de845eee-07f6-48f8-b953-ce1177fe458d&quot;,&quot;name&quot;:&quot;Petri dish 2&quot;,&quot;displayName&quot;:&quot;Petri dish&quot;,&quot;type&quot;:&quot;FIGURE_OBJECT&quot;,&quot;relativeTransform&quot;:{&quot;translate&quot;:{&quot;x&quot;:486.7079052810173,&quot;y&quot;:-99.19074854064138},&quot;rotate&quot;:0,&quot;skewX&quot;:0,&quot;scale&quot;:{&quot;x&quot;:2.188081819218629,&quot;y&quot;:2.188081819218629}},&quot;image&quot;:{&quot;url&quot;:&quot;https://icons.biorender.com/biorender/6335d62d63513800215a19cb/petri-dish-2.png&quot;,&quot;fallbackUrl&quot;:&quot;https://res.cloudinary.com/dlcjuc3ej/image/upload/v1664472598/urwjagbvgsjonp7i0mt3.svg#/keystone/api/icons/6335d62d63513800215a19cb/petri-dish-2.svg#/keystone/api/icons/6335d62d63513800215a19cb/petri-dish-2.svg#/keystone/api/icons/6335d62d63513800215a19cb/petri-dish-2.svg&quot;,&quot;isPremium&quot;:false,&quot;size&quot;:{&quot;x&quot;:100,&quot;y&quot;:74.76923076923077}},&quot;source&quot;:{&quot;id&quot;:&quot;5ee0f3bac4e9c30027d95cee&quot;,&quot;type&quot;:&quot;ASSETS&quot;},&quot;isPremium&quot;:false,&quot;parent&quot;:{&quot;type&quot;:&quot;CHILD&quot;,&quot;parentId&quot;:&quot;ad43b8e3-fa7a-4ab1-bafc-0011d666f137&quot;,&quot;order&quot;:&quot;2&quot;},&quot;opacity&quot;:0.96},&quot;01a7cdb8-b0cb-4de5-977a-9c8eaae458c0&quot;:{&quot;type&quot;:&quot;FIGURE_OBJECT&quot;,&quot;id&quot;:&quot;01a7cdb8-b0cb-4de5-977a-9c8eaae458c0&quot;,&quot;name&quot;:&quot;Adrenal gland (left)&quot;,&quot;relativeTransform&quot;:{&quot;translate&quot;:{&quot;x&quot;:495.8606423434204,&quot;y&quot;:-107.42718587062562},&quot;rotate&quot;:-2.116303241129531e-15,&quot;skewX&quot;:-2.037921639606213e-15,&quot;scale&quot;:{&quot;x&quot;:0.5768171747645309,&quot;y&quot;:0.6140908121435612}},&quot;opacity&quot;:1,&quot;image&quot;:{&quot;url&quot;:&quot;https://icons.biorender.com/biorender/5c9545ecc2753f33003dad37/20190322203441/image/adrenal-gland-left.png&quot;,&quot;fallbackUrl&quot;:&quot;https://res.cloudinary.com/dlcjuc3ej/image/upload/v1553286881/ysfqc8ja9vitlx8vkxjx.svg#/keystone/api/icons/5c9545ecc2753f33003dad37/20190322203441/image/adrenal-gland-left.svg#/keystone/api/icons/5c9545ecc2753f33003dad37/20190322203441/image/adrenal-gland-left.svg&quot;,&quot;size&quot;:{&quot;x&quot;:239,&quot;y&quot;:185},&quot;isPremium&quot;:false},&quot;source&quot;:{&quot;id&quot;:&quot;5c9545ecc2753f33003dad37&quot;,&quot;type&quot;:&quot;ASSETS&quot;},&quot;pathStyles&quot;:[{&quot;type&quot;:&quot;FILL&quot;,&quot;fillStyle&quot;:&quot;rgb(0,0,0)&quot;}],&quot;isLocked&quot;:false,&quot;parent&quot;:{&quot;type&quot;:&quot;CHILD&quot;,&quot;parentId&quot;:&quot;ad43b8e3-fa7a-4ab1-bafc-0011d666f137&quot;,&quot;order&quot;:&quot;6&quot;}},&quot;0c77e11d-1c33-4c90-9a3c-337d161f694b&quot;:{&quot;id&quot;:&quot;0c77e11d-1c33-4c90-9a3c-337d161f694b&quot;,&quot;type&quot;:&quot;FIGURE_OBJECT&quot;,&quot;relativeTransform&quot;:{&quot;translate&quot;:{&quot;x&quot;:173.67546179576016,&quot;y&quot;:61.35173298277435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7]}],&quot;text&quot;:&quot;Steroids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82&quot;}},&quot;d0b2c11e-962b-4e9c-a53e-618d914a009c&quot;:{&quot;id&quot;:&quot;d0b2c11e-962b-4e9c-a53e-618d914a009c&quot;,&quot;type&quot;:&quot;FIGURE_OBJECT&quot;,&quot;relativeTransform&quot;:{&quot;translate&quot;:{&quot;x&quot;:182.18922479724978,&quot;y&quot;:2.5464194507258764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3}},&quot;format&quot;:&quot;BETTER_TEXT&quot;,&quot;size&quot;:{&quot;x&quot;:186.37227288355874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9999999999999985&quot;}},&quot;1632a7e9-f2c6-46be-ade5-c8fa087bcadd&quot;:{&quot;type&quot;:&quot;FIGURE_OBJECT&quot;,&quot;id&quot;:&quot;1632a7e9-f2c6-46be-ade5-c8fa087bcadd&quot;,&quot;parent&quot;:{&quot;type&quot;:&quot;CHILD&quot;,&quot;parentId&quot;:&quot;8563537e-9ecc-4632-9afc-00afd7e3699c&quot;,&quot;order&quot;:&quot;99999999999999999999999999999999999&quot;},&quot;relativeTransform&quot;:{&quot;translate&quot;:{&quot;x&quot;:-253.4160277239672,&quot;y&quot;:-16.615289381498286},&quot;rotate&quot;:-1.5707963267948966,&quot;skewX&quot;:0,&quot;scale&quot;:{&quot;x&quot;:1,&quot;y&quot;:1}}},&quot;0a597ccf-3eef-4ea1-968c-3c64ef27f011&quot;:{&quot;type&quot;:&quot;FIGURE_OBJECT&quot;,&quot;id&quot;:&quot;0a597ccf-3eef-4ea1-968c-3c64ef27f011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632a7e9-f2c6-46be-ade5-c8fa087bcadd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79d64b1e-ed4e-4dc4-831e-6032b09c248f&quot;:{&quot;type&quot;:&quot;FIGURE_OBJECT&quot;,&quot;id&quot;:&quot;79d64b1e-ed4e-4dc4-831e-6032b09c248f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632a7e9-f2c6-46be-ade5-c8fa087bcadd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d813df69-ca6d-4771-bf38-e5296608c734&quot;:{&quot;type&quot;:&quot;FIGURE_OBJECT&quot;,&quot;id&quot;:&quot;d813df69-ca6d-4771-bf38-e5296608c734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1632a7e9-f2c6-46be-ade5-c8fa087bcadd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ffbc4b5e-1c66-45a5-b63d-96aee1b117c4&quot;:{&quot;type&quot;:&quot;FIGURE_OBJECT&quot;,&quot;id&quot;:&quot;ffbc4b5e-1c66-45a5-b63d-96aee1b117c4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632a7e9-f2c6-46be-ade5-c8fa087bcadd&quot;,&quot;order&quot;:&quot;8&quot;},&quot;connectorInfo&quot;:{&quot;connectedObjects&quot;:[],&quot;type&quot;:&quot;ELBOW&quot;,&quot;offset&quot;:{&quot;x&quot;:0,&quot;y&quot;:0},&quot;bending&quot;:-0.1,&quot;firstElementIsHead&quot;:true,&quot;customized&quot;:false}},&quot;4e82be8c-e70c-4d41-970d-93c1c29a4601&quot;:{&quot;id&quot;:&quot;4e82be8c-e70c-4d41-970d-93c1c29a4601&quot;,&quot;type&quot;:&quot;FIGURE_OBJECT&quot;,&quot;relativeTransform&quot;:{&quot;translate&quot;:{&quot;x&quot;:173.6763409296052,&quot;y&quot;:-77.782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1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5&quot;}}}}"/>
    <we:property name="660568e8c28129074205aeab_1712174634116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66.29117599212623,&quot;y&quot;:17.088778983441955},&quot;rotate&quot;:0,&quot;skewX&quot;:0,&quot;scale&quot;:{&quot;x&quot;:1,&quot;y&quot;:1}},&quot;path&quot;:{&quot;type&quot;:&quot;RECT&quot;,&quot;size&quot;:{&quot;x&quot;:1263.7844000901623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535.7149671949715,&quot;y&quot;:96.03279202263849},&quot;rotate&quot;:0,&quot;skewX&quot;:0,&quot;scale&quot;:{&quot;x&quot;:1,&quot;y&quot;:1}},&quot;text&quot;:{&quot;textData&quot;:{&quot;lineSpacing&quot;:&quot;normal&quot;,&quot;alignment&quot;:&quot;center&quot;,&quot;lines&quot;:[{&quot;runs&quot;:[{&quot;style&quot;:{&quot;fontWeight&quot;:&quot;bold&quot;,&quot;fontStyle&quot;:&quot;normal&quot;,&quot;fontSize&quot;:18.666666666666664,&quot;fontFamily&quot;:&quot;Roboto&quot;,&quot;color&quot;:&quot;black&quot;,&quot;decoration&quot;:&quot;none&quot;},&quot;range&quot;:[0,16]}],&quot;text&quot;:&quot;Mouse Ad. Glands &quot;},{&quot;runs&quot;:[{&quot;style&quot;:{&quot;fontWeight&quot;:&quot;bold&quot;,&quot;fontStyle&quot;:&quot;italic&quot;,&quot;fontSize&quot;:18.666666666666664,&quot;fontFamily&quot;:&quot;Roboto&quot;,&quot;color&quot;:&quot;black&quot;,&quot;decoration&quot;:&quot;none&quot;},&quot;range&quot;:[0,6]}],&quot;text&quot;:&quot;ex vivo&quot;,&quot;baseStyle&quot;:{&quot;fontFamily&quot;:&quot;Roboto&quot;,&quot;fontSize&quot;:18.666666666666664,&quot;color&quot;:&quot;black&quot;,&quot;fontWeight&quot;:&quot;bold&quot;,&quot;fontStyle&quot;:&quot;italic&quot;,&quot;decoration&quot;:&quot;none&quot;,&quot;script&quot;:&quot;none&quot;}}],&quot;verticalAlign&quot;:&quot;TOP&quot;,&quot;_lastCaretLocation&quot;:{&quot;lineIndex&quot;:1,&quot;runIndex&quot;:0,&quot;charIndex&quot;:0}},&quot;format&quot;:&quot;BETTER_TEXT&quot;,&quot;size&quot;:{&quot;x&quot;:458.10963204412633,&quot;y&quot;:43.093333333333334},&quot;targetSize&quot;:{&quot;x&quot;:458.10963204412633,&quot;y&quot;:40.45495813527425},&quot;verticalAlign&quot;:&quot;TOP&quot;},&quot;parent&quot;:{&quot;type&quot;:&quot;CHILD&quot;,&quot;parentId&quot;:&quot;8563537e-9ecc-4632-9afc-00afd7e3699c&quot;,&quot;order&quot;:&quot;9999999999998&quot;}},&quot;e41eec1d-3196-45a6-82cf-753d1e42e3fa&quot;:{&quot;type&quot;:&quot;FIGURE_OBJECT&quot;,&quot;id&quot;:&quot;e41eec1d-3196-45a6-82cf-753d1e42e3fa&quot;,&quot;relativeTransform&quot;:{&quot;translate&quot;:{&quot;x&quot;:-340.9557589709548,&quot;y&quot;:-10.46770226935675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8&quot;}},&quot;8c1f0d3b-62cb-45cf-903b-2957e7ae9337&quot;:{&quot;id&quot;:&quot;8c1f0d3b-62cb-45cf-903b-2957e7ae9337&quot;,&quot;type&quot;:&quot;FIGURE_OBJECT&quot;,&quot;relativeTransform&quot;:{&quot;translate&quot;:{&quot;x&quot;:-353.3938578673129,&quot;y&quot;:-5.454460167510831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5% O2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3,&quot;runIndex&quot;:0,&quot;charIndex&quot;:0,&quot;endOfLine&quot;:true}},&quot;format&quot;:&quot;BETTER_TEXT&quot;,&quot;size&quot;:{&quot;x&quot;:107.4680801421614,&quot;y&quot;:106.37333333333332},&quot;targetSize&quot;:{&quot;x&quot;:107.4680801421614,&quot;y&quot;:91.32}},&quot;parent&quot;:{&quot;type&quot;:&quot;CHILD&quot;,&quot;parentId&quot;:&quot;8563537e-9ecc-4632-9afc-00afd7e3699c&quot;,&quot;order&quot;:&quot;99999999999999975&quot;}},&quot;c969259a-799b-4d6a-ad6e-4d8c96378898&quot;:{&quot;type&quot;:&quot;FIGURE_OBJECT&quot;,&quot;id&quot;:&quot;c969259a-799b-4d6a-ad6e-4d8c96378898&quot;,&quot;parent&quot;:{&quot;type&quot;:&quot;CHILD&quot;,&quot;parentId&quot;:&quot;8563537e-9ecc-4632-9afc-00afd7e3699c&quot;,&quot;order&quot;:&quot;99999999999999999999999999999999997&quot;},&quot;relativeTransform&quot;:{&quot;translate&quot;:{&quot;x&quot;:-622.4590000000001,&quot;y&quot;:92.387},&quot;rotate&quot;:0,&quot;skewX&quot;:0,&quot;scale&quot;:{&quot;x&quot;:1,&quot;y&quot;:1}}},&quot;01a26c66-2ae1-4962-90bf-91461eb2ca01&quot;:{&quot;id&quot;:&quot;01a26c66-2ae1-4962-90bf-91461eb2ca01&quot;,&quot;name&quot;:&quot;Petri dish 2&quot;,&quot;displayName&quot;:&quot;Petri dish&quot;,&quot;type&quot;:&quot;FIGURE_OBJECT&quot;,&quot;relativeTransform&quot;:{&quot;translate&quot;:{&quot;x&quot;:486.7079052810173,&quot;y&quot;:-99.19074854064138},&quot;rotate&quot;:0,&quot;skewX&quot;:0,&quot;scale&quot;:{&quot;x&quot;:2.188081819218629,&quot;y&quot;:2.188081819218629}},&quot;image&quot;:{&quot;url&quot;:&quot;https://icons.biorender.com/biorender/5ee0f3bac4e9c30027d95cee/20220929172958/image/petri-dish-2.png&quot;,&quot;fallbackUrl&quot;:&quot;https://res.cloudinary.com/dlcjuc3ej/image/upload/v1664472598/vupt6ioewxdstmrts8mx.svg#/keystone/api/icons/5ee0f3bac4e9c30027d95cee/20220929172958/image/petri-dish-2.svg&quot;,&quot;isPremium&quot;:false,&quot;size&quot;:{&quot;x&quot;:100,&quot;y&quot;:74.76923076923077}},&quot;source&quot;:{&quot;id&quot;:&quot;5ee0f3bac4e9c30027d95cee&quot;,&quot;type&quot;:&quot;ASSETS&quot;},&quot;isPremium&quot;:false,&quot;parent&quot;:{&quot;type&quot;:&quot;CHILD&quot;,&quot;parentId&quot;:&quot;c969259a-799b-4d6a-ad6e-4d8c96378898&quot;,&quot;order&quot;:&quot;2&quot;},&quot;styles&quot;:{&quot;petri_dish&quot;:[{&quot;styleName&quot;:&quot;MONOCHROME_COLOR&quot;,&quot;index&quot;:0,&quot;color&quot;:&quot;#FF0D00&quot;}],&quot;liquid&quot;:[{&quot;styleName&quot;:&quot;MONOCHROME_COLOR&quot;,&quot;index&quot;:0,&quot;color&quot;:&quot;#FF0D00&quot;}]},&quot;opacity&quot;:0.96},&quot;2604914f-a174-4b15-ae47-03a7f94c46a9&quot;:{&quot;type&quot;:&quot;FIGURE_OBJECT&quot;,&quot;id&quot;:&quot;2604914f-a174-4b15-ae47-03a7f94c46a9&quot;,&quot;name&quot;:&quot;Adrenal gland (left)&quot;,&quot;relativeTransform&quot;:{&quot;translate&quot;:{&quot;x&quot;:495.8606423434204,&quot;y&quot;:-107.42718587062562},&quot;rotate&quot;:-2.116303241129531e-15,&quot;skewX&quot;:-2.037921639606213e-15,&quot;scale&quot;:{&quot;x&quot;:0.5768171747645309,&quot;y&quot;:0.6140908121435612}},&quot;opacity&quot;:1,&quot;image&quot;:{&quot;url&quot;:&quot;https://icons.biorender.com/biorender/5c9546e5c2753f33003dad3d/adrenal-gland-left.png&quot;,&quot;fallbackUrl&quot;:&quot;https://res.cloudinary.com/dlcjuc3ej/image/upload/v1553286881/z6jc1hdzosv7xhvk6vc1.svg#/keystone/api/icons/5c9546e5c2753f33003dad3d/adrenal-gland-left.svg#/keystone/api/icons/5c9546e5c2753f33003dad3d/adrenal-gland-left.svg&quot;,&quot;size&quot;:{&quot;x&quot;:239,&quot;y&quot;:185},&quot;isPremium&quot;:false},&quot;source&quot;:{&quot;id&quot;:&quot;5c9545ecc2753f33003dad37&quot;,&quot;type&quot;:&quot;ASSETS&quot;},&quot;pathStyles&quot;:[{&quot;type&quot;:&quot;FILL&quot;,&quot;fillStyle&quot;:&quot;rgb(0,0,0)&quot;}],&quot;isLocked&quot;:false,&quot;parent&quot;:{&quot;type&quot;:&quot;CHILD&quot;,&quot;parentId&quot;:&quot;c969259a-799b-4d6a-ad6e-4d8c96378898&quot;,&quot;order&quot;:&quot;6&quot;}},&quot;ad43b8e3-fa7a-4ab1-bafc-0011d666f137&quot;:{&quot;type&quot;:&quot;FIGURE_OBJECT&quot;,&quot;id&quot;:&quot;ad43b8e3-fa7a-4ab1-bafc-0011d666f137&quot;,&quot;parent&quot;:{&quot;type&quot;:&quot;CHILD&quot;,&quot;parentId&quot;:&quot;8563537e-9ecc-4632-9afc-00afd7e3699c&quot;,&quot;order&quot;:&quot;99999999999999999999999999999999998&quot;},&quot;relativeTransform&quot;:{&quot;translate&quot;:{&quot;x&quot;:-1032.868,&quot;y&quot;:92.387},&quot;rotate&quot;:0,&quot;skewX&quot;:0,&quot;scale&quot;:{&quot;x&quot;:1,&quot;y&quot;:1}},&quot;opacity&quot;:1},&quot;de845eee-07f6-48f8-b953-ce1177fe458d&quot;:{&quot;id&quot;:&quot;de845eee-07f6-48f8-b953-ce1177fe458d&quot;,&quot;name&quot;:&quot;Petri dish 2&quot;,&quot;displayName&quot;:&quot;Petri dish&quot;,&quot;type&quot;:&quot;FIGURE_OBJECT&quot;,&quot;relativeTransform&quot;:{&quot;translate&quot;:{&quot;x&quot;:486.7079052810173,&quot;y&quot;:-99.19074854064138},&quot;rotate&quot;:0,&quot;skewX&quot;:0,&quot;scale&quot;:{&quot;x&quot;:2.188081819218629,&quot;y&quot;:2.188081819218629}},&quot;image&quot;:{&quot;url&quot;:&quot;https://icons.biorender.com/biorender/6335d62d63513800215a19cb/petri-dish-2.png&quot;,&quot;fallbackUrl&quot;:&quot;https://res.cloudinary.com/dlcjuc3ej/image/upload/v1664472598/urwjagbvgsjonp7i0mt3.svg#/keystone/api/icons/6335d62d63513800215a19cb/petri-dish-2.svg#/keystone/api/icons/6335d62d63513800215a19cb/petri-dish-2.svg#/keystone/api/icons/6335d62d63513800215a19cb/petri-dish-2.svg&quot;,&quot;isPremium&quot;:false,&quot;size&quot;:{&quot;x&quot;:100,&quot;y&quot;:74.76923076923077}},&quot;source&quot;:{&quot;id&quot;:&quot;5ee0f3bac4e9c30027d95cee&quot;,&quot;type&quot;:&quot;ASSETS&quot;},&quot;isPremium&quot;:false,&quot;parent&quot;:{&quot;type&quot;:&quot;CHILD&quot;,&quot;parentId&quot;:&quot;ad43b8e3-fa7a-4ab1-bafc-0011d666f137&quot;,&quot;order&quot;:&quot;2&quot;},&quot;opacity&quot;:0.96},&quot;01a7cdb8-b0cb-4de5-977a-9c8eaae458c0&quot;:{&quot;type&quot;:&quot;FIGURE_OBJECT&quot;,&quot;id&quot;:&quot;01a7cdb8-b0cb-4de5-977a-9c8eaae458c0&quot;,&quot;name&quot;:&quot;Adrenal gland (left)&quot;,&quot;relativeTransform&quot;:{&quot;translate&quot;:{&quot;x&quot;:495.8606423434204,&quot;y&quot;:-107.42718587062562},&quot;rotate&quot;:-2.116303241129531e-15,&quot;skewX&quot;:-2.037921639606213e-15,&quot;scale&quot;:{&quot;x&quot;:0.5768171747645309,&quot;y&quot;:0.6140908121435612}},&quot;opacity&quot;:1,&quot;image&quot;:{&quot;url&quot;:&quot;https://icons.biorender.com/biorender/5c9545ecc2753f33003dad37/20190322203441/image/adrenal-gland-left.png&quot;,&quot;fallbackUrl&quot;:&quot;https://res.cloudinary.com/dlcjuc3ej/image/upload/v1553286881/ysfqc8ja9vitlx8vkxjx.svg#/keystone/api/icons/5c9545ecc2753f33003dad37/20190322203441/image/adrenal-gland-left.svg#/keystone/api/icons/5c9545ecc2753f33003dad37/20190322203441/image/adrenal-gland-left.svg&quot;,&quot;size&quot;:{&quot;x&quot;:239,&quot;y&quot;:185},&quot;isPremium&quot;:false},&quot;source&quot;:{&quot;id&quot;:&quot;5c9545ecc2753f33003dad37&quot;,&quot;type&quot;:&quot;ASSETS&quot;},&quot;pathStyles&quot;:[{&quot;type&quot;:&quot;FILL&quot;,&quot;fillStyle&quot;:&quot;rgb(0,0,0)&quot;}],&quot;isLocked&quot;:false,&quot;parent&quot;:{&quot;type&quot;:&quot;CHILD&quot;,&quot;parentId&quot;:&quot;ad43b8e3-fa7a-4ab1-bafc-0011d666f137&quot;,&quot;order&quot;:&quot;6&quot;}},&quot;0c77e11d-1c33-4c90-9a3c-337d161f694b&quot;:{&quot;id&quot;:&quot;0c77e11d-1c33-4c90-9a3c-337d161f694b&quot;,&quot;type&quot;:&quot;FIGURE_OBJECT&quot;,&quot;relativeTransform&quot;:{&quot;translate&quot;:{&quot;x&quot;:173.67546179576016,&quot;y&quot;:61.35173298277435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7]}],&quot;text&quot;:&quot;Steroids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82&quot;}},&quot;d0b2c11e-962b-4e9c-a53e-618d914a009c&quot;:{&quot;id&quot;:&quot;d0b2c11e-962b-4e9c-a53e-618d914a009c&quot;,&quot;type&quot;:&quot;FIGURE_OBJECT&quot;,&quot;relativeTransform&quot;:{&quot;translate&quot;:{&quot;x&quot;:182.18922479724978,&quot;y&quot;:2.5464194507258764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3}},&quot;format&quot;:&quot;BETTER_TEXT&quot;,&quot;size&quot;:{&quot;x&quot;:186.37227288355874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9999999999999985&quot;}},&quot;1632a7e9-f2c6-46be-ade5-c8fa087bcadd&quot;:{&quot;type&quot;:&quot;FIGURE_OBJECT&quot;,&quot;id&quot;:&quot;1632a7e9-f2c6-46be-ade5-c8fa087bcadd&quot;,&quot;parent&quot;:{&quot;type&quot;:&quot;CHILD&quot;,&quot;parentId&quot;:&quot;8563537e-9ecc-4632-9afc-00afd7e3699c&quot;,&quot;order&quot;:&quot;99999999999999999999999999999999999&quot;},&quot;relativeTransform&quot;:{&quot;translate&quot;:{&quot;x&quot;:-253.4160277239672,&quot;y&quot;:-16.615289381498286},&quot;rotate&quot;:-1.5707963267948966,&quot;skewX&quot;:0,&quot;scale&quot;:{&quot;x&quot;:1,&quot;y&quot;:1}}},&quot;0a597ccf-3eef-4ea1-968c-3c64ef27f011&quot;:{&quot;type&quot;:&quot;FIGURE_OBJECT&quot;,&quot;id&quot;:&quot;0a597ccf-3eef-4ea1-968c-3c64ef27f011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632a7e9-f2c6-46be-ade5-c8fa087bcadd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79d64b1e-ed4e-4dc4-831e-6032b09c248f&quot;:{&quot;type&quot;:&quot;FIGURE_OBJECT&quot;,&quot;id&quot;:&quot;79d64b1e-ed4e-4dc4-831e-6032b09c248f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632a7e9-f2c6-46be-ade5-c8fa087bcadd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d813df69-ca6d-4771-bf38-e5296608c734&quot;:{&quot;type&quot;:&quot;FIGURE_OBJECT&quot;,&quot;id&quot;:&quot;d813df69-ca6d-4771-bf38-e5296608c734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1632a7e9-f2c6-46be-ade5-c8fa087bcadd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ffbc4b5e-1c66-45a5-b63d-96aee1b117c4&quot;:{&quot;type&quot;:&quot;FIGURE_OBJECT&quot;,&quot;id&quot;:&quot;ffbc4b5e-1c66-45a5-b63d-96aee1b117c4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1632a7e9-f2c6-46be-ade5-c8fa087bcadd&quot;,&quot;order&quot;:&quot;8&quot;},&quot;connectorInfo&quot;:{&quot;connectedObjects&quot;:[],&quot;type&quot;:&quot;ELBOW&quot;,&quot;offset&quot;:{&quot;x&quot;:0,&quot;y&quot;:0},&quot;bending&quot;:-0.1,&quot;firstElementIsHead&quot;:true,&quot;customized&quot;:false}},&quot;4e82be8c-e70c-4d41-970d-93c1c29a4601&quot;:{&quot;id&quot;:&quot;4e82be8c-e70c-4d41-970d-93c1c29a4601&quot;,&quot;type&quot;:&quot;FIGURE_OBJECT&quot;,&quot;relativeTransform&quot;:{&quot;translate&quot;:{&quot;x&quot;:173.6763409296052,&quot;y&quot;:-77.782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1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5&quot;}}}}"/>
    <we:property name="660568f08afa6a13d6dc68fc_1712175759591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79.79117570602398,&quot;y&quot;:17.088778983441955},&quot;rotate&quot;:0,&quot;skewX&quot;:0,&quot;scale&quot;:{&quot;x&quot;:1,&quot;y&quot;:1}},&quot;path&quot;:{&quot;type&quot;:&quot;RECT&quot;,&quot;size&quot;:{&quot;x&quot;:1290.7843995179578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617.7901913591245,&quot;y&quot;:65.72479202263851},&quot;rotate&quot;:0,&quot;skewX&quot;:0,&quot;scale&quot;:{&quot;x&quot;:1,&quot;y&quot;:1}},&quot;text&quot;:{&quot;textData&quot;:{&quot;lineSpacing&quot;:&quot;normal&quot;,&quot;alignment&quot;:&quot;center&quot;,&quot;lines&quot;:[{&quot;runs&quot;:[{&quot;style&quot;:{&quot;fontWeight&quot;:&quot;bold&quot;,&quot;fontStyle&quot;:&quot;normal&quot;,&quot;fontSize&quot;:18.666666666666664,&quot;fontFamily&quot;:&quot;Roboto&quot;,&quot;color&quot;:&quot;black&quot;,&quot;decoration&quot;:&quot;none&quot;},&quot;range&quot;:[0,9]}],&quot;text&quot;:&quot;WT mouse  &quot;},{&quot;runs&quot;:[{&quot;style&quot;:{&quot;fontWeight&quot;:&quot;bold&quot;,&quot;fontStyle&quot;:&quot;italic&quot;,&quot;fontSize&quot;:18.666666666666664,&quot;fontFamily&quot;:&quot;Roboto&quot;,&quot;color&quot;:&quot;black&quot;,&quot;decoration&quot;:&quot;none&quot;},&quot;range&quot;:[0,6]}],&quot;text&quot;:&quot;in vivo&quot;,&quot;baseStyle&quot;:{&quot;fontFamily&quot;:&quot;Roboto&quot;,&quot;fontSize&quot;:18.666666666666664,&quot;color&quot;:&quot;black&quot;,&quot;fontWeight&quot;:&quot;bold&quot;,&quot;fontStyle&quot;:&quot;italic&quot;,&quot;decoration&quot;:&quot;none&quot;,&quot;script&quot;:&quot;none&quot;}}],&quot;verticalAlign&quot;:&quot;TOP&quot;,&quot;_lastCaretLocation&quot;:{&quot;lineIndex&quot;:0,&quot;runIndex&quot;:0,&quot;charIndex&quot;:9}},&quot;format&quot;:&quot;BETTER_TEXT&quot;,&quot;size&quot;:{&quot;x&quot;:256.4851837158203,&quot;y&quot;:43.093333333333334},&quot;targetSize&quot;:{&quot;x&quot;:256.4851837158203,&quot;y&quot;:40.45495813527425},&quot;verticalAlign&quot;:&quot;TOP&quot;},&quot;parent&quot;:{&quot;type&quot;:&quot;CHILD&quot;,&quot;parentId&quot;:&quot;8563537e-9ecc-4632-9afc-00afd7e3699c&quot;,&quot;order&quot;:&quot;9999999999998&quot;}},&quot;8c1f0d3b-62cb-45cf-903b-2957e7ae9337&quot;:{&quot;id&quot;:&quot;8c1f0d3b-62cb-45cf-903b-2957e7ae9337&quot;,&quot;type&quot;:&quot;FIGURE_OBJECT&quot;,&quot;relativeTransform&quot;:{&quot;translate&quot;:{&quot;x&quot;:-460.71485786731284,&quot;y&quot;:17.088782739226033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9% O2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2,&quot;runIndex&quot;:-1,&quot;charIndex&quot;:-1,&quot;endOfLine&quot;:true}},&quot;format&quot;:&quot;BETTER_TEXT&quot;,&quot;size&quot;:{&quot;x&quot;:107.4680801421614,&quot;y&quot;:127.46666666666667},&quot;targetSize&quot;:{&quot;x&quot;:107.4680801421614,&quot;y&quot;:91.32}},&quot;parent&quot;:{&quot;type&quot;:&quot;CHILD&quot;,&quot;parentId&quot;:&quot;8563537e-9ecc-4632-9afc-00afd7e3699c&quot;,&quot;order&quot;:&quot;99999999999999975&quot;}},&quot;7fe9c513-5a5b-4ad2-9186-3554592f5107&quot;:{&quot;id&quot;:&quot;7fe9c513-5a5b-4ad2-9186-3554592f5107&quot;,&quot;name&quot;:&quot;Adrenal gland (left, cut)&quot;,&quot;displayName&quot;:&quot;&quot;,&quot;type&quot;:&quot;FIGURE_OBJECT&quot;,&quot;relativeTransform&quot;:{&quot;translate&quot;:{&quot;x&quot;:3.4950788091171034,&quot;y&quot;:4.0594494058927},&quot;rotate&quot;:0,&quot;skewX&quot;:0,&quot;scale&quot;:{&quot;x&quot;:1.4470048465926237,&quot;y&quot;:1.447004846592624}},&quot;image&quot;:{&quot;url&quot;:&quot;https://icons.biorender.com/biorender/62ffa6910b0c6a0028194db5/adrenal-gland-left-01.png&quot;,&quot;fallbackUrl&quot;:&quot;https://res.cloudinary.com/dlcjuc3ej/image/upload/v1660921483/t0scx51xhkpunrthshxh.svg#/keystone/api/icons/62ffa6910b0c6a0028194db5/adrenal-gland-left-01.svg#/keystone/api/icons/62ffa6910b0c6a0028194db5/adrenal-gland-left-01.svg#/keystone/api/icons/62ffa6910b0c6a0028194db5/adrenal-gland-left-01.svg&quot;,&quot;isPremium&quot;:false,&quot;size&quot;:{&quot;x&quot;:100,&quot;y&quot;:77.40585774058577}},&quot;source&quot;:{&quot;id&quot;:&quot;62ffa3290b0c6a0028194da4&quot;,&quot;type&quot;:&quot;ASSETS&quot;},&quot;isPremium&quot;:false,&quot;parent&quot;:{&quot;type&quot;:&quot;CHILD&quot;,&quot;parentId&quot;:&quot;8563537e-9ecc-4632-9afc-00afd7e3699c&quot;,&quot;order&quot;:&quot;99999999999999999999999999999999996&quot;}},&quot;58011070-4e26-4b94-9f48-fa45aae8e63d&quot;:{&quot;type&quot;:&quot;FIGURE_OBJECT&quot;,&quot;id&quot;:&quot;58011070-4e26-4b94-9f48-fa45aae8e63d&quot;,&quot;parent&quot;:{&quot;type&quot;:&quot;CHILD&quot;,&quot;parentId&quot;:&quot;8563537e-9ecc-4632-9afc-00afd7e3699c&quot;,&quot;order&quot;:&quot;999999999999999999999999999999999975&quot;},&quot;relativeTransform&quot;:{&quot;translate&quot;:{&quot;x&quot;:-226.47992970613072,&quot;y&quot;:27.847122994420808},&quot;rotate&quot;:0,&quot;skewX&quot;:0,&quot;scale&quot;:{&quot;x&quot;:1,&quot;y&quot;:1}}},&quot;de6f37cc-70af-4899-94bd-7502cb354636&quot;:{&quot;type&quot;:&quot;FIGURE_OBJECT&quot;,&quot;id&quot;:&quot;de6f37cc-70af-4899-94bd-7502cb354636&quot;,&quot;parent&quot;:{&quot;type&quot;:&quot;CHILD&quot;,&quot;parentId&quot;:&quot;58011070-4e26-4b94-9f48-fa45aae8e63d&quot;,&quot;order&quot;:&quot;2&quot;},&quot;relativeTransform&quot;:{&quot;translate&quot;:{&quot;x&quot;:-51.34816994040851,&quot;y&quot;:37.425046546512284},&quot;rotate&quot;:0}},&quot;145bac72-52c8-4496-8c06-09384829039c&quot;:{&quot;id&quot;:&quot;145bac72-52c8-4496-8c06-09384829039c&quot;,&quot;name&quot;:&quot;Compressed gas tank&quot;,&quot;displayName&quot;:&quot;&quot;,&quot;type&quot;:&quot;FIGURE_OBJECT&quot;,&quot;relativeTransform&quot;:{&quot;translate&quot;:{&quot;x&quot;:61.3313631486884,&quot;y&quot;:-68.39028581591374},&quot;rotate&quot;:0,&quot;skewX&quot;:0,&quot;scale&quot;:{&quot;x&quot;:0.5287186478335207,&quot;y&quot;:0.5287186478335207}},&quot;image&quot;:{&quot;url&quot;:&quot;https://icons.biorender.com/biorender/5da628ac645275000458d6fa/20191015202050/image/compressed-gas-tank.png&quot;,&quot;fallbackUrl&quot;:&quot;https://res.cloudinary.com/dlcjuc3ej/image/upload/v1571170850/penwt8wvnryq1orafxxg.svg#/keystone/api/icons/5da628ac645275000458d6fa/20191015202050/image/compressed-gas-tank.svg&quot;,&quot;isPremium&quot;:false,&quot;size&quot;:{&quot;x&quot;:125,&quot;y&quot;:251.5923566878981}},&quot;source&quot;:{&quot;id&quot;:&quot;5da628ac645275000458d6fa&quot;,&quot;type&quot;:&quot;ASSETS&quot;},&quot;isPremium&quot;:false,&quot;parent&quot;:{&quot;type&quot;:&quot;CHILD&quot;,&quot;parentId&quot;:&quot;de6f37cc-70af-4899-94bd-7502cb354636&quot;,&quot;order&quot;:&quot;2&quot;}},&quot;b13af848-f07b-4f7a-837a-64e6e018d482&quot;:{&quot;type&quot;:&quot;FIGURE_OBJECT&quot;,&quot;id&quot;:&quot;b13af848-f07b-4f7a-837a-64e6e018d482&quot;,&quot;parent&quot;:{&quot;type&quot;:&quot;CHILD&quot;,&quot;parentId&quot;:&quot;de6f37cc-70af-4899-94bd-7502cb354636&quot;,&quot;order&quot;:&quot;5&quot;},&quot;relativeTransform&quot;:{&quot;translate&quot;:{&quot;x&quot;:123.89622690277243,&quot;y&quot;:-16.390278082839142},&quot;rotate&quot;:0}},&quot;3640dc48-1c7b-479f-8760-337c398bc979&quot;:{&quot;id&quot;:&quot;3640dc48-1c7b-479f-8760-337c398bc979&quot;,&quot;name&quot;:&quot;Incubated stackable shaker (MaxQ 6000, single)&quot;,&quot;displayName&quot;:&quot;Incubated stackable shaker (MaxQ)&quot;,&quot;type&quot;:&quot;FIGURE_OBJECT&quot;,&quot;relativeTransform&quot;:{&quot;translate&quot;:{&quot;x&quot;:-152.9757905648621,&quot;y&quot;:-31.792910499068256},&quot;rotate&quot;:0,&quot;skewX&quot;:0,&quot;scale&quot;:{&quot;x&quot;:0.7804412157545995,&quot;y&quot;:0.7804412157545995}},&quot;image&quot;:{&quot;url&quot;:&quot;https://icons.biorender.com/biorender/5f8f54b1269fc400282cbd7c/20201020212401/image/incubated-stackable-shaker-maxq-6000-single.png&quot;,&quot;fallbackUrl&quot;:&quot;https://res.cloudinary.com/dlcjuc3ej/image/upload/v1603229041/lltf1ayw7dfe9dxjktnv.svg#/keystone/api/icons/5f8f54b1269fc400282cbd7c/20201020212401/image/incubated-stackable-shaker-maxq-6000-single.svg&quot;,&quot;isPremium&quot;:true,&quot;size&quot;:{&quot;x&quot;:200,&quot;y&quot;:287.7551020408163}},&quot;source&quot;:{&quot;id&quot;:&quot;5f8f54b1269fc400282cbd7c&quot;,&quot;type&quot;:&quot;ASSETS&quot;},&quot;isPremium&quot;:true,&quot;parent&quot;:{&quot;type&quot;:&quot;CHILD&quot;,&quot;parentId&quot;:&quot;b13af848-f07b-4f7a-837a-64e6e018d482&quot;,&quot;order&quot;:&quot;2&quot;}},&quot;eb6c3a9d-c554-4ee1-9a69-2fe0878db30c&quot;:{&quot;id&quot;:&quot;eb6c3a9d-c554-4ee1-9a69-2fe0878db30c&quot;,&quot;name&quot;:&quot;Mouse (black, anterior 1)&quot;,&quot;displayName&quot;:&quot;&quot;,&quot;type&quot;:&quot;FIGURE_OBJECT&quot;,&quot;relativeTransform&quot;:{&quot;translate&quot;:{&quot;x&quot;:-152.9757525336161,&quot;y&quot;:-33.82847652568434},&quot;rotate&quot;:0,&quot;skewX&quot;:0,&quot;scale&quot;:{&quot;x&quot;:0.5287186478335207,&quot;y&quot;:0.5287186478335207}},&quot;image&quot;:{&quot;url&quot;:&quot;https://icons.biorender.com/biorender/6413583d8cac750020ff304b/20230317155722/image/mouse-black-anterior-1.png&quot;,&quot;fallbackUrl&quot;:&quot;https://res.cloudinary.com/dlcjuc3ej/image/upload/v1679068642/tfu33lh7f6p3ioggwena.svg#/keystone/api/icons/6413583d8cac750020ff304b/20230317155722/image/mouse-black-anterior-1.svg&quot;,&quot;isPremium&quot;:true,&quot;size&quot;:{&quot;x&quot;:200,&quot;y&quot;:117}},&quot;source&quot;:{&quot;id&quot;:&quot;6413583d8cac750020ff304b&quot;,&quot;type&quot;:&quot;ASSETS&quot;},&quot;isPremium&quot;:true,&quot;parent&quot;:{&quot;type&quot;:&quot;CHILD&quot;,&quot;parentId&quot;:&quot;b13af848-f07b-4f7a-837a-64e6e018d482&quot;,&quot;order&quot;:&quot;5&quot;},&quot;styles&quot;:{&quot;fur&quot;:[{&quot;styleName&quot;:&quot;MONOCHROME_COLOR&quot;,&quot;index&quot;:0,&quot;color&quot;:&quot;#94221F&quot;}],&quot;flesh&quot;:[{&quot;styleName&quot;:&quot;MONOCHROME_COLOR&quot;,&quot;index&quot;:0,&quot;color&quot;:&quot;#94221F&quot;}],&quot;eye&quot;:[{&quot;styleName&quot;:&quot;MONOCHROME_COLOR&quot;,&quot;index&quot;:0,&quot;color&quot;:&quot;#94221F&quot;}]}},&quot;9853d6b0-1f5e-4faf-b974-7de2e2b18a10&quot;:{&quot;id&quot;:&quot;9853d6b0-1f5e-4faf-b974-7de2e2b18a10&quot;,&quot;type&quot;:&quot;FIGURE_OBJECT&quot;,&quot;relativeTransform&quot;:{&quot;translate&quot;:{&quot;x&quot;:30.45858425427475,&quot;y&quot;:-20.29478353888176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2.448465463913456,&quot;color&quot;:&quot;black&quot;,&quot;fontWeight&quot;:&quot;normal&quot;,&quot;fontStyle&quot;:&quot;normal&quot;,&quot;decoration&quot;:&quot;none&quot;},&quot;range&quot;:[0,0]},{&quot;style&quot;:{&quot;fontFamily&quot;:&quot;Roboto&quot;,&quot;fontSize&quot;:12.448465463913456,&quot;color&quot;:&quot;black&quot;,&quot;fontWeight&quot;:&quot;normal&quot;,&quot;fontStyle&quot;:&quot;normal&quot;,&quot;decoration&quot;:&quot;none&quot;,&quot;script&quot;:&quot;sub&quot;},&quot;range&quot;:[1,1]}],&quot;text&quot;:&quot;N2&quot;}],&quot;_lastCaretLocation&quot;:{&quot;lineIndex&quot;:0,&quot;runIndex&quot;:1,&quot;charIndex&quot;:1}},&quot;format&quot;:&quot;BETTER_TEXT&quot;,&quot;size&quot;:{&quot;x&quot;:15.858831515935817,&quot;y&quot;:14.671405725326572},&quot;targetSize&quot;:{&quot;x&quot;:15.858831515935817,&quot;y&quot;:14.671405725326572}},&quot;parent&quot;:{&quot;type&quot;:&quot;CHILD&quot;,&quot;parentId&quot;:&quot;58011070-4e26-4b94-9f48-fa45aae8e63d&quot;,&quot;order&quot;:&quot;5&quot;}},&quot;773a0a7e-5fa4-40b3-bc39-3acf8707863d&quot;:{&quot;type&quot;:&quot;FIGURE_OBJECT&quot;,&quot;id&quot;:&quot;773a0a7e-5fa4-40b3-bc39-3acf8707863d&quot;,&quot;relativeTransform&quot;:{&quot;translate&quot;:{&quot;x&quot;:-449.1197589709548,&quot;y&quot;:-0.5092022693567531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(63, 120, 193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99999999999999999999977&quot;}},&quot;cf61650b-1630-47eb-b73e-87a1771169c5&quot;:{&quot;type&quot;:&quot;FIGURE_OBJECT&quot;,&quot;id&quot;:&quot;cf61650b-1630-47eb-b73e-87a1771169c5&quot;,&quot;relativeTransform&quot;:{&quot;translate&quot;:{&quot;x&quot;:-121.24022586074773,&quot;y&quot;:-0.5092022693567576},&quot;rotate&quot;:4.440892098500626e-16,&quot;skewX&quot;:-2.7755575615628895e-17},&quot;opacity&quot;:1,&quot;path&quot;:{&quot;type&quot;:&quot;ARROW&quot;,&quot;size&quot;:{&quot;x&quot;:91.82963669095837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9999999999999999999998&quot;}},&quot;2b180109-0e63-463e-8cbd-5235618fd8cb&quot;:{&quot;id&quot;:&quot;2b180109-0e63-463e-8cbd-5235618fd8cb&quot;,&quot;type&quot;:&quot;FIGURE_OBJECT&quot;,&quot;relativeTransform&quot;:{&quot;translate&quot;:{&quot;x&quot;:281.38946179576016,&quot;y&quot;:73.62573298277435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7]}],&quot;text&quot;:&quot;Steroids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1&quot;}},&quot;c4c45555-c034-4c83-8859-fe4cc0014d7b&quot;:{&quot;id&quot;:&quot;c4c45555-c034-4c83-8859-fe4cc0014d7b&quot;,&quot;type&quot;:&quot;FIGURE_OBJECT&quot;,&quot;relativeTransform&quot;:{&quot;translate&quot;:{&quot;x&quot;:289.9032247972498,&quot;y&quot;:11.586419450725884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4}},&quot;format&quot;:&quot;BETTER_TEXT&quot;,&quot;size&quot;:{&quot;x&quot;:186.37227288355874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9999999999999992&quot;}},&quot;93c88468-796e-4e67-9026-8ed8e6beb654&quot;:{&quot;type&quot;:&quot;FIGURE_OBJECT&quot;,&quot;id&quot;:&quot;93c88468-796e-4e67-9026-8ed8e6beb654&quot;,&quot;parent&quot;:{&quot;type&quot;:&quot;CHILD&quot;,&quot;parentId&quot;:&quot;8563537e-9ecc-4632-9afc-00afd7e3699c&quot;,&quot;order&quot;:&quot;999999999999999999999999999999999995&quot;},&quot;relativeTransform&quot;:{&quot;translate&quot;:{&quot;x&quot;:-161.4050277239672,&quot;y&quot;:-3.4042893814982818},&quot;rotate&quot;:-1.5707963267948966,&quot;skewX&quot;:0,&quot;scale&quot;:{&quot;x&quot;:1,&quot;y&quot;:1}}},&quot;dd35a806-726b-466d-b87c-858e45d7dca9&quot;:{&quot;type&quot;:&quot;FIGURE_OBJECT&quot;,&quot;id&quot;:&quot;dd35a806-726b-466d-b87c-858e45d7dca9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3c88468-796e-4e67-9026-8ed8e6beb654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9e568b46-b177-4104-bb20-7e2831e7bdc0&quot;:{&quot;type&quot;:&quot;FIGURE_OBJECT&quot;,&quot;id&quot;:&quot;9e568b46-b177-4104-bb20-7e2831e7bdc0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3c88468-796e-4e67-9026-8ed8e6beb654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6fe2629e-9658-4e88-89ab-5817e4bdae6f&quot;:{&quot;type&quot;:&quot;FIGURE_OBJECT&quot;,&quot;id&quot;:&quot;6fe2629e-9658-4e88-89ab-5817e4bdae6f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93c88468-796e-4e67-9026-8ed8e6beb654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e242ab13-5b32-4f2f-a5fb-b6cdba80859a&quot;:{&quot;type&quot;:&quot;FIGURE_OBJECT&quot;,&quot;id&quot;:&quot;e242ab13-5b32-4f2f-a5fb-b6cdba80859a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3c88468-796e-4e67-9026-8ed8e6beb654&quot;,&quot;order&quot;:&quot;8&quot;},&quot;connectorInfo&quot;:{&quot;connectedObjects&quot;:[],&quot;type&quot;:&quot;ELBOW&quot;,&quot;offset&quot;:{&quot;x&quot;:0,&quot;y&quot;:0},&quot;bending&quot;:-0.1,&quot;firstElementIsHead&quot;:true,&quot;customized&quot;:false}},&quot;b2fd3380-a0da-4844-ba67-fb6547e752a1&quot;:{&quot;id&quot;:&quot;b2fd3380-a0da-4844-ba67-fb6547e752a1&quot;,&quot;type&quot;:&quot;FIGURE_OBJECT&quot;,&quot;relativeTransform&quot;:{&quot;translate&quot;:{&quot;x&quot;:281.3903409296052,&quot;y&quot;:-65.508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1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7&quot;}},&quot;8e1b7e43-a445-45b3-ad2e-31b8224f6196&quot;:{&quot;id&quot;:&quot;8e1b7e43-a445-45b3-ad2e-31b8224f6196&quot;,&quot;name&quot;:&quot;Mouse (symbol)&quot;,&quot;displayName&quot;:&quot;&quot;,&quot;type&quot;:&quot;FIGURE_OBJECT&quot;,&quot;relativeTransform&quot;:{&quot;translate&quot;:{&quot;x&quot;:-608.64,&quot;y&quot;:-8.596295503211941},&quot;rotate&quot;:0,&quot;skewX&quot;:0,&quot;scale&quot;:{&quot;x&quot;:1.4432399999999999,&quot;y&quot;:1.4432399999999999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#/keystone/api/icons/601c2818b376e300280e707d/mouse-icon.svg#/keystone/api/icons/601c2818b376e300280e707d/mouse-icon.svg#/keystone/api/icons/601c2818b376e300280e707d/mouse-icon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8563537e-9ecc-4632-9afc-00afd7e3699c&quot;,&quot;order&quot;:&quot;999999999999999999999999999999999998&quot;}}}}"/>
    <we:property name="660568f08afa6a13d6dc68fc_1712208844304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79.79117570602398,&quot;y&quot;:17.088778983441955},&quot;rotate&quot;:0,&quot;skewX&quot;:0,&quot;scale&quot;:{&quot;x&quot;:1,&quot;y&quot;:1}},&quot;path&quot;:{&quot;type&quot;:&quot;RECT&quot;,&quot;size&quot;:{&quot;x&quot;:1290.7843995179578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617.7901913591245,&quot;y&quot;:65.72479202263851},&quot;rotate&quot;:0,&quot;skewX&quot;:0,&quot;scale&quot;:{&quot;x&quot;:1,&quot;y&quot;:1}},&quot;text&quot;:{&quot;textData&quot;:{&quot;lineSpacing&quot;:&quot;normal&quot;,&quot;alignment&quot;:&quot;center&quot;,&quot;lines&quot;:[{&quot;runs&quot;:[{&quot;style&quot;:{&quot;fontWeight&quot;:&quot;bold&quot;,&quot;fontStyle&quot;:&quot;normal&quot;,&quot;fontSize&quot;:18.666666666666664,&quot;fontFamily&quot;:&quot;Roboto&quot;,&quot;color&quot;:&quot;black&quot;,&quot;decoration&quot;:&quot;none&quot;},&quot;range&quot;:[0,9]}],&quot;text&quot;:&quot;WT mouse  &quot;},{&quot;runs&quot;:[{&quot;style&quot;:{&quot;fontWeight&quot;:&quot;bold&quot;,&quot;fontStyle&quot;:&quot;italic&quot;,&quot;fontSize&quot;:18.666666666666664,&quot;fontFamily&quot;:&quot;Roboto&quot;,&quot;color&quot;:&quot;black&quot;,&quot;decoration&quot;:&quot;none&quot;},&quot;range&quot;:[0,6]}],&quot;text&quot;:&quot;in vivo&quot;,&quot;baseStyle&quot;:{&quot;fontFamily&quot;:&quot;Roboto&quot;,&quot;fontSize&quot;:18.666666666666664,&quot;color&quot;:&quot;black&quot;,&quot;fontWeight&quot;:&quot;bold&quot;,&quot;fontStyle&quot;:&quot;italic&quot;,&quot;decoration&quot;:&quot;none&quot;,&quot;script&quot;:&quot;none&quot;}}],&quot;verticalAlign&quot;:&quot;TOP&quot;,&quot;_lastCaretLocation&quot;:{&quot;lineIndex&quot;:0,&quot;runIndex&quot;:0,&quot;charIndex&quot;:9}},&quot;format&quot;:&quot;BETTER_TEXT&quot;,&quot;size&quot;:{&quot;x&quot;:256.4851837158203,&quot;y&quot;:43.093333333333334},&quot;targetSize&quot;:{&quot;x&quot;:256.4851837158203,&quot;y&quot;:40.45495813527425},&quot;verticalAlign&quot;:&quot;TOP&quot;},&quot;parent&quot;:{&quot;type&quot;:&quot;CHILD&quot;,&quot;parentId&quot;:&quot;8563537e-9ecc-4632-9afc-00afd7e3699c&quot;,&quot;order&quot;:&quot;9999999999998&quot;}},&quot;8c1f0d3b-62cb-45cf-903b-2957e7ae9337&quot;:{&quot;id&quot;:&quot;8c1f0d3b-62cb-45cf-903b-2957e7ae9337&quot;,&quot;type&quot;:&quot;FIGURE_OBJECT&quot;,&quot;relativeTransform&quot;:{&quot;translate&quot;:{&quot;x&quot;:-460.71485786731284,&quot;y&quot;:17.088782739226033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9% O2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2,&quot;runIndex&quot;:-1,&quot;charIndex&quot;:-1,&quot;endOfLine&quot;:true}},&quot;format&quot;:&quot;BETTER_TEXT&quot;,&quot;size&quot;:{&quot;x&quot;:107.4680801421614,&quot;y&quot;:127.46666666666667},&quot;targetSize&quot;:{&quot;x&quot;:107.4680801421614,&quot;y&quot;:91.32}},&quot;parent&quot;:{&quot;type&quot;:&quot;CHILD&quot;,&quot;parentId&quot;:&quot;8563537e-9ecc-4632-9afc-00afd7e3699c&quot;,&quot;order&quot;:&quot;99999999999999975&quot;}},&quot;7fe9c513-5a5b-4ad2-9186-3554592f5107&quot;:{&quot;id&quot;:&quot;7fe9c513-5a5b-4ad2-9186-3554592f5107&quot;,&quot;name&quot;:&quot;Adrenal gland (left, cut)&quot;,&quot;displayName&quot;:&quot;&quot;,&quot;type&quot;:&quot;FIGURE_OBJECT&quot;,&quot;relativeTransform&quot;:{&quot;translate&quot;:{&quot;x&quot;:3.4950788091171034,&quot;y&quot;:4.0594494058927},&quot;rotate&quot;:0,&quot;skewX&quot;:0,&quot;scale&quot;:{&quot;x&quot;:1.4470048465926237,&quot;y&quot;:1.447004846592624}},&quot;image&quot;:{&quot;url&quot;:&quot;https://icons.biorender.com/biorender/62ffa6910b0c6a0028194db5/adrenal-gland-left-01.png&quot;,&quot;fallbackUrl&quot;:&quot;https://res.cloudinary.com/dlcjuc3ej/image/upload/v1660921483/t0scx51xhkpunrthshxh.svg#/keystone/api/icons/62ffa6910b0c6a0028194db5/adrenal-gland-left-01.svg#/keystone/api/icons/62ffa6910b0c6a0028194db5/adrenal-gland-left-01.svg#/keystone/api/icons/62ffa6910b0c6a0028194db5/adrenal-gland-left-01.svg&quot;,&quot;isPremium&quot;:false,&quot;size&quot;:{&quot;x&quot;:100,&quot;y&quot;:77.40585774058577}},&quot;source&quot;:{&quot;id&quot;:&quot;62ffa3290b0c6a0028194da4&quot;,&quot;type&quot;:&quot;ASSETS&quot;},&quot;isPremium&quot;:false,&quot;parent&quot;:{&quot;type&quot;:&quot;CHILD&quot;,&quot;parentId&quot;:&quot;8563537e-9ecc-4632-9afc-00afd7e3699c&quot;,&quot;order&quot;:&quot;99999999999999999999999999999999996&quot;}},&quot;58011070-4e26-4b94-9f48-fa45aae8e63d&quot;:{&quot;type&quot;:&quot;FIGURE_OBJECT&quot;,&quot;id&quot;:&quot;58011070-4e26-4b94-9f48-fa45aae8e63d&quot;,&quot;parent&quot;:{&quot;type&quot;:&quot;CHILD&quot;,&quot;parentId&quot;:&quot;8563537e-9ecc-4632-9afc-00afd7e3699c&quot;,&quot;order&quot;:&quot;999999999999999999999999999999999975&quot;},&quot;relativeTransform&quot;:{&quot;translate&quot;:{&quot;x&quot;:-226.47992970613072,&quot;y&quot;:27.847122994420808},&quot;rotate&quot;:0,&quot;skewX&quot;:0,&quot;scale&quot;:{&quot;x&quot;:1,&quot;y&quot;:1}}},&quot;de6f37cc-70af-4899-94bd-7502cb354636&quot;:{&quot;type&quot;:&quot;FIGURE_OBJECT&quot;,&quot;id&quot;:&quot;de6f37cc-70af-4899-94bd-7502cb354636&quot;,&quot;parent&quot;:{&quot;type&quot;:&quot;CHILD&quot;,&quot;parentId&quot;:&quot;58011070-4e26-4b94-9f48-fa45aae8e63d&quot;,&quot;order&quot;:&quot;2&quot;},&quot;relativeTransform&quot;:{&quot;translate&quot;:{&quot;x&quot;:-51.34816994040851,&quot;y&quot;:37.425046546512284},&quot;rotate&quot;:0}},&quot;145bac72-52c8-4496-8c06-09384829039c&quot;:{&quot;id&quot;:&quot;145bac72-52c8-4496-8c06-09384829039c&quot;,&quot;name&quot;:&quot;Compressed gas tank&quot;,&quot;displayName&quot;:&quot;&quot;,&quot;type&quot;:&quot;FIGURE_OBJECT&quot;,&quot;relativeTransform&quot;:{&quot;translate&quot;:{&quot;x&quot;:61.3313631486884,&quot;y&quot;:-68.39028581591374},&quot;rotate&quot;:0,&quot;skewX&quot;:0,&quot;scale&quot;:{&quot;x&quot;:0.5287186478335207,&quot;y&quot;:0.5287186478335207}},&quot;image&quot;:{&quot;url&quot;:&quot;https://icons.biorender.com/biorender/5da628ac645275000458d6fa/20191015202050/image/compressed-gas-tank.png&quot;,&quot;fallbackUrl&quot;:&quot;https://res.cloudinary.com/dlcjuc3ej/image/upload/v1571170850/penwt8wvnryq1orafxxg.svg#/keystone/api/icons/5da628ac645275000458d6fa/20191015202050/image/compressed-gas-tank.svg&quot;,&quot;isPremium&quot;:false,&quot;size&quot;:{&quot;x&quot;:125,&quot;y&quot;:251.5923566878981}},&quot;source&quot;:{&quot;id&quot;:&quot;5da628ac645275000458d6fa&quot;,&quot;type&quot;:&quot;ASSETS&quot;},&quot;isPremium&quot;:false,&quot;parent&quot;:{&quot;type&quot;:&quot;CHILD&quot;,&quot;parentId&quot;:&quot;de6f37cc-70af-4899-94bd-7502cb354636&quot;,&quot;order&quot;:&quot;2&quot;}},&quot;b13af848-f07b-4f7a-837a-64e6e018d482&quot;:{&quot;type&quot;:&quot;FIGURE_OBJECT&quot;,&quot;id&quot;:&quot;b13af848-f07b-4f7a-837a-64e6e018d482&quot;,&quot;parent&quot;:{&quot;type&quot;:&quot;CHILD&quot;,&quot;parentId&quot;:&quot;de6f37cc-70af-4899-94bd-7502cb354636&quot;,&quot;order&quot;:&quot;5&quot;},&quot;relativeTransform&quot;:{&quot;translate&quot;:{&quot;x&quot;:123.89622690277243,&quot;y&quot;:-16.390278082839142},&quot;rotate&quot;:0}},&quot;3640dc48-1c7b-479f-8760-337c398bc979&quot;:{&quot;id&quot;:&quot;3640dc48-1c7b-479f-8760-337c398bc979&quot;,&quot;name&quot;:&quot;Incubated stackable shaker (MaxQ 6000, single)&quot;,&quot;displayName&quot;:&quot;Incubated stackable shaker (MaxQ)&quot;,&quot;type&quot;:&quot;FIGURE_OBJECT&quot;,&quot;relativeTransform&quot;:{&quot;translate&quot;:{&quot;x&quot;:-152.9757905648621,&quot;y&quot;:-31.792910499068256},&quot;rotate&quot;:0,&quot;skewX&quot;:0,&quot;scale&quot;:{&quot;x&quot;:0.7804412157545995,&quot;y&quot;:0.7804412157545995}},&quot;image&quot;:{&quot;url&quot;:&quot;https://icons.biorender.com/biorender/5f8f54b1269fc400282cbd7c/20201020212401/image/incubated-stackable-shaker-maxq-6000-single.png&quot;,&quot;fallbackUrl&quot;:&quot;https://res.cloudinary.com/dlcjuc3ej/image/upload/v1603229041/lltf1ayw7dfe9dxjktnv.svg#/keystone/api/icons/5f8f54b1269fc400282cbd7c/20201020212401/image/incubated-stackable-shaker-maxq-6000-single.svg&quot;,&quot;isPremium&quot;:true,&quot;size&quot;:{&quot;x&quot;:200,&quot;y&quot;:287.7551020408163}},&quot;source&quot;:{&quot;id&quot;:&quot;5f8f54b1269fc400282cbd7c&quot;,&quot;type&quot;:&quot;ASSETS&quot;},&quot;isPremium&quot;:true,&quot;parent&quot;:{&quot;type&quot;:&quot;CHILD&quot;,&quot;parentId&quot;:&quot;b13af848-f07b-4f7a-837a-64e6e018d482&quot;,&quot;order&quot;:&quot;2&quot;}},&quot;eb6c3a9d-c554-4ee1-9a69-2fe0878db30c&quot;:{&quot;id&quot;:&quot;eb6c3a9d-c554-4ee1-9a69-2fe0878db30c&quot;,&quot;name&quot;:&quot;Mouse (black, anterior 1)&quot;,&quot;displayName&quot;:&quot;&quot;,&quot;type&quot;:&quot;FIGURE_OBJECT&quot;,&quot;relativeTransform&quot;:{&quot;translate&quot;:{&quot;x&quot;:-152.9757525336161,&quot;y&quot;:-33.82847652568434},&quot;rotate&quot;:0,&quot;skewX&quot;:0,&quot;scale&quot;:{&quot;x&quot;:0.5287186478335207,&quot;y&quot;:0.5287186478335207}},&quot;image&quot;:{&quot;url&quot;:&quot;https://icons.biorender.com/biorender/6413583d8cac750020ff304b/20230317155722/image/mouse-black-anterior-1.png&quot;,&quot;fallbackUrl&quot;:&quot;https://res.cloudinary.com/dlcjuc3ej/image/upload/v1679068642/tfu33lh7f6p3ioggwena.svg#/keystone/api/icons/6413583d8cac750020ff304b/20230317155722/image/mouse-black-anterior-1.svg&quot;,&quot;isPremium&quot;:true,&quot;size&quot;:{&quot;x&quot;:200,&quot;y&quot;:117}},&quot;source&quot;:{&quot;id&quot;:&quot;6413583d8cac750020ff304b&quot;,&quot;type&quot;:&quot;ASSETS&quot;},&quot;isPremium&quot;:true,&quot;parent&quot;:{&quot;type&quot;:&quot;CHILD&quot;,&quot;parentId&quot;:&quot;b13af848-f07b-4f7a-837a-64e6e018d482&quot;,&quot;order&quot;:&quot;5&quot;},&quot;styles&quot;:{&quot;fur&quot;:[{&quot;styleName&quot;:&quot;MONOCHROME_COLOR&quot;,&quot;index&quot;:0,&quot;color&quot;:&quot;#94221F&quot;}],&quot;flesh&quot;:[{&quot;styleName&quot;:&quot;MONOCHROME_COLOR&quot;,&quot;index&quot;:0,&quot;color&quot;:&quot;#94221F&quot;}],&quot;eye&quot;:[{&quot;styleName&quot;:&quot;MONOCHROME_COLOR&quot;,&quot;index&quot;:0,&quot;color&quot;:&quot;#94221F&quot;}]}},&quot;9853d6b0-1f5e-4faf-b974-7de2e2b18a10&quot;:{&quot;id&quot;:&quot;9853d6b0-1f5e-4faf-b974-7de2e2b18a10&quot;,&quot;type&quot;:&quot;FIGURE_OBJECT&quot;,&quot;relativeTransform&quot;:{&quot;translate&quot;:{&quot;x&quot;:30.45858425427475,&quot;y&quot;:-20.29478353888176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2.448465463913456,&quot;color&quot;:&quot;black&quot;,&quot;fontWeight&quot;:&quot;normal&quot;,&quot;fontStyle&quot;:&quot;normal&quot;,&quot;decoration&quot;:&quot;none&quot;},&quot;range&quot;:[0,0]},{&quot;style&quot;:{&quot;fontFamily&quot;:&quot;Roboto&quot;,&quot;fontSize&quot;:12.448465463913456,&quot;color&quot;:&quot;black&quot;,&quot;fontWeight&quot;:&quot;normal&quot;,&quot;fontStyle&quot;:&quot;normal&quot;,&quot;decoration&quot;:&quot;none&quot;,&quot;script&quot;:&quot;sub&quot;},&quot;range&quot;:[1,1]}],&quot;text&quot;:&quot;N2&quot;}],&quot;_lastCaretLocation&quot;:{&quot;lineIndex&quot;:0,&quot;runIndex&quot;:1,&quot;charIndex&quot;:1}},&quot;format&quot;:&quot;BETTER_TEXT&quot;,&quot;size&quot;:{&quot;x&quot;:15.858831515935817,&quot;y&quot;:14.671405725326572},&quot;targetSize&quot;:{&quot;x&quot;:15.858831515935817,&quot;y&quot;:14.671405725326572}},&quot;parent&quot;:{&quot;type&quot;:&quot;CHILD&quot;,&quot;parentId&quot;:&quot;58011070-4e26-4b94-9f48-fa45aae8e63d&quot;,&quot;order&quot;:&quot;5&quot;}},&quot;773a0a7e-5fa4-40b3-bc39-3acf8707863d&quot;:{&quot;type&quot;:&quot;FIGURE_OBJECT&quot;,&quot;id&quot;:&quot;773a0a7e-5fa4-40b3-bc39-3acf8707863d&quot;,&quot;relativeTransform&quot;:{&quot;translate&quot;:{&quot;x&quot;:-449.1197589709548,&quot;y&quot;:-0.5092022693567531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(63, 120, 193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99999999999999999999977&quot;}},&quot;cf61650b-1630-47eb-b73e-87a1771169c5&quot;:{&quot;type&quot;:&quot;FIGURE_OBJECT&quot;,&quot;id&quot;:&quot;cf61650b-1630-47eb-b73e-87a1771169c5&quot;,&quot;relativeTransform&quot;:{&quot;translate&quot;:{&quot;x&quot;:-121.24022586074773,&quot;y&quot;:-0.5092022693567576},&quot;rotate&quot;:4.440892098500626e-16,&quot;skewX&quot;:-2.7755575615628895e-17},&quot;opacity&quot;:1,&quot;path&quot;:{&quot;type&quot;:&quot;ARROW&quot;,&quot;size&quot;:{&quot;x&quot;:91.82963669095837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9999999999999999999998&quot;}},&quot;2b180109-0e63-463e-8cbd-5235618fd8cb&quot;:{&quot;id&quot;:&quot;2b180109-0e63-463e-8cbd-5235618fd8cb&quot;,&quot;type&quot;:&quot;FIGURE_OBJECT&quot;,&quot;relativeTransform&quot;:{&quot;translate&quot;:{&quot;x&quot;:281.38946179576016,&quot;y&quot;:73.62573298277435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7]}],&quot;text&quot;:&quot;Steroids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1&quot;}},&quot;c4c45555-c034-4c83-8859-fe4cc0014d7b&quot;:{&quot;id&quot;:&quot;c4c45555-c034-4c83-8859-fe4cc0014d7b&quot;,&quot;type&quot;:&quot;FIGURE_OBJECT&quot;,&quot;relativeTransform&quot;:{&quot;translate&quot;:{&quot;x&quot;:289.9032247972498,&quot;y&quot;:11.586419450725884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4}},&quot;format&quot;:&quot;BETTER_TEXT&quot;,&quot;size&quot;:{&quot;x&quot;:186.37227288355874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9999999999999992&quot;}},&quot;93c88468-796e-4e67-9026-8ed8e6beb654&quot;:{&quot;type&quot;:&quot;FIGURE_OBJECT&quot;,&quot;id&quot;:&quot;93c88468-796e-4e67-9026-8ed8e6beb654&quot;,&quot;parent&quot;:{&quot;type&quot;:&quot;CHILD&quot;,&quot;parentId&quot;:&quot;8563537e-9ecc-4632-9afc-00afd7e3699c&quot;,&quot;order&quot;:&quot;999999999999999999999999999999999995&quot;},&quot;relativeTransform&quot;:{&quot;translate&quot;:{&quot;x&quot;:-161.4050277239672,&quot;y&quot;:-3.4042893814982818},&quot;rotate&quot;:-1.5707963267948966,&quot;skewX&quot;:0,&quot;scale&quot;:{&quot;x&quot;:1,&quot;y&quot;:1}}},&quot;dd35a806-726b-466d-b87c-858e45d7dca9&quot;:{&quot;type&quot;:&quot;FIGURE_OBJECT&quot;,&quot;id&quot;:&quot;dd35a806-726b-466d-b87c-858e45d7dca9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3c88468-796e-4e67-9026-8ed8e6beb654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9e568b46-b177-4104-bb20-7e2831e7bdc0&quot;:{&quot;type&quot;:&quot;FIGURE_OBJECT&quot;,&quot;id&quot;:&quot;9e568b46-b177-4104-bb20-7e2831e7bdc0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3c88468-796e-4e67-9026-8ed8e6beb654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6fe2629e-9658-4e88-89ab-5817e4bdae6f&quot;:{&quot;type&quot;:&quot;FIGURE_OBJECT&quot;,&quot;id&quot;:&quot;6fe2629e-9658-4e88-89ab-5817e4bdae6f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93c88468-796e-4e67-9026-8ed8e6beb654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e242ab13-5b32-4f2f-a5fb-b6cdba80859a&quot;:{&quot;type&quot;:&quot;FIGURE_OBJECT&quot;,&quot;id&quot;:&quot;e242ab13-5b32-4f2f-a5fb-b6cdba80859a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93c88468-796e-4e67-9026-8ed8e6beb654&quot;,&quot;order&quot;:&quot;8&quot;},&quot;connectorInfo&quot;:{&quot;connectedObjects&quot;:[],&quot;type&quot;:&quot;ELBOW&quot;,&quot;offset&quot;:{&quot;x&quot;:0,&quot;y&quot;:0},&quot;bending&quot;:-0.1,&quot;firstElementIsHead&quot;:true,&quot;customized&quot;:false}},&quot;b2fd3380-a0da-4844-ba67-fb6547e752a1&quot;:{&quot;id&quot;:&quot;b2fd3380-a0da-4844-ba67-fb6547e752a1&quot;,&quot;type&quot;:&quot;FIGURE_OBJECT&quot;,&quot;relativeTransform&quot;:{&quot;translate&quot;:{&quot;x&quot;:281.3903409296052,&quot;y&quot;:-65.508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1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7&quot;}},&quot;8e1b7e43-a445-45b3-ad2e-31b8224f6196&quot;:{&quot;id&quot;:&quot;8e1b7e43-a445-45b3-ad2e-31b8224f6196&quot;,&quot;name&quot;:&quot;Mouse (symbol)&quot;,&quot;displayName&quot;:&quot;&quot;,&quot;type&quot;:&quot;FIGURE_OBJECT&quot;,&quot;relativeTransform&quot;:{&quot;translate&quot;:{&quot;x&quot;:-608.64,&quot;y&quot;:-8.596295503211941},&quot;rotate&quot;:0,&quot;skewX&quot;:0,&quot;scale&quot;:{&quot;x&quot;:1.4432399999999999,&quot;y&quot;:1.4432399999999999}},&quot;image&quot;:{&quot;url&quot;:&quot;https://icons.biorender.com/biorender/601c2818b376e300280e707d/mouse-icon.png&quot;,&quot;fallbackUrl&quot;:&quot;https://res.cloudinary.com/dlcjuc3ej/image/upload/v1612458006/kn3jq2u5chw7uq36babw.svg#/keystone/api/icons/601c2818b376e300280e707d/mouse-icon.svg#/keystone/api/icons/601c2818b376e300280e707d/mouse-icon.svg#/keystone/api/icons/601c2818b376e300280e707d/mouse-icon.svg#/keystone/api/icons/601c2818b376e300280e707d/mouse-icon.svg#/keystone/api/icons/601c2818b376e300280e707d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8563537e-9ecc-4632-9afc-00afd7e3699c&quot;,&quot;order&quot;:&quot;999999999999999999999999999999999998&quot;}}}}"/>
    <we:property name="660568f51927813db44fbf54_1712169877935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66.29117599212623,&quot;y&quot;:17.088778983441955},&quot;rotate&quot;:0,&quot;skewX&quot;:0,&quot;scale&quot;:{&quot;x&quot;:1,&quot;y&quot;:1}},&quot;path&quot;:{&quot;type&quot;:&quot;RECT&quot;,&quot;size&quot;:{&quot;x&quot;:1263.7844000901623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535.7149671949715,&quot;y&quot;:82.84160442360896},&quot;rotate&quot;:0,&quot;skewX&quot;:0,&quot;scale&quot;:{&quot;x&quot;:1,&quot;y&quot;:1}},&quot;text&quot;:{&quot;textData&quot;:{&quot;lineSpacing&quot;:&quot;normal&quot;,&quot;alignment&quot;:&quot;center&quot;,&quot;lines&quot;:[{&quot;runs&quot;:[{&quot;range&quot;:[0,12],&quot;style&quot;:{&quot;fontWeight&quot;:&quot;bold&quot;,&quot;fontStyle&quot;:&quot;normal&quot;,&quot;fontSize&quot;:18.666666666666664,&quot;fontFamily&quot;:&quot;Roboto&quot;,&quot;color&quot;:&quot;black&quot;,&quot;decoration&quot;:&quot;none&quot;}}],&quot;text&quot;:&quot;Y1- Ad. Cells&quot;}],&quot;verticalAlign&quot;:&quot;TOP&quot;,&quot;_lastCaretLocation&quot;:{&quot;lineIndex&quot;:0,&quot;runIndex&quot;:0,&quot;charIndex&quot;:8}},&quot;format&quot;:&quot;BETTER_TEXT&quot;,&quot;size&quot;:{&quot;x&quot;:458.10963204412633,&quot;y&quot;:40.45495813527425},&quot;targetSize&quot;:{&quot;x&quot;:458.10963204412633,&quot;y&quot;:40.45495813527425},&quot;verticalAlign&quot;:&quot;TOP&quot;},&quot;parent&quot;:{&quot;type&quot;:&quot;CHILD&quot;,&quot;parentId&quot;:&quot;8563537e-9ecc-4632-9afc-00afd7e3699c&quot;,&quot;order&quot;:&quot;9999999999998&quot;}},&quot;b27a5ede-1d29-43d6-8f9a-ad70ce886ff4&quot;:{&quot;relativeTransform&quot;:{&quot;translate&quot;:{&quot;x&quot;:-535.7148472724849,&quot;y&quot;:-11.157564975970843},&quot;rotate&quot;:0,&quot;skewX&quot;:0,&quot;scale&quot;:{&quot;x&quot;:1,&quot;y&quot;:1}},&quot;type&quot;:&quot;FIGURE_OBJECT&quot;,&quot;id&quot;:&quot;b27a5ede-1d29-43d6-8f9a-ad70ce886ff4&quot;,&quot;name&quot;:&quot;Petri dish with cells&quot;,&quot;displayName&quot;:&quot;Petri dish with cells&quot;,&quot;opacity&quot;:1,&quot;source&quot;:{&quot;id&quot;:&quot;5f6126e51ad2c000b63ff478&quot;,&quot;type&quot;:&quot;ASSETS&quot;},&quot;pathStyles&quot;:[{&quot;type&quot;:&quot;FILL&quot;,&quot;fillStyle&quot;:&quot;rgb(0,0,0)&quot;}],&quot;isLocked&quot;:false,&quot;parent&quot;:{&quot;type&quot;:&quot;CHILD&quot;,&quot;parentId&quot;:&quot;8563537e-9ecc-4632-9afc-00afd7e3699c&quot;,&quot;order&quot;:&quot;99999999999995&quot;},&quot;isPremium&quot;:true},&quot;0f94f3b9-cf76-41e3-8e93-4a9c32d0734b&quot;:{&quot;type&quot;:&quot;FIGURE_OBJECT&quot;,&quot;id&quot;:&quot;0f94f3b9-cf76-41e3-8e93-4a9c32d0734b&quot;,&quot;name&quot;:&quot;Petri dish&quot;,&quot;relativeTransform&quot;:{&quot;translate&quot;:{&quot;x&quot;:0,&quot;y&quot;:5.608524144431269e-14},&quot;rotate&quot;:0,&quot;skewX&quot;:0,&quot;scale&quot;:{&quot;x&quot;:0.6071766165134398,&quot;y&quot;:0.6071766165134398}},&quot;opacity&quot;:1,&quot;image&quot;:{&quot;url&quot;:&quot;https://icons.biorender.com/biorender/5ee0f3bac4e9c30027d95cee/20200611181518/image/petri-dish-2.png&quot;,&quot;fallbackUrl&quot;:&quot;https://res.cloudinary.com/dlcjuc3ej/image/upload/v1591899318/jdx6mgytawhncb5ao57x.svg#/keystone/api/icons/5ee0f3bac4e9c30027d95cee/20200611181518/image/petri-dish-2.svg&quot;,&quot;size&quot;:{&quot;x&quot;:325,&quot;y&quot;:243},&quot;isPremium&quot;:false},&quot;source&quot;:{&quot;id&quot;:&quot;5ee0f3bac4e9c30027d95cee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02&quot;}},&quot;80b5a369-5a07-4fbf-8e61-fd7e5cb9b993&quot;:{&quot;type&quot;:&quot;FIGURE_OBJECT&quot;,&quot;id&quot;:&quot;80b5a369-5a07-4fbf-8e61-fd7e5cb9b993&quot;,&quot;name&quot;:&quot;Spheroidal cell&quot;,&quot;relativeTransform&quot;:{&quot;translate&quot;:{&quot;x&quot;:-35.94816670623872,&quot;y&quot;:17.667452063677587},&quot;rotate&quot;:0,&quot;skewX&quot;:0,&quot;scale&quot;:{&quot;x&quot;:0.15784657354899181,&quot;y&quot;:0.091809510780823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05&quot;}},&quot;9f5041b7-8da0-40a3-9f57-8553129329b2&quot;:{&quot;type&quot;:&quot;FIGURE_OBJECT&quot;,&quot;id&quot;:&quot;9f5041b7-8da0-40a3-9f57-8553129329b2&quot;,&quot;name&quot;:&quot;Spheroidal cell&quot;,&quot;relativeTransform&quot;:{&quot;translate&quot;:{&quot;x&quot;:18.13054297598798,&quot;y&quot;:6.823000424368783},&quot;rotate&quot;:-0.8441643388031763,&quot;skewX&quot;:0.5142096794425836,&quot;scale&quot;:{&quot;x&quot;:0.109115702397623,&quot;y&quot;:0.1328114687210952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&quot;}},&quot;33e32d4a-2a6c-4972-9ace-f64760cf18e4&quot;:{&quot;type&quot;:&quot;FIGURE_OBJECT&quot;,&quot;id&quot;:&quot;33e32d4a-2a6c-4972-9ace-f64760cf18e4&quot;,&quot;name&quot;:&quot;Spheroidal cell&quot;,&quot;relativeTransform&quot;:{&quot;translate&quot;:{&quot;x&quot;:-25.666075796752715,&quot;y&quot;:7.25960221562042},&quot;rotate&quot;:-0.9242877860074409,&quot;skewX&quot;:0.5005509573056879,&quot;scale&quot;:{&quot;x&quot;:0.10532127007158326,&quot;y&quot;:0.137596296418687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2&quot;}},&quot;5b319b16-dbf1-42fc-a2c6-5deed5c1cecf&quot;:{&quot;type&quot;:&quot;FIGURE_OBJECT&quot;,&quot;id&quot;:&quot;5b319b16-dbf1-42fc-a2c6-5deed5c1cecf&quot;,&quot;name&quot;:&quot;Spheroidal cell&quot;,&quot;relativeTransform&quot;:{&quot;translate&quot;:{&quot;x&quot;:-27.037268676931472,&quot;y&quot;:-14.148816604714987},&quot;rotate&quot;:-1.9669828044671898,&quot;skewX&quot;:-0.38482140423679745,&quot;scale&quot;:{&quot;x&quot;:0.0966973626519624,&quot;y&quot;:0.1498677554228841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5&quot;}},&quot;85d5c287-9c1b-4109-9cd3-44ebe2b6c89b&quot;:{&quot;type&quot;:&quot;FIGURE_OBJECT&quot;,&quot;id&quot;:&quot;85d5c287-9c1b-4109-9cd3-44ebe2b6c89b&quot;,&quot;name&quot;:&quot;Spheroidal cell&quot;,&quot;relativeTransform&quot;:{&quot;translate&quot;:{&quot;x&quot;:6.22442247159574,&quot;y&quot;:-4.1354271764679575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&quot;}},&quot;e2a9a4b4-d9df-49c1-b70a-b6b1f9abbe24&quot;:{&quot;type&quot;:&quot;FIGURE_OBJECT&quot;,&quot;id&quot;:&quot;e2a9a4b4-d9df-49c1-b70a-b6b1f9abbe24&quot;,&quot;name&quot;:&quot;Spheroidal cell&quot;,&quot;relativeTransform&quot;:{&quot;translate&quot;:{&quot;x&quot;:25.307956286786244,&quot;y&quot;:-25.434303978061937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2&quot;}},&quot;2e4c8787-c235-414a-8928-3a113e4a8230&quot;:{&quot;type&quot;:&quot;FIGURE_OBJECT&quot;,&quot;id&quot;:&quot;2e4c8787-c235-414a-8928-3a113e4a8230&quot;,&quot;name&quot;:&quot;Spheroidal cell&quot;,&quot;relativeTransform&quot;:{&quot;translate&quot;:{&quot;x&quot;:-45.904258988878105,&quot;y&quot;:6.836275248689061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5&quot;}},&quot;f1eb5606-e506-457b-822b-9deb0032fe35&quot;:{&quot;type&quot;:&quot;FIGURE_OBJECT&quot;,&quot;id&quot;:&quot;f1eb5606-e506-457b-822b-9deb0032fe35&quot;,&quot;name&quot;:&quot;Spheroidal cell&quot;,&quot;relativeTransform&quot;:{&quot;translate&quot;:{&quot;x&quot;:26.941907186973612,&quot;y&quot;:17.668650872453796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3&quot;}},&quot;3ed3776e-4ee4-4fa8-bfc1-9053f3158897&quot;:{&quot;type&quot;:&quot;FIGURE_OBJECT&quot;,&quot;id&quot;:&quot;3ed3776e-4ee4-4fa8-bfc1-9053f3158897&quot;,&quot;name&quot;:&quot;Spheroidal cell&quot;,&quot;relativeTransform&quot;:{&quot;translate&quot;:{&quot;x&quot;:-4.734830595262368,&quot;y&quot;:6.836083564854624},&quot;rotate&quot;:0.7464574379873126,&quot;skewX&quot;:-0.5158759485514509,&quot;scale&quot;:{&quot;x&quot;:0.11445735108071943,&quot;y&quot;:0.1266132455375633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35&quot;}},&quot;c5bc723e-2569-40f1-866b-dae69b27d0e8&quot;:{&quot;type&quot;:&quot;FIGURE_OBJECT&quot;,&quot;id&quot;:&quot;c5bc723e-2569-40f1-866b-dae69b27d0e8&quot;,&quot;name&quot;:&quot;Spheroidal cell&quot;,&quot;relativeTransform&quot;:{&quot;translate&quot;:{&quot;x&quot;:-6.68555595462649,&quot;y&quot;:-14.803466749408686},&quot;rotate&quot;:0.213734288930394,&quot;skewX&quot;:-0.23158516584838867,&quot;scale&quot;:{&quot;x&quot;:0.15132853682888134,&quot;y&quot;:0.09576393851180379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4&quot;}},&quot;c990af1e-a89f-4a4f-a104-12022f09891a&quot;:{&quot;type&quot;:&quot;FIGURE_OBJECT&quot;,&quot;id&quot;:&quot;c990af1e-a89f-4a4f-a104-12022f09891a&quot;,&quot;name&quot;:&quot;Spheroidal cell&quot;,&quot;relativeTransform&quot;:{&quot;translate&quot;:{&quot;x&quot;:-18.09248556476985,&quot;y&quot;:-25.14594105576579},&quot;rotate&quot;:2.8082484065025266,&quot;skewX&quot;:0.3382353591056591,&quot;scale&quot;:{&quot;x&quot;:0.14353196763903742,&quot;y&quot;:0.10096577741069561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&quot;}},&quot;8d63e0cc-073d-4fbe-ba90-9dbe94d1fb20&quot;:{&quot;type&quot;:&quot;FIGURE_OBJECT&quot;,&quot;id&quot;:&quot;8d63e0cc-073d-4fbe-ba90-9dbe94d1fb20&quot;,&quot;name&quot;:&quot;Spheroidal cell&quot;,&quot;relativeTransform&quot;:{&quot;translate&quot;:{&quot;x&quot;:14.414761428434927,&quot;y&quot;:-15.1722763283521},&quot;rotate&quot;:-0.04903278895355655,&quot;skewX&quot;:0.05563510897168514,&quot;scale&quot;:{&quot;x&quot;:0.15747703678324385,&quot;y&quot;:0.0920249516499932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2&quot;}},&quot;4bc2ca67-3b95-448a-a9e1-d050eb63fd23&quot;:{&quot;type&quot;:&quot;FIGURE_OBJECT&quot;,&quot;id&quot;:&quot;4bc2ca67-3b95-448a-a9e1-d050eb63fd23&quot;,&quot;name&quot;:&quot;Spheroidal cell&quot;,&quot;relativeTransform&quot;:{&quot;translate&quot;:{&quot;x&quot;:6.224521886152677,&quot;y&quot;:17.218462161979325},&quot;rotate&quot;:-1.7846385290398883,&quot;skewX&quot;:-0.23169099291879855,&quot;scale&quot;:{&quot;x&quot;:0.09320882656316883,&quot;y&quot;:0.1554768709178088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5&quot;}},&quot;05f874b7-ccce-4ed0-af12-1f618cf9df08&quot;:{&quot;type&quot;:&quot;FIGURE_OBJECT&quot;,&quot;id&quot;:&quot;05f874b7-ccce-4ed0-af12-1f618cf9df08&quot;,&quot;name&quot;:&quot;Spheroidal cell&quot;,&quot;relativeTransform&quot;:{&quot;translate&quot;:{&quot;x&quot;:36.81280325856201,&quot;y&quot;:-15.172630928442713},&quot;rotate&quot;:-2.931431735711825,&quot;skewX&quot;:-0.22807204878781118,&quot;scale&quot;:{&quot;x&quot;:0.15152885905234068,&quot;y&quot;:0.0956373379077347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&quot;}},&quot;e9170a20-58c0-44c0-ad26-d4e055c1faaf&quot;:{&quot;type&quot;:&quot;FIGURE_OBJECT&quot;,&quot;id&quot;:&quot;e9170a20-58c0-44c0-ad26-d4e055c1faaf&quot;,&quot;name&quot;:&quot;Spheroidal cell&quot;,&quot;relativeTransform&quot;:{&quot;translate&quot;:{&quot;x&quot;:-25.360090131766835,&quot;y&quot;:28.13378015320774},&quot;rotate&quot;:2.9762120695107392,&quot;skewX&quot;:0.1826732519111916,&quot;scale&quot;:{&quot;x&quot;:0.153822137438127,&quot;y&quot;:0.0942115155680460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2&quot;}},&quot;8dc402cc-58ab-4c82-a3da-59e4e1b5368a&quot;:{&quot;type&quot;:&quot;FIGURE_OBJECT&quot;,&quot;id&quot;:&quot;8dc402cc-58ab-4c82-a3da-59e4e1b5368a&quot;,&quot;name&quot;:&quot;Spheroidal cell&quot;,&quot;relativeTransform&quot;:{&quot;translate&quot;:{&quot;x&quot;:-16.100024024192354,&quot;y&quot;:-3.688477714766073},&quot;rotate&quot;:2.4774495271634254,&quot;skewX&quot;:0.5045139632431672,&quot;scale&quot;:{&quot;x&quot;:0.11955608588347261,&quot;y&quot;:0.121213542488225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5&quot;}},&quot;9c5d3df9-acd4-48b2-ba99-de3704f20974&quot;:{&quot;type&quot;:&quot;FIGURE_OBJECT&quot;,&quot;id&quot;:&quot;9c5d3df9-acd4-48b2-ba99-de3704f20974&quot;,&quot;name&quot;:&quot;Spheroidal cell&quot;,&quot;relativeTransform&quot;:{&quot;translate&quot;:{&quot;x&quot;:38.27992794850325,&quot;y&quot;:8.016880765852614},&quot;rotate&quot;:1.9024858372198619,&quot;skewX&quot;:0.33691651854106114,&quot;scale&quot;:{&quot;x&quot;:0.09521061475176545,&quot;y&quot;:0.1522079941794886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&quot;}},&quot;81dc45dc-8271-4f3f-9e74-875aa34b8fc9&quot;:{&quot;type&quot;:&quot;FIGURE_OBJECT&quot;,&quot;id&quot;:&quot;81dc45dc-8271-4f3f-9e74-875aa34b8fc9&quot;,&quot;name&quot;:&quot;Spheroidal cell&quot;,&quot;relativeTransform&quot;:{&quot;translate&quot;:{&quot;x&quot;:-14.750562463610251,&quot;y&quot;:17.667624441741154},&quot;rotate&quot;:1.3100682807713566,&quot;skewX&quot;:-0.2761173365540062,&quot;scale&quot;:{&quot;x&quot;:0.09389711816491687,&quot;y&quot;:0.1543371828569800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2&quot;}},&quot;5a786d8a-65b8-4605-bd1a-b3929d922cc7&quot;:{&quot;type&quot;:&quot;FIGURE_OBJECT&quot;,&quot;id&quot;:&quot;5a786d8a-65b8-4605-bd1a-b3929d922cc7&quot;,&quot;name&quot;:&quot;Spheroidal cell&quot;,&quot;relativeTransform&quot;:{&quot;translate&quot;:{&quot;x&quot;:26.94092764963195,&quot;y&quot;:-4.129120720665408},&quot;rotate&quot;:0.19240739639058355,&quot;skewX&quot;:-0.2103697253931654,&quot;scale&quot;:{&quot;x&quot;:0.1524877170143775,&quot;y&quot;:0.0950359607954249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5&quot;}},&quot;cd39a473-eb36-4e7c-aa55-7ad4e1383139&quot;:{&quot;type&quot;:&quot;FIGURE_OBJECT&quot;,&quot;id&quot;:&quot;cd39a473-eb36-4e7c-aa55-7ad4e1383139&quot;,&quot;name&quot;:&quot;Spheroidal cell&quot;,&quot;relativeTransform&quot;:{&quot;translate&quot;:{&quot;x&quot;:-4.734994663181028,&quot;y&quot;:27.597581402745778},&quot;rotate&quot;:2.007270146731144,&quot;skewX&quot;:0.4110222361829166,&quot;scale&quot;:{&quot;x&quot;:0.09155760461031981,&quot;y&quot;:0.1387985394518730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8&quot;}},&quot;cab82327-16a1-4437-a672-eed1657aed59&quot;:{&quot;type&quot;:&quot;FIGURE_OBJECT&quot;,&quot;id&quot;:&quot;cab82327-16a1-4437-a672-eed1657aed59&quot;,&quot;name&quot;:&quot;Spheroidal cell&quot;,&quot;relativeTransform&quot;:{&quot;translate&quot;:{&quot;x&quot;:46.97789185639535,&quot;y&quot;:-3.6955206117122055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85&quot;}},&quot;69cee881-4524-47c3-8953-ade152aa39c3&quot;:{&quot;type&quot;:&quot;FIGURE_OBJECT&quot;,&quot;id&quot;:&quot;69cee881-4524-47c3-8953-ade152aa39c3&quot;,&quot;name&quot;:&quot;Spheroidal cell&quot;,&quot;relativeTransform&quot;:{&quot;translate&quot;:{&quot;x&quot;:58.33393055617962,&quot;y&quot;:6.463736283693512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9&quot;}},&quot;e41eec1d-3196-45a6-82cf-753d1e42e3fa&quot;:{&quot;type&quot;:&quot;FIGURE_OBJECT&quot;,&quot;id&quot;:&quot;e41eec1d-3196-45a6-82cf-753d1e42e3fa&quot;,&quot;relativeTransform&quot;:{&quot;translate&quot;:{&quot;x&quot;:-340.9557589709548,&quot;y&quot;:-10.46770226935675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8&quot;}},&quot;8c1f0d3b-62cb-45cf-903b-2957e7ae9337&quot;:{&quot;id&quot;:&quot;8c1f0d3b-62cb-45cf-903b-2957e7ae9337&quot;,&quot;type&quot;:&quot;FIGURE_OBJECT&quot;,&quot;relativeTransform&quot;:{&quot;translate&quot;:{&quot;x&quot;:-352.3938578673129,&quot;y&quot;:14.733873165822494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6]}],&quot;text&quot;:&quot;DMOG or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5% O2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5,&quot;runIndex&quot;:-1,&quot;charIndex&quot;:-1,&quot;endOfLine&quot;:true}},&quot;format&quot;:&quot;BETTER_TEXT&quot;,&quot;size&quot;:{&quot;x&quot;:107.4680801421614,&quot;y&quot;:148.56},&quot;targetSize&quot;:{&quot;x&quot;:107.4680801421614,&quot;y&quot;:91.32}},&quot;parent&quot;:{&quot;type&quot;:&quot;CHILD&quot;,&quot;parentId&quot;:&quot;8563537e-9ecc-4632-9afc-00afd7e3699c&quot;,&quot;order&quot;:&quot;99999999999999975&quot;}},&quot;ca618793-9cbd-4c31-8f3f-49468f7fc775&quot;:{&quot;id&quot;:&quot;ca618793-9cbd-4c31-8f3f-49468f7fc775&quot;,&quot;type&quot;:&quot;FIGURE_OBJECT&quot;,&quot;relativeTransform&quot;:{&quot;translate&quot;:{&quot;x&quot;:190.67546179576016,&quot;y&quot;:67.84973298277436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1]}],&quot;text&quot;:&quot;Progesterone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8&quot;}},&quot;fdab5c3b-8357-4917-9845-f1f64d6e575a&quot;:{&quot;id&quot;:&quot;fdab5c3b-8357-4917-9845-f1f64d6e575a&quot;,&quot;type&quot;:&quot;FIGURE_OBJECT&quot;,&quot;relativeTransform&quot;:{&quot;translate&quot;:{&quot;x&quot;:200.85194242041183,&quot;y&quot;:4.18741945072587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3}},&quot;format&quot;:&quot;BETTER_TEXT&quot;,&quot;size&quot;:{&quot;x&quot;:189.6977081298828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&quot;}},&quot;d5ddadf7-0730-4e76-a49f-2bd78b45341f&quot;:{&quot;relativeTransform&quot;:{&quot;translate&quot;:{&quot;x&quot;:-123.48813841370996,&quot;y&quot;:-11.157564975970843},&quot;rotate&quot;:0,&quot;skewX&quot;:0,&quot;scale&quot;:{&quot;x&quot;:1,&quot;y&quot;:1}},&quot;type&quot;:&quot;FIGURE_OBJECT&quot;,&quot;id&quot;:&quot;d5ddadf7-0730-4e76-a49f-2bd78b45341f&quot;,&quot;name&quot;:&quot;Petri dish with cells&quot;,&quot;displayName&quot;:&quot;Petri dish with cells&quot;,&quot;opacity&quot;:1,&quot;source&quot;:{&quot;id&quot;:&quot;5f6126e51ad2c000b63ff478&quot;,&quot;type&quot;:&quot;ASSETS&quot;},&quot;pathStyles&quot;:[{&quot;type&quot;:&quot;FILL&quot;,&quot;fillStyle&quot;:&quot;rgb(0,0,0)&quot;}],&quot;isLocked&quot;:false,&quot;parent&quot;:{&quot;type&quot;:&quot;CHILD&quot;,&quot;parentId&quot;:&quot;8563537e-9ecc-4632-9afc-00afd7e3699c&quot;,&quot;order&quot;:&quot;9999999999999999999999999999999999&quot;},&quot;isPremium&quot;:true},&quot;2a83b3a6-a5c5-4a9a-8523-953e6226815f&quot;:{&quot;type&quot;:&quot;FIGURE_OBJECT&quot;,&quot;id&quot;:&quot;2a83b3a6-a5c5-4a9a-8523-953e6226815f&quot;,&quot;name&quot;:&quot;Petri dish&quot;,&quot;relativeTransform&quot;:{&quot;translate&quot;:{&quot;x&quot;:0,&quot;y&quot;:5.608524144431269e-14},&quot;rotate&quot;:0,&quot;skewX&quot;:0,&quot;scale&quot;:{&quot;x&quot;:0.6071766165134398,&quot;y&quot;:0.6071766165134398}},&quot;opacity&quot;:1,&quot;image&quot;:{&quot;url&quot;:&quot;https://icons.biorender.com/biorender/5ee0f3bac4e9c30027d95cee/20200611181518/image/petri-dish-2.png&quot;,&quot;fallbackUrl&quot;:&quot;https://res.cloudinary.com/dlcjuc3ej/image/upload/v1591899318/jdx6mgytawhncb5ao57x.svg#/keystone/api/icons/5ee0f3bac4e9c30027d95cee/20200611181518/image/petri-dish-2.svg&quot;,&quot;size&quot;:{&quot;x&quot;:325,&quot;y&quot;:243},&quot;isPremium&quot;:false},&quot;source&quot;:{&quot;id&quot;:&quot;5ee0f3bac4e9c30027d95cee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02&quot;},&quot;styles&quot;:{&quot;petriDish&quot;:[{&quot;styleName&quot;:&quot;MONOCHROME_COLOR&quot;,&quot;index&quot;:0,&quot;color&quot;:&quot;#FF0D00&quot;}],&quot;liquid&quot;:[{&quot;styleName&quot;:&quot;MONOCHROME_COLOR&quot;,&quot;index&quot;:0,&quot;color&quot;:&quot;#FF0D00&quot;}]}},&quot;42512d50-6840-4d76-830e-be72f76c9ba6&quot;:{&quot;type&quot;:&quot;FIGURE_OBJECT&quot;,&quot;id&quot;:&quot;42512d50-6840-4d76-830e-be72f76c9ba6&quot;,&quot;name&quot;:&quot;Spheroidal cell&quot;,&quot;relativeTransform&quot;:{&quot;translate&quot;:{&quot;x&quot;:-35.94816670623872,&quot;y&quot;:17.667452063677587},&quot;rotate&quot;:0,&quot;skewX&quot;:0,&quot;scale&quot;:{&quot;x&quot;:0.15784657354899181,&quot;y&quot;:0.091809510780823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05&quot;},&quot;styles&quot;:{&quot;cell&quot;:[{&quot;monochromeTargetColor&quot;:&quot;#FF0D00&quot;,&quot;styleName&quot;:&quot;FILL&quot;,&quot;color&quot;:&quot;#ff2924&quot;},{&quot;monochromeTargetColor&quot;:&quot;#FF0D00&quot;,&quot;styleName&quot;:&quot;STROKE&quot;,&quot;color&quot;:&quot;#ff0806&quot;}],&quot;nucleus&quot;:[{&quot;monochromeTargetColor&quot;:&quot;#FF0D00&quot;,&quot;styleName&quot;:&quot;FILL&quot;,&quot;color&quot;:&quot;#ff1410&quot;},{&quot;monochromeTargetColor&quot;:&quot;#FF0D00&quot;,&quot;styleName&quot;:&quot;STROKE&quot;,&quot;color&quot;:&quot;#ff0f0c&quot;}]}},&quot;4b9cbe9b-c92f-454f-bf80-da3a9304d28e&quot;:{&quot;type&quot;:&quot;FIGURE_OBJECT&quot;,&quot;id&quot;:&quot;4b9cbe9b-c92f-454f-bf80-da3a9304d28e&quot;,&quot;name&quot;:&quot;Spheroidal cell&quot;,&quot;relativeTransform&quot;:{&quot;translate&quot;:{&quot;x&quot;:18.13054297598798,&quot;y&quot;:6.823000424368783},&quot;rotate&quot;:-0.8441643388031763,&quot;skewX&quot;:0.5142096794425836,&quot;scale&quot;:{&quot;x&quot;:0.109115702397623,&quot;y&quot;:0.1328114687210952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&quot;},&quot;styles&quot;:{&quot;&quot;:[{&quot;styleName&quot;:&quot;MONOCHROME_COLOR&quot;,&quot;index&quot;:0,&quot;color&quot;:&quot;#FF0D00&quot;}]}},&quot;d5e04ab6-af8b-419e-97d2-2d40b351f1b0&quot;:{&quot;type&quot;:&quot;FIGURE_OBJECT&quot;,&quot;id&quot;:&quot;d5e04ab6-af8b-419e-97d2-2d40b351f1b0&quot;,&quot;name&quot;:&quot;Spheroidal cell&quot;,&quot;relativeTransform&quot;:{&quot;translate&quot;:{&quot;x&quot;:-25.666075796752715,&quot;y&quot;:7.25960221562042},&quot;rotate&quot;:-0.9242877860074409,&quot;skewX&quot;:0.5005509573056879,&quot;scale&quot;:{&quot;x&quot;:0.10532127007158326,&quot;y&quot;:0.137596296418687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2&quot;},&quot;styles&quot;:{&quot;&quot;:[{&quot;styleName&quot;:&quot;MONOCHROME_COLOR&quot;,&quot;index&quot;:0,&quot;color&quot;:&quot;#FF0D00&quot;}]}},&quot;d9e8de39-b83b-4709-9da2-1667f9f379f5&quot;:{&quot;type&quot;:&quot;FIGURE_OBJECT&quot;,&quot;id&quot;:&quot;d9e8de39-b83b-4709-9da2-1667f9f379f5&quot;,&quot;name&quot;:&quot;Spheroidal cell&quot;,&quot;relativeTransform&quot;:{&quot;translate&quot;:{&quot;x&quot;:-27.037268676931472,&quot;y&quot;:-14.148816604714987},&quot;rotate&quot;:-1.9669828044671898,&quot;skewX&quot;:-0.38482140423679745,&quot;scale&quot;:{&quot;x&quot;:0.0966973626519624,&quot;y&quot;:0.1498677554228841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5&quot;},&quot;styles&quot;:{&quot;&quot;:[{&quot;styleName&quot;:&quot;MONOCHROME_COLOR&quot;,&quot;index&quot;:0,&quot;color&quot;:&quot;#FF0D00&quot;}]}},&quot;d50be6de-f0aa-4b62-ad3f-3db24efe407a&quot;:{&quot;type&quot;:&quot;FIGURE_OBJECT&quot;,&quot;id&quot;:&quot;d50be6de-f0aa-4b62-ad3f-3db24efe407a&quot;,&quot;name&quot;:&quot;Spheroidal cell&quot;,&quot;relativeTransform&quot;:{&quot;translate&quot;:{&quot;x&quot;:6.22442247159574,&quot;y&quot;:-4.1354271764679575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&quot;},&quot;styles&quot;:{&quot;&quot;:[{&quot;styleName&quot;:&quot;MONOCHROME_COLOR&quot;,&quot;index&quot;:0,&quot;color&quot;:&quot;#FF0D00&quot;}]}},&quot;ff15a6bd-9585-4569-8486-931f6b9e2c2d&quot;:{&quot;type&quot;:&quot;FIGURE_OBJECT&quot;,&quot;id&quot;:&quot;ff15a6bd-9585-4569-8486-931f6b9e2c2d&quot;,&quot;name&quot;:&quot;Spheroidal cell&quot;,&quot;relativeTransform&quot;:{&quot;translate&quot;:{&quot;x&quot;:25.307956286786244,&quot;y&quot;:-25.434303978061937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2&quot;},&quot;styles&quot;:{&quot;&quot;:[{&quot;styleName&quot;:&quot;MONOCHROME_COLOR&quot;,&quot;index&quot;:0,&quot;color&quot;:&quot;#FF0D00&quot;}]}},&quot;d83416b5-b33b-43fb-872c-550175cbf600&quot;:{&quot;type&quot;:&quot;FIGURE_OBJECT&quot;,&quot;id&quot;:&quot;d83416b5-b33b-43fb-872c-550175cbf600&quot;,&quot;name&quot;:&quot;Spheroidal cell&quot;,&quot;relativeTransform&quot;:{&quot;translate&quot;:{&quot;x&quot;:-45.904258988878105,&quot;y&quot;:6.836275248689061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5&quot;},&quot;styles&quot;:{&quot;&quot;:[{&quot;styleName&quot;:&quot;MONOCHROME_COLOR&quot;,&quot;index&quot;:0,&quot;color&quot;:&quot;#FF0D00&quot;}]}},&quot;8509e4bc-4d63-44a4-94ad-fa24a57cdd7a&quot;:{&quot;type&quot;:&quot;FIGURE_OBJECT&quot;,&quot;id&quot;:&quot;8509e4bc-4d63-44a4-94ad-fa24a57cdd7a&quot;,&quot;name&quot;:&quot;Spheroidal cell&quot;,&quot;relativeTransform&quot;:{&quot;translate&quot;:{&quot;x&quot;:26.941907186973612,&quot;y&quot;:17.668650872453796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3&quot;},&quot;styles&quot;:{&quot;&quot;:[{&quot;styleName&quot;:&quot;MONOCHROME_COLOR&quot;,&quot;index&quot;:0,&quot;color&quot;:&quot;#FF0D00&quot;}]}},&quot;9b9e3d25-b789-4a21-a432-bbbbb0b640bb&quot;:{&quot;type&quot;:&quot;FIGURE_OBJECT&quot;,&quot;id&quot;:&quot;9b9e3d25-b789-4a21-a432-bbbbb0b640bb&quot;,&quot;name&quot;:&quot;Spheroidal cell&quot;,&quot;relativeTransform&quot;:{&quot;translate&quot;:{&quot;x&quot;:-4.734830595262368,&quot;y&quot;:6.836083564854624},&quot;rotate&quot;:0.7464574379873126,&quot;skewX&quot;:-0.5158759485514509,&quot;scale&quot;:{&quot;x&quot;:0.11445735108071943,&quot;y&quot;:0.1266132455375633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35&quot;},&quot;styles&quot;:{&quot;&quot;:[{&quot;styleName&quot;:&quot;MONOCHROME_COLOR&quot;,&quot;index&quot;:0,&quot;color&quot;:&quot;#FF0D00&quot;}]}},&quot;1d04420f-04ad-4b92-b4b5-c6fe651a33f5&quot;:{&quot;type&quot;:&quot;FIGURE_OBJECT&quot;,&quot;id&quot;:&quot;1d04420f-04ad-4b92-b4b5-c6fe651a33f5&quot;,&quot;name&quot;:&quot;Spheroidal cell&quot;,&quot;relativeTransform&quot;:{&quot;translate&quot;:{&quot;x&quot;:-6.68555595462649,&quot;y&quot;:-14.803466749408686},&quot;rotate&quot;:0.213734288930394,&quot;skewX&quot;:-0.23158516584838867,&quot;scale&quot;:{&quot;x&quot;:0.15132853682888134,&quot;y&quot;:0.09576393851180379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4&quot;},&quot;styles&quot;:{&quot;&quot;:[{&quot;styleName&quot;:&quot;MONOCHROME_COLOR&quot;,&quot;index&quot;:0,&quot;color&quot;:&quot;#FF0D00&quot;}]}},&quot;7312d6db-f458-46d1-9331-82a2cef99657&quot;:{&quot;type&quot;:&quot;FIGURE_OBJECT&quot;,&quot;id&quot;:&quot;7312d6db-f458-46d1-9331-82a2cef99657&quot;,&quot;name&quot;:&quot;Spheroidal cell&quot;,&quot;relativeTransform&quot;:{&quot;translate&quot;:{&quot;x&quot;:-18.09248556476985,&quot;y&quot;:-25.14594105576579},&quot;rotate&quot;:2.8082484065025266,&quot;skewX&quot;:0.3382353591056591,&quot;scale&quot;:{&quot;x&quot;:0.14353196763903742,&quot;y&quot;:0.10096577741069561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&quot;},&quot;styles&quot;:{&quot;&quot;:[{&quot;styleName&quot;:&quot;MONOCHROME_COLOR&quot;,&quot;index&quot;:0,&quot;color&quot;:&quot;#FF0D00&quot;}]}},&quot;ad44f701-ebe9-4524-ae5d-b0ab4c0bc21e&quot;:{&quot;type&quot;:&quot;FIGURE_OBJECT&quot;,&quot;id&quot;:&quot;ad44f701-ebe9-4524-ae5d-b0ab4c0bc21e&quot;,&quot;name&quot;:&quot;Spheroidal cell&quot;,&quot;relativeTransform&quot;:{&quot;translate&quot;:{&quot;x&quot;:14.414761428434927,&quot;y&quot;:-15.1722763283521},&quot;rotate&quot;:-0.04903278895355655,&quot;skewX&quot;:0.05563510897168514,&quot;scale&quot;:{&quot;x&quot;:0.15747703678324385,&quot;y&quot;:0.0920249516499932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2&quot;},&quot;styles&quot;:{&quot;&quot;:[{&quot;styleName&quot;:&quot;MONOCHROME_COLOR&quot;,&quot;index&quot;:0,&quot;color&quot;:&quot;#FF0D00&quot;}]}},&quot;7aff5a26-5a34-4b0d-ab7a-d6281b4e9714&quot;:{&quot;type&quot;:&quot;FIGURE_OBJECT&quot;,&quot;id&quot;:&quot;7aff5a26-5a34-4b0d-ab7a-d6281b4e9714&quot;,&quot;name&quot;:&quot;Spheroidal cell&quot;,&quot;relativeTransform&quot;:{&quot;translate&quot;:{&quot;x&quot;:6.224521886152677,&quot;y&quot;:17.218462161979325},&quot;rotate&quot;:-1.7846385290398883,&quot;skewX&quot;:-0.23169099291879855,&quot;scale&quot;:{&quot;x&quot;:0.09320882656316883,&quot;y&quot;:0.1554768709178088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5&quot;},&quot;styles&quot;:{&quot;&quot;:[{&quot;styleName&quot;:&quot;MONOCHROME_COLOR&quot;,&quot;index&quot;:0,&quot;color&quot;:&quot;#FF0D00&quot;}]}},&quot;328b10f5-1313-4cd1-aa72-365e737e4350&quot;:{&quot;type&quot;:&quot;FIGURE_OBJECT&quot;,&quot;id&quot;:&quot;328b10f5-1313-4cd1-aa72-365e737e4350&quot;,&quot;name&quot;:&quot;Spheroidal cell&quot;,&quot;relativeTransform&quot;:{&quot;translate&quot;:{&quot;x&quot;:36.81280325856201,&quot;y&quot;:-15.172630928442713},&quot;rotate&quot;:-2.931431735711825,&quot;skewX&quot;:-0.22807204878781118,&quot;scale&quot;:{&quot;x&quot;:0.15152885905234068,&quot;y&quot;:0.0956373379077347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&quot;},&quot;styles&quot;:{&quot;&quot;:[{&quot;styleName&quot;:&quot;MONOCHROME_COLOR&quot;,&quot;index&quot;:0,&quot;color&quot;:&quot;#FF0D00&quot;}]}},&quot;6a50141e-9fee-44b9-9a93-7b0b034add00&quot;:{&quot;type&quot;:&quot;FIGURE_OBJECT&quot;,&quot;id&quot;:&quot;6a50141e-9fee-44b9-9a93-7b0b034add00&quot;,&quot;name&quot;:&quot;Spheroidal cell&quot;,&quot;relativeTransform&quot;:{&quot;translate&quot;:{&quot;x&quot;:-25.360090131766835,&quot;y&quot;:28.13378015320774},&quot;rotate&quot;:2.9762120695107392,&quot;skewX&quot;:0.1826732519111916,&quot;scale&quot;:{&quot;x&quot;:0.153822137438127,&quot;y&quot;:0.0942115155680460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2&quot;},&quot;styles&quot;:{&quot;&quot;:[{&quot;styleName&quot;:&quot;MONOCHROME_COLOR&quot;,&quot;index&quot;:0,&quot;color&quot;:&quot;#FF0D00&quot;}]}},&quot;3782474d-f16b-45d7-b83c-90ad7acbad8e&quot;:{&quot;type&quot;:&quot;FIGURE_OBJECT&quot;,&quot;id&quot;:&quot;3782474d-f16b-45d7-b83c-90ad7acbad8e&quot;,&quot;name&quot;:&quot;Spheroidal cell&quot;,&quot;relativeTransform&quot;:{&quot;translate&quot;:{&quot;x&quot;:-16.100024024192354,&quot;y&quot;:-3.688477714766073},&quot;rotate&quot;:2.4774495271634254,&quot;skewX&quot;:0.5045139632431672,&quot;scale&quot;:{&quot;x&quot;:0.11955608588347261,&quot;y&quot;:0.121213542488225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5&quot;},&quot;styles&quot;:{&quot;&quot;:[{&quot;styleName&quot;:&quot;MONOCHROME_COLOR&quot;,&quot;index&quot;:0,&quot;color&quot;:&quot;#FF0D00&quot;}]}},&quot;79a4b294-6fd6-4684-bbdc-731748bff801&quot;:{&quot;type&quot;:&quot;FIGURE_OBJECT&quot;,&quot;id&quot;:&quot;79a4b294-6fd6-4684-bbdc-731748bff801&quot;,&quot;name&quot;:&quot;Spheroidal cell&quot;,&quot;relativeTransform&quot;:{&quot;translate&quot;:{&quot;x&quot;:38.27992794850325,&quot;y&quot;:8.016880765852614},&quot;rotate&quot;:1.9024858372198619,&quot;skewX&quot;:0.33691651854106114,&quot;scale&quot;:{&quot;x&quot;:0.09521061475176545,&quot;y&quot;:0.1522079941794886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&quot;},&quot;styles&quot;:{&quot;&quot;:[{&quot;styleName&quot;:&quot;MONOCHROME_COLOR&quot;,&quot;index&quot;:0,&quot;color&quot;:&quot;#FF0D00&quot;}]}},&quot;bc1efc4e-acae-4458-93fd-1b4c4d3c331e&quot;:{&quot;type&quot;:&quot;FIGURE_OBJECT&quot;,&quot;id&quot;:&quot;bc1efc4e-acae-4458-93fd-1b4c4d3c331e&quot;,&quot;name&quot;:&quot;Spheroidal cell&quot;,&quot;relativeTransform&quot;:{&quot;translate&quot;:{&quot;x&quot;:-14.750562463610251,&quot;y&quot;:17.667624441741154},&quot;rotate&quot;:1.3100682807713566,&quot;skewX&quot;:-0.2761173365540062,&quot;scale&quot;:{&quot;x&quot;:0.09389711816491687,&quot;y&quot;:0.1543371828569800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2&quot;},&quot;styles&quot;:{&quot;&quot;:[{&quot;styleName&quot;:&quot;MONOCHROME_COLOR&quot;,&quot;index&quot;:0,&quot;color&quot;:&quot;#FF0D00&quot;}]}},&quot;c35a2c28-9e05-4c59-9556-98792bc5b8dc&quot;:{&quot;type&quot;:&quot;FIGURE_OBJECT&quot;,&quot;id&quot;:&quot;c35a2c28-9e05-4c59-9556-98792bc5b8dc&quot;,&quot;name&quot;:&quot;Spheroidal cell&quot;,&quot;relativeTransform&quot;:{&quot;translate&quot;:{&quot;x&quot;:26.94092764963195,&quot;y&quot;:-4.129120720665408},&quot;rotate&quot;:0.19240739639058355,&quot;skewX&quot;:-0.2103697253931654,&quot;scale&quot;:{&quot;x&quot;:0.1524877170143775,&quot;y&quot;:0.0950359607954249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5&quot;},&quot;styles&quot;:{&quot;&quot;:[{&quot;styleName&quot;:&quot;MONOCHROME_COLOR&quot;,&quot;index&quot;:0,&quot;color&quot;:&quot;#FF0D00&quot;}]}},&quot;c415f798-048e-4b08-b21a-9a5087f41ff9&quot;:{&quot;type&quot;:&quot;FIGURE_OBJECT&quot;,&quot;id&quot;:&quot;c415f798-048e-4b08-b21a-9a5087f41ff9&quot;,&quot;name&quot;:&quot;Spheroidal cell&quot;,&quot;relativeTransform&quot;:{&quot;translate&quot;:{&quot;x&quot;:-4.734994663181028,&quot;y&quot;:27.597581402745778},&quot;rotate&quot;:2.007270146731144,&quot;skewX&quot;:0.4110222361829166,&quot;scale&quot;:{&quot;x&quot;:0.09155760461031981,&quot;y&quot;:0.1387985394518730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8&quot;},&quot;styles&quot;:{&quot;&quot;:[{&quot;styleName&quot;:&quot;MONOCHROME_COLOR&quot;,&quot;index&quot;:0,&quot;color&quot;:&quot;#FF0D00&quot;}]}},&quot;12949984-9fdc-4741-989c-7438dcbc1b22&quot;:{&quot;type&quot;:&quot;FIGURE_OBJECT&quot;,&quot;id&quot;:&quot;12949984-9fdc-4741-989c-7438dcbc1b22&quot;,&quot;name&quot;:&quot;Spheroidal cell&quot;,&quot;relativeTransform&quot;:{&quot;translate&quot;:{&quot;x&quot;:46.97789185639535,&quot;y&quot;:-3.6955206117122055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85&quot;},&quot;styles&quot;:{&quot;&quot;:[{&quot;styleName&quot;:&quot;MONOCHROME_COLOR&quot;,&quot;index&quot;:0,&quot;color&quot;:&quot;#FF0D00&quot;}]}},&quot;41473d35-e20e-43dd-8486-904c120ef37a&quot;:{&quot;type&quot;:&quot;FIGURE_OBJECT&quot;,&quot;id&quot;:&quot;41473d35-e20e-43dd-8486-904c120ef37a&quot;,&quot;name&quot;:&quot;Spheroidal cell&quot;,&quot;relativeTransform&quot;:{&quot;translate&quot;:{&quot;x&quot;:58.33393055617962,&quot;y&quot;:6.463736283693512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9&quot;},&quot;styles&quot;:{&quot;&quot;:[{&quot;styleName&quot;:&quot;MONOCHROME_COLOR&quot;,&quot;index&quot;:0,&quot;color&quot;:&quot;#FF0D00&quot;}]}},&quot;9f7f6583-bb35-4329-833e-56fc4e73ba73&quot;:{&quot;type&quot;:&quot;FIGURE_OBJECT&quot;,&quot;id&quot;:&quot;9f7f6583-bb35-4329-833e-56fc4e73ba73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d9bd02e7-08a7-44cb-91ef-b277982807c8&quot;:{&quot;type&quot;:&quot;FIGURE_OBJECT&quot;,&quot;id&quot;:&quot;d9bd02e7-08a7-44cb-91ef-b277982807c8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b21c5746-6502-4a3e-8c3b-f780e96fbd46&quot;:{&quot;type&quot;:&quot;FIGURE_OBJECT&quot;,&quot;id&quot;:&quot;b21c5746-6502-4a3e-8c3b-f780e96fbd46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b6e60238-7a0b-47be-96f3-15dfb46160c0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b6e60238-7a0b-47be-96f3-15dfb46160c0&quot;:{&quot;type&quot;:&quot;FIGURE_OBJECT&quot;,&quot;id&quot;:&quot;b6e60238-7a0b-47be-96f3-15dfb46160c0&quot;,&quot;parent&quot;:{&quot;type&quot;:&quot;CHILD&quot;,&quot;parentId&quot;:&quot;8563537e-9ecc-4632-9afc-00afd7e3699c&quot;,&quot;order&quot;:&quot;99999999999999999999999998&quot;},&quot;relativeTransform&quot;:{&quot;translate&quot;:{&quot;x&quot;:-236.4160277239672,&quot;y&quot;:-10.117289381498281},&quot;rotate&quot;:-1.5707963267948966,&quot;skewX&quot;:0,&quot;scale&quot;:{&quot;x&quot;:1,&quot;y&quot;:1}}},&quot;af357b87-1477-449c-8986-1c935208e987&quot;:{&quot;id&quot;:&quot;af357b87-1477-449c-8986-1c935208e987&quot;,&quot;type&quot;:&quot;FIGURE_OBJECT&quot;,&quot;relativeTransform&quot;:{&quot;translate&quot;:{&quot;x&quot;:190.6763409296052,&quot;y&quot;:-71.284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],&quot;verticalAlign&quot;:&quot;TOP&quot;,&quot;useStrokeForWeight&quot;:false,&quot;_lastCaretLocation&quot;:{&quot;lineIndex&quot;:0,&quot;runIndex&quot;:0,&quot;charIndex&quot;:2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5&quot;}},&quot;05e63131-8e15-4362-a850-11d39e9751eb&quot;:{&quot;type&quot;:&quot;FIGURE_OBJECT&quot;,&quot;id&quot;:&quot;05e63131-8e15-4362-a850-11d39e9751eb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8&quot;},&quot;connectorInfo&quot;:{&quot;connectedObjects&quot;:[],&quot;type&quot;:&quot;ELBOW&quot;,&quot;offset&quot;:{&quot;x&quot;:0,&quot;y&quot;:0},&quot;bending&quot;:-0.1,&quot;firstElementIsHead&quot;:true,&quot;customized&quot;:false}}}}"/>
    <we:property name="660568f51927813db44fbf54_1717140951933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66.29117599212623,&quot;y&quot;:17.088778983441955},&quot;rotate&quot;:0,&quot;skewX&quot;:0,&quot;scale&quot;:{&quot;x&quot;:1,&quot;y&quot;:1}},&quot;path&quot;:{&quot;type&quot;:&quot;RECT&quot;,&quot;size&quot;:{&quot;x&quot;:1263.7844000901623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535.7149671949715,&quot;y&quot;:82.84160442360896},&quot;rotate&quot;:0,&quot;skewX&quot;:0,&quot;scale&quot;:{&quot;x&quot;:1,&quot;y&quot;:1}},&quot;text&quot;:{&quot;textData&quot;:{&quot;lineSpacing&quot;:&quot;normal&quot;,&quot;alignment&quot;:&quot;center&quot;,&quot;lines&quot;:[{&quot;runs&quot;:[{&quot;range&quot;:[0,12],&quot;style&quot;:{&quot;fontWeight&quot;:&quot;bold&quot;,&quot;fontStyle&quot;:&quot;normal&quot;,&quot;fontSize&quot;:18.666666666666664,&quot;fontFamily&quot;:&quot;Roboto&quot;,&quot;color&quot;:&quot;black&quot;,&quot;decoration&quot;:&quot;none&quot;}}],&quot;text&quot;:&quot;Y1- Ad. Cells&quot;}],&quot;verticalAlign&quot;:&quot;TOP&quot;,&quot;_lastCaretLocation&quot;:{&quot;lineIndex&quot;:0,&quot;runIndex&quot;:0,&quot;charIndex&quot;:8}},&quot;format&quot;:&quot;BETTER_TEXT&quot;,&quot;size&quot;:{&quot;x&quot;:458.10963204412633,&quot;y&quot;:40.45495813527425},&quot;targetSize&quot;:{&quot;x&quot;:458.10963204412633,&quot;y&quot;:40.45495813527425},&quot;verticalAlign&quot;:&quot;TOP&quot;},&quot;parent&quot;:{&quot;type&quot;:&quot;CHILD&quot;,&quot;parentId&quot;:&quot;8563537e-9ecc-4632-9afc-00afd7e3699c&quot;,&quot;order&quot;:&quot;9999999999998&quot;}},&quot;b27a5ede-1d29-43d6-8f9a-ad70ce886ff4&quot;:{&quot;relativeTransform&quot;:{&quot;translate&quot;:{&quot;x&quot;:-535.7148472724849,&quot;y&quot;:-11.157564975970843},&quot;rotate&quot;:0,&quot;skewX&quot;:0,&quot;scale&quot;:{&quot;x&quot;:1,&quot;y&quot;:1}},&quot;type&quot;:&quot;FIGURE_OBJECT&quot;,&quot;id&quot;:&quot;b27a5ede-1d29-43d6-8f9a-ad70ce886ff4&quot;,&quot;name&quot;:&quot;Petri dish with cells&quot;,&quot;displayName&quot;:&quot;Petri dish with cells&quot;,&quot;opacity&quot;:1,&quot;source&quot;:{&quot;id&quot;:&quot;5f6126e51ad2c000b63ff478&quot;,&quot;type&quot;:&quot;ASSETS&quot;},&quot;pathStyles&quot;:[{&quot;type&quot;:&quot;FILL&quot;,&quot;fillStyle&quot;:&quot;rgb(0,0,0)&quot;}],&quot;isLocked&quot;:false,&quot;parent&quot;:{&quot;type&quot;:&quot;CHILD&quot;,&quot;parentId&quot;:&quot;8563537e-9ecc-4632-9afc-00afd7e3699c&quot;,&quot;order&quot;:&quot;99999999999995&quot;},&quot;isPremium&quot;:true},&quot;0f94f3b9-cf76-41e3-8e93-4a9c32d0734b&quot;:{&quot;type&quot;:&quot;FIGURE_OBJECT&quot;,&quot;id&quot;:&quot;0f94f3b9-cf76-41e3-8e93-4a9c32d0734b&quot;,&quot;name&quot;:&quot;Petri dish&quot;,&quot;relativeTransform&quot;:{&quot;translate&quot;:{&quot;x&quot;:0,&quot;y&quot;:5.608524144431269e-14},&quot;rotate&quot;:0,&quot;skewX&quot;:0,&quot;scale&quot;:{&quot;x&quot;:0.6071766165134398,&quot;y&quot;:0.6071766165134398}},&quot;opacity&quot;:1,&quot;image&quot;:{&quot;url&quot;:&quot;https://icons.biorender.com/biorender/5ee0f3bac4e9c30027d95cee/20200611181518/image/petri-dish-2.png&quot;,&quot;fallbackUrl&quot;:&quot;https://res.cloudinary.com/dlcjuc3ej/image/upload/v1591899318/jdx6mgytawhncb5ao57x.svg#/keystone/api/icons/5ee0f3bac4e9c30027d95cee/20200611181518/image/petri-dish-2.svg&quot;,&quot;size&quot;:{&quot;x&quot;:325,&quot;y&quot;:243},&quot;isPremium&quot;:false},&quot;source&quot;:{&quot;id&quot;:&quot;5ee0f3bac4e9c30027d95cee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02&quot;}},&quot;80b5a369-5a07-4fbf-8e61-fd7e5cb9b993&quot;:{&quot;type&quot;:&quot;FIGURE_OBJECT&quot;,&quot;id&quot;:&quot;80b5a369-5a07-4fbf-8e61-fd7e5cb9b993&quot;,&quot;name&quot;:&quot;Spheroidal cell&quot;,&quot;relativeTransform&quot;:{&quot;translate&quot;:{&quot;x&quot;:-35.94816670623872,&quot;y&quot;:17.667452063677587},&quot;rotate&quot;:0,&quot;skewX&quot;:0,&quot;scale&quot;:{&quot;x&quot;:0.15784657354899181,&quot;y&quot;:0.091809510780823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05&quot;}},&quot;9f5041b7-8da0-40a3-9f57-8553129329b2&quot;:{&quot;type&quot;:&quot;FIGURE_OBJECT&quot;,&quot;id&quot;:&quot;9f5041b7-8da0-40a3-9f57-8553129329b2&quot;,&quot;name&quot;:&quot;Spheroidal cell&quot;,&quot;relativeTransform&quot;:{&quot;translate&quot;:{&quot;x&quot;:18.13054297598798,&quot;y&quot;:6.823000424368783},&quot;rotate&quot;:-0.8441643388031763,&quot;skewX&quot;:0.5142096794425836,&quot;scale&quot;:{&quot;x&quot;:0.109115702397623,&quot;y&quot;:0.1328114687210952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&quot;}},&quot;33e32d4a-2a6c-4972-9ace-f64760cf18e4&quot;:{&quot;type&quot;:&quot;FIGURE_OBJECT&quot;,&quot;id&quot;:&quot;33e32d4a-2a6c-4972-9ace-f64760cf18e4&quot;,&quot;name&quot;:&quot;Spheroidal cell&quot;,&quot;relativeTransform&quot;:{&quot;translate&quot;:{&quot;x&quot;:-25.666075796752715,&quot;y&quot;:7.25960221562042},&quot;rotate&quot;:-0.9242877860074409,&quot;skewX&quot;:0.5005509573056879,&quot;scale&quot;:{&quot;x&quot;:0.10532127007158326,&quot;y&quot;:0.137596296418687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2&quot;}},&quot;5b319b16-dbf1-42fc-a2c6-5deed5c1cecf&quot;:{&quot;type&quot;:&quot;FIGURE_OBJECT&quot;,&quot;id&quot;:&quot;5b319b16-dbf1-42fc-a2c6-5deed5c1cecf&quot;,&quot;name&quot;:&quot;Spheroidal cell&quot;,&quot;relativeTransform&quot;:{&quot;translate&quot;:{&quot;x&quot;:-27.037268676931472,&quot;y&quot;:-14.148816604714987},&quot;rotate&quot;:-1.9669828044671898,&quot;skewX&quot;:-0.38482140423679745,&quot;scale&quot;:{&quot;x&quot;:0.0966973626519624,&quot;y&quot;:0.1498677554228841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5&quot;}},&quot;85d5c287-9c1b-4109-9cd3-44ebe2b6c89b&quot;:{&quot;type&quot;:&quot;FIGURE_OBJECT&quot;,&quot;id&quot;:&quot;85d5c287-9c1b-4109-9cd3-44ebe2b6c89b&quot;,&quot;name&quot;:&quot;Spheroidal cell&quot;,&quot;relativeTransform&quot;:{&quot;translate&quot;:{&quot;x&quot;:6.22442247159574,&quot;y&quot;:-4.1354271764679575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&quot;}},&quot;e2a9a4b4-d9df-49c1-b70a-b6b1f9abbe24&quot;:{&quot;type&quot;:&quot;FIGURE_OBJECT&quot;,&quot;id&quot;:&quot;e2a9a4b4-d9df-49c1-b70a-b6b1f9abbe24&quot;,&quot;name&quot;:&quot;Spheroidal cell&quot;,&quot;relativeTransform&quot;:{&quot;translate&quot;:{&quot;x&quot;:25.307956286786244,&quot;y&quot;:-25.434303978061937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2&quot;}},&quot;2e4c8787-c235-414a-8928-3a113e4a8230&quot;:{&quot;type&quot;:&quot;FIGURE_OBJECT&quot;,&quot;id&quot;:&quot;2e4c8787-c235-414a-8928-3a113e4a8230&quot;,&quot;name&quot;:&quot;Spheroidal cell&quot;,&quot;relativeTransform&quot;:{&quot;translate&quot;:{&quot;x&quot;:-45.904258988878105,&quot;y&quot;:6.836275248689061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5&quot;}},&quot;f1eb5606-e506-457b-822b-9deb0032fe35&quot;:{&quot;type&quot;:&quot;FIGURE_OBJECT&quot;,&quot;id&quot;:&quot;f1eb5606-e506-457b-822b-9deb0032fe35&quot;,&quot;name&quot;:&quot;Spheroidal cell&quot;,&quot;relativeTransform&quot;:{&quot;translate&quot;:{&quot;x&quot;:26.941907186973612,&quot;y&quot;:17.668650872453796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3&quot;}},&quot;3ed3776e-4ee4-4fa8-bfc1-9053f3158897&quot;:{&quot;type&quot;:&quot;FIGURE_OBJECT&quot;,&quot;id&quot;:&quot;3ed3776e-4ee4-4fa8-bfc1-9053f3158897&quot;,&quot;name&quot;:&quot;Spheroidal cell&quot;,&quot;relativeTransform&quot;:{&quot;translate&quot;:{&quot;x&quot;:-4.734830595262368,&quot;y&quot;:6.836083564854624},&quot;rotate&quot;:0.7464574379873126,&quot;skewX&quot;:-0.5158759485514509,&quot;scale&quot;:{&quot;x&quot;:0.11445735108071943,&quot;y&quot;:0.1266132455375633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35&quot;}},&quot;c5bc723e-2569-40f1-866b-dae69b27d0e8&quot;:{&quot;type&quot;:&quot;FIGURE_OBJECT&quot;,&quot;id&quot;:&quot;c5bc723e-2569-40f1-866b-dae69b27d0e8&quot;,&quot;name&quot;:&quot;Spheroidal cell&quot;,&quot;relativeTransform&quot;:{&quot;translate&quot;:{&quot;x&quot;:-6.68555595462649,&quot;y&quot;:-14.803466749408686},&quot;rotate&quot;:0.213734288930394,&quot;skewX&quot;:-0.23158516584838867,&quot;scale&quot;:{&quot;x&quot;:0.15132853682888134,&quot;y&quot;:0.09576393851180379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4&quot;}},&quot;c990af1e-a89f-4a4f-a104-12022f09891a&quot;:{&quot;type&quot;:&quot;FIGURE_OBJECT&quot;,&quot;id&quot;:&quot;c990af1e-a89f-4a4f-a104-12022f09891a&quot;,&quot;name&quot;:&quot;Spheroidal cell&quot;,&quot;relativeTransform&quot;:{&quot;translate&quot;:{&quot;x&quot;:-18.09248556476985,&quot;y&quot;:-25.14594105576579},&quot;rotate&quot;:2.8082484065025266,&quot;skewX&quot;:0.3382353591056591,&quot;scale&quot;:{&quot;x&quot;:0.14353196763903742,&quot;y&quot;:0.10096577741069561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&quot;}},&quot;8d63e0cc-073d-4fbe-ba90-9dbe94d1fb20&quot;:{&quot;type&quot;:&quot;FIGURE_OBJECT&quot;,&quot;id&quot;:&quot;8d63e0cc-073d-4fbe-ba90-9dbe94d1fb20&quot;,&quot;name&quot;:&quot;Spheroidal cell&quot;,&quot;relativeTransform&quot;:{&quot;translate&quot;:{&quot;x&quot;:14.414761428434927,&quot;y&quot;:-15.1722763283521},&quot;rotate&quot;:-0.04903278895355655,&quot;skewX&quot;:0.05563510897168514,&quot;scale&quot;:{&quot;x&quot;:0.15747703678324385,&quot;y&quot;:0.0920249516499932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2&quot;}},&quot;4bc2ca67-3b95-448a-a9e1-d050eb63fd23&quot;:{&quot;type&quot;:&quot;FIGURE_OBJECT&quot;,&quot;id&quot;:&quot;4bc2ca67-3b95-448a-a9e1-d050eb63fd23&quot;,&quot;name&quot;:&quot;Spheroidal cell&quot;,&quot;relativeTransform&quot;:{&quot;translate&quot;:{&quot;x&quot;:6.224521886152677,&quot;y&quot;:17.218462161979325},&quot;rotate&quot;:-1.7846385290398883,&quot;skewX&quot;:-0.23169099291879855,&quot;scale&quot;:{&quot;x&quot;:0.09320882656316883,&quot;y&quot;:0.1554768709178088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5&quot;}},&quot;05f874b7-ccce-4ed0-af12-1f618cf9df08&quot;:{&quot;type&quot;:&quot;FIGURE_OBJECT&quot;,&quot;id&quot;:&quot;05f874b7-ccce-4ed0-af12-1f618cf9df08&quot;,&quot;name&quot;:&quot;Spheroidal cell&quot;,&quot;relativeTransform&quot;:{&quot;translate&quot;:{&quot;x&quot;:36.81280325856201,&quot;y&quot;:-15.172630928442713},&quot;rotate&quot;:-2.931431735711825,&quot;skewX&quot;:-0.22807204878781118,&quot;scale&quot;:{&quot;x&quot;:0.15152885905234068,&quot;y&quot;:0.0956373379077347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&quot;}},&quot;e9170a20-58c0-44c0-ad26-d4e055c1faaf&quot;:{&quot;type&quot;:&quot;FIGURE_OBJECT&quot;,&quot;id&quot;:&quot;e9170a20-58c0-44c0-ad26-d4e055c1faaf&quot;,&quot;name&quot;:&quot;Spheroidal cell&quot;,&quot;relativeTransform&quot;:{&quot;translate&quot;:{&quot;x&quot;:-25.360090131766835,&quot;y&quot;:28.13378015320774},&quot;rotate&quot;:2.9762120695107392,&quot;skewX&quot;:0.1826732519111916,&quot;scale&quot;:{&quot;x&quot;:0.153822137438127,&quot;y&quot;:0.0942115155680460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2&quot;}},&quot;8dc402cc-58ab-4c82-a3da-59e4e1b5368a&quot;:{&quot;type&quot;:&quot;FIGURE_OBJECT&quot;,&quot;id&quot;:&quot;8dc402cc-58ab-4c82-a3da-59e4e1b5368a&quot;,&quot;name&quot;:&quot;Spheroidal cell&quot;,&quot;relativeTransform&quot;:{&quot;translate&quot;:{&quot;x&quot;:-16.100024024192354,&quot;y&quot;:-3.688477714766073},&quot;rotate&quot;:2.4774495271634254,&quot;skewX&quot;:0.5045139632431672,&quot;scale&quot;:{&quot;x&quot;:0.11955608588347261,&quot;y&quot;:0.121213542488225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5&quot;}},&quot;9c5d3df9-acd4-48b2-ba99-de3704f20974&quot;:{&quot;type&quot;:&quot;FIGURE_OBJECT&quot;,&quot;id&quot;:&quot;9c5d3df9-acd4-48b2-ba99-de3704f20974&quot;,&quot;name&quot;:&quot;Spheroidal cell&quot;,&quot;relativeTransform&quot;:{&quot;translate&quot;:{&quot;x&quot;:38.27992794850325,&quot;y&quot;:8.016880765852614},&quot;rotate&quot;:1.9024858372198619,&quot;skewX&quot;:0.33691651854106114,&quot;scale&quot;:{&quot;x&quot;:0.09521061475176545,&quot;y&quot;:0.1522079941794886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&quot;}},&quot;81dc45dc-8271-4f3f-9e74-875aa34b8fc9&quot;:{&quot;type&quot;:&quot;FIGURE_OBJECT&quot;,&quot;id&quot;:&quot;81dc45dc-8271-4f3f-9e74-875aa34b8fc9&quot;,&quot;name&quot;:&quot;Spheroidal cell&quot;,&quot;relativeTransform&quot;:{&quot;translate&quot;:{&quot;x&quot;:-14.750562463610251,&quot;y&quot;:17.667624441741154},&quot;rotate&quot;:1.3100682807713566,&quot;skewX&quot;:-0.2761173365540062,&quot;scale&quot;:{&quot;x&quot;:0.09389711816491687,&quot;y&quot;:0.1543371828569800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2&quot;}},&quot;5a786d8a-65b8-4605-bd1a-b3929d922cc7&quot;:{&quot;type&quot;:&quot;FIGURE_OBJECT&quot;,&quot;id&quot;:&quot;5a786d8a-65b8-4605-bd1a-b3929d922cc7&quot;,&quot;name&quot;:&quot;Spheroidal cell&quot;,&quot;relativeTransform&quot;:{&quot;translate&quot;:{&quot;x&quot;:26.94092764963195,&quot;y&quot;:-4.129120720665408},&quot;rotate&quot;:0.19240739639058355,&quot;skewX&quot;:-0.2103697253931654,&quot;scale&quot;:{&quot;x&quot;:0.1524877170143775,&quot;y&quot;:0.0950359607954249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5&quot;}},&quot;cd39a473-eb36-4e7c-aa55-7ad4e1383139&quot;:{&quot;type&quot;:&quot;FIGURE_OBJECT&quot;,&quot;id&quot;:&quot;cd39a473-eb36-4e7c-aa55-7ad4e1383139&quot;,&quot;name&quot;:&quot;Spheroidal cell&quot;,&quot;relativeTransform&quot;:{&quot;translate&quot;:{&quot;x&quot;:-4.734994663181028,&quot;y&quot;:27.597581402745778},&quot;rotate&quot;:2.007270146731144,&quot;skewX&quot;:0.4110222361829166,&quot;scale&quot;:{&quot;x&quot;:0.09155760461031981,&quot;y&quot;:0.1387985394518730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8&quot;}},&quot;cab82327-16a1-4437-a672-eed1657aed59&quot;:{&quot;type&quot;:&quot;FIGURE_OBJECT&quot;,&quot;id&quot;:&quot;cab82327-16a1-4437-a672-eed1657aed59&quot;,&quot;name&quot;:&quot;Spheroidal cell&quot;,&quot;relativeTransform&quot;:{&quot;translate&quot;:{&quot;x&quot;:46.97789185639535,&quot;y&quot;:-3.6955206117122055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85&quot;}},&quot;69cee881-4524-47c3-8953-ade152aa39c3&quot;:{&quot;type&quot;:&quot;FIGURE_OBJECT&quot;,&quot;id&quot;:&quot;69cee881-4524-47c3-8953-ade152aa39c3&quot;,&quot;name&quot;:&quot;Spheroidal cell&quot;,&quot;relativeTransform&quot;:{&quot;translate&quot;:{&quot;x&quot;:58.33393055617962,&quot;y&quot;:6.463736283693512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9&quot;}},&quot;e41eec1d-3196-45a6-82cf-753d1e42e3fa&quot;:{&quot;type&quot;:&quot;FIGURE_OBJECT&quot;,&quot;id&quot;:&quot;e41eec1d-3196-45a6-82cf-753d1e42e3fa&quot;,&quot;relativeTransform&quot;:{&quot;translate&quot;:{&quot;x&quot;:-340.9557589709548,&quot;y&quot;:-10.46770226935675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8&quot;}},&quot;8c1f0d3b-62cb-45cf-903b-2957e7ae9337&quot;:{&quot;id&quot;:&quot;8c1f0d3b-62cb-45cf-903b-2957e7ae9337&quot;,&quot;type&quot;:&quot;FIGURE_OBJECT&quot;,&quot;relativeTransform&quot;:{&quot;translate&quot;:{&quot;x&quot;:-352.3938578673129,&quot;y&quot;:14.733873165822494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6]}],&quot;text&quot;:&quot;DMOG or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5% O2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5,&quot;runIndex&quot;:-1,&quot;charIndex&quot;:-1,&quot;endOfLine&quot;:true}},&quot;format&quot;:&quot;BETTER_TEXT&quot;,&quot;size&quot;:{&quot;x&quot;:107.4680801421614,&quot;y&quot;:148.56},&quot;targetSize&quot;:{&quot;x&quot;:107.4680801421614,&quot;y&quot;:91.32}},&quot;parent&quot;:{&quot;type&quot;:&quot;CHILD&quot;,&quot;parentId&quot;:&quot;8563537e-9ecc-4632-9afc-00afd7e3699c&quot;,&quot;order&quot;:&quot;99999999999999975&quot;}},&quot;ca618793-9cbd-4c31-8f3f-49468f7fc775&quot;:{&quot;id&quot;:&quot;ca618793-9cbd-4c31-8f3f-49468f7fc775&quot;,&quot;type&quot;:&quot;FIGURE_OBJECT&quot;,&quot;relativeTransform&quot;:{&quot;translate&quot;:{&quot;x&quot;:190.67546179576016,&quot;y&quot;:67.84973298277436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1]}],&quot;text&quot;:&quot;Progesterone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8&quot;}},&quot;fdab5c3b-8357-4917-9845-f1f64d6e575a&quot;:{&quot;id&quot;:&quot;fdab5c3b-8357-4917-9845-f1f64d6e575a&quot;,&quot;type&quot;:&quot;FIGURE_OBJECT&quot;,&quot;relativeTransform&quot;:{&quot;translate&quot;:{&quot;x&quot;:200.85194242041183,&quot;y&quot;:4.18741945072587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3}},&quot;format&quot;:&quot;BETTER_TEXT&quot;,&quot;size&quot;:{&quot;x&quot;:189.6977081298828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&quot;}},&quot;d5ddadf7-0730-4e76-a49f-2bd78b45341f&quot;:{&quot;relativeTransform&quot;:{&quot;translate&quot;:{&quot;x&quot;:-123.48813841370996,&quot;y&quot;:-11.157564975970843},&quot;rotate&quot;:0,&quot;skewX&quot;:0,&quot;scale&quot;:{&quot;x&quot;:1,&quot;y&quot;:1}},&quot;type&quot;:&quot;FIGURE_OBJECT&quot;,&quot;id&quot;:&quot;d5ddadf7-0730-4e76-a49f-2bd78b45341f&quot;,&quot;name&quot;:&quot;Petri dish with cells&quot;,&quot;displayName&quot;:&quot;Petri dish with cells&quot;,&quot;opacity&quot;:1,&quot;source&quot;:{&quot;id&quot;:&quot;5f6126e51ad2c000b63ff478&quot;,&quot;type&quot;:&quot;ASSETS&quot;},&quot;pathStyles&quot;:[{&quot;type&quot;:&quot;FILL&quot;,&quot;fillStyle&quot;:&quot;rgb(0,0,0)&quot;}],&quot;isLocked&quot;:false,&quot;parent&quot;:{&quot;type&quot;:&quot;CHILD&quot;,&quot;parentId&quot;:&quot;8563537e-9ecc-4632-9afc-00afd7e3699c&quot;,&quot;order&quot;:&quot;9999999999999999999999999999999999&quot;},&quot;isPremium&quot;:true},&quot;2a83b3a6-a5c5-4a9a-8523-953e6226815f&quot;:{&quot;type&quot;:&quot;FIGURE_OBJECT&quot;,&quot;id&quot;:&quot;2a83b3a6-a5c5-4a9a-8523-953e6226815f&quot;,&quot;name&quot;:&quot;Petri dish&quot;,&quot;relativeTransform&quot;:{&quot;translate&quot;:{&quot;x&quot;:0,&quot;y&quot;:5.608524144431269e-14},&quot;rotate&quot;:0,&quot;skewX&quot;:0,&quot;scale&quot;:{&quot;x&quot;:0.6071766165134398,&quot;y&quot;:0.6071766165134398}},&quot;opacity&quot;:1,&quot;image&quot;:{&quot;url&quot;:&quot;https://icons.biorender.com/biorender/5ee0f3bac4e9c30027d95cee/20200611181518/image/petri-dish-2.png&quot;,&quot;fallbackUrl&quot;:&quot;https://res.cloudinary.com/dlcjuc3ej/image/upload/v1591899318/jdx6mgytawhncb5ao57x.svg#/keystone/api/icons/5ee0f3bac4e9c30027d95cee/20200611181518/image/petri-dish-2.svg&quot;,&quot;size&quot;:{&quot;x&quot;:325,&quot;y&quot;:243},&quot;isPremium&quot;:false},&quot;source&quot;:{&quot;id&quot;:&quot;5ee0f3bac4e9c30027d95cee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02&quot;},&quot;styles&quot;:{&quot;petriDish&quot;:[{&quot;styleName&quot;:&quot;MONOCHROME_COLOR&quot;,&quot;index&quot;:0,&quot;color&quot;:&quot;#FF0D00&quot;}],&quot;liquid&quot;:[{&quot;styleName&quot;:&quot;MONOCHROME_COLOR&quot;,&quot;index&quot;:0,&quot;color&quot;:&quot;#FF0D00&quot;}]}},&quot;42512d50-6840-4d76-830e-be72f76c9ba6&quot;:{&quot;type&quot;:&quot;FIGURE_OBJECT&quot;,&quot;id&quot;:&quot;42512d50-6840-4d76-830e-be72f76c9ba6&quot;,&quot;name&quot;:&quot;Spheroidal cell&quot;,&quot;relativeTransform&quot;:{&quot;translate&quot;:{&quot;x&quot;:-35.94816670623872,&quot;y&quot;:17.667452063677587},&quot;rotate&quot;:0,&quot;skewX&quot;:0,&quot;scale&quot;:{&quot;x&quot;:0.15784657354899181,&quot;y&quot;:0.091809510780823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05&quot;},&quot;styles&quot;:{&quot;cell&quot;:[{&quot;monochromeTargetColor&quot;:&quot;#FF0D00&quot;,&quot;styleName&quot;:&quot;FILL&quot;,&quot;color&quot;:&quot;#ff2924&quot;},{&quot;monochromeTargetColor&quot;:&quot;#FF0D00&quot;,&quot;styleName&quot;:&quot;STROKE&quot;,&quot;color&quot;:&quot;#ff0806&quot;}],&quot;nucleus&quot;:[{&quot;monochromeTargetColor&quot;:&quot;#FF0D00&quot;,&quot;styleName&quot;:&quot;FILL&quot;,&quot;color&quot;:&quot;#ff1410&quot;},{&quot;monochromeTargetColor&quot;:&quot;#FF0D00&quot;,&quot;styleName&quot;:&quot;STROKE&quot;,&quot;color&quot;:&quot;#ff0f0c&quot;}]}},&quot;4b9cbe9b-c92f-454f-bf80-da3a9304d28e&quot;:{&quot;type&quot;:&quot;FIGURE_OBJECT&quot;,&quot;id&quot;:&quot;4b9cbe9b-c92f-454f-bf80-da3a9304d28e&quot;,&quot;name&quot;:&quot;Spheroidal cell&quot;,&quot;relativeTransform&quot;:{&quot;translate&quot;:{&quot;x&quot;:18.13054297598798,&quot;y&quot;:6.823000424368783},&quot;rotate&quot;:-0.8441643388031763,&quot;skewX&quot;:0.5142096794425836,&quot;scale&quot;:{&quot;x&quot;:0.109115702397623,&quot;y&quot;:0.1328114687210952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&quot;},&quot;styles&quot;:{&quot;&quot;:[{&quot;styleName&quot;:&quot;MONOCHROME_COLOR&quot;,&quot;index&quot;:0,&quot;color&quot;:&quot;#FF0D00&quot;}]}},&quot;d5e04ab6-af8b-419e-97d2-2d40b351f1b0&quot;:{&quot;type&quot;:&quot;FIGURE_OBJECT&quot;,&quot;id&quot;:&quot;d5e04ab6-af8b-419e-97d2-2d40b351f1b0&quot;,&quot;name&quot;:&quot;Spheroidal cell&quot;,&quot;relativeTransform&quot;:{&quot;translate&quot;:{&quot;x&quot;:-25.666075796752715,&quot;y&quot;:7.25960221562042},&quot;rotate&quot;:-0.9242877860074409,&quot;skewX&quot;:0.5005509573056879,&quot;scale&quot;:{&quot;x&quot;:0.10532127007158326,&quot;y&quot;:0.137596296418687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2&quot;},&quot;styles&quot;:{&quot;&quot;:[{&quot;styleName&quot;:&quot;MONOCHROME_COLOR&quot;,&quot;index&quot;:0,&quot;color&quot;:&quot;#FF0D00&quot;}]}},&quot;d9e8de39-b83b-4709-9da2-1667f9f379f5&quot;:{&quot;type&quot;:&quot;FIGURE_OBJECT&quot;,&quot;id&quot;:&quot;d9e8de39-b83b-4709-9da2-1667f9f379f5&quot;,&quot;name&quot;:&quot;Spheroidal cell&quot;,&quot;relativeTransform&quot;:{&quot;translate&quot;:{&quot;x&quot;:-27.037268676931472,&quot;y&quot;:-14.148816604714987},&quot;rotate&quot;:-1.9669828044671898,&quot;skewX&quot;:-0.38482140423679745,&quot;scale&quot;:{&quot;x&quot;:0.0966973626519624,&quot;y&quot;:0.1498677554228841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5&quot;},&quot;styles&quot;:{&quot;&quot;:[{&quot;styleName&quot;:&quot;MONOCHROME_COLOR&quot;,&quot;index&quot;:0,&quot;color&quot;:&quot;#FF0D00&quot;}]}},&quot;d50be6de-f0aa-4b62-ad3f-3db24efe407a&quot;:{&quot;type&quot;:&quot;FIGURE_OBJECT&quot;,&quot;id&quot;:&quot;d50be6de-f0aa-4b62-ad3f-3db24efe407a&quot;,&quot;name&quot;:&quot;Spheroidal cell&quot;,&quot;relativeTransform&quot;:{&quot;translate&quot;:{&quot;x&quot;:6.22442247159574,&quot;y&quot;:-4.1354271764679575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&quot;},&quot;styles&quot;:{&quot;&quot;:[{&quot;styleName&quot;:&quot;MONOCHROME_COLOR&quot;,&quot;index&quot;:0,&quot;color&quot;:&quot;#FF0D00&quot;}]}},&quot;ff15a6bd-9585-4569-8486-931f6b9e2c2d&quot;:{&quot;type&quot;:&quot;FIGURE_OBJECT&quot;,&quot;id&quot;:&quot;ff15a6bd-9585-4569-8486-931f6b9e2c2d&quot;,&quot;name&quot;:&quot;Spheroidal cell&quot;,&quot;relativeTransform&quot;:{&quot;translate&quot;:{&quot;x&quot;:25.307956286786244,&quot;y&quot;:-25.434303978061937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2&quot;},&quot;styles&quot;:{&quot;&quot;:[{&quot;styleName&quot;:&quot;MONOCHROME_COLOR&quot;,&quot;index&quot;:0,&quot;color&quot;:&quot;#FF0D00&quot;}]}},&quot;d83416b5-b33b-43fb-872c-550175cbf600&quot;:{&quot;type&quot;:&quot;FIGURE_OBJECT&quot;,&quot;id&quot;:&quot;d83416b5-b33b-43fb-872c-550175cbf600&quot;,&quot;name&quot;:&quot;Spheroidal cell&quot;,&quot;relativeTransform&quot;:{&quot;translate&quot;:{&quot;x&quot;:-45.904258988878105,&quot;y&quot;:6.836275248689061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5&quot;},&quot;styles&quot;:{&quot;&quot;:[{&quot;styleName&quot;:&quot;MONOCHROME_COLOR&quot;,&quot;index&quot;:0,&quot;color&quot;:&quot;#FF0D00&quot;}]}},&quot;8509e4bc-4d63-44a4-94ad-fa24a57cdd7a&quot;:{&quot;type&quot;:&quot;FIGURE_OBJECT&quot;,&quot;id&quot;:&quot;8509e4bc-4d63-44a4-94ad-fa24a57cdd7a&quot;,&quot;name&quot;:&quot;Spheroidal cell&quot;,&quot;relativeTransform&quot;:{&quot;translate&quot;:{&quot;x&quot;:26.941907186973612,&quot;y&quot;:17.668650872453796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3&quot;},&quot;styles&quot;:{&quot;&quot;:[{&quot;styleName&quot;:&quot;MONOCHROME_COLOR&quot;,&quot;index&quot;:0,&quot;color&quot;:&quot;#FF0D00&quot;}]}},&quot;9b9e3d25-b789-4a21-a432-bbbbb0b640bb&quot;:{&quot;type&quot;:&quot;FIGURE_OBJECT&quot;,&quot;id&quot;:&quot;9b9e3d25-b789-4a21-a432-bbbbb0b640bb&quot;,&quot;name&quot;:&quot;Spheroidal cell&quot;,&quot;relativeTransform&quot;:{&quot;translate&quot;:{&quot;x&quot;:-4.734830595262368,&quot;y&quot;:6.836083564854624},&quot;rotate&quot;:0.7464574379873126,&quot;skewX&quot;:-0.5158759485514509,&quot;scale&quot;:{&quot;x&quot;:0.11445735108071943,&quot;y&quot;:0.1266132455375633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35&quot;},&quot;styles&quot;:{&quot;&quot;:[{&quot;styleName&quot;:&quot;MONOCHROME_COLOR&quot;,&quot;index&quot;:0,&quot;color&quot;:&quot;#FF0D00&quot;}]}},&quot;1d04420f-04ad-4b92-b4b5-c6fe651a33f5&quot;:{&quot;type&quot;:&quot;FIGURE_OBJECT&quot;,&quot;id&quot;:&quot;1d04420f-04ad-4b92-b4b5-c6fe651a33f5&quot;,&quot;name&quot;:&quot;Spheroidal cell&quot;,&quot;relativeTransform&quot;:{&quot;translate&quot;:{&quot;x&quot;:-6.68555595462649,&quot;y&quot;:-14.803466749408686},&quot;rotate&quot;:0.213734288930394,&quot;skewX&quot;:-0.23158516584838867,&quot;scale&quot;:{&quot;x&quot;:0.15132853682888134,&quot;y&quot;:0.09576393851180379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4&quot;},&quot;styles&quot;:{&quot;&quot;:[{&quot;styleName&quot;:&quot;MONOCHROME_COLOR&quot;,&quot;index&quot;:0,&quot;color&quot;:&quot;#FF0D00&quot;}]}},&quot;7312d6db-f458-46d1-9331-82a2cef99657&quot;:{&quot;type&quot;:&quot;FIGURE_OBJECT&quot;,&quot;id&quot;:&quot;7312d6db-f458-46d1-9331-82a2cef99657&quot;,&quot;name&quot;:&quot;Spheroidal cell&quot;,&quot;relativeTransform&quot;:{&quot;translate&quot;:{&quot;x&quot;:-18.09248556476985,&quot;y&quot;:-25.14594105576579},&quot;rotate&quot;:2.8082484065025266,&quot;skewX&quot;:0.3382353591056591,&quot;scale&quot;:{&quot;x&quot;:0.14353196763903742,&quot;y&quot;:0.10096577741069561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&quot;},&quot;styles&quot;:{&quot;&quot;:[{&quot;styleName&quot;:&quot;MONOCHROME_COLOR&quot;,&quot;index&quot;:0,&quot;color&quot;:&quot;#FF0D00&quot;}]}},&quot;ad44f701-ebe9-4524-ae5d-b0ab4c0bc21e&quot;:{&quot;type&quot;:&quot;FIGURE_OBJECT&quot;,&quot;id&quot;:&quot;ad44f701-ebe9-4524-ae5d-b0ab4c0bc21e&quot;,&quot;name&quot;:&quot;Spheroidal cell&quot;,&quot;relativeTransform&quot;:{&quot;translate&quot;:{&quot;x&quot;:14.414761428434927,&quot;y&quot;:-15.1722763283521},&quot;rotate&quot;:-0.04903278895355655,&quot;skewX&quot;:0.05563510897168514,&quot;scale&quot;:{&quot;x&quot;:0.15747703678324385,&quot;y&quot;:0.0920249516499932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2&quot;},&quot;styles&quot;:{&quot;&quot;:[{&quot;styleName&quot;:&quot;MONOCHROME_COLOR&quot;,&quot;index&quot;:0,&quot;color&quot;:&quot;#FF0D00&quot;}]}},&quot;7aff5a26-5a34-4b0d-ab7a-d6281b4e9714&quot;:{&quot;type&quot;:&quot;FIGURE_OBJECT&quot;,&quot;id&quot;:&quot;7aff5a26-5a34-4b0d-ab7a-d6281b4e9714&quot;,&quot;name&quot;:&quot;Spheroidal cell&quot;,&quot;relativeTransform&quot;:{&quot;translate&quot;:{&quot;x&quot;:6.224521886152677,&quot;y&quot;:17.218462161979325},&quot;rotate&quot;:-1.7846385290398883,&quot;skewX&quot;:-0.23169099291879855,&quot;scale&quot;:{&quot;x&quot;:0.09320882656316883,&quot;y&quot;:0.1554768709178088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5&quot;},&quot;styles&quot;:{&quot;&quot;:[{&quot;styleName&quot;:&quot;MONOCHROME_COLOR&quot;,&quot;index&quot;:0,&quot;color&quot;:&quot;#FF0D00&quot;}]}},&quot;328b10f5-1313-4cd1-aa72-365e737e4350&quot;:{&quot;type&quot;:&quot;FIGURE_OBJECT&quot;,&quot;id&quot;:&quot;328b10f5-1313-4cd1-aa72-365e737e4350&quot;,&quot;name&quot;:&quot;Spheroidal cell&quot;,&quot;relativeTransform&quot;:{&quot;translate&quot;:{&quot;x&quot;:36.81280325856201,&quot;y&quot;:-15.172630928442713},&quot;rotate&quot;:-2.931431735711825,&quot;skewX&quot;:-0.22807204878781118,&quot;scale&quot;:{&quot;x&quot;:0.15152885905234068,&quot;y&quot;:0.0956373379077347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&quot;},&quot;styles&quot;:{&quot;&quot;:[{&quot;styleName&quot;:&quot;MONOCHROME_COLOR&quot;,&quot;index&quot;:0,&quot;color&quot;:&quot;#FF0D00&quot;}]}},&quot;6a50141e-9fee-44b9-9a93-7b0b034add00&quot;:{&quot;type&quot;:&quot;FIGURE_OBJECT&quot;,&quot;id&quot;:&quot;6a50141e-9fee-44b9-9a93-7b0b034add00&quot;,&quot;name&quot;:&quot;Spheroidal cell&quot;,&quot;relativeTransform&quot;:{&quot;translate&quot;:{&quot;x&quot;:-25.360090131766835,&quot;y&quot;:28.13378015320774},&quot;rotate&quot;:2.9762120695107392,&quot;skewX&quot;:0.1826732519111916,&quot;scale&quot;:{&quot;x&quot;:0.153822137438127,&quot;y&quot;:0.0942115155680460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2&quot;},&quot;styles&quot;:{&quot;&quot;:[{&quot;styleName&quot;:&quot;MONOCHROME_COLOR&quot;,&quot;index&quot;:0,&quot;color&quot;:&quot;#FF0D00&quot;}]}},&quot;3782474d-f16b-45d7-b83c-90ad7acbad8e&quot;:{&quot;type&quot;:&quot;FIGURE_OBJECT&quot;,&quot;id&quot;:&quot;3782474d-f16b-45d7-b83c-90ad7acbad8e&quot;,&quot;name&quot;:&quot;Spheroidal cell&quot;,&quot;relativeTransform&quot;:{&quot;translate&quot;:{&quot;x&quot;:-16.100024024192354,&quot;y&quot;:-3.688477714766073},&quot;rotate&quot;:2.4774495271634254,&quot;skewX&quot;:0.5045139632431672,&quot;scale&quot;:{&quot;x&quot;:0.11955608588347261,&quot;y&quot;:0.121213542488225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5&quot;},&quot;styles&quot;:{&quot;&quot;:[{&quot;styleName&quot;:&quot;MONOCHROME_COLOR&quot;,&quot;index&quot;:0,&quot;color&quot;:&quot;#FF0D00&quot;}]}},&quot;79a4b294-6fd6-4684-bbdc-731748bff801&quot;:{&quot;type&quot;:&quot;FIGURE_OBJECT&quot;,&quot;id&quot;:&quot;79a4b294-6fd6-4684-bbdc-731748bff801&quot;,&quot;name&quot;:&quot;Spheroidal cell&quot;,&quot;relativeTransform&quot;:{&quot;translate&quot;:{&quot;x&quot;:38.27992794850325,&quot;y&quot;:8.016880765852614},&quot;rotate&quot;:1.9024858372198619,&quot;skewX&quot;:0.33691651854106114,&quot;scale&quot;:{&quot;x&quot;:0.09521061475176545,&quot;y&quot;:0.1522079941794886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&quot;},&quot;styles&quot;:{&quot;&quot;:[{&quot;styleName&quot;:&quot;MONOCHROME_COLOR&quot;,&quot;index&quot;:0,&quot;color&quot;:&quot;#FF0D00&quot;}]}},&quot;bc1efc4e-acae-4458-93fd-1b4c4d3c331e&quot;:{&quot;type&quot;:&quot;FIGURE_OBJECT&quot;,&quot;id&quot;:&quot;bc1efc4e-acae-4458-93fd-1b4c4d3c331e&quot;,&quot;name&quot;:&quot;Spheroidal cell&quot;,&quot;relativeTransform&quot;:{&quot;translate&quot;:{&quot;x&quot;:-14.750562463610251,&quot;y&quot;:17.667624441741154},&quot;rotate&quot;:1.3100682807713566,&quot;skewX&quot;:-0.2761173365540062,&quot;scale&quot;:{&quot;x&quot;:0.09389711816491687,&quot;y&quot;:0.1543371828569800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2&quot;},&quot;styles&quot;:{&quot;&quot;:[{&quot;styleName&quot;:&quot;MONOCHROME_COLOR&quot;,&quot;index&quot;:0,&quot;color&quot;:&quot;#FF0D00&quot;}]}},&quot;c35a2c28-9e05-4c59-9556-98792bc5b8dc&quot;:{&quot;type&quot;:&quot;FIGURE_OBJECT&quot;,&quot;id&quot;:&quot;c35a2c28-9e05-4c59-9556-98792bc5b8dc&quot;,&quot;name&quot;:&quot;Spheroidal cell&quot;,&quot;relativeTransform&quot;:{&quot;translate&quot;:{&quot;x&quot;:26.94092764963195,&quot;y&quot;:-4.129120720665408},&quot;rotate&quot;:0.19240739639058355,&quot;skewX&quot;:-0.2103697253931654,&quot;scale&quot;:{&quot;x&quot;:0.1524877170143775,&quot;y&quot;:0.0950359607954249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5&quot;},&quot;styles&quot;:{&quot;&quot;:[{&quot;styleName&quot;:&quot;MONOCHROME_COLOR&quot;,&quot;index&quot;:0,&quot;color&quot;:&quot;#FF0D00&quot;}]}},&quot;c415f798-048e-4b08-b21a-9a5087f41ff9&quot;:{&quot;type&quot;:&quot;FIGURE_OBJECT&quot;,&quot;id&quot;:&quot;c415f798-048e-4b08-b21a-9a5087f41ff9&quot;,&quot;name&quot;:&quot;Spheroidal cell&quot;,&quot;relativeTransform&quot;:{&quot;translate&quot;:{&quot;x&quot;:-4.734994663181028,&quot;y&quot;:27.597581402745778},&quot;rotate&quot;:2.007270146731144,&quot;skewX&quot;:0.4110222361829166,&quot;scale&quot;:{&quot;x&quot;:0.09155760461031981,&quot;y&quot;:0.1387985394518730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8&quot;},&quot;styles&quot;:{&quot;&quot;:[{&quot;styleName&quot;:&quot;MONOCHROME_COLOR&quot;,&quot;index&quot;:0,&quot;color&quot;:&quot;#FF0D00&quot;}]}},&quot;12949984-9fdc-4741-989c-7438dcbc1b22&quot;:{&quot;type&quot;:&quot;FIGURE_OBJECT&quot;,&quot;id&quot;:&quot;12949984-9fdc-4741-989c-7438dcbc1b22&quot;,&quot;name&quot;:&quot;Spheroidal cell&quot;,&quot;relativeTransform&quot;:{&quot;translate&quot;:{&quot;x&quot;:46.97789185639535,&quot;y&quot;:-3.6955206117122055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85&quot;},&quot;styles&quot;:{&quot;&quot;:[{&quot;styleName&quot;:&quot;MONOCHROME_COLOR&quot;,&quot;index&quot;:0,&quot;color&quot;:&quot;#FF0D00&quot;}]}},&quot;41473d35-e20e-43dd-8486-904c120ef37a&quot;:{&quot;type&quot;:&quot;FIGURE_OBJECT&quot;,&quot;id&quot;:&quot;41473d35-e20e-43dd-8486-904c120ef37a&quot;,&quot;name&quot;:&quot;Spheroidal cell&quot;,&quot;relativeTransform&quot;:{&quot;translate&quot;:{&quot;x&quot;:58.33393055617962,&quot;y&quot;:6.463736283693512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9&quot;},&quot;styles&quot;:{&quot;&quot;:[{&quot;styleName&quot;:&quot;MONOCHROME_COLOR&quot;,&quot;index&quot;:0,&quot;color&quot;:&quot;#FF0D00&quot;}]}},&quot;9f7f6583-bb35-4329-833e-56fc4e73ba73&quot;:{&quot;type&quot;:&quot;FIGURE_OBJECT&quot;,&quot;id&quot;:&quot;9f7f6583-bb35-4329-833e-56fc4e73ba73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d9bd02e7-08a7-44cb-91ef-b277982807c8&quot;:{&quot;type&quot;:&quot;FIGURE_OBJECT&quot;,&quot;id&quot;:&quot;d9bd02e7-08a7-44cb-91ef-b277982807c8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b21c5746-6502-4a3e-8c3b-f780e96fbd46&quot;:{&quot;type&quot;:&quot;FIGURE_OBJECT&quot;,&quot;id&quot;:&quot;b21c5746-6502-4a3e-8c3b-f780e96fbd46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b6e60238-7a0b-47be-96f3-15dfb46160c0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b6e60238-7a0b-47be-96f3-15dfb46160c0&quot;:{&quot;type&quot;:&quot;FIGURE_OBJECT&quot;,&quot;id&quot;:&quot;b6e60238-7a0b-47be-96f3-15dfb46160c0&quot;,&quot;parent&quot;:{&quot;type&quot;:&quot;CHILD&quot;,&quot;parentId&quot;:&quot;8563537e-9ecc-4632-9afc-00afd7e3699c&quot;,&quot;order&quot;:&quot;99999999999999999999999998&quot;},&quot;relativeTransform&quot;:{&quot;translate&quot;:{&quot;x&quot;:-236.4160277239672,&quot;y&quot;:-10.117289381498281},&quot;rotate&quot;:-1.5707963267948966,&quot;skewX&quot;:0,&quot;scale&quot;:{&quot;x&quot;:1,&quot;y&quot;:1}}},&quot;af357b87-1477-449c-8986-1c935208e987&quot;:{&quot;id&quot;:&quot;af357b87-1477-449c-8986-1c935208e987&quot;,&quot;type&quot;:&quot;FIGURE_OBJECT&quot;,&quot;relativeTransform&quot;:{&quot;translate&quot;:{&quot;x&quot;:190.6763409296052,&quot;y&quot;:-71.284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1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5&quot;}},&quot;05e63131-8e15-4362-a850-11d39e9751eb&quot;:{&quot;type&quot;:&quot;FIGURE_OBJECT&quot;,&quot;id&quot;:&quot;05e63131-8e15-4362-a850-11d39e9751eb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8&quot;},&quot;connectorInfo&quot;:{&quot;connectedObjects&quot;:[],&quot;type&quot;:&quot;ELBOW&quot;,&quot;offset&quot;:{&quot;x&quot;:0,&quot;y&quot;:0},&quot;bending&quot;:-0.1,&quot;firstElementIsHead&quot;:true,&quot;customized&quot;:false}}}}"/>
    <we:property name="660568f51927813db44fbf54_1717141052955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66.29117599212623,&quot;y&quot;:17.088778983441955},&quot;rotate&quot;:0,&quot;skewX&quot;:0,&quot;scale&quot;:{&quot;x&quot;:1,&quot;y&quot;:1}},&quot;path&quot;:{&quot;type&quot;:&quot;RECT&quot;,&quot;size&quot;:{&quot;x&quot;:1263.7844000901623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535.7149671949715,&quot;y&quot;:82.84160442360896},&quot;rotate&quot;:0,&quot;skewX&quot;:0,&quot;scale&quot;:{&quot;x&quot;:1,&quot;y&quot;:1}},&quot;text&quot;:{&quot;textData&quot;:{&quot;lineSpacing&quot;:&quot;normal&quot;,&quot;alignment&quot;:&quot;center&quot;,&quot;lines&quot;:[{&quot;runs&quot;:[{&quot;range&quot;:[0,12],&quot;style&quot;:{&quot;fontWeight&quot;:&quot;bold&quot;,&quot;fontStyle&quot;:&quot;normal&quot;,&quot;fontSize&quot;:18.666666666666664,&quot;fontFamily&quot;:&quot;Roboto&quot;,&quot;color&quot;:&quot;black&quot;,&quot;decoration&quot;:&quot;none&quot;}}],&quot;text&quot;:&quot;Y1- Ad. Cells&quot;}],&quot;verticalAlign&quot;:&quot;TOP&quot;,&quot;_lastCaretLocation&quot;:{&quot;lineIndex&quot;:0,&quot;runIndex&quot;:0,&quot;charIndex&quot;:8}},&quot;format&quot;:&quot;BETTER_TEXT&quot;,&quot;size&quot;:{&quot;x&quot;:458.10963204412633,&quot;y&quot;:40.45495813527425},&quot;targetSize&quot;:{&quot;x&quot;:458.10963204412633,&quot;y&quot;:40.45495813527425},&quot;verticalAlign&quot;:&quot;TOP&quot;},&quot;parent&quot;:{&quot;type&quot;:&quot;CHILD&quot;,&quot;parentId&quot;:&quot;8563537e-9ecc-4632-9afc-00afd7e3699c&quot;,&quot;order&quot;:&quot;9999999999998&quot;}},&quot;b27a5ede-1d29-43d6-8f9a-ad70ce886ff4&quot;:{&quot;relativeTransform&quot;:{&quot;translate&quot;:{&quot;x&quot;:-535.7148472724849,&quot;y&quot;:-11.157564975970843},&quot;rotate&quot;:0,&quot;skewX&quot;:0,&quot;scale&quot;:{&quot;x&quot;:1,&quot;y&quot;:1}},&quot;type&quot;:&quot;FIGURE_OBJECT&quot;,&quot;id&quot;:&quot;b27a5ede-1d29-43d6-8f9a-ad70ce886ff4&quot;,&quot;name&quot;:&quot;Petri dish with cells&quot;,&quot;displayName&quot;:&quot;Petri dish with cells&quot;,&quot;opacity&quot;:1,&quot;source&quot;:{&quot;id&quot;:&quot;5f6126e51ad2c000b63ff478&quot;,&quot;type&quot;:&quot;ASSETS&quot;},&quot;pathStyles&quot;:[{&quot;type&quot;:&quot;FILL&quot;,&quot;fillStyle&quot;:&quot;rgb(0,0,0)&quot;}],&quot;isLocked&quot;:false,&quot;parent&quot;:{&quot;type&quot;:&quot;CHILD&quot;,&quot;parentId&quot;:&quot;8563537e-9ecc-4632-9afc-00afd7e3699c&quot;,&quot;order&quot;:&quot;99999999999995&quot;},&quot;isPremium&quot;:true},&quot;0f94f3b9-cf76-41e3-8e93-4a9c32d0734b&quot;:{&quot;type&quot;:&quot;FIGURE_OBJECT&quot;,&quot;id&quot;:&quot;0f94f3b9-cf76-41e3-8e93-4a9c32d0734b&quot;,&quot;name&quot;:&quot;Petri dish&quot;,&quot;relativeTransform&quot;:{&quot;translate&quot;:{&quot;x&quot;:0,&quot;y&quot;:5.608524144431269e-14},&quot;rotate&quot;:0,&quot;skewX&quot;:0,&quot;scale&quot;:{&quot;x&quot;:0.6071766165134398,&quot;y&quot;:0.6071766165134398}},&quot;opacity&quot;:1,&quot;image&quot;:{&quot;url&quot;:&quot;https://icons.biorender.com/biorender/5ee0f3bac4e9c30027d95cee/20200611181518/image/petri-dish-2.png&quot;,&quot;fallbackUrl&quot;:&quot;https://res.cloudinary.com/dlcjuc3ej/image/upload/v1591899318/jdx6mgytawhncb5ao57x.svg#/keystone/api/icons/5ee0f3bac4e9c30027d95cee/20200611181518/image/petri-dish-2.svg&quot;,&quot;size&quot;:{&quot;x&quot;:325,&quot;y&quot;:243},&quot;isPremium&quot;:false},&quot;source&quot;:{&quot;id&quot;:&quot;5ee0f3bac4e9c30027d95cee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02&quot;}},&quot;80b5a369-5a07-4fbf-8e61-fd7e5cb9b993&quot;:{&quot;type&quot;:&quot;FIGURE_OBJECT&quot;,&quot;id&quot;:&quot;80b5a369-5a07-4fbf-8e61-fd7e5cb9b993&quot;,&quot;name&quot;:&quot;Spheroidal cell&quot;,&quot;relativeTransform&quot;:{&quot;translate&quot;:{&quot;x&quot;:-35.94816670623872,&quot;y&quot;:17.667452063677587},&quot;rotate&quot;:0,&quot;skewX&quot;:0,&quot;scale&quot;:{&quot;x&quot;:0.15784657354899181,&quot;y&quot;:0.091809510780823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05&quot;}},&quot;9f5041b7-8da0-40a3-9f57-8553129329b2&quot;:{&quot;type&quot;:&quot;FIGURE_OBJECT&quot;,&quot;id&quot;:&quot;9f5041b7-8da0-40a3-9f57-8553129329b2&quot;,&quot;name&quot;:&quot;Spheroidal cell&quot;,&quot;relativeTransform&quot;:{&quot;translate&quot;:{&quot;x&quot;:18.13054297598798,&quot;y&quot;:6.823000424368783},&quot;rotate&quot;:-0.8441643388031763,&quot;skewX&quot;:0.5142096794425836,&quot;scale&quot;:{&quot;x&quot;:0.109115702397623,&quot;y&quot;:0.1328114687210952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&quot;}},&quot;33e32d4a-2a6c-4972-9ace-f64760cf18e4&quot;:{&quot;type&quot;:&quot;FIGURE_OBJECT&quot;,&quot;id&quot;:&quot;33e32d4a-2a6c-4972-9ace-f64760cf18e4&quot;,&quot;name&quot;:&quot;Spheroidal cell&quot;,&quot;relativeTransform&quot;:{&quot;translate&quot;:{&quot;x&quot;:-25.666075796752715,&quot;y&quot;:7.25960221562042},&quot;rotate&quot;:-0.9242877860074409,&quot;skewX&quot;:0.5005509573056879,&quot;scale&quot;:{&quot;x&quot;:0.10532127007158326,&quot;y&quot;:0.137596296418687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2&quot;}},&quot;5b319b16-dbf1-42fc-a2c6-5deed5c1cecf&quot;:{&quot;type&quot;:&quot;FIGURE_OBJECT&quot;,&quot;id&quot;:&quot;5b319b16-dbf1-42fc-a2c6-5deed5c1cecf&quot;,&quot;name&quot;:&quot;Spheroidal cell&quot;,&quot;relativeTransform&quot;:{&quot;translate&quot;:{&quot;x&quot;:-27.037268676931472,&quot;y&quot;:-14.148816604714987},&quot;rotate&quot;:-1.9669828044671898,&quot;skewX&quot;:-0.38482140423679745,&quot;scale&quot;:{&quot;x&quot;:0.0966973626519624,&quot;y&quot;:0.1498677554228841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15&quot;}},&quot;85d5c287-9c1b-4109-9cd3-44ebe2b6c89b&quot;:{&quot;type&quot;:&quot;FIGURE_OBJECT&quot;,&quot;id&quot;:&quot;85d5c287-9c1b-4109-9cd3-44ebe2b6c89b&quot;,&quot;name&quot;:&quot;Spheroidal cell&quot;,&quot;relativeTransform&quot;:{&quot;translate&quot;:{&quot;x&quot;:6.22442247159574,&quot;y&quot;:-4.1354271764679575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&quot;}},&quot;e2a9a4b4-d9df-49c1-b70a-b6b1f9abbe24&quot;:{&quot;type&quot;:&quot;FIGURE_OBJECT&quot;,&quot;id&quot;:&quot;e2a9a4b4-d9df-49c1-b70a-b6b1f9abbe24&quot;,&quot;name&quot;:&quot;Spheroidal cell&quot;,&quot;relativeTransform&quot;:{&quot;translate&quot;:{&quot;x&quot;:25.307956286786244,&quot;y&quot;:-25.434303978061937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2&quot;}},&quot;2e4c8787-c235-414a-8928-3a113e4a8230&quot;:{&quot;type&quot;:&quot;FIGURE_OBJECT&quot;,&quot;id&quot;:&quot;2e4c8787-c235-414a-8928-3a113e4a8230&quot;,&quot;name&quot;:&quot;Spheroidal cell&quot;,&quot;relativeTransform&quot;:{&quot;translate&quot;:{&quot;x&quot;:-45.904258988878105,&quot;y&quot;:6.836275248689061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25&quot;}},&quot;f1eb5606-e506-457b-822b-9deb0032fe35&quot;:{&quot;type&quot;:&quot;FIGURE_OBJECT&quot;,&quot;id&quot;:&quot;f1eb5606-e506-457b-822b-9deb0032fe35&quot;,&quot;name&quot;:&quot;Spheroidal cell&quot;,&quot;relativeTransform&quot;:{&quot;translate&quot;:{&quot;x&quot;:26.941907186973612,&quot;y&quot;:17.668650872453796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3&quot;}},&quot;3ed3776e-4ee4-4fa8-bfc1-9053f3158897&quot;:{&quot;type&quot;:&quot;FIGURE_OBJECT&quot;,&quot;id&quot;:&quot;3ed3776e-4ee4-4fa8-bfc1-9053f3158897&quot;,&quot;name&quot;:&quot;Spheroidal cell&quot;,&quot;relativeTransform&quot;:{&quot;translate&quot;:{&quot;x&quot;:-4.734830595262368,&quot;y&quot;:6.836083564854624},&quot;rotate&quot;:0.7464574379873126,&quot;skewX&quot;:-0.5158759485514509,&quot;scale&quot;:{&quot;x&quot;:0.11445735108071943,&quot;y&quot;:0.1266132455375633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35&quot;}},&quot;c5bc723e-2569-40f1-866b-dae69b27d0e8&quot;:{&quot;type&quot;:&quot;FIGURE_OBJECT&quot;,&quot;id&quot;:&quot;c5bc723e-2569-40f1-866b-dae69b27d0e8&quot;,&quot;name&quot;:&quot;Spheroidal cell&quot;,&quot;relativeTransform&quot;:{&quot;translate&quot;:{&quot;x&quot;:-6.68555595462649,&quot;y&quot;:-14.803466749408686},&quot;rotate&quot;:0.213734288930394,&quot;skewX&quot;:-0.23158516584838867,&quot;scale&quot;:{&quot;x&quot;:0.15132853682888134,&quot;y&quot;:0.09576393851180379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4&quot;}},&quot;c990af1e-a89f-4a4f-a104-12022f09891a&quot;:{&quot;type&quot;:&quot;FIGURE_OBJECT&quot;,&quot;id&quot;:&quot;c990af1e-a89f-4a4f-a104-12022f09891a&quot;,&quot;name&quot;:&quot;Spheroidal cell&quot;,&quot;relativeTransform&quot;:{&quot;translate&quot;:{&quot;x&quot;:-18.09248556476985,&quot;y&quot;:-25.14594105576579},&quot;rotate&quot;:2.8082484065025266,&quot;skewX&quot;:0.3382353591056591,&quot;scale&quot;:{&quot;x&quot;:0.14353196763903742,&quot;y&quot;:0.10096577741069561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&quot;}},&quot;8d63e0cc-073d-4fbe-ba90-9dbe94d1fb20&quot;:{&quot;type&quot;:&quot;FIGURE_OBJECT&quot;,&quot;id&quot;:&quot;8d63e0cc-073d-4fbe-ba90-9dbe94d1fb20&quot;,&quot;name&quot;:&quot;Spheroidal cell&quot;,&quot;relativeTransform&quot;:{&quot;translate&quot;:{&quot;x&quot;:14.414761428434927,&quot;y&quot;:-15.1722763283521},&quot;rotate&quot;:-0.04903278895355655,&quot;skewX&quot;:0.05563510897168514,&quot;scale&quot;:{&quot;x&quot;:0.15747703678324385,&quot;y&quot;:0.0920249516499932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2&quot;}},&quot;4bc2ca67-3b95-448a-a9e1-d050eb63fd23&quot;:{&quot;type&quot;:&quot;FIGURE_OBJECT&quot;,&quot;id&quot;:&quot;4bc2ca67-3b95-448a-a9e1-d050eb63fd23&quot;,&quot;name&quot;:&quot;Spheroidal cell&quot;,&quot;relativeTransform&quot;:{&quot;translate&quot;:{&quot;x&quot;:6.224521886152677,&quot;y&quot;:17.218462161979325},&quot;rotate&quot;:-1.7846385290398883,&quot;skewX&quot;:-0.23169099291879855,&quot;scale&quot;:{&quot;x&quot;:0.09320882656316883,&quot;y&quot;:0.1554768709178088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55&quot;}},&quot;05f874b7-ccce-4ed0-af12-1f618cf9df08&quot;:{&quot;type&quot;:&quot;FIGURE_OBJECT&quot;,&quot;id&quot;:&quot;05f874b7-ccce-4ed0-af12-1f618cf9df08&quot;,&quot;name&quot;:&quot;Spheroidal cell&quot;,&quot;relativeTransform&quot;:{&quot;translate&quot;:{&quot;x&quot;:36.81280325856201,&quot;y&quot;:-15.172630928442713},&quot;rotate&quot;:-2.931431735711825,&quot;skewX&quot;:-0.22807204878781118,&quot;scale&quot;:{&quot;x&quot;:0.15152885905234068,&quot;y&quot;:0.0956373379077347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&quot;}},&quot;e9170a20-58c0-44c0-ad26-d4e055c1faaf&quot;:{&quot;type&quot;:&quot;FIGURE_OBJECT&quot;,&quot;id&quot;:&quot;e9170a20-58c0-44c0-ad26-d4e055c1faaf&quot;,&quot;name&quot;:&quot;Spheroidal cell&quot;,&quot;relativeTransform&quot;:{&quot;translate&quot;:{&quot;x&quot;:-25.360090131766835,&quot;y&quot;:28.13378015320774},&quot;rotate&quot;:2.9762120695107392,&quot;skewX&quot;:0.1826732519111916,&quot;scale&quot;:{&quot;x&quot;:0.153822137438127,&quot;y&quot;:0.0942115155680460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2&quot;}},&quot;8dc402cc-58ab-4c82-a3da-59e4e1b5368a&quot;:{&quot;type&quot;:&quot;FIGURE_OBJECT&quot;,&quot;id&quot;:&quot;8dc402cc-58ab-4c82-a3da-59e4e1b5368a&quot;,&quot;name&quot;:&quot;Spheroidal cell&quot;,&quot;relativeTransform&quot;:{&quot;translate&quot;:{&quot;x&quot;:-16.100024024192354,&quot;y&quot;:-3.688477714766073},&quot;rotate&quot;:2.4774495271634254,&quot;skewX&quot;:0.5045139632431672,&quot;scale&quot;:{&quot;x&quot;:0.11955608588347261,&quot;y&quot;:0.121213542488225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65&quot;}},&quot;9c5d3df9-acd4-48b2-ba99-de3704f20974&quot;:{&quot;type&quot;:&quot;FIGURE_OBJECT&quot;,&quot;id&quot;:&quot;9c5d3df9-acd4-48b2-ba99-de3704f20974&quot;,&quot;name&quot;:&quot;Spheroidal cell&quot;,&quot;relativeTransform&quot;:{&quot;translate&quot;:{&quot;x&quot;:38.27992794850325,&quot;y&quot;:8.016880765852614},&quot;rotate&quot;:1.9024858372198619,&quot;skewX&quot;:0.33691651854106114,&quot;scale&quot;:{&quot;x&quot;:0.09521061475176545,&quot;y&quot;:0.1522079941794886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&quot;}},&quot;81dc45dc-8271-4f3f-9e74-875aa34b8fc9&quot;:{&quot;type&quot;:&quot;FIGURE_OBJECT&quot;,&quot;id&quot;:&quot;81dc45dc-8271-4f3f-9e74-875aa34b8fc9&quot;,&quot;name&quot;:&quot;Spheroidal cell&quot;,&quot;relativeTransform&quot;:{&quot;translate&quot;:{&quot;x&quot;:-14.750562463610251,&quot;y&quot;:17.667624441741154},&quot;rotate&quot;:1.3100682807713566,&quot;skewX&quot;:-0.2761173365540062,&quot;scale&quot;:{&quot;x&quot;:0.09389711816491687,&quot;y&quot;:0.1543371828569800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2&quot;}},&quot;5a786d8a-65b8-4605-bd1a-b3929d922cc7&quot;:{&quot;type&quot;:&quot;FIGURE_OBJECT&quot;,&quot;id&quot;:&quot;5a786d8a-65b8-4605-bd1a-b3929d922cc7&quot;,&quot;name&quot;:&quot;Spheroidal cell&quot;,&quot;relativeTransform&quot;:{&quot;translate&quot;:{&quot;x&quot;:26.94092764963195,&quot;y&quot;:-4.129120720665408},&quot;rotate&quot;:0.19240739639058355,&quot;skewX&quot;:-0.2103697253931654,&quot;scale&quot;:{&quot;x&quot;:0.1524877170143775,&quot;y&quot;:0.0950359607954249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75&quot;}},&quot;cd39a473-eb36-4e7c-aa55-7ad4e1383139&quot;:{&quot;type&quot;:&quot;FIGURE_OBJECT&quot;,&quot;id&quot;:&quot;cd39a473-eb36-4e7c-aa55-7ad4e1383139&quot;,&quot;name&quot;:&quot;Spheroidal cell&quot;,&quot;relativeTransform&quot;:{&quot;translate&quot;:{&quot;x&quot;:-4.734994663181028,&quot;y&quot;:27.597581402745778},&quot;rotate&quot;:2.007270146731144,&quot;skewX&quot;:0.4110222361829166,&quot;scale&quot;:{&quot;x&quot;:0.09155760461031981,&quot;y&quot;:0.1387985394518730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8&quot;}},&quot;cab82327-16a1-4437-a672-eed1657aed59&quot;:{&quot;type&quot;:&quot;FIGURE_OBJECT&quot;,&quot;id&quot;:&quot;cab82327-16a1-4437-a672-eed1657aed59&quot;,&quot;name&quot;:&quot;Spheroidal cell&quot;,&quot;relativeTransform&quot;:{&quot;translate&quot;:{&quot;x&quot;:46.97789185639535,&quot;y&quot;:-3.6955206117122055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85&quot;}},&quot;69cee881-4524-47c3-8953-ade152aa39c3&quot;:{&quot;type&quot;:&quot;FIGURE_OBJECT&quot;,&quot;id&quot;:&quot;69cee881-4524-47c3-8953-ade152aa39c3&quot;,&quot;name&quot;:&quot;Spheroidal cell&quot;,&quot;relativeTransform&quot;:{&quot;translate&quot;:{&quot;x&quot;:58.33393055617962,&quot;y&quot;:6.463736283693512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b27a5ede-1d29-43d6-8f9a-ad70ce886ff4&quot;,&quot;order&quot;:&quot;9&quot;}},&quot;e41eec1d-3196-45a6-82cf-753d1e42e3fa&quot;:{&quot;type&quot;:&quot;FIGURE_OBJECT&quot;,&quot;id&quot;:&quot;e41eec1d-3196-45a6-82cf-753d1e42e3fa&quot;,&quot;relativeTransform&quot;:{&quot;translate&quot;:{&quot;x&quot;:-340.9557589709548,&quot;y&quot;:-10.46770226935675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8&quot;}},&quot;8c1f0d3b-62cb-45cf-903b-2957e7ae9337&quot;:{&quot;id&quot;:&quot;8c1f0d3b-62cb-45cf-903b-2957e7ae9337&quot;,&quot;type&quot;:&quot;FIGURE_OBJECT&quot;,&quot;relativeTransform&quot;:{&quot;translate&quot;:{&quot;x&quot;:-352.3938578673129,&quot;y&quot;:14.733873165822494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6]}],&quot;text&quot;:&quot;DMOG or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5% O2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5,&quot;runIndex&quot;:-1,&quot;charIndex&quot;:-1,&quot;endOfLine&quot;:true}},&quot;format&quot;:&quot;BETTER_TEXT&quot;,&quot;size&quot;:{&quot;x&quot;:107.4680801421614,&quot;y&quot;:148.56},&quot;targetSize&quot;:{&quot;x&quot;:107.4680801421614,&quot;y&quot;:91.32}},&quot;parent&quot;:{&quot;type&quot;:&quot;CHILD&quot;,&quot;parentId&quot;:&quot;8563537e-9ecc-4632-9afc-00afd7e3699c&quot;,&quot;order&quot;:&quot;99999999999999975&quot;}},&quot;ca618793-9cbd-4c31-8f3f-49468f7fc775&quot;:{&quot;id&quot;:&quot;ca618793-9cbd-4c31-8f3f-49468f7fc775&quot;,&quot;type&quot;:&quot;FIGURE_OBJECT&quot;,&quot;relativeTransform&quot;:{&quot;translate&quot;:{&quot;x&quot;:190.67546179576016,&quot;y&quot;:67.84973298277436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1]}],&quot;text&quot;:&quot;Progesterone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8&quot;}},&quot;fdab5c3b-8357-4917-9845-f1f64d6e575a&quot;:{&quot;id&quot;:&quot;fdab5c3b-8357-4917-9845-f1f64d6e575a&quot;,&quot;type&quot;:&quot;FIGURE_OBJECT&quot;,&quot;relativeTransform&quot;:{&quot;translate&quot;:{&quot;x&quot;:200.85194242041183,&quot;y&quot;:4.18741945072587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3}},&quot;format&quot;:&quot;BETTER_TEXT&quot;,&quot;size&quot;:{&quot;x&quot;:189.6977081298828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&quot;}},&quot;d5ddadf7-0730-4e76-a49f-2bd78b45341f&quot;:{&quot;relativeTransform&quot;:{&quot;translate&quot;:{&quot;x&quot;:-123.48813841370996,&quot;y&quot;:-11.157564975970843},&quot;rotate&quot;:0,&quot;skewX&quot;:0,&quot;scale&quot;:{&quot;x&quot;:1,&quot;y&quot;:1}},&quot;type&quot;:&quot;FIGURE_OBJECT&quot;,&quot;id&quot;:&quot;d5ddadf7-0730-4e76-a49f-2bd78b45341f&quot;,&quot;name&quot;:&quot;Petri dish with cells&quot;,&quot;displayName&quot;:&quot;Petri dish with cells&quot;,&quot;opacity&quot;:1,&quot;source&quot;:{&quot;id&quot;:&quot;5f6126e51ad2c000b63ff478&quot;,&quot;type&quot;:&quot;ASSETS&quot;},&quot;pathStyles&quot;:[{&quot;type&quot;:&quot;FILL&quot;,&quot;fillStyle&quot;:&quot;rgb(0,0,0)&quot;}],&quot;isLocked&quot;:false,&quot;parent&quot;:{&quot;type&quot;:&quot;CHILD&quot;,&quot;parentId&quot;:&quot;8563537e-9ecc-4632-9afc-00afd7e3699c&quot;,&quot;order&quot;:&quot;9999999999999999999999999999999999&quot;},&quot;isPremium&quot;:true},&quot;2a83b3a6-a5c5-4a9a-8523-953e6226815f&quot;:{&quot;type&quot;:&quot;FIGURE_OBJECT&quot;,&quot;id&quot;:&quot;2a83b3a6-a5c5-4a9a-8523-953e6226815f&quot;,&quot;name&quot;:&quot;Petri dish&quot;,&quot;relativeTransform&quot;:{&quot;translate&quot;:{&quot;x&quot;:0,&quot;y&quot;:5.608524144431269e-14},&quot;rotate&quot;:0,&quot;skewX&quot;:0,&quot;scale&quot;:{&quot;x&quot;:0.6071766165134398,&quot;y&quot;:0.6071766165134398}},&quot;opacity&quot;:1,&quot;image&quot;:{&quot;url&quot;:&quot;https://icons.biorender.com/biorender/5ee0f3bac4e9c30027d95cee/20200611181518/image/petri-dish-2.png&quot;,&quot;fallbackUrl&quot;:&quot;https://res.cloudinary.com/dlcjuc3ej/image/upload/v1591899318/jdx6mgytawhncb5ao57x.svg#/keystone/api/icons/5ee0f3bac4e9c30027d95cee/20200611181518/image/petri-dish-2.svg&quot;,&quot;size&quot;:{&quot;x&quot;:325,&quot;y&quot;:243},&quot;isPremium&quot;:false},&quot;source&quot;:{&quot;id&quot;:&quot;5ee0f3bac4e9c30027d95cee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02&quot;},&quot;styles&quot;:{&quot;petriDish&quot;:[{&quot;styleName&quot;:&quot;MONOCHROME_COLOR&quot;,&quot;index&quot;:0,&quot;color&quot;:&quot;#FF0D00&quot;}],&quot;liquid&quot;:[{&quot;styleName&quot;:&quot;MONOCHROME_COLOR&quot;,&quot;index&quot;:0,&quot;color&quot;:&quot;#FF0D00&quot;}]}},&quot;42512d50-6840-4d76-830e-be72f76c9ba6&quot;:{&quot;type&quot;:&quot;FIGURE_OBJECT&quot;,&quot;id&quot;:&quot;42512d50-6840-4d76-830e-be72f76c9ba6&quot;,&quot;name&quot;:&quot;Spheroidal cell&quot;,&quot;relativeTransform&quot;:{&quot;translate&quot;:{&quot;x&quot;:-35.94816670623872,&quot;y&quot;:17.667452063677587},&quot;rotate&quot;:0,&quot;skewX&quot;:0,&quot;scale&quot;:{&quot;x&quot;:0.15784657354899181,&quot;y&quot;:0.091809510780823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05&quot;},&quot;styles&quot;:{&quot;cell&quot;:[{&quot;monochromeTargetColor&quot;:&quot;#FF0D00&quot;,&quot;styleName&quot;:&quot;FILL&quot;,&quot;color&quot;:&quot;#ff2924&quot;},{&quot;monochromeTargetColor&quot;:&quot;#FF0D00&quot;,&quot;styleName&quot;:&quot;STROKE&quot;,&quot;color&quot;:&quot;#ff0806&quot;}],&quot;nucleus&quot;:[{&quot;monochromeTargetColor&quot;:&quot;#FF0D00&quot;,&quot;styleName&quot;:&quot;FILL&quot;,&quot;color&quot;:&quot;#ff1410&quot;},{&quot;monochromeTargetColor&quot;:&quot;#FF0D00&quot;,&quot;styleName&quot;:&quot;STROKE&quot;,&quot;color&quot;:&quot;#ff0f0c&quot;}]}},&quot;4b9cbe9b-c92f-454f-bf80-da3a9304d28e&quot;:{&quot;type&quot;:&quot;FIGURE_OBJECT&quot;,&quot;id&quot;:&quot;4b9cbe9b-c92f-454f-bf80-da3a9304d28e&quot;,&quot;name&quot;:&quot;Spheroidal cell&quot;,&quot;relativeTransform&quot;:{&quot;translate&quot;:{&quot;x&quot;:18.13054297598798,&quot;y&quot;:6.823000424368783},&quot;rotate&quot;:-0.8441643388031763,&quot;skewX&quot;:0.5142096794425836,&quot;scale&quot;:{&quot;x&quot;:0.109115702397623,&quot;y&quot;:0.1328114687210952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&quot;},&quot;styles&quot;:{&quot;&quot;:[{&quot;styleName&quot;:&quot;MONOCHROME_COLOR&quot;,&quot;index&quot;:0,&quot;color&quot;:&quot;#FF0D00&quot;}]}},&quot;d5e04ab6-af8b-419e-97d2-2d40b351f1b0&quot;:{&quot;type&quot;:&quot;FIGURE_OBJECT&quot;,&quot;id&quot;:&quot;d5e04ab6-af8b-419e-97d2-2d40b351f1b0&quot;,&quot;name&quot;:&quot;Spheroidal cell&quot;,&quot;relativeTransform&quot;:{&quot;translate&quot;:{&quot;x&quot;:-25.666075796752715,&quot;y&quot;:7.25960221562042},&quot;rotate&quot;:-0.9242877860074409,&quot;skewX&quot;:0.5005509573056879,&quot;scale&quot;:{&quot;x&quot;:0.10532127007158326,&quot;y&quot;:0.137596296418687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2&quot;},&quot;styles&quot;:{&quot;&quot;:[{&quot;styleName&quot;:&quot;MONOCHROME_COLOR&quot;,&quot;index&quot;:0,&quot;color&quot;:&quot;#FF0D00&quot;}]}},&quot;d9e8de39-b83b-4709-9da2-1667f9f379f5&quot;:{&quot;type&quot;:&quot;FIGURE_OBJECT&quot;,&quot;id&quot;:&quot;d9e8de39-b83b-4709-9da2-1667f9f379f5&quot;,&quot;name&quot;:&quot;Spheroidal cell&quot;,&quot;relativeTransform&quot;:{&quot;translate&quot;:{&quot;x&quot;:-27.037268676931472,&quot;y&quot;:-14.148816604714987},&quot;rotate&quot;:-1.9669828044671898,&quot;skewX&quot;:-0.38482140423679745,&quot;scale&quot;:{&quot;x&quot;:0.0966973626519624,&quot;y&quot;:0.1498677554228841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15&quot;},&quot;styles&quot;:{&quot;&quot;:[{&quot;styleName&quot;:&quot;MONOCHROME_COLOR&quot;,&quot;index&quot;:0,&quot;color&quot;:&quot;#FF0D00&quot;}]}},&quot;d50be6de-f0aa-4b62-ad3f-3db24efe407a&quot;:{&quot;type&quot;:&quot;FIGURE_OBJECT&quot;,&quot;id&quot;:&quot;d50be6de-f0aa-4b62-ad3f-3db24efe407a&quot;,&quot;name&quot;:&quot;Spheroidal cell&quot;,&quot;relativeTransform&quot;:{&quot;translate&quot;:{&quot;x&quot;:6.22442247159574,&quot;y&quot;:-4.1354271764679575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&quot;},&quot;styles&quot;:{&quot;&quot;:[{&quot;styleName&quot;:&quot;MONOCHROME_COLOR&quot;,&quot;index&quot;:0,&quot;color&quot;:&quot;#FF0D00&quot;}]}},&quot;ff15a6bd-9585-4569-8486-931f6b9e2c2d&quot;:{&quot;type&quot;:&quot;FIGURE_OBJECT&quot;,&quot;id&quot;:&quot;ff15a6bd-9585-4569-8486-931f6b9e2c2d&quot;,&quot;name&quot;:&quot;Spheroidal cell&quot;,&quot;relativeTransform&quot;:{&quot;translate&quot;:{&quot;x&quot;:25.307956286786244,&quot;y&quot;:-25.434303978061937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2&quot;},&quot;styles&quot;:{&quot;&quot;:[{&quot;styleName&quot;:&quot;MONOCHROME_COLOR&quot;,&quot;index&quot;:0,&quot;color&quot;:&quot;#FF0D00&quot;}]}},&quot;d83416b5-b33b-43fb-872c-550175cbf600&quot;:{&quot;type&quot;:&quot;FIGURE_OBJECT&quot;,&quot;id&quot;:&quot;d83416b5-b33b-43fb-872c-550175cbf600&quot;,&quot;name&quot;:&quot;Spheroidal cell&quot;,&quot;relativeTransform&quot;:{&quot;translate&quot;:{&quot;x&quot;:-45.904258988878105,&quot;y&quot;:6.836275248689061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25&quot;},&quot;styles&quot;:{&quot;&quot;:[{&quot;styleName&quot;:&quot;MONOCHROME_COLOR&quot;,&quot;index&quot;:0,&quot;color&quot;:&quot;#FF0D00&quot;}]}},&quot;8509e4bc-4d63-44a4-94ad-fa24a57cdd7a&quot;:{&quot;type&quot;:&quot;FIGURE_OBJECT&quot;,&quot;id&quot;:&quot;8509e4bc-4d63-44a4-94ad-fa24a57cdd7a&quot;,&quot;name&quot;:&quot;Spheroidal cell&quot;,&quot;relativeTransform&quot;:{&quot;translate&quot;:{&quot;x&quot;:26.941907186973612,&quot;y&quot;:17.668650872453796},&quot;rotate&quot;:-2.518056665662852,&quot;skewX&quot;:-0.4945730877435788,&quot;scale&quot;:{&quot;x&quot;:0.12225973094234883,&quot;y&quot;:0.1185330327840801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3&quot;},&quot;styles&quot;:{&quot;&quot;:[{&quot;styleName&quot;:&quot;MONOCHROME_COLOR&quot;,&quot;index&quot;:0,&quot;color&quot;:&quot;#FF0D00&quot;}]}},&quot;9b9e3d25-b789-4a21-a432-bbbbb0b640bb&quot;:{&quot;type&quot;:&quot;FIGURE_OBJECT&quot;,&quot;id&quot;:&quot;9b9e3d25-b789-4a21-a432-bbbbb0b640bb&quot;,&quot;name&quot;:&quot;Spheroidal cell&quot;,&quot;relativeTransform&quot;:{&quot;translate&quot;:{&quot;x&quot;:-4.734830595262368,&quot;y&quot;:6.836083564854624},&quot;rotate&quot;:0.7464574379873126,&quot;skewX&quot;:-0.5158759485514509,&quot;scale&quot;:{&quot;x&quot;:0.11445735108071943,&quot;y&quot;:0.1266132455375633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35&quot;},&quot;styles&quot;:{&quot;&quot;:[{&quot;styleName&quot;:&quot;MONOCHROME_COLOR&quot;,&quot;index&quot;:0,&quot;color&quot;:&quot;#FF0D00&quot;}]}},&quot;1d04420f-04ad-4b92-b4b5-c6fe651a33f5&quot;:{&quot;type&quot;:&quot;FIGURE_OBJECT&quot;,&quot;id&quot;:&quot;1d04420f-04ad-4b92-b4b5-c6fe651a33f5&quot;,&quot;name&quot;:&quot;Spheroidal cell&quot;,&quot;relativeTransform&quot;:{&quot;translate&quot;:{&quot;x&quot;:-6.68555595462649,&quot;y&quot;:-14.803466749408686},&quot;rotate&quot;:0.213734288930394,&quot;skewX&quot;:-0.23158516584838867,&quot;scale&quot;:{&quot;x&quot;:0.15132853682888134,&quot;y&quot;:0.09576393851180379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4&quot;},&quot;styles&quot;:{&quot;&quot;:[{&quot;styleName&quot;:&quot;MONOCHROME_COLOR&quot;,&quot;index&quot;:0,&quot;color&quot;:&quot;#FF0D00&quot;}]}},&quot;7312d6db-f458-46d1-9331-82a2cef99657&quot;:{&quot;type&quot;:&quot;FIGURE_OBJECT&quot;,&quot;id&quot;:&quot;7312d6db-f458-46d1-9331-82a2cef99657&quot;,&quot;name&quot;:&quot;Spheroidal cell&quot;,&quot;relativeTransform&quot;:{&quot;translate&quot;:{&quot;x&quot;:-18.09248556476985,&quot;y&quot;:-25.14594105576579},&quot;rotate&quot;:2.8082484065025266,&quot;skewX&quot;:0.3382353591056591,&quot;scale&quot;:{&quot;x&quot;:0.14353196763903742,&quot;y&quot;:0.10096577741069561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&quot;},&quot;styles&quot;:{&quot;&quot;:[{&quot;styleName&quot;:&quot;MONOCHROME_COLOR&quot;,&quot;index&quot;:0,&quot;color&quot;:&quot;#FF0D00&quot;}]}},&quot;ad44f701-ebe9-4524-ae5d-b0ab4c0bc21e&quot;:{&quot;type&quot;:&quot;FIGURE_OBJECT&quot;,&quot;id&quot;:&quot;ad44f701-ebe9-4524-ae5d-b0ab4c0bc21e&quot;,&quot;name&quot;:&quot;Spheroidal cell&quot;,&quot;relativeTransform&quot;:{&quot;translate&quot;:{&quot;x&quot;:14.414761428434927,&quot;y&quot;:-15.1722763283521},&quot;rotate&quot;:-0.04903278895355655,&quot;skewX&quot;:0.05563510897168514,&quot;scale&quot;:{&quot;x&quot;:0.15747703678324385,&quot;y&quot;:0.0920249516499932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2&quot;},&quot;styles&quot;:{&quot;&quot;:[{&quot;styleName&quot;:&quot;MONOCHROME_COLOR&quot;,&quot;index&quot;:0,&quot;color&quot;:&quot;#FF0D00&quot;}]}},&quot;7aff5a26-5a34-4b0d-ab7a-d6281b4e9714&quot;:{&quot;type&quot;:&quot;FIGURE_OBJECT&quot;,&quot;id&quot;:&quot;7aff5a26-5a34-4b0d-ab7a-d6281b4e9714&quot;,&quot;name&quot;:&quot;Spheroidal cell&quot;,&quot;relativeTransform&quot;:{&quot;translate&quot;:{&quot;x&quot;:6.224521886152677,&quot;y&quot;:17.218462161979325},&quot;rotate&quot;:-1.7846385290398883,&quot;skewX&quot;:-0.23169099291879855,&quot;scale&quot;:{&quot;x&quot;:0.09320882656316883,&quot;y&quot;:0.1554768709178088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55&quot;},&quot;styles&quot;:{&quot;&quot;:[{&quot;styleName&quot;:&quot;MONOCHROME_COLOR&quot;,&quot;index&quot;:0,&quot;color&quot;:&quot;#FF0D00&quot;}]}},&quot;328b10f5-1313-4cd1-aa72-365e737e4350&quot;:{&quot;type&quot;:&quot;FIGURE_OBJECT&quot;,&quot;id&quot;:&quot;328b10f5-1313-4cd1-aa72-365e737e4350&quot;,&quot;name&quot;:&quot;Spheroidal cell&quot;,&quot;relativeTransform&quot;:{&quot;translate&quot;:{&quot;x&quot;:36.81280325856201,&quot;y&quot;:-15.172630928442713},&quot;rotate&quot;:-2.931431735711825,&quot;skewX&quot;:-0.22807204878781118,&quot;scale&quot;:{&quot;x&quot;:0.15152885905234068,&quot;y&quot;:0.0956373379077347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&quot;},&quot;styles&quot;:{&quot;&quot;:[{&quot;styleName&quot;:&quot;MONOCHROME_COLOR&quot;,&quot;index&quot;:0,&quot;color&quot;:&quot;#FF0D00&quot;}]}},&quot;6a50141e-9fee-44b9-9a93-7b0b034add00&quot;:{&quot;type&quot;:&quot;FIGURE_OBJECT&quot;,&quot;id&quot;:&quot;6a50141e-9fee-44b9-9a93-7b0b034add00&quot;,&quot;name&quot;:&quot;Spheroidal cell&quot;,&quot;relativeTransform&quot;:{&quot;translate&quot;:{&quot;x&quot;:-25.360090131766835,&quot;y&quot;:28.13378015320774},&quot;rotate&quot;:2.9762120695107392,&quot;skewX&quot;:0.1826732519111916,&quot;scale&quot;:{&quot;x&quot;:0.153822137438127,&quot;y&quot;:0.09421151556804605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2&quot;},&quot;styles&quot;:{&quot;&quot;:[{&quot;styleName&quot;:&quot;MONOCHROME_COLOR&quot;,&quot;index&quot;:0,&quot;color&quot;:&quot;#FF0D00&quot;}]}},&quot;3782474d-f16b-45d7-b83c-90ad7acbad8e&quot;:{&quot;type&quot;:&quot;FIGURE_OBJECT&quot;,&quot;id&quot;:&quot;3782474d-f16b-45d7-b83c-90ad7acbad8e&quot;,&quot;name&quot;:&quot;Spheroidal cell&quot;,&quot;relativeTransform&quot;:{&quot;translate&quot;:{&quot;x&quot;:-16.100024024192354,&quot;y&quot;:-3.688477714766073},&quot;rotate&quot;:2.4774495271634254,&quot;skewX&quot;:0.5045139632431672,&quot;scale&quot;:{&quot;x&quot;:0.11955608588347261,&quot;y&quot;:0.1212135424882255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65&quot;},&quot;styles&quot;:{&quot;&quot;:[{&quot;styleName&quot;:&quot;MONOCHROME_COLOR&quot;,&quot;index&quot;:0,&quot;color&quot;:&quot;#FF0D00&quot;}]}},&quot;79a4b294-6fd6-4684-bbdc-731748bff801&quot;:{&quot;type&quot;:&quot;FIGURE_OBJECT&quot;,&quot;id&quot;:&quot;79a4b294-6fd6-4684-bbdc-731748bff801&quot;,&quot;name&quot;:&quot;Spheroidal cell&quot;,&quot;relativeTransform&quot;:{&quot;translate&quot;:{&quot;x&quot;:38.27992794850325,&quot;y&quot;:8.016880765852614},&quot;rotate&quot;:1.9024858372198619,&quot;skewX&quot;:0.33691651854106114,&quot;scale&quot;:{&quot;x&quot;:0.09521061475176545,&quot;y&quot;:0.1522079941794886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&quot;},&quot;styles&quot;:{&quot;&quot;:[{&quot;styleName&quot;:&quot;MONOCHROME_COLOR&quot;,&quot;index&quot;:0,&quot;color&quot;:&quot;#FF0D00&quot;}]}},&quot;bc1efc4e-acae-4458-93fd-1b4c4d3c331e&quot;:{&quot;type&quot;:&quot;FIGURE_OBJECT&quot;,&quot;id&quot;:&quot;bc1efc4e-acae-4458-93fd-1b4c4d3c331e&quot;,&quot;name&quot;:&quot;Spheroidal cell&quot;,&quot;relativeTransform&quot;:{&quot;translate&quot;:{&quot;x&quot;:-14.750562463610251,&quot;y&quot;:17.667624441741154},&quot;rotate&quot;:1.3100682807713566,&quot;skewX&quot;:-0.2761173365540062,&quot;scale&quot;:{&quot;x&quot;:0.09389711816491687,&quot;y&quot;:0.15433718285698006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2&quot;},&quot;styles&quot;:{&quot;&quot;:[{&quot;styleName&quot;:&quot;MONOCHROME_COLOR&quot;,&quot;index&quot;:0,&quot;color&quot;:&quot;#FF0D00&quot;}]}},&quot;c35a2c28-9e05-4c59-9556-98792bc5b8dc&quot;:{&quot;type&quot;:&quot;FIGURE_OBJECT&quot;,&quot;id&quot;:&quot;c35a2c28-9e05-4c59-9556-98792bc5b8dc&quot;,&quot;name&quot;:&quot;Spheroidal cell&quot;,&quot;relativeTransform&quot;:{&quot;translate&quot;:{&quot;x&quot;:26.94092764963195,&quot;y&quot;:-4.129120720665408},&quot;rotate&quot;:0.19240739639058355,&quot;skewX&quot;:-0.2103697253931654,&quot;scale&quot;:{&quot;x&quot;:0.1524877170143775,&quot;y&quot;:0.09503596079542494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75&quot;},&quot;styles&quot;:{&quot;&quot;:[{&quot;styleName&quot;:&quot;MONOCHROME_COLOR&quot;,&quot;index&quot;:0,&quot;color&quot;:&quot;#FF0D00&quot;}]}},&quot;c415f798-048e-4b08-b21a-9a5087f41ff9&quot;:{&quot;type&quot;:&quot;FIGURE_OBJECT&quot;,&quot;id&quot;:&quot;c415f798-048e-4b08-b21a-9a5087f41ff9&quot;,&quot;name&quot;:&quot;Spheroidal cell&quot;,&quot;relativeTransform&quot;:{&quot;translate&quot;:{&quot;x&quot;:-4.734994663181028,&quot;y&quot;:27.597581402745778},&quot;rotate&quot;:2.007270146731144,&quot;skewX&quot;:0.4110222361829166,&quot;scale&quot;:{&quot;x&quot;:0.09155760461031981,&quot;y&quot;:0.13879853945187307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8&quot;},&quot;styles&quot;:{&quot;&quot;:[{&quot;styleName&quot;:&quot;MONOCHROME_COLOR&quot;,&quot;index&quot;:0,&quot;color&quot;:&quot;#FF0D00&quot;}]}},&quot;12949984-9fdc-4741-989c-7438dcbc1b22&quot;:{&quot;type&quot;:&quot;FIGURE_OBJECT&quot;,&quot;id&quot;:&quot;12949984-9fdc-4741-989c-7438dcbc1b22&quot;,&quot;name&quot;:&quot;Spheroidal cell&quot;,&quot;relativeTransform&quot;:{&quot;translate&quot;:{&quot;x&quot;:46.97789185639535,&quot;y&quot;:-3.6955206117122055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85&quot;},&quot;styles&quot;:{&quot;&quot;:[{&quot;styleName&quot;:&quot;MONOCHROME_COLOR&quot;,&quot;index&quot;:0,&quot;color&quot;:&quot;#FF0D00&quot;}]}},&quot;41473d35-e20e-43dd-8486-904c120ef37a&quot;:{&quot;type&quot;:&quot;FIGURE_OBJECT&quot;,&quot;id&quot;:&quot;41473d35-e20e-43dd-8486-904c120ef37a&quot;,&quot;name&quot;:&quot;Spheroidal cell&quot;,&quot;relativeTransform&quot;:{&quot;translate&quot;:{&quot;x&quot;:58.33393055617962,&quot;y&quot;:6.463736283693512},&quot;rotate&quot;:0.48995510255153724,&quot;skewX&quot;:-0.4413064158590025,&quot;scale&quot;:{&quot;x&quot;:0.1308999746261694,&quot;y&quot;:0.10911441715432328}},&quot;opacity&quot;:1,&quot;image&quot;:{&quot;url&quot;:&quot;https://icons.biorender.com/biorender/5f35964d8d485800287e5096/spheroidal-cell.png&quot;,&quot;fallbackUrl&quot;:&quot;https://res.cloudinary.com/dlcjuc3ej/image/upload/v1597347396/nrogjrxetvkiq8xe8piz.svg#/keystone/api/icons/5f35964d8d485800287e5096/spheroidal-cell.svg&quot;,&quot;size&quot;:{&quot;x&quot;:157,&quot;y&quot;:154},&quot;isPremium&quot;:false},&quot;source&quot;:{&quot;id&quot;:&quot;5f32bc680be41f0028c4b1b3&quot;,&quot;type&quot;:&quot;ASSETS&quot;},&quot;pathStyles&quot;:[{&quot;type&quot;:&quot;FILL&quot;,&quot;fillStyle&quot;:&quot;rgb(0,0,0)&quot;}],&quot;isLocked&quot;:false,&quot;parent&quot;:{&quot;type&quot;:&quot;CHILD&quot;,&quot;parentId&quot;:&quot;d5ddadf7-0730-4e76-a49f-2bd78b45341f&quot;,&quot;order&quot;:&quot;9&quot;},&quot;styles&quot;:{&quot;&quot;:[{&quot;styleName&quot;:&quot;MONOCHROME_COLOR&quot;,&quot;index&quot;:0,&quot;color&quot;:&quot;#FF0D00&quot;}]}},&quot;9f7f6583-bb35-4329-833e-56fc4e73ba73&quot;:{&quot;type&quot;:&quot;FIGURE_OBJECT&quot;,&quot;id&quot;:&quot;9f7f6583-bb35-4329-833e-56fc4e73ba73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d9bd02e7-08a7-44cb-91ef-b277982807c8&quot;:{&quot;type&quot;:&quot;FIGURE_OBJECT&quot;,&quot;id&quot;:&quot;d9bd02e7-08a7-44cb-91ef-b277982807c8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b21c5746-6502-4a3e-8c3b-f780e96fbd46&quot;:{&quot;type&quot;:&quot;FIGURE_OBJECT&quot;,&quot;id&quot;:&quot;b21c5746-6502-4a3e-8c3b-f780e96fbd46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b6e60238-7a0b-47be-96f3-15dfb46160c0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b6e60238-7a0b-47be-96f3-15dfb46160c0&quot;:{&quot;type&quot;:&quot;FIGURE_OBJECT&quot;,&quot;id&quot;:&quot;b6e60238-7a0b-47be-96f3-15dfb46160c0&quot;,&quot;parent&quot;:{&quot;type&quot;:&quot;CHILD&quot;,&quot;parentId&quot;:&quot;8563537e-9ecc-4632-9afc-00afd7e3699c&quot;,&quot;order&quot;:&quot;99999999999999999999999998&quot;},&quot;relativeTransform&quot;:{&quot;translate&quot;:{&quot;x&quot;:-236.4160277239672,&quot;y&quot;:-10.117289381498281},&quot;rotate&quot;:-1.5707963267948966,&quot;skewX&quot;:0,&quot;scale&quot;:{&quot;x&quot;:1,&quot;y&quot;:1}}},&quot;af357b87-1477-449c-8986-1c935208e987&quot;:{&quot;id&quot;:&quot;af357b87-1477-449c-8986-1c935208e987&quot;,&quot;type&quot;:&quot;FIGURE_OBJECT&quot;,&quot;relativeTransform&quot;:{&quot;translate&quot;:{&quot;x&quot;:190.6763409296052,&quot;y&quot;:-71.284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1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5&quot;}},&quot;05e63131-8e15-4362-a850-11d39e9751eb&quot;:{&quot;type&quot;:&quot;FIGURE_OBJECT&quot;,&quot;id&quot;:&quot;05e63131-8e15-4362-a850-11d39e9751eb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b6e60238-7a0b-47be-96f3-15dfb46160c0&quot;,&quot;order&quot;:&quot;8&quot;},&quot;connectorInfo&quot;:{&quot;connectedObjects&quot;:[],&quot;type&quot;:&quot;ELBOW&quot;,&quot;offset&quot;:{&quot;x&quot;:0,&quot;y&quot;:0},&quot;bending&quot;:-0.1,&quot;firstElementIsHead&quot;:true,&quot;customized&quot;:false}}}}"/>
    <we:property name="660568fc43c856a6285d066f_1712209261485" value="{&quot;id&quot;:&quot;154b2bbb-2e89-43ce-87eb-d1c0ddf3d544&quot;,&quot;objects&quot;:{&quot;154b2bbb-2e89-43ce-87eb-d1c0ddf3d544&quot;:{&quot;id&quot;:&quot;154b2bbb-2e89-43ce-87eb-d1c0ddf3d544&quot;,&quot;type&quot;:&quot;FIGURE_OBJECT&quot;,&quot;document&quot;:{&quot;type&quot;:&quot;DOCUMENT_GROUP&quot;,&quot;canvasType&quot;:&quot;FIGURE&quot;,&quot;units&quot;:&quot;in&quot;},&quot;source&quot;:{&quot;id&quot;:&quot;60215dc4778c4a00a247c9f3&quot;,&quot;type&quot;:&quot;TEMPLATES&quot;}},&quot;8563537e-9ecc-4632-9afc-00afd7e3699c&quot;:{&quot;type&quot;:&quot;FIGURE_OBJECT&quot;,&quot;id&quot;:&quot;8563537e-9ecc-4632-9afc-00afd7e3699c&quot;,&quot;document&quot;:{&quot;type&quot;:&quot;FIGURE&quot;,&quot;canvasType&quot;:&quot;FIGURE&quot;,&quot;units&quot;:&quot;in&quot;,&quot;aspectRatio&quot;:0},&quot;relativeTransform&quot;:{&quot;translate&quot;:{&quot;x&quot;:0,&quot;y&quot;:0},&quot;rotate&quot;:0,&quot;skewX&quot;:0,&quot;scale&quot;:{&quot;x&quot;:1,&quot;y&quot;:1}},&quot;isLocked&quot;:false,&quot;parent&quot;:{&quot;type&quot;:&quot;DOCUMENT&quot;,&quot;parentId&quot;:&quot;154b2bbb-2e89-43ce-87eb-d1c0ddf3d544&quot;,&quot;order&quot;:&quot;5&quot;},&quot;source&quot;:{&quot;id&quot;:&quot;60215dc4778c4a00a247c9f3&quot;,&quot;type&quot;:&quot;TEMPLATES&quot;}},&quot;4566a81b-7c16-4555-82ce-e55df715210b&quot;:{&quot;type&quot;:&quot;FIGURE_OBJECT&quot;,&quot;id&quot;:&quot;4566a81b-7c16-4555-82ce-e55df715210b&quot;,&quot;relativeTransform&quot;:{&quot;translate&quot;:{&quot;x&quot;:-66.29117599212623,&quot;y&quot;:17.088778983441955},&quot;rotate&quot;:0,&quot;skewX&quot;:0,&quot;scale&quot;:{&quot;x&quot;:1,&quot;y&quot;:1}},&quot;path&quot;:{&quot;type&quot;:&quot;RECT&quot;,&quot;size&quot;:{&quot;x&quot;:1263.7844000901623,&quot;y&quot;:269.57791199341443}},&quot;pathStyles&quot;:[{&quot;type&quot;:&quot;FILL&quot;,&quot;fillStyle&quot;:&quot;rgb(255, 255, 255)&quot;}],&quot;parent&quot;:{&quot;type&quot;:&quot;FRAME&quot;,&quot;parentId&quot;:&quot;8563537e-9ecc-4632-9afc-00afd7e3699c&quot;,&quot;order&quot;:&quot;5&quot;}},&quot;76af6888-a788-4306-8be8-0896f37958a7&quot;:{&quot;type&quot;:&quot;FIGURE_OBJECT&quot;,&quot;id&quot;:&quot;76af6888-a788-4306-8be8-0896f37958a7&quot;,&quot;guide&quot;:{&quot;type&quot;:&quot;GRID&quot;,&quot;distance&quot;:0.5,&quot;units&quot;:&quot;in&quot;},&quot;parent&quot;:{&quot;type&quot;:&quot;GUIDE&quot;,&quot;parentId&quot;:&quot;154b2bbb-2e89-43ce-87eb-d1c0ddf3d544&quot;,&quot;order&quot;:&quot;5&quot;}},&quot;52c244e1-4b63-41de-917c-9c53182d1ce8&quot;:{&quot;type&quot;:&quot;FIGURE_OBJECT&quot;,&quot;id&quot;:&quot;52c244e1-4b63-41de-917c-9c53182d1ce8&quot;,&quot;relativeTransform&quot;:{&quot;translate&quot;:{&quot;x&quot;:0,&quot;y&quot;:0},&quot;rotate&quot;:0,&quot;skewX&quot;:0,&quot;scale&quot;:{&quot;x&quot;:1,&quot;y&quot;:1}},&quot;path&quot;:{&quot;type&quot;:&quot;RECT&quot;,&quot;size&quot;:{&quot;x&quot;:1536,&quot;y&quot;:1500.48}},&quot;pathStyles&quot;:[{&quot;type&quot;:&quot;FILL&quot;,&quot;fillStyle&quot;:&quot;rgb(255, 255, 255)&quot;}],&quot;parent&quot;:{&quot;type&quot;:&quot;FRAME&quot;,&quot;parentId&quot;:&quot;154b2bbb-2e89-43ce-87eb-d1c0ddf3d544&quot;,&quot;order&quot;:&quot;5&quot;}},&quot;032ed90b-12bd-4f43-bd0f-e8c2b22c9bef&quot;:{&quot;id&quot;:&quot;032ed90b-12bd-4f43-bd0f-e8c2b22c9bef&quot;,&quot;type&quot;:&quot;FIGURE_OBJECT&quot;,&quot;relativeTransform&quot;:{&quot;translate&quot;:{&quot;x&quot;:-535.7145746789546,&quot;y&quot;:-318.6178547868111},&quot;rotate&quot;:0},&quot;text&quot;:{&quot;textData&quot;:{&quot;lineSpacing&quot;:&quot;normal&quot;,&quot;alignment&quot;:&quot;left&quot;,&quot;lines&quot;:[{&quot;runs&quot;:[],&quot;text&quot;:&quot;&quot;,&quot;baseStyle&quot;:{&quot;fontFamily&quot;:&quot;Roboto&quot;,&quot;fontSize&quot;:18.666666666666664,&quot;color&quot;:&quot;black&quot;,&quot;fontWeight&quot;:&quot;normal&quot;,&quot;fontStyle&quot;:&quot;normal&quot;,&quot;decoration&quot;:&quot;none&quot;,&quot;script&quot;:&quot;none&quot;}}],&quot;verticalAlign&quot;:&quot;TOP&quot;},&quot;format&quot;:&quot;BETTER_TEXT&quot;,&quot;size&quot;:{&quot;x&quot;:138.4585099111415,&quot;y&quot;:51.28092959671909},&quot;targetSize&quot;:{&quot;x&quot;:138.4585099111415,&quot;y&quot;:51.28092959671909},&quot;verticalAlign&quot;:&quot;TOP&quot;},&quot;parent&quot;:{&quot;type&quot;:&quot;CHILD&quot;,&quot;parentId&quot;:&quot;8563537e-9ecc-4632-9afc-00afd7e3699c&quot;,&quot;order&quot;:&quot;95&quot;}},&quot;8b5e6bc7-5a0d-4a4a-a534-057f391556aa&quot;:{&quot;id&quot;:&quot;8b5e6bc7-5a0d-4a4a-a534-057f391556aa&quot;,&quot;type&quot;:&quot;FIGURE_OBJECT&quot;,&quot;relativeTransform&quot;:{&quot;translate&quot;:{&quot;x&quot;:-608.0271907551307,&quot;y&quot;:70.90160442360896},&quot;rotate&quot;:0,&quot;skewX&quot;:0,&quot;scale&quot;:{&quot;x&quot;:1,&quot;y&quot;:1}},&quot;text&quot;:{&quot;textData&quot;:{&quot;lineSpacing&quot;:&quot;normal&quot;,&quot;alignment&quot;:&quot;center&quot;,&quot;lines&quot;:[{&quot;runs&quot;:[{&quot;style&quot;:{&quot;fontWeight&quot;:&quot;bold&quot;,&quot;fontStyle&quot;:&quot;normal&quot;,&quot;fontSize&quot;:18.666666666666664,&quot;fontFamily&quot;:&quot;Roboto&quot;,&quot;color&quot;:&quot;black&quot;,&quot;decoration&quot;:&quot;none&quot;},&quot;range&quot;:[0,4]},{&quot;range&quot;:[5,13],&quot;style&quot;:{&quot;fontWeight&quot;:&quot;bold&quot;,&quot;fontStyle&quot;:&quot;normal&quot;,&quot;script&quot;:&quot;super&quot;,&quot;fontSize&quot;:18.666666666666664,&quot;fontFamily&quot;:&quot;Roboto&quot;,&quot;color&quot;:&quot;black&quot;,&quot;decoration&quot;:&quot;none&quot;}},{&quot;style&quot;:{&quot;fontWeight&quot;:&quot;bold&quot;,&quot;fontStyle&quot;:&quot;normal&quot;,&quot;fontSize&quot;:18.666666666666664,&quot;fontFamily&quot;:&quot;Roboto&quot;,&quot;color&quot;:&quot;black&quot;,&quot;decoration&quot;:&quot;none&quot;},&quot;range&quot;:[14,20]}],&quot;text&quot;:&quot; P2H1Ad.Cortex\nmouse &quot;},{&quot;runs&quot;:[{&quot;style&quot;:{&quot;fontWeight&quot;:&quot;bold&quot;,&quot;fontStyle&quot;:&quot;italic&quot;,&quot;fontSize&quot;:18.666666666666664,&quot;fontFamily&quot;:&quot;Roboto&quot;,&quot;color&quot;:&quot;black&quot;,&quot;decoration&quot;:&quot;none&quot;},&quot;range&quot;:[0,7]}],&quot;text&quot;:&quot;in vivo &quot;,&quot;baseStyle&quot;:{&quot;fontFamily&quot;:&quot;Roboto&quot;,&quot;fontSize&quot;:18.666666666666664,&quot;color&quot;:&quot;black&quot;,&quot;fontWeight&quot;:&quot;bold&quot;,&quot;fontStyle&quot;:&quot;italic&quot;,&quot;decoration&quot;:&quot;none&quot;,&quot;script&quot;:&quot;none&quot;}}],&quot;verticalAlign&quot;:&quot;TOP&quot;,&quot;_lastCaretLocation&quot;:{&quot;lineIndex&quot;:0,&quot;runIndex&quot;:2,&quot;charIndex&quot;:14}},&quot;format&quot;:&quot;BETTER_TEXT&quot;,&quot;size&quot;:{&quot;x&quot;:199.48518492380776,&quot;y&quot;:43.093333333333334},&quot;targetSize&quot;:{&quot;x&quot;:199.48518492380776,&quot;y&quot;:40.45495813527425},&quot;verticalAlign&quot;:&quot;TOP&quot;},&quot;parent&quot;:{&quot;type&quot;:&quot;CHILD&quot;,&quot;parentId&quot;:&quot;8563537e-9ecc-4632-9afc-00afd7e3699c&quot;,&quot;order&quot;:&quot;9999999999998&quot;}},&quot;8c1f0d3b-62cb-45cf-903b-2957e7ae9337&quot;:{&quot;id&quot;:&quot;8c1f0d3b-62cb-45cf-903b-2957e7ae9337&quot;,&quot;type&quot;:&quot;FIGURE_OBJECT&quot;,&quot;relativeTransform&quot;:{&quot;translate&quot;:{&quot;x&quot;:-454.5508578673128,&quot;y&quot;:11.87078273922603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4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5,5]}],&quot;text&quot;:&quot;21% O2&quot;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1]}],&quot;text&quot;:&quot;vs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},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3]},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,&quot;range&quot;:[4,4]}],&quot;text&quot;:&quot;9% O2&quot;},{&quot;runs&quot;:[],&quot;text&quot;:&quot;&quot;,&quot;base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sub&quot;}},{&quot;runs&quot;:[],&quot;text&quot;:&quot;&quot;,&quot;baseStyle&quot;:{&quot;fontFamily&quot;:&quot;Roboto&quot;,&quot;fontSize&quot;:18.666666666666664,&quot;color&quot;:&quot;rgba(81, 189, 82, 1)&quot;,&quot;fontWeight&quot;:&quot;bold&quot;,&quot;fontStyle&quot;:&quot;normal&quot;,&quot;decoration&quot;:&quot;none&quot;,&quot;script&quot;:&quot;none&quot;}}],&quot;_lastCaretLocation&quot;:{&quot;lineIndex&quot;:4,&quot;runIndex&quot;:-1,&quot;charIndex&quot;:-1,&quot;endOfLine&quot;:true}},&quot;format&quot;:&quot;BETTER_TEXT&quot;,&quot;size&quot;:{&quot;x&quot;:107.4680801421614,&quot;y&quot;:127.46666666666665},&quot;targetSize&quot;:{&quot;x&quot;:107.4680801421614,&quot;y&quot;:91.32}},&quot;parent&quot;:{&quot;type&quot;:&quot;CHILD&quot;,&quot;parentId&quot;:&quot;8563537e-9ecc-4632-9afc-00afd7e3699c&quot;,&quot;order&quot;:&quot;99999999999999975&quot;}},&quot;7fe9c513-5a5b-4ad2-9186-3554592f5107&quot;:{&quot;id&quot;:&quot;7fe9c513-5a5b-4ad2-9186-3554592f5107&quot;,&quot;name&quot;:&quot;Adrenal gland (left, cut)&quot;,&quot;displayName&quot;:&quot;&quot;,&quot;type&quot;:&quot;FIGURE_OBJECT&quot;,&quot;relativeTransform&quot;:{&quot;translate&quot;:{&quot;x&quot;:32.4950788091171,&quot;y&quot;:4.0594494058927},&quot;rotate&quot;:0,&quot;skewX&quot;:0,&quot;scale&quot;:{&quot;x&quot;:1.4470048465926237,&quot;y&quot;:1.447004846592624}},&quot;image&quot;:{&quot;url&quot;:&quot;https://icons.biorender.com/biorender/62ffa6910b0c6a0028194db5/adrenal-gland-left-01.png&quot;,&quot;fallbackUrl&quot;:&quot;https://res.cloudinary.com/dlcjuc3ej/image/upload/v1660921483/t0scx51xhkpunrthshxh.svg#/keystone/api/icons/62ffa6910b0c6a0028194db5/adrenal-gland-left-01.svg#/keystone/api/icons/62ffa6910b0c6a0028194db5/adrenal-gland-left-01.svg#/keystone/api/icons/62ffa6910b0c6a0028194db5/adrenal-gland-left-01.svg&quot;,&quot;isPremium&quot;:false,&quot;size&quot;:{&quot;x&quot;:100,&quot;y&quot;:77.40585774058577}},&quot;source&quot;:{&quot;id&quot;:&quot;62ffa3290b0c6a0028194da4&quot;,&quot;type&quot;:&quot;ASSETS&quot;},&quot;isPremium&quot;:false,&quot;parent&quot;:{&quot;type&quot;:&quot;CHILD&quot;,&quot;parentId&quot;:&quot;8563537e-9ecc-4632-9afc-00afd7e3699c&quot;,&quot;order&quot;:&quot;99999999999999999999999999999999996&quot;}},&quot;58011070-4e26-4b94-9f48-fa45aae8e63d&quot;:{&quot;type&quot;:&quot;FIGURE_OBJECT&quot;,&quot;id&quot;:&quot;58011070-4e26-4b94-9f48-fa45aae8e63d&quot;,&quot;parent&quot;:{&quot;type&quot;:&quot;CHILD&quot;,&quot;parentId&quot;:&quot;8563537e-9ecc-4632-9afc-00afd7e3699c&quot;,&quot;order&quot;:&quot;999999999999999999999999999999999975&quot;},&quot;relativeTransform&quot;:{&quot;translate&quot;:{&quot;x&quot;:-231.48292970613073,&quot;y&quot;:27.847122994420808},&quot;rotate&quot;:0,&quot;skewX&quot;:0,&quot;scale&quot;:{&quot;x&quot;:1,&quot;y&quot;:1}}},&quot;de6f37cc-70af-4899-94bd-7502cb354636&quot;:{&quot;type&quot;:&quot;FIGURE_OBJECT&quot;,&quot;id&quot;:&quot;de6f37cc-70af-4899-94bd-7502cb354636&quot;,&quot;parent&quot;:{&quot;type&quot;:&quot;CHILD&quot;,&quot;parentId&quot;:&quot;58011070-4e26-4b94-9f48-fa45aae8e63d&quot;,&quot;order&quot;:&quot;2&quot;},&quot;relativeTransform&quot;:{&quot;translate&quot;:{&quot;x&quot;:-51.34816994040851,&quot;y&quot;:37.425046546512284},&quot;rotate&quot;:0}},&quot;145bac72-52c8-4496-8c06-09384829039c&quot;:{&quot;id&quot;:&quot;145bac72-52c8-4496-8c06-09384829039c&quot;,&quot;name&quot;:&quot;Compressed gas tank&quot;,&quot;displayName&quot;:&quot;&quot;,&quot;type&quot;:&quot;FIGURE_OBJECT&quot;,&quot;relativeTransform&quot;:{&quot;translate&quot;:{&quot;x&quot;:61.3313631486884,&quot;y&quot;:-68.39028581591374},&quot;rotate&quot;:0,&quot;skewX&quot;:0,&quot;scale&quot;:{&quot;x&quot;:0.5287186478335207,&quot;y&quot;:0.5287186478335207}},&quot;image&quot;:{&quot;url&quot;:&quot;https://icons.biorender.com/biorender/5da628ac645275000458d6fa/20191015202050/image/compressed-gas-tank.png&quot;,&quot;fallbackUrl&quot;:&quot;https://res.cloudinary.com/dlcjuc3ej/image/upload/v1571170850/penwt8wvnryq1orafxxg.svg#/keystone/api/icons/5da628ac645275000458d6fa/20191015202050/image/compressed-gas-tank.svg&quot;,&quot;isPremium&quot;:false,&quot;size&quot;:{&quot;x&quot;:125,&quot;y&quot;:251.5923566878981}},&quot;source&quot;:{&quot;id&quot;:&quot;5da628ac645275000458d6fa&quot;,&quot;type&quot;:&quot;ASSETS&quot;},&quot;isPremium&quot;:false,&quot;parent&quot;:{&quot;type&quot;:&quot;CHILD&quot;,&quot;parentId&quot;:&quot;de6f37cc-70af-4899-94bd-7502cb354636&quot;,&quot;order&quot;:&quot;2&quot;}},&quot;3640dc48-1c7b-479f-8760-337c398bc979&quot;:{&quot;id&quot;:&quot;3640dc48-1c7b-479f-8760-337c398bc979&quot;,&quot;name&quot;:&quot;Incubated stackable shaker (MaxQ 6000, single)&quot;,&quot;displayName&quot;:&quot;Incubated stackable shaker (MaxQ)&quot;,&quot;type&quot;:&quot;FIGURE_OBJECT&quot;,&quot;relativeTransform&quot;:{&quot;translate&quot;:{&quot;x&quot;:-29.079563662089683,&quot;y&quot;:-48.1831885819074},&quot;rotate&quot;:0,&quot;skewX&quot;:0,&quot;scale&quot;:{&quot;x&quot;:0.7804412157545995,&quot;y&quot;:0.7804412157545995}},&quot;image&quot;:{&quot;url&quot;:&quot;https://icons.biorender.com/biorender/5f8f54b1269fc400282cbd7c/20201020212401/image/incubated-stackable-shaker-maxq-6000-single.png&quot;,&quot;fallbackUrl&quot;:&quot;https://res.cloudinary.com/dlcjuc3ej/image/upload/v1603229041/lltf1ayw7dfe9dxjktnv.svg#/keystone/api/icons/5f8f54b1269fc400282cbd7c/20201020212401/image/incubated-stackable-shaker-maxq-6000-single.svg&quot;,&quot;isPremium&quot;:true,&quot;size&quot;:{&quot;x&quot;:200,&quot;y&quot;:287.7551020408163}},&quot;source&quot;:{&quot;id&quot;:&quot;5f8f54b1269fc400282cbd7c&quot;,&quot;type&quot;:&quot;ASSETS&quot;},&quot;isPremium&quot;:true,&quot;parent&quot;:{&quot;type&quot;:&quot;CHILD&quot;,&quot;parentId&quot;:&quot;de6f37cc-70af-4899-94bd-7502cb354636&quot;,&quot;order&quot;:&quot;6&quot;}},&quot;9853d6b0-1f5e-4faf-b974-7de2e2b18a10&quot;:{&quot;id&quot;:&quot;9853d6b0-1f5e-4faf-b974-7de2e2b18a10&quot;,&quot;type&quot;:&quot;FIGURE_OBJECT&quot;,&quot;relativeTransform&quot;:{&quot;translate&quot;:{&quot;x&quot;:30.45858425427475,&quot;y&quot;:-20.29478353888176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12.448465463913456,&quot;color&quot;:&quot;black&quot;,&quot;fontWeight&quot;:&quot;normal&quot;,&quot;fontStyle&quot;:&quot;normal&quot;,&quot;decoration&quot;:&quot;none&quot;},&quot;range&quot;:[0,0]},{&quot;style&quot;:{&quot;fontFamily&quot;:&quot;Roboto&quot;,&quot;fontSize&quot;:12.448465463913456,&quot;color&quot;:&quot;black&quot;,&quot;fontWeight&quot;:&quot;normal&quot;,&quot;fontStyle&quot;:&quot;normal&quot;,&quot;decoration&quot;:&quot;none&quot;,&quot;script&quot;:&quot;sub&quot;},&quot;range&quot;:[1,1]}],&quot;text&quot;:&quot;N2&quot;}],&quot;_lastCaretLocation&quot;:{&quot;lineIndex&quot;:0,&quot;runIndex&quot;:1,&quot;charIndex&quot;:1}},&quot;format&quot;:&quot;BETTER_TEXT&quot;,&quot;size&quot;:{&quot;x&quot;:15.858831515935817,&quot;y&quot;:14.671405725326572},&quot;targetSize&quot;:{&quot;x&quot;:15.858831515935817,&quot;y&quot;:14.671405725326572}},&quot;parent&quot;:{&quot;type&quot;:&quot;CHILD&quot;,&quot;parentId&quot;:&quot;58011070-4e26-4b94-9f48-fa45aae8e63d&quot;,&quot;order&quot;:&quot;5&quot;}},&quot;773a0a7e-5fa4-40b3-bc39-3acf8707863d&quot;:{&quot;type&quot;:&quot;FIGURE_OBJECT&quot;,&quot;id&quot;:&quot;773a0a7e-5fa4-40b3-bc39-3acf8707863d&quot;,&quot;relativeTransform&quot;:{&quot;translate&quot;:{&quot;x&quot;:-449.1197589709548,&quot;y&quot;:-0.5092022693567531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99999999999999999999977&quot;}},&quot;cf61650b-1630-47eb-b73e-87a1771169c5&quot;:{&quot;type&quot;:&quot;FIGURE_OBJECT&quot;,&quot;id&quot;:&quot;cf61650b-1630-47eb-b73e-87a1771169c5&quot;,&quot;relativeTransform&quot;:{&quot;translate&quot;:{&quot;x&quot;:-108.99022586074774,&quot;y&quot;:-0.5092022693567522},&quot;rotate&quot;:4.440892098500626e-16,&quot;skewX&quot;:-2.7755575615628815e-17,&quot;scale&quot;:{&quot;x&quot;:1,&quot;y&quot;:1}},&quot;opacity&quot;:1,&quot;path&quot;:{&quot;type&quot;:&quot;ARROW&quot;,&quot;size&quot;:{&quot;x&quot;:116.32963669095835,&quot;y&quot;:37.89070616800438},&quot;wingsOffsetRight&quot;:25,&quot;bodyHeightRatio&quot;:0.25},&quot;isLocked&quot;:false,&quot;pathStyles&quot;:[{&quot;type&quot;:&quot;FILL&quot;,&quot;fillStyle&quot;:&quot;rgba(63, 120, 193, 1)&quot;},{&quot;type&quot;:&quot;STROKE&quot;,&quot;strokeStyle&quot;:&quot;rgba(19,54,122,1)&quot;,&quot;lineWidth&quot;:1.9999999999999993,&quot;lineJoin&quot;:&quot;round&quot;}],&quot;parent&quot;:{&quot;type&quot;:&quot;CHILD&quot;,&quot;parentId&quot;:&quot;8563537e-9ecc-4632-9afc-00afd7e3699c&quot;,&quot;order&quot;:&quot;99999999999999999999999999999999998&quot;}},&quot;6c7bd470-7bc9-4bfc-872f-d3957ebd1966&quot;:{&quot;id&quot;:&quot;6c7bd470-7bc9-4bfc-872f-d3957ebd1966&quot;,&quot;type&quot;:&quot;FIGURE_OBJECT&quot;,&quot;relativeTransform&quot;:{&quot;translate&quot;:{&quot;x&quot;:299.1864617957601,&quot;y&quot;:73.62573298277435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7]}],&quot;text&quot;:&quot;Steroids&quot;}],&quot;verticalAlign&quot;:&quot;TOP&quot;,&quot;useStrokeForWeight&quot;:false,&quot;_lastCaretLocation&quot;:{&quot;lineIndex&quot;:0,&quot;runIndex&quot;:-1,&quot;charIndex&quot;:-1,&quot;endOfLine&quot;:true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55&quot;}},&quot;3e253ad7-1b1c-448a-862b-f6df6b5005f3&quot;:{&quot;id&quot;:&quot;3e253ad7-1b1c-448a-862b-f6df6b5005f3&quot;,&quot;type&quot;:&quot;FIGURE_OBJECT&quot;,&quot;relativeTransform&quot;:{&quot;translate&quot;:{&quot;x&quot;:307.70022475486417,&quot;y&quot;:10.51941921760544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20]}],&quot;text&quot;:&quot;Steroidogenic enzymes&quot;}],&quot;verticalAlign&quot;:&quot;TOP&quot;,&quot;useStrokeForWeight&quot;:false,&quot;_lastCaretLocation&quot;:{&quot;lineIndex&quot;:0,&quot;runIndex&quot;:0,&quot;charIndex&quot;:13}},&quot;format&quot;:&quot;BETTER_TEXT&quot;,&quot;size&quot;:{&quot;x&quot;:186.37227288355874,&quot;y&quot;:69.19999999999999},&quot;targetSize&quot;:{&quot;x&quot;:186.37227288355874,&quot;y&quot;:69.19999999999999},&quot;verticalAlign&quot;:&quot;TOP&quot;},&quot;parent&quot;:{&quot;type&quot;:&quot;CHILD&quot;,&quot;parentId&quot;:&quot;8563537e-9ecc-4632-9afc-00afd7e3699c&quot;,&quot;order&quot;:&quot;999999999999999999999999999999999996&quot;}},&quot;6994859c-b3eb-41e1-aeb8-5e0b4210431c&quot;:{&quot;type&quot;:&quot;FIGURE_OBJECT&quot;,&quot;id&quot;:&quot;6994859c-b3eb-41e1-aeb8-5e0b4210431c&quot;,&quot;parent&quot;:{&quot;type&quot;:&quot;CHILD&quot;,&quot;parentId&quot;:&quot;8563537e-9ecc-4632-9afc-00afd7e3699c&quot;,&quot;order&quot;:&quot;999999999999999999999999999999999997&quot;},&quot;relativeTransform&quot;:{&quot;translate&quot;:{&quot;x&quot;:-127.90502772396721,&quot;y&quot;:-4.341289381498282},&quot;rotate&quot;:-1.5707963267948966,&quot;skewX&quot;:0,&quot;scale&quot;:{&quot;x&quot;:1,&quot;y&quot;:1}}},&quot;b424dc20-0668-4750-b156-1cfe08cfe265&quot;:{&quot;type&quot;:&quot;FIGURE_OBJECT&quot;,&quot;id&quot;:&quot;b424dc20-0668-4750-b156-1cfe08cfe265&quot;,&quot;relativeTransform&quot;:{&quot;translate&quot;:{&quot;x&quot;:-49.93222378531453,&quot;y&quot;:304.8168850633593},&quot;rotate&quot;:1.5707963267948968},&quot;opacity&quot;:1,&quot;path&quot;:{&quot;type&quot;:&quot;POLY_LINE&quot;,&quot;points&quot;:[{&quot;x&quot;:-24.322546539329124,&quot;y&quot;:-48.071345700755046},{&quot;x&quot;:-24.322546539329142,&quot;y&quot;:22.18677484301125},{&quot;x&quot;: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6994859c-b3eb-41e1-aeb8-5e0b4210431c&quot;,&quot;order&quot;:&quot;1&quot;},&quot;connectorInfo&quot;:{&quot;connectedObjects&quot;:[],&quot;type&quot;:&quot;ELBOW&quot;,&quot;offset&quot;:{&quot;x&quot;:0,&quot;y&quot;:0},&quot;bending&quot;:-0.1,&quot;firstElementIsHead&quot;:true,&quot;customized&quot;:false}},&quot;171fbae3-d50b-4929-8b2d-3914c226f4b6&quot;:{&quot;type&quot;:&quot;FIGURE_OBJECT&quot;,&quot;id&quot;:&quot;171fbae3-d50b-4929-8b2d-3914c226f4b6&quot;,&quot;relativeTransform&quot;:{&quot;translate&quot;:{&quot;x&quot;:-4.430122126256237,&quot;y&quot;:307.6742785193435},&quot;rotate&quot;:0},&quot;opacity&quot;:1,&quot;path&quot;:{&quot;type&quot;:&quot;POLY_LINE&quot;,&quot;points&quot;:[{&quot;x&quot;:0,&quot;y&quot;:-26.146737529778743},{&quot;x&quot;:0,&quot;y&quot;:26.146737529778743}],&quot;closed&quot;:false},&quot;pathStyles&quot;:[{&quot;type&quot;:&quot;FILL&quot;,&quot;fillStyle&quot;:&quot;rgba(0,0,0,0)&quot;},{&quot;type&quot;:&quot;STROKE&quot;,&quot;strokeStyle&quot;:&quot;rgb(63, 120, 193)&quot;,&quot;lineWidth&quot;:5,&quot;lineJoin&quot;:&quot;round&quot;}],&quot;pathMarkers&quot;:{&quot;markerEnd&quot;:{&quot;type&quot;:&quot;PATH&quot;,&quot;units&quot;:{&quot;type&quot;:&quot;STROKE_WIDTH&quot;,&quot;scale&quot;:0.8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6994859c-b3eb-41e1-aeb8-5e0b4210431c&quot;,&quot;order&quot;:&quot;5&quot;},&quot;connectorInfo&quot;:{&quot;connectedObjects&quot;:[],&quot;type&quot;:&quot;LINE&quot;,&quot;offset&quot;:{&quot;x&quot;:0,&quot;y&quot;:0},&quot;bending&quot;:0.1,&quot;firstElementIsHead&quot;:true,&quot;customized&quot;:false}},&quot;1fe4c59e-c278-4f3f-9a6a-2bb728514144&quot;:{&quot;type&quot;:&quot;FIGURE_OBJECT&quot;,&quot;id&quot;:&quot;1fe4c59e-c278-4f3f-9a6a-2bb728514144&quot;,&quot;relativeTransform&quot;:{&quot;translate&quot;:{&quot;x&quot;:-4.430122126256237,&quot;y&quot;:263.9633184296581},&quot;rotate&quot;:0},&quot;opacity&quot;:1,&quot;path&quot;:{&quot;type&quot;:&quot;POLY_LINE&quot;,&quot;points&quot;:[{&quot;x&quot;:0,&quot;y&quot;:18.241909904496907},{&quot;x&quot;:0,&quot;y&quot;:-18.241909904496907}],&quot;closed&quot;:false},&quot;pathStyles&quot;:[{&quot;type&quot;:&quot;FILL&quot;,&quot;fillStyle&quot;:&quot;rgba(0,0,0,0)&quot;},{&quot;type&quot;:&quot;STROKE&quot;,&quot;strokeStyle&quot;:&quot;rgb(63, 120, 193)&quot;,&quot;lineWidth&quot;:6,&quot;lineJoin&quot;:&quot;round&quot;}],&quot;isLocked&quot;:false,&quot;parent&quot;:{&quot;type&quot;:&quot;CHILD&quot;,&quot;parentId&quot;:&quot;6994859c-b3eb-41e1-aeb8-5e0b4210431c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197e62b6-2482-4229-a43c-0b5cd6ca4ec9&quot;:{&quot;type&quot;:&quot;FIGURE_OBJECT&quot;,&quot;id&quot;:&quot;197e62b6-2482-4229-a43c-0b5cd6ca4ec9&quot;,&quot;relativeTransform&quot;:{&quot;translate&quot;:{&quot;x&quot;:44.14134707242926,&quot;y&quot;:304.8168850633593},&quot;rotate&quot;:-1.570796326794897,&quot;skewX&quot;:0,&quot;scale&quot;:{&quot;x&quot;:1,&quot;y&quot;:1}},&quot;opacity&quot;:1,&quot;path&quot;:{&quot;type&quot;:&quot;POLY_LINE&quot;,&quot;points&quot;:[{&quot;x&quot;:24.322546539329124,&quot;y&quot;:-48.071345700755046},{&quot;x&quot;:24.322546539329142,&quot;y&quot;:22.18677484301125},{&quot;x&quot;:-24.322546539329135,&quot;y&quot;:22.18677484301125}],&quot;closed&quot;:false,&quot;cornerRounding&quot;:{&quot;type&quot;:&quot;ARC_LENGTH&quot;,&quot;global&quot;:15.707963267948985},&quot;selectedObjectIds&quot;:[&quot;9f7f6583-bb35-4329-833e-56fc4e73ba73&quot;]},&quot;pathStyles&quot;:[{&quot;type&quot;:&quot;FILL&quot;,&quot;fillStyle&quot;:&quot;rgba(0,0,0,0)&quot;},{&quot;type&quot;:&quot;STROKE&quot;,&quot;strokeStyle&quot;:&quot;rgb(63, 120, 193)&quot;,&quot;lineWidth&quot;:6,&quot;lineJoin&quot;:&quot;round&quot;}],&quot;pathMarkers&quot;:{&quot;markerEnd&quot;:{&quot;type&quot;:&quot;PATH&quot;,&quot;units&quot;:{&quot;type&quot;:&quot;STROKE_WIDTH&quot;,&quot;scale&quot;:0.600000000000000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6994859c-b3eb-41e1-aeb8-5e0b4210431c&quot;,&quot;order&quot;:&quot;8&quot;},&quot;connectorInfo&quot;:{&quot;connectedObjects&quot;:[],&quot;type&quot;:&quot;ELBOW&quot;,&quot;offset&quot;:{&quot;x&quot;:0,&quot;y&quot;:0},&quot;bending&quot;:-0.1,&quot;firstElementIsHead&quot;:true,&quot;customized&quot;:false}},&quot;98cd95ae-efcb-4b0a-9682-f434b7096cea&quot;:{&quot;id&quot;:&quot;98cd95ae-efcb-4b0a-9682-f434b7096cea&quot;,&quot;type&quot;:&quot;FIGURE_OBJECT&quot;,&quot;relativeTransform&quot;:{&quot;translate&quot;:{&quot;x&quot;:299.18734092960517,&quot;y&quot;:-65.50824055768068},&quot;rotate&quot;:0,&quot;skewX&quot;:0,&quot;scale&quot;:{&quot;x&quot;:1,&quot;y&quot;:1}},&quot;text&quot;:{&quot;textData&quot;:{&quot;lineSpacing&quot;:&quot;normal&quot;,&quot;alignment&quot;:&quot;left&quot;,&quot;lines&quot;:[{&quot;runs&quot;:[{&quot;style&quot;:{&quot;fontFamily&quot;:&quot;Roboto&quot;,&quot;fontSize&quot;:18.666666666666664,&quot;color&quot;:&quot;rgba(23,23,23,1)&quot;,&quot;fontWeight&quot;:&quot;bold&quot;,&quot;fontStyle&quot;:&quot;normal&quot;,&quot;decoration&quot;:&quot;none&quot;,&quot;script&quot;:&quot;none&quot;},&quot;range&quot;:[0,5]}],&quot;text&quot;:&quot;miRNAs&quot;}],&quot;verticalAlign&quot;:&quot;TOP&quot;,&quot;useStrokeForWeight&quot;:false,&quot;_lastCaretLocation&quot;:{&quot;lineIndex&quot;:0,&quot;runIndex&quot;:0,&quot;charIndex&quot;:2}},&quot;format&quot;:&quot;BETTER_TEXT&quot;,&quot;size&quot;:{&quot;x&quot;:169.345703125,&quot;y&quot;:27.291027747190796},&quot;targetSize&quot;:{&quot;x&quot;:100.36607617986444,&quot;y&quot;:27.291027747190796},&quot;verticalAlign&quot;:&quot;TOP&quot;},&quot;parent&quot;:{&quot;type&quot;:&quot;CHILD&quot;,&quot;parentId&quot;:&quot;8563537e-9ecc-4632-9afc-00afd7e3699c&quot;,&quot;order&quot;:&quot;999999999999999999999999999999999998&quot;}},&quot;1a36599b-d810-44df-aa1a-4155c6ac9782&quot;:{&quot;id&quot;:&quot;1a36599b-d810-44df-aa1a-4155c6ac9782&quot;,&quot;name&quot;:&quot;Mouse (symbol)&quot;,&quot;displayName&quot;:&quot;&quot;,&quot;type&quot;:&quot;FIGURE_OBJECT&quot;,&quot;relativeTransform&quot;:{&quot;translate&quot;:{&quot;x&quot;:-311.23100000000005,&quot;y&quot;:11.871152034261257},&quot;rotate&quot;:0,&quot;skewX&quot;:0,&quot;scale&quot;:{&quot;x&quot;:0.9486199999999991,&quot;y&quot;:0.9486199999999991}},&quot;image&quot;:{&quot;url&quot;:&quot;https://icons.biorender.com/biorender/5fb58802d6bd96002858258b/mouse-icon.png&quot;,&quot;fallbackUrl&quot;:&quot;https://res.cloudinary.com/dlcjuc3ej/image/upload/v1605732349/rimrj4n97wjez1yibmcx.svg#/keystone/api/icons/5fb58802d6bd96002858258b/mouse-icon.svg#/keystone/api/icons/5fb58802d6bd96002858258b/mouse-icon.svg#/keystone/api/icons/5fb58802d6bd96002858258b/mouse-icon.svg#/keystone/api/icons/5fb58802d6bd96002858258b/mouse-icon.svg#/keystone/api/icons/5fb58802d6bd96002858258b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8563537e-9ecc-4632-9afc-00afd7e3699c&quot;,&quot;order&quot;:&quot;9999999999999999999999999999999999997&quot;}},&quot;f5bf0036-539c-47b0-a37a-770a0f19acbf&quot;:{&quot;id&quot;:&quot;f5bf0036-539c-47b0-a37a-770a0f19acbf&quot;,&quot;name&quot;:&quot;Mouse (symbol)&quot;,&quot;displayName&quot;:&quot;&quot;,&quot;type&quot;:&quot;FIGURE_OBJECT&quot;,&quot;relativeTransform&quot;:{&quot;translate&quot;:{&quot;x&quot;:-598.44,&quot;y&quot;:-8.677295503211944},&quot;rotate&quot;:0,&quot;skewX&quot;:0,&quot;scale&quot;:{&quot;x&quot;:1.4432399999999999,&quot;y&quot;:1.4432399999999999}},&quot;image&quot;:{&quot;url&quot;:&quot;https://icons.biorender.com/biorender/5fb58802d6bd96002858258b/mouse-icon.png&quot;,&quot;fallbackUrl&quot;:&quot;https://res.cloudinary.com/dlcjuc3ej/image/upload/v1605732349/rimrj4n97wjez1yibmcx.svg#/keystone/api/icons/5fb58802d6bd96002858258b/mouse-icon.svg#/keystone/api/icons/5fb58802d6bd96002858258b/mouse-icon.svg#/keystone/api/icons/5fb58802d6bd96002858258b/mouse-icon.svg#/keystone/api/icons/5fb58802d6bd96002858258b/mouse-icon.svg#/keystone/api/icons/5fb58802d6bd96002858258b/mouse-icon.svg&quot;,&quot;isPremium&quot;:false,&quot;size&quot;:{&quot;x&quot;:100,&quot;y&quot;:59.95717344753748}},&quot;source&quot;:{&quot;id&quot;:&quot;5fb57bd05b10bf00287ae158&quot;,&quot;type&quot;:&quot;ASSETS&quot;},&quot;isPremium&quot;:false,&quot;parent&quot;:{&quot;type&quot;:&quot;CHILD&quot;,&quot;parentId&quot;:&quot;8563537e-9ecc-4632-9afc-00afd7e3699c&quot;,&quot;order&quot;:&quot;9999999999999999999999999999999999998&quot;}}}}"/>
    <we:property name="has-seen-first-time-experience" value="true"/>
    <we:property name="has-user-completed-add" value="true"/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ppt/webextensions/webextension2.xml><?xml version="1.0" encoding="utf-8"?>
<we:webextension xmlns:we="http://schemas.microsoft.com/office/webextensions/webextension/2010/11" id="{75138D6F-AD47-465F-8918-3F343A26F379}">
  <we:reference id="wa200003915" version="2.0.0.0" store="en-US" storeType="OMEX"/>
  <we:alternateReferences>
    <we:reference id="WA200003915" version="2.0.0.0" store="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301</Words>
  <Application>Microsoft Office PowerPoint</Application>
  <PresentationFormat>A4 Paper (210x297 mm)</PresentationFormat>
  <Paragraphs>171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ptos</vt:lpstr>
      <vt:lpstr>Arial</vt:lpstr>
      <vt:lpstr>Calibri</vt:lpstr>
      <vt:lpstr>Calibri Light</vt:lpstr>
      <vt:lpstr>Times New Roman</vt:lpstr>
      <vt:lpstr>Office 2013 - 2022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uscript Figures</dc:title>
  <dc:creator>Ariyeloye, Stephen</dc:creator>
  <cp:lastModifiedBy>Ben Wielockx</cp:lastModifiedBy>
  <cp:revision>70</cp:revision>
  <dcterms:created xsi:type="dcterms:W3CDTF">2024-03-04T09:33:06Z</dcterms:created>
  <dcterms:modified xsi:type="dcterms:W3CDTF">2025-01-07T09:43:56Z</dcterms:modified>
</cp:coreProperties>
</file>